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4.xml" ContentType="application/vnd.openxmlformats-officedocument.presentationml.notesSlide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diagrams/data3.xml" ContentType="application/vnd.openxmlformats-officedocument.drawingml.diagramData+xml"/>
  <Override PartName="/ppt/diagrams/layout3.xml" ContentType="application/vnd.openxmlformats-officedocument.drawingml.diagramLayout+xml"/>
  <Override PartName="/ppt/diagrams/quickStyle3.xml" ContentType="application/vnd.openxmlformats-officedocument.drawingml.diagramStyle+xml"/>
  <Override PartName="/ppt/diagrams/colors3.xml" ContentType="application/vnd.openxmlformats-officedocument.drawingml.diagramColors+xml"/>
  <Override PartName="/ppt/diagrams/drawing3.xml" ContentType="application/vnd.ms-office.drawingml.diagramDrawing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diagrams/data4.xml" ContentType="application/vnd.openxmlformats-officedocument.drawingml.diagramData+xml"/>
  <Override PartName="/ppt/diagrams/layout4.xml" ContentType="application/vnd.openxmlformats-officedocument.drawingml.diagramLayout+xml"/>
  <Override PartName="/ppt/diagrams/quickStyle4.xml" ContentType="application/vnd.openxmlformats-officedocument.drawingml.diagramStyle+xml"/>
  <Override PartName="/ppt/diagrams/colors4.xml" ContentType="application/vnd.openxmlformats-officedocument.drawingml.diagramColors+xml"/>
  <Override PartName="/ppt/diagrams/drawing4.xml" ContentType="application/vnd.ms-office.drawingml.diagramDrawing+xml"/>
  <Override PartName="/ppt/notesSlides/notesSlide9.xml" ContentType="application/vnd.openxmlformats-officedocument.presentationml.notesSlide+xml"/>
  <Override PartName="/ppt/diagrams/data5.xml" ContentType="application/vnd.openxmlformats-officedocument.drawingml.diagramData+xml"/>
  <Override PartName="/ppt/diagrams/layout5.xml" ContentType="application/vnd.openxmlformats-officedocument.drawingml.diagramLayout+xml"/>
  <Override PartName="/ppt/diagrams/quickStyle5.xml" ContentType="application/vnd.openxmlformats-officedocument.drawingml.diagramStyle+xml"/>
  <Override PartName="/ppt/diagrams/colors5.xml" ContentType="application/vnd.openxmlformats-officedocument.drawingml.diagramColors+xml"/>
  <Override PartName="/ppt/diagrams/drawing5.xml" ContentType="application/vnd.ms-office.drawingml.diagramDrawing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diagrams/data6.xml" ContentType="application/vnd.openxmlformats-officedocument.drawingml.diagramData+xml"/>
  <Override PartName="/ppt/diagrams/layout6.xml" ContentType="application/vnd.openxmlformats-officedocument.drawingml.diagramLayout+xml"/>
  <Override PartName="/ppt/diagrams/quickStyle6.xml" ContentType="application/vnd.openxmlformats-officedocument.drawingml.diagramStyle+xml"/>
  <Override PartName="/ppt/diagrams/colors6.xml" ContentType="application/vnd.openxmlformats-officedocument.drawingml.diagramColors+xml"/>
  <Override PartName="/ppt/diagrams/drawing6.xml" ContentType="application/vnd.ms-office.drawingml.diagramDrawing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diagrams/data7.xml" ContentType="application/vnd.openxmlformats-officedocument.drawingml.diagramData+xml"/>
  <Override PartName="/ppt/diagrams/layout7.xml" ContentType="application/vnd.openxmlformats-officedocument.drawingml.diagramLayout+xml"/>
  <Override PartName="/ppt/diagrams/quickStyle7.xml" ContentType="application/vnd.openxmlformats-officedocument.drawingml.diagramStyle+xml"/>
  <Override PartName="/ppt/diagrams/colors7.xml" ContentType="application/vnd.openxmlformats-officedocument.drawingml.diagramColors+xml"/>
  <Override PartName="/ppt/diagrams/drawing7.xml" ContentType="application/vnd.ms-office.drawingml.diagramDrawing+xml"/>
  <Override PartName="/ppt/notesSlides/notesSlide1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26"/>
  </p:notesMasterIdLst>
  <p:sldIdLst>
    <p:sldId id="256" r:id="rId2"/>
    <p:sldId id="270" r:id="rId3"/>
    <p:sldId id="296" r:id="rId4"/>
    <p:sldId id="297" r:id="rId5"/>
    <p:sldId id="298" r:id="rId6"/>
    <p:sldId id="299" r:id="rId7"/>
    <p:sldId id="300" r:id="rId8"/>
    <p:sldId id="295" r:id="rId9"/>
    <p:sldId id="294" r:id="rId10"/>
    <p:sldId id="301" r:id="rId11"/>
    <p:sldId id="302" r:id="rId12"/>
    <p:sldId id="303" r:id="rId13"/>
    <p:sldId id="304" r:id="rId14"/>
    <p:sldId id="265" r:id="rId15"/>
    <p:sldId id="305" r:id="rId16"/>
    <p:sldId id="306" r:id="rId17"/>
    <p:sldId id="307" r:id="rId18"/>
    <p:sldId id="308" r:id="rId19"/>
    <p:sldId id="309" r:id="rId20"/>
    <p:sldId id="311" r:id="rId21"/>
    <p:sldId id="280" r:id="rId22"/>
    <p:sldId id="281" r:id="rId23"/>
    <p:sldId id="277" r:id="rId24"/>
    <p:sldId id="278" r:id="rId2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3A0"/>
    <a:srgbClr val="B23445"/>
    <a:srgbClr val="138098"/>
    <a:srgbClr val="58C9E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884"/>
    <p:restoredTop sz="92173"/>
  </p:normalViewPr>
  <p:slideViewPr>
    <p:cSldViewPr snapToGrid="0" snapToObjects="1">
      <p:cViewPr varScale="1">
        <p:scale>
          <a:sx n="59" d="100"/>
          <a:sy n="59" d="100"/>
        </p:scale>
        <p:origin x="269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2">
  <dgm:title val=""/>
  <dgm:desc val=""/>
  <dgm:catLst>
    <dgm:cat type="colorful" pri="10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2"/>
      <a:schemeClr val="accent3"/>
    </dgm:fillClrLst>
    <dgm:linClrLst>
      <a:schemeClr val="accent2"/>
      <a:schemeClr val="accent3"/>
    </dgm:linClrLst>
    <dgm:effectClrLst/>
    <dgm:txLinClrLst/>
    <dgm:txFillClrLst/>
    <dgm:txEffectClrLst/>
  </dgm:styleLbl>
  <dgm:styleLbl name="ln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2">
        <a:alpha val="50000"/>
      </a:schemeClr>
      <a:schemeClr val="accent3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2">
        <a:tint val="50000"/>
      </a:schemeClr>
      <a:schemeClr val="accent3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2"/>
      <a:schemeClr val="accent3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2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3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2">
        <a:tint val="9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2">
        <a:tint val="7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2">
        <a:tint val="5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2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colorful1">
  <dgm:title val=""/>
  <dgm:desc val=""/>
  <dgm:catLst>
    <dgm:cat type="colorful" pri="101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/>
    <dgm:txEffectClrLst/>
  </dgm:styleLbl>
  <dgm:styleLbl name="ln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2">
        <a:alpha val="50000"/>
      </a:schemeClr>
      <a:schemeClr val="accent3">
        <a:alpha val="50000"/>
      </a:schemeClr>
      <a:schemeClr val="accent4">
        <a:alpha val="50000"/>
      </a:schemeClr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2">
        <a:tint val="50000"/>
      </a:schemeClr>
      <a:schemeClr val="accent3">
        <a:tint val="50000"/>
      </a:schemeClr>
      <a:schemeClr val="accent4">
        <a:tint val="50000"/>
      </a:schemeClr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1">
        <a:tint val="50000"/>
      </a:schemeClr>
      <a:schemeClr val="accent2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1">
        <a:tint val="50000"/>
      </a:schemeClr>
      <a:schemeClr val="accent2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/>
    <dgm:txEffectClrLst/>
  </dgm:styleLbl>
  <dgm:styleLbl name="fg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3">
        <a:tint val="9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4">
        <a:tint val="7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5">
        <a:tint val="5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3.xml><?xml version="1.0" encoding="utf-8"?>
<dgm:colorsDef xmlns:dgm="http://schemas.openxmlformats.org/drawingml/2006/diagram" xmlns:a="http://schemas.openxmlformats.org/drawingml/2006/main" uniqueId="urn:microsoft.com/office/officeart/2005/8/colors/colorful5">
  <dgm:title val=""/>
  <dgm:desc val=""/>
  <dgm:catLst>
    <dgm:cat type="colorful" pri="105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/>
      <a:schemeClr val="accent6"/>
    </dgm:fillClrLst>
    <dgm:linClrLst>
      <a:schemeClr val="accent5"/>
      <a:schemeClr val="accent6"/>
    </dgm:linClrLst>
    <dgm:effectClrLst/>
    <dgm:txLinClrLst/>
    <dgm:txFillClrLst/>
    <dgm:txEffectClrLst/>
  </dgm:styleLbl>
  <dgm:styleLbl name="ln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4.xml><?xml version="1.0" encoding="utf-8"?>
<dgm:colorsDef xmlns:dgm="http://schemas.openxmlformats.org/drawingml/2006/diagram" xmlns:a="http://schemas.openxmlformats.org/drawingml/2006/main" uniqueId="urn:microsoft.com/office/officeart/2005/8/colors/accent0_3">
  <dgm:title val=""/>
  <dgm:desc val=""/>
  <dgm:catLst>
    <dgm:cat type="mainScheme" pri="10300"/>
  </dgm:catLst>
  <dgm:styleLbl name="node0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alignNode1">
    <dgm:fillClrLst meth="repeat">
      <a:schemeClr val="dk2"/>
    </dgm:fillClrLst>
    <dgm:linClrLst meth="repeat">
      <a:schemeClr val="dk2"/>
    </dgm:linClrLst>
    <dgm:effectClrLst/>
    <dgm:txLinClrLst/>
    <dgm:txFillClrLst/>
    <dgm:txEffectClrLst/>
  </dgm:styleLbl>
  <dgm:styleLbl name="node1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lnNode1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vennNode1">
    <dgm:fillClrLst meth="repeat">
      <a:schemeClr val="dk2">
        <a:alpha val="50000"/>
      </a:schemeClr>
    </dgm:fillClrLst>
    <dgm:linClrLst meth="repeat">
      <a:schemeClr val="lt2"/>
    </dgm:linClrLst>
    <dgm:effectClrLst/>
    <dgm:txLinClrLst/>
    <dgm:txFillClrLst/>
    <dgm:txEffectClrLst/>
  </dgm:styleLbl>
  <dgm:styleLbl name="node2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node3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node4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fgImgPlace1">
    <dgm:fillClrLst meth="repeat">
      <a:schemeClr val="dk2">
        <a:tint val="50000"/>
      </a:schemeClr>
    </dgm:fillClrLst>
    <dgm:linClrLst meth="repeat">
      <a:schemeClr val="lt2"/>
    </dgm:linClrLst>
    <dgm:effectClrLst/>
    <dgm:txLinClrLst/>
    <dgm:txFillClrLst meth="repeat">
      <a:schemeClr val="lt2"/>
    </dgm:txFillClrLst>
    <dgm:txEffectClrLst/>
  </dgm:styleLbl>
  <dgm:styleLbl name="alignImgPlace1">
    <dgm:fillClrLst meth="repeat">
      <a:schemeClr val="dk2">
        <a:tint val="5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2"/>
    </dgm:txFillClrLst>
    <dgm:txEffectClrLst/>
  </dgm:styleLbl>
  <dgm:styleLbl name="bgImgPlace1">
    <dgm:fillClrLst meth="repeat">
      <a:schemeClr val="dk2">
        <a:tint val="5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2"/>
    </dgm:txFillClrLst>
    <dgm:txEffectClrLst/>
  </dgm:styleLbl>
  <dgm:styleLbl name="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callout">
    <dgm:fillClrLst meth="repeat">
      <a:schemeClr val="dk2"/>
    </dgm:fillClrLst>
    <dgm:linClrLst meth="repeat">
      <a:schemeClr val="dk2">
        <a:tint val="50000"/>
      </a:schemeClr>
    </dgm:linClrLst>
    <dgm:effectClrLst/>
    <dgm:txLinClrLst/>
    <dgm:txFillClrLst meth="repeat">
      <a:schemeClr val="lt2"/>
    </dgm:txFillClrLst>
    <dgm:txEffectClrLst/>
  </dgm:styleLbl>
  <dgm:styleLbl name="asst0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asst1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asst2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asst3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asst4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parCh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 meth="repeat">
      <a:schemeClr val="lt2"/>
    </dgm:txFillClrLst>
    <dgm:txEffectClrLst/>
  </dgm:styleLbl>
  <dgm:styleLbl name="parChTrans2D2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parChTrans2D3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parChTrans2D4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parChTrans1D1">
    <dgm:fillClrLst meth="repeat">
      <a:schemeClr val="dk2"/>
    </dgm:fillClrLst>
    <dgm:linClrLst meth="repeat">
      <a:schemeClr val="dk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2"/>
    </dgm:fillClrLst>
    <dgm:linClrLst meth="repeat">
      <a:schemeClr val="dk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2"/>
    </dgm:fillClrLst>
    <dgm:linClrLst meth="repeat">
      <a:schemeClr val="dk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2"/>
    </dgm:fillClrLst>
    <dgm:linClrLst meth="repeat">
      <a:schemeClr val="dk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2">
        <a:alpha val="4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2"/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2"/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2"/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dk2">
        <a:alpha val="90000"/>
        <a:tint val="40000"/>
      </a:schemeClr>
    </dgm:fillClrLst>
    <dgm:linClrLst meth="repeat">
      <a:schemeClr val="dk2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dk2">
        <a:alpha val="90000"/>
        <a:tint val="40000"/>
      </a:schemeClr>
    </dgm:fillClrLst>
    <dgm:linClrLst meth="repeat">
      <a:schemeClr val="dk2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dk2">
        <a:alpha val="90000"/>
        <a:tint val="40000"/>
      </a:schemeClr>
    </dgm:fillClrLst>
    <dgm:linClrLst meth="repeat">
      <a:schemeClr val="dk2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dk2">
        <a:tint val="4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2">
        <a:shade val="80000"/>
      </a:schemeClr>
    </dgm:fillClrLst>
    <dgm:linClrLst meth="repeat">
      <a:schemeClr val="dk2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dk2">
        <a:tint val="50000"/>
        <a:alpha val="40000"/>
      </a:schemeClr>
    </dgm:fillClrLst>
    <dgm:linClrLst meth="repeat">
      <a:schemeClr val="dk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dk2">
        <a:tint val="60000"/>
      </a:schemeClr>
    </dgm:fillClrLst>
    <dgm:linClrLst meth="repeat">
      <a:schemeClr val="lt2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2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5.xml><?xml version="1.0" encoding="utf-8"?>
<dgm:colorsDef xmlns:dgm="http://schemas.openxmlformats.org/drawingml/2006/diagram" xmlns:a="http://schemas.openxmlformats.org/drawingml/2006/main" uniqueId="urn:microsoft.com/office/officeart/2005/8/colors/colorful2">
  <dgm:title val=""/>
  <dgm:desc val=""/>
  <dgm:catLst>
    <dgm:cat type="colorful" pri="10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2"/>
      <a:schemeClr val="accent3"/>
    </dgm:fillClrLst>
    <dgm:linClrLst>
      <a:schemeClr val="accent2"/>
      <a:schemeClr val="accent3"/>
    </dgm:linClrLst>
    <dgm:effectClrLst/>
    <dgm:txLinClrLst/>
    <dgm:txFillClrLst/>
    <dgm:txEffectClrLst/>
  </dgm:styleLbl>
  <dgm:styleLbl name="ln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2">
        <a:alpha val="50000"/>
      </a:schemeClr>
      <a:schemeClr val="accent3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2">
        <a:tint val="50000"/>
      </a:schemeClr>
      <a:schemeClr val="accent3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2"/>
      <a:schemeClr val="accent3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2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3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2">
        <a:tint val="9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2">
        <a:tint val="7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2">
        <a:tint val="5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2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6.xml><?xml version="1.0" encoding="utf-8"?>
<dgm:colorsDef xmlns:dgm="http://schemas.openxmlformats.org/drawingml/2006/diagram" xmlns:a="http://schemas.openxmlformats.org/drawingml/2006/main" uniqueId="urn:microsoft.com/office/officeart/2005/8/colors/colorful5">
  <dgm:title val=""/>
  <dgm:desc val=""/>
  <dgm:catLst>
    <dgm:cat type="colorful" pri="105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/>
      <a:schemeClr val="accent6"/>
    </dgm:fillClrLst>
    <dgm:linClrLst>
      <a:schemeClr val="accent5"/>
      <a:schemeClr val="accent6"/>
    </dgm:linClrLst>
    <dgm:effectClrLst/>
    <dgm:txLinClrLst/>
    <dgm:txFillClrLst/>
    <dgm:txEffectClrLst/>
  </dgm:styleLbl>
  <dgm:styleLbl name="ln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7.xml><?xml version="1.0" encoding="utf-8"?>
<dgm:colorsDef xmlns:dgm="http://schemas.openxmlformats.org/drawingml/2006/diagram" xmlns:a="http://schemas.openxmlformats.org/drawingml/2006/main" uniqueId="urn:microsoft.com/office/officeart/2005/8/colors/accent0_3">
  <dgm:title val=""/>
  <dgm:desc val=""/>
  <dgm:catLst>
    <dgm:cat type="mainScheme" pri="10300"/>
  </dgm:catLst>
  <dgm:styleLbl name="node0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alignNode1">
    <dgm:fillClrLst meth="repeat">
      <a:schemeClr val="dk2"/>
    </dgm:fillClrLst>
    <dgm:linClrLst meth="repeat">
      <a:schemeClr val="dk2"/>
    </dgm:linClrLst>
    <dgm:effectClrLst/>
    <dgm:txLinClrLst/>
    <dgm:txFillClrLst/>
    <dgm:txEffectClrLst/>
  </dgm:styleLbl>
  <dgm:styleLbl name="node1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lnNode1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vennNode1">
    <dgm:fillClrLst meth="repeat">
      <a:schemeClr val="dk2">
        <a:alpha val="50000"/>
      </a:schemeClr>
    </dgm:fillClrLst>
    <dgm:linClrLst meth="repeat">
      <a:schemeClr val="lt2"/>
    </dgm:linClrLst>
    <dgm:effectClrLst/>
    <dgm:txLinClrLst/>
    <dgm:txFillClrLst/>
    <dgm:txEffectClrLst/>
  </dgm:styleLbl>
  <dgm:styleLbl name="node2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node3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node4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fgImgPlace1">
    <dgm:fillClrLst meth="repeat">
      <a:schemeClr val="dk2">
        <a:tint val="50000"/>
      </a:schemeClr>
    </dgm:fillClrLst>
    <dgm:linClrLst meth="repeat">
      <a:schemeClr val="lt2"/>
    </dgm:linClrLst>
    <dgm:effectClrLst/>
    <dgm:txLinClrLst/>
    <dgm:txFillClrLst meth="repeat">
      <a:schemeClr val="lt2"/>
    </dgm:txFillClrLst>
    <dgm:txEffectClrLst/>
  </dgm:styleLbl>
  <dgm:styleLbl name="alignImgPlace1">
    <dgm:fillClrLst meth="repeat">
      <a:schemeClr val="dk2">
        <a:tint val="5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2"/>
    </dgm:txFillClrLst>
    <dgm:txEffectClrLst/>
  </dgm:styleLbl>
  <dgm:styleLbl name="bgImgPlace1">
    <dgm:fillClrLst meth="repeat">
      <a:schemeClr val="dk2">
        <a:tint val="5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2"/>
    </dgm:txFillClrLst>
    <dgm:txEffectClrLst/>
  </dgm:styleLbl>
  <dgm:styleLbl name="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callout">
    <dgm:fillClrLst meth="repeat">
      <a:schemeClr val="dk2"/>
    </dgm:fillClrLst>
    <dgm:linClrLst meth="repeat">
      <a:schemeClr val="dk2">
        <a:tint val="50000"/>
      </a:schemeClr>
    </dgm:linClrLst>
    <dgm:effectClrLst/>
    <dgm:txLinClrLst/>
    <dgm:txFillClrLst meth="repeat">
      <a:schemeClr val="lt2"/>
    </dgm:txFillClrLst>
    <dgm:txEffectClrLst/>
  </dgm:styleLbl>
  <dgm:styleLbl name="asst0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asst1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asst2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asst3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asst4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parCh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 meth="repeat">
      <a:schemeClr val="lt2"/>
    </dgm:txFillClrLst>
    <dgm:txEffectClrLst/>
  </dgm:styleLbl>
  <dgm:styleLbl name="parChTrans2D2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parChTrans2D3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parChTrans2D4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parChTrans1D1">
    <dgm:fillClrLst meth="repeat">
      <a:schemeClr val="dk2"/>
    </dgm:fillClrLst>
    <dgm:linClrLst meth="repeat">
      <a:schemeClr val="dk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2"/>
    </dgm:fillClrLst>
    <dgm:linClrLst meth="repeat">
      <a:schemeClr val="dk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2"/>
    </dgm:fillClrLst>
    <dgm:linClrLst meth="repeat">
      <a:schemeClr val="dk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2"/>
    </dgm:fillClrLst>
    <dgm:linClrLst meth="repeat">
      <a:schemeClr val="dk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2">
        <a:alpha val="4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2"/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2"/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2"/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dk2">
        <a:alpha val="90000"/>
        <a:tint val="40000"/>
      </a:schemeClr>
    </dgm:fillClrLst>
    <dgm:linClrLst meth="repeat">
      <a:schemeClr val="dk2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dk2">
        <a:alpha val="90000"/>
        <a:tint val="40000"/>
      </a:schemeClr>
    </dgm:fillClrLst>
    <dgm:linClrLst meth="repeat">
      <a:schemeClr val="dk2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dk2">
        <a:alpha val="90000"/>
        <a:tint val="40000"/>
      </a:schemeClr>
    </dgm:fillClrLst>
    <dgm:linClrLst meth="repeat">
      <a:schemeClr val="dk2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dk2">
        <a:tint val="4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2">
        <a:shade val="80000"/>
      </a:schemeClr>
    </dgm:fillClrLst>
    <dgm:linClrLst meth="repeat">
      <a:schemeClr val="dk2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dk2">
        <a:tint val="50000"/>
        <a:alpha val="40000"/>
      </a:schemeClr>
    </dgm:fillClrLst>
    <dgm:linClrLst meth="repeat">
      <a:schemeClr val="dk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dk2">
        <a:tint val="60000"/>
      </a:schemeClr>
    </dgm:fillClrLst>
    <dgm:linClrLst meth="repeat">
      <a:schemeClr val="lt2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2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AE8D4D93-9829-4DC1-BD76-4698CE256163}" type="doc">
      <dgm:prSet loTypeId="urn:microsoft.com/office/officeart/2005/8/layout/process4" loCatId="process" qsTypeId="urn:microsoft.com/office/officeart/2005/8/quickstyle/simple1" qsCatId="simple" csTypeId="urn:microsoft.com/office/officeart/2005/8/colors/colorful2" csCatId="colorful" phldr="1"/>
      <dgm:spPr/>
      <dgm:t>
        <a:bodyPr/>
        <a:lstStyle/>
        <a:p>
          <a:endParaRPr lang="en-US"/>
        </a:p>
      </dgm:t>
    </dgm:pt>
    <dgm:pt modelId="{37F014AF-4C96-448E-8964-2E264C1FCCAA}">
      <dgm:prSet custT="1"/>
      <dgm:spPr>
        <a:solidFill>
          <a:schemeClr val="accent2"/>
        </a:solidFill>
      </dgm:spPr>
      <dgm:t>
        <a:bodyPr/>
        <a:lstStyle/>
        <a:p>
          <a:r>
            <a:rPr lang="en-US" sz="28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rPr>
            <a:t>Which cancer is easier to cure?</a:t>
          </a:r>
        </a:p>
      </dgm:t>
    </dgm:pt>
    <dgm:pt modelId="{23C8B8AF-F476-4548-A4F7-C1342C664CE5}" type="parTrans" cxnId="{8CF55067-C1E9-4D01-A68B-28C07DF65152}">
      <dgm:prSet/>
      <dgm:spPr/>
      <dgm:t>
        <a:bodyPr/>
        <a:lstStyle/>
        <a:p>
          <a:endParaRPr lang="en-US" sz="1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250A817-2856-4615-84A9-6B33E715138C}" type="sibTrans" cxnId="{8CF55067-C1E9-4D01-A68B-28C07DF65152}">
      <dgm:prSet/>
      <dgm:spPr/>
      <dgm:t>
        <a:bodyPr/>
        <a:lstStyle/>
        <a:p>
          <a:endParaRPr lang="en-US" sz="1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AB42D3D-BAA5-4697-BD2D-8F361959B037}">
      <dgm:prSet custT="1"/>
      <dgm:spPr/>
      <dgm:t>
        <a:bodyPr/>
        <a:lstStyle/>
        <a:p>
          <a:r>
            <a:rPr lang="en-US" sz="1800" dirty="0">
              <a:latin typeface="Arial" panose="020B0604020202020204" pitchFamily="34" charset="0"/>
              <a:cs typeface="Arial" panose="020B0604020202020204" pitchFamily="34" charset="0"/>
            </a:rPr>
            <a:t>A cancer that is large and has spread to different areas of the body.</a:t>
          </a:r>
        </a:p>
      </dgm:t>
    </dgm:pt>
    <dgm:pt modelId="{4573D3D2-19B5-4790-A2CE-63A0FB1E194B}" type="parTrans" cxnId="{F5DD2C33-1170-4050-86D3-8FCEF8FA17E0}">
      <dgm:prSet/>
      <dgm:spPr/>
      <dgm:t>
        <a:bodyPr/>
        <a:lstStyle/>
        <a:p>
          <a:endParaRPr lang="en-US" sz="1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F1CC4F8-4757-41DF-8E70-0E3EE894CF9A}" type="sibTrans" cxnId="{F5DD2C33-1170-4050-86D3-8FCEF8FA17E0}">
      <dgm:prSet/>
      <dgm:spPr/>
      <dgm:t>
        <a:bodyPr/>
        <a:lstStyle/>
        <a:p>
          <a:endParaRPr lang="en-US" sz="1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B4E00F1-FC21-488B-B412-74D9EF789672}">
      <dgm:prSet custT="1"/>
      <dgm:spPr/>
      <dgm:t>
        <a:bodyPr/>
        <a:lstStyle/>
        <a:p>
          <a:r>
            <a:rPr lang="en-US" sz="1800" dirty="0">
              <a:latin typeface="Arial" panose="020B0604020202020204" pitchFamily="34" charset="0"/>
              <a:cs typeface="Arial" panose="020B0604020202020204" pitchFamily="34" charset="0"/>
            </a:rPr>
            <a:t>A cancer that is small and has not yet spread.</a:t>
          </a:r>
        </a:p>
      </dgm:t>
    </dgm:pt>
    <dgm:pt modelId="{613CC381-2F3D-4A1E-A7D9-01001675CAFA}" type="parTrans" cxnId="{2274101D-43A6-40FB-AF7F-D4E800F986B7}">
      <dgm:prSet/>
      <dgm:spPr/>
      <dgm:t>
        <a:bodyPr/>
        <a:lstStyle/>
        <a:p>
          <a:endParaRPr lang="en-US" sz="1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209A5A1-1C37-4245-9405-ADA0E2EC6DBF}" type="sibTrans" cxnId="{2274101D-43A6-40FB-AF7F-D4E800F986B7}">
      <dgm:prSet/>
      <dgm:spPr/>
      <dgm:t>
        <a:bodyPr/>
        <a:lstStyle/>
        <a:p>
          <a:endParaRPr lang="en-US" sz="1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BE72CD2-FDF6-43CB-9972-85C8F4BD67A9}">
      <dgm:prSet custT="1"/>
      <dgm:spPr/>
      <dgm:t>
        <a:bodyPr/>
        <a:lstStyle/>
        <a:p>
          <a:r>
            <a:rPr lang="en-US" sz="28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rPr>
            <a:t>Early detection improves a patient’s chances of surviving!</a:t>
          </a:r>
        </a:p>
      </dgm:t>
    </dgm:pt>
    <dgm:pt modelId="{7A315A60-982E-4799-B899-718C16942D1B}" type="parTrans" cxnId="{7CEF88F6-72F7-4AF7-922E-9AD38E7B0EB5}">
      <dgm:prSet/>
      <dgm:spPr/>
      <dgm:t>
        <a:bodyPr/>
        <a:lstStyle/>
        <a:p>
          <a:endParaRPr lang="en-US" sz="1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3B63D77-1409-4662-981F-B92D8F03BA44}" type="sibTrans" cxnId="{7CEF88F6-72F7-4AF7-922E-9AD38E7B0EB5}">
      <dgm:prSet/>
      <dgm:spPr/>
      <dgm:t>
        <a:bodyPr/>
        <a:lstStyle/>
        <a:p>
          <a:endParaRPr lang="en-US" sz="18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973BD99-D0D9-1E4E-B18A-171B377890B6}" type="pres">
      <dgm:prSet presAssocID="{AE8D4D93-9829-4DC1-BD76-4698CE256163}" presName="Name0" presStyleCnt="0">
        <dgm:presLayoutVars>
          <dgm:dir/>
          <dgm:animLvl val="lvl"/>
          <dgm:resizeHandles val="exact"/>
        </dgm:presLayoutVars>
      </dgm:prSet>
      <dgm:spPr/>
    </dgm:pt>
    <dgm:pt modelId="{0247F70A-BFAB-574D-82F7-F30F7BE31EFD}" type="pres">
      <dgm:prSet presAssocID="{DBE72CD2-FDF6-43CB-9972-85C8F4BD67A9}" presName="boxAndChildren" presStyleCnt="0"/>
      <dgm:spPr/>
    </dgm:pt>
    <dgm:pt modelId="{3FD4148D-6B49-AD41-90C5-41DD662864F5}" type="pres">
      <dgm:prSet presAssocID="{DBE72CD2-FDF6-43CB-9972-85C8F4BD67A9}" presName="parentTextBox" presStyleLbl="node1" presStyleIdx="0" presStyleCnt="2"/>
      <dgm:spPr/>
    </dgm:pt>
    <dgm:pt modelId="{2CA01856-664C-904B-B5E2-9DFD15428E1B}" type="pres">
      <dgm:prSet presAssocID="{3250A817-2856-4615-84A9-6B33E715138C}" presName="sp" presStyleCnt="0"/>
      <dgm:spPr/>
    </dgm:pt>
    <dgm:pt modelId="{4CE842D0-63B1-134E-A894-644AA33D80F2}" type="pres">
      <dgm:prSet presAssocID="{37F014AF-4C96-448E-8964-2E264C1FCCAA}" presName="arrowAndChildren" presStyleCnt="0"/>
      <dgm:spPr/>
    </dgm:pt>
    <dgm:pt modelId="{44C88EB7-2EC7-9741-AAAE-835289E510C7}" type="pres">
      <dgm:prSet presAssocID="{37F014AF-4C96-448E-8964-2E264C1FCCAA}" presName="parentTextArrow" presStyleLbl="node1" presStyleIdx="0" presStyleCnt="2"/>
      <dgm:spPr/>
    </dgm:pt>
    <dgm:pt modelId="{AF89BADF-58C8-5842-94ED-CAA8DF6F236A}" type="pres">
      <dgm:prSet presAssocID="{37F014AF-4C96-448E-8964-2E264C1FCCAA}" presName="arrow" presStyleLbl="node1" presStyleIdx="1" presStyleCnt="2"/>
      <dgm:spPr/>
    </dgm:pt>
    <dgm:pt modelId="{054677D7-509A-214B-A8E6-B4B27EA02085}" type="pres">
      <dgm:prSet presAssocID="{37F014AF-4C96-448E-8964-2E264C1FCCAA}" presName="descendantArrow" presStyleCnt="0"/>
      <dgm:spPr/>
    </dgm:pt>
    <dgm:pt modelId="{554077BE-745F-CE46-8CF0-A0266077A8ED}" type="pres">
      <dgm:prSet presAssocID="{7AB42D3D-BAA5-4697-BD2D-8F361959B037}" presName="childTextArrow" presStyleLbl="fgAccFollowNode1" presStyleIdx="0" presStyleCnt="2">
        <dgm:presLayoutVars>
          <dgm:bulletEnabled val="1"/>
        </dgm:presLayoutVars>
      </dgm:prSet>
      <dgm:spPr/>
    </dgm:pt>
    <dgm:pt modelId="{4BB81CE8-84EC-AD49-BE35-941A71871F12}" type="pres">
      <dgm:prSet presAssocID="{DB4E00F1-FC21-488B-B412-74D9EF789672}" presName="childTextArrow" presStyleLbl="fgAccFollowNode1" presStyleIdx="1" presStyleCnt="2">
        <dgm:presLayoutVars>
          <dgm:bulletEnabled val="1"/>
        </dgm:presLayoutVars>
      </dgm:prSet>
      <dgm:spPr/>
    </dgm:pt>
  </dgm:ptLst>
  <dgm:cxnLst>
    <dgm:cxn modelId="{2274101D-43A6-40FB-AF7F-D4E800F986B7}" srcId="{37F014AF-4C96-448E-8964-2E264C1FCCAA}" destId="{DB4E00F1-FC21-488B-B412-74D9EF789672}" srcOrd="1" destOrd="0" parTransId="{613CC381-2F3D-4A1E-A7D9-01001675CAFA}" sibTransId="{8209A5A1-1C37-4245-9405-ADA0E2EC6DBF}"/>
    <dgm:cxn modelId="{F5DD2C33-1170-4050-86D3-8FCEF8FA17E0}" srcId="{37F014AF-4C96-448E-8964-2E264C1FCCAA}" destId="{7AB42D3D-BAA5-4697-BD2D-8F361959B037}" srcOrd="0" destOrd="0" parTransId="{4573D3D2-19B5-4790-A2CE-63A0FB1E194B}" sibTransId="{5F1CC4F8-4757-41DF-8E70-0E3EE894CF9A}"/>
    <dgm:cxn modelId="{D654223B-29FB-C948-A14A-61B880F33794}" type="presOf" srcId="{37F014AF-4C96-448E-8964-2E264C1FCCAA}" destId="{AF89BADF-58C8-5842-94ED-CAA8DF6F236A}" srcOrd="1" destOrd="0" presId="urn:microsoft.com/office/officeart/2005/8/layout/process4"/>
    <dgm:cxn modelId="{8CF55067-C1E9-4D01-A68B-28C07DF65152}" srcId="{AE8D4D93-9829-4DC1-BD76-4698CE256163}" destId="{37F014AF-4C96-448E-8964-2E264C1FCCAA}" srcOrd="0" destOrd="0" parTransId="{23C8B8AF-F476-4548-A4F7-C1342C664CE5}" sibTransId="{3250A817-2856-4615-84A9-6B33E715138C}"/>
    <dgm:cxn modelId="{3B6E3670-4511-3244-A397-E31CF431326A}" type="presOf" srcId="{DBE72CD2-FDF6-43CB-9972-85C8F4BD67A9}" destId="{3FD4148D-6B49-AD41-90C5-41DD662864F5}" srcOrd="0" destOrd="0" presId="urn:microsoft.com/office/officeart/2005/8/layout/process4"/>
    <dgm:cxn modelId="{C7551975-73D8-6849-9FE8-3F1C39503E5A}" type="presOf" srcId="{7AB42D3D-BAA5-4697-BD2D-8F361959B037}" destId="{554077BE-745F-CE46-8CF0-A0266077A8ED}" srcOrd="0" destOrd="0" presId="urn:microsoft.com/office/officeart/2005/8/layout/process4"/>
    <dgm:cxn modelId="{EF132C7C-78BC-914D-A13A-830ED6B4BDAE}" type="presOf" srcId="{AE8D4D93-9829-4DC1-BD76-4698CE256163}" destId="{4973BD99-D0D9-1E4E-B18A-171B377890B6}" srcOrd="0" destOrd="0" presId="urn:microsoft.com/office/officeart/2005/8/layout/process4"/>
    <dgm:cxn modelId="{1B89FDDE-F191-A049-B7AF-35B0AAEF2533}" type="presOf" srcId="{DB4E00F1-FC21-488B-B412-74D9EF789672}" destId="{4BB81CE8-84EC-AD49-BE35-941A71871F12}" srcOrd="0" destOrd="0" presId="urn:microsoft.com/office/officeart/2005/8/layout/process4"/>
    <dgm:cxn modelId="{7CEF88F6-72F7-4AF7-922E-9AD38E7B0EB5}" srcId="{AE8D4D93-9829-4DC1-BD76-4698CE256163}" destId="{DBE72CD2-FDF6-43CB-9972-85C8F4BD67A9}" srcOrd="1" destOrd="0" parTransId="{7A315A60-982E-4799-B899-718C16942D1B}" sibTransId="{73B63D77-1409-4662-981F-B92D8F03BA44}"/>
    <dgm:cxn modelId="{998C0FF7-5C4E-F249-A27E-0A09D307CCA5}" type="presOf" srcId="{37F014AF-4C96-448E-8964-2E264C1FCCAA}" destId="{44C88EB7-2EC7-9741-AAAE-835289E510C7}" srcOrd="0" destOrd="0" presId="urn:microsoft.com/office/officeart/2005/8/layout/process4"/>
    <dgm:cxn modelId="{68042EA8-32D7-C549-822D-20DD8484915A}" type="presParOf" srcId="{4973BD99-D0D9-1E4E-B18A-171B377890B6}" destId="{0247F70A-BFAB-574D-82F7-F30F7BE31EFD}" srcOrd="0" destOrd="0" presId="urn:microsoft.com/office/officeart/2005/8/layout/process4"/>
    <dgm:cxn modelId="{FB725BE7-687C-0740-AC90-DB78C107BC9D}" type="presParOf" srcId="{0247F70A-BFAB-574D-82F7-F30F7BE31EFD}" destId="{3FD4148D-6B49-AD41-90C5-41DD662864F5}" srcOrd="0" destOrd="0" presId="urn:microsoft.com/office/officeart/2005/8/layout/process4"/>
    <dgm:cxn modelId="{A72A8E21-643A-DC42-89C3-C9418F56448D}" type="presParOf" srcId="{4973BD99-D0D9-1E4E-B18A-171B377890B6}" destId="{2CA01856-664C-904B-B5E2-9DFD15428E1B}" srcOrd="1" destOrd="0" presId="urn:microsoft.com/office/officeart/2005/8/layout/process4"/>
    <dgm:cxn modelId="{4A4B2A77-D046-C846-BA2D-1D64FAEBA5BF}" type="presParOf" srcId="{4973BD99-D0D9-1E4E-B18A-171B377890B6}" destId="{4CE842D0-63B1-134E-A894-644AA33D80F2}" srcOrd="2" destOrd="0" presId="urn:microsoft.com/office/officeart/2005/8/layout/process4"/>
    <dgm:cxn modelId="{750EAAFA-DC95-DB4E-9E58-528EF841027F}" type="presParOf" srcId="{4CE842D0-63B1-134E-A894-644AA33D80F2}" destId="{44C88EB7-2EC7-9741-AAAE-835289E510C7}" srcOrd="0" destOrd="0" presId="urn:microsoft.com/office/officeart/2005/8/layout/process4"/>
    <dgm:cxn modelId="{9AAE8C6D-7C7D-9E47-9E98-FD55570ABD14}" type="presParOf" srcId="{4CE842D0-63B1-134E-A894-644AA33D80F2}" destId="{AF89BADF-58C8-5842-94ED-CAA8DF6F236A}" srcOrd="1" destOrd="0" presId="urn:microsoft.com/office/officeart/2005/8/layout/process4"/>
    <dgm:cxn modelId="{8AB39A72-D988-3E4C-8306-E0D1EF602E59}" type="presParOf" srcId="{4CE842D0-63B1-134E-A894-644AA33D80F2}" destId="{054677D7-509A-214B-A8E6-B4B27EA02085}" srcOrd="2" destOrd="0" presId="urn:microsoft.com/office/officeart/2005/8/layout/process4"/>
    <dgm:cxn modelId="{8EFCF3D9-F4A7-9641-9FCA-7C70F64FE4B1}" type="presParOf" srcId="{054677D7-509A-214B-A8E6-B4B27EA02085}" destId="{554077BE-745F-CE46-8CF0-A0266077A8ED}" srcOrd="0" destOrd="0" presId="urn:microsoft.com/office/officeart/2005/8/layout/process4"/>
    <dgm:cxn modelId="{1D552E7F-8CD0-EE45-8135-EA0B189062DC}" type="presParOf" srcId="{054677D7-509A-214B-A8E6-B4B27EA02085}" destId="{4BB81CE8-84EC-AD49-BE35-941A71871F12}" srcOrd="1" destOrd="0" presId="urn:microsoft.com/office/officeart/2005/8/layout/process4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4B6300ED-2805-4A0E-A0A2-772F2D761042}" type="doc">
      <dgm:prSet loTypeId="urn:microsoft.com/office/officeart/2005/8/layout/process4" loCatId="process" qsTypeId="urn:microsoft.com/office/officeart/2005/8/quickstyle/simple1" qsCatId="simple" csTypeId="urn:microsoft.com/office/officeart/2005/8/colors/colorful1" csCatId="colorful" phldr="1"/>
      <dgm:spPr/>
      <dgm:t>
        <a:bodyPr/>
        <a:lstStyle/>
        <a:p>
          <a:endParaRPr lang="en-US"/>
        </a:p>
      </dgm:t>
    </dgm:pt>
    <dgm:pt modelId="{EB098CA8-EAD6-4849-ACAD-12DE6327C48E}">
      <dgm:prSet custT="1"/>
      <dgm:spPr>
        <a:solidFill>
          <a:schemeClr val="accent5">
            <a:lumMod val="60000"/>
            <a:lumOff val="40000"/>
          </a:schemeClr>
        </a:solidFill>
      </dgm:spPr>
      <dgm:t>
        <a:bodyPr/>
        <a:lstStyle/>
        <a:p>
          <a:r>
            <a:rPr lang="en-US" sz="2800" dirty="0">
              <a:solidFill>
                <a:schemeClr val="tx1">
                  <a:lumMod val="85000"/>
                  <a:lumOff val="1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rPr>
            <a:t>It is more common for patients living in rural areas to present with later stage cancers than those living in urban areas.</a:t>
          </a:r>
        </a:p>
      </dgm:t>
    </dgm:pt>
    <dgm:pt modelId="{603CAD4F-2EAC-4153-A39A-72D7F8D31357}" type="parTrans" cxnId="{B723CF77-8988-4998-B2E0-FDEFB7FF9DC2}">
      <dgm:prSet/>
      <dgm:spPr/>
      <dgm:t>
        <a:bodyPr/>
        <a:lstStyle/>
        <a:p>
          <a:endParaRPr lang="en-US"/>
        </a:p>
      </dgm:t>
    </dgm:pt>
    <dgm:pt modelId="{1591A2C7-9A7F-4226-BB22-2B49FDCEEF70}" type="sibTrans" cxnId="{B723CF77-8988-4998-B2E0-FDEFB7FF9DC2}">
      <dgm:prSet/>
      <dgm:spPr/>
      <dgm:t>
        <a:bodyPr/>
        <a:lstStyle/>
        <a:p>
          <a:endParaRPr lang="en-US"/>
        </a:p>
      </dgm:t>
    </dgm:pt>
    <dgm:pt modelId="{659BAD12-C987-4023-958B-BB63443E8F59}">
      <dgm:prSet custT="1"/>
      <dgm:spPr>
        <a:solidFill>
          <a:schemeClr val="accent2">
            <a:lumMod val="60000"/>
            <a:lumOff val="40000"/>
            <a:alpha val="90000"/>
          </a:schemeClr>
        </a:solidFill>
      </dgm:spPr>
      <dgm:t>
        <a:bodyPr/>
        <a:lstStyle/>
        <a:p>
          <a:r>
            <a:rPr lang="en-US" sz="2000" kern="1200" dirty="0">
              <a:solidFill>
                <a:srgbClr val="000000">
                  <a:hueOff val="0"/>
                  <a:satOff val="0"/>
                  <a:lumOff val="0"/>
                  <a:alphaOff val="0"/>
                </a:srgb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rPr>
            <a:t>This</a:t>
          </a:r>
          <a:r>
            <a:rPr lang="en-US" sz="2400" kern="1200" dirty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n-US" sz="2000" kern="1200" dirty="0">
              <a:latin typeface="Arial" panose="020B0604020202020204" pitchFamily="34" charset="0"/>
              <a:cs typeface="Arial" panose="020B0604020202020204" pitchFamily="34" charset="0"/>
            </a:rPr>
            <a:t>may be caused by a lack of access to healthcare services.</a:t>
          </a:r>
          <a:endParaRPr lang="en-US" sz="2400" kern="12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37FFF91-A1FD-4971-9B9F-D13A8579318E}" type="parTrans" cxnId="{25A05E7D-9A9B-4776-A373-29B7299FFC1B}">
      <dgm:prSet/>
      <dgm:spPr/>
      <dgm:t>
        <a:bodyPr/>
        <a:lstStyle/>
        <a:p>
          <a:endParaRPr lang="en-US"/>
        </a:p>
      </dgm:t>
    </dgm:pt>
    <dgm:pt modelId="{CAF0BC23-3046-4D44-B3D2-5E06A22A3453}" type="sibTrans" cxnId="{25A05E7D-9A9B-4776-A373-29B7299FFC1B}">
      <dgm:prSet/>
      <dgm:spPr/>
      <dgm:t>
        <a:bodyPr/>
        <a:lstStyle/>
        <a:p>
          <a:endParaRPr lang="en-US"/>
        </a:p>
      </dgm:t>
    </dgm:pt>
    <dgm:pt modelId="{E1366B5E-3D7B-478B-BA0B-4CAC534D7C50}">
      <dgm:prSet/>
      <dgm:spPr>
        <a:solidFill>
          <a:schemeClr val="accent2">
            <a:lumMod val="75000"/>
          </a:schemeClr>
        </a:solidFill>
      </dgm:spPr>
      <dgm:t>
        <a:bodyPr/>
        <a:lstStyle/>
        <a:p>
          <a:r>
            <a:rPr lang="en-US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rPr>
            <a:t>Think: </a:t>
          </a:r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What areas of Kentucky may have limited access to cancer care?</a:t>
          </a:r>
        </a:p>
      </dgm:t>
    </dgm:pt>
    <dgm:pt modelId="{7FCC875A-0696-4336-B470-2379D2CA2853}" type="parTrans" cxnId="{B8CC2ECF-019E-43D2-846E-9760B347602F}">
      <dgm:prSet/>
      <dgm:spPr/>
      <dgm:t>
        <a:bodyPr/>
        <a:lstStyle/>
        <a:p>
          <a:endParaRPr lang="en-US"/>
        </a:p>
      </dgm:t>
    </dgm:pt>
    <dgm:pt modelId="{5D618E61-A72C-4D8B-AF53-45BD2A8639FB}" type="sibTrans" cxnId="{B8CC2ECF-019E-43D2-846E-9760B347602F}">
      <dgm:prSet/>
      <dgm:spPr/>
      <dgm:t>
        <a:bodyPr/>
        <a:lstStyle/>
        <a:p>
          <a:endParaRPr lang="en-US"/>
        </a:p>
      </dgm:t>
    </dgm:pt>
    <dgm:pt modelId="{2BBC2BCD-52EE-C242-A2A4-5B90B341B72F}">
      <dgm:prSet custT="1"/>
      <dgm:spPr>
        <a:solidFill>
          <a:schemeClr val="accent2">
            <a:lumMod val="40000"/>
            <a:lumOff val="60000"/>
            <a:alpha val="90000"/>
          </a:schemeClr>
        </a:solidFill>
      </dgm:spPr>
      <dgm:t>
        <a:bodyPr/>
        <a:lstStyle/>
        <a:p>
          <a:r>
            <a:rPr lang="en-US" sz="2400" dirty="0">
              <a:latin typeface="Arial" panose="020B0604020202020204" pitchFamily="34" charset="0"/>
              <a:cs typeface="Arial" panose="020B0604020202020204" pitchFamily="34" charset="0"/>
            </a:rPr>
            <a:t>This can affect their treatment regimen.</a:t>
          </a:r>
        </a:p>
      </dgm:t>
    </dgm:pt>
    <dgm:pt modelId="{874D884E-C227-AA4B-B578-C0E43E83A64A}" type="parTrans" cxnId="{E7C1D22C-6C4A-DF4E-942F-90AC13818896}">
      <dgm:prSet/>
      <dgm:spPr/>
      <dgm:t>
        <a:bodyPr/>
        <a:lstStyle/>
        <a:p>
          <a:endParaRPr lang="en-US"/>
        </a:p>
      </dgm:t>
    </dgm:pt>
    <dgm:pt modelId="{0E97E327-D31C-7F42-A7FC-73DAC4752553}" type="sibTrans" cxnId="{E7C1D22C-6C4A-DF4E-942F-90AC13818896}">
      <dgm:prSet/>
      <dgm:spPr/>
      <dgm:t>
        <a:bodyPr/>
        <a:lstStyle/>
        <a:p>
          <a:endParaRPr lang="en-US"/>
        </a:p>
      </dgm:t>
    </dgm:pt>
    <dgm:pt modelId="{EA944A9C-95B4-C540-AC8F-16D3B914F96D}" type="pres">
      <dgm:prSet presAssocID="{4B6300ED-2805-4A0E-A0A2-772F2D761042}" presName="Name0" presStyleCnt="0">
        <dgm:presLayoutVars>
          <dgm:dir/>
          <dgm:animLvl val="lvl"/>
          <dgm:resizeHandles val="exact"/>
        </dgm:presLayoutVars>
      </dgm:prSet>
      <dgm:spPr/>
    </dgm:pt>
    <dgm:pt modelId="{A6768376-9976-464A-B63B-06667D42794C}" type="pres">
      <dgm:prSet presAssocID="{E1366B5E-3D7B-478B-BA0B-4CAC534D7C50}" presName="boxAndChildren" presStyleCnt="0"/>
      <dgm:spPr/>
    </dgm:pt>
    <dgm:pt modelId="{D7F3AA9C-8CCB-6445-AFE1-0FB4926AA6AB}" type="pres">
      <dgm:prSet presAssocID="{E1366B5E-3D7B-478B-BA0B-4CAC534D7C50}" presName="parentTextBox" presStyleLbl="node1" presStyleIdx="0" presStyleCnt="2"/>
      <dgm:spPr/>
    </dgm:pt>
    <dgm:pt modelId="{CB69F24E-5973-1D4C-A7A0-930CDD00B6D9}" type="pres">
      <dgm:prSet presAssocID="{1591A2C7-9A7F-4226-BB22-2B49FDCEEF70}" presName="sp" presStyleCnt="0"/>
      <dgm:spPr/>
    </dgm:pt>
    <dgm:pt modelId="{E8305DFF-7AAA-6042-9FA3-23EFA6B8A833}" type="pres">
      <dgm:prSet presAssocID="{EB098CA8-EAD6-4849-ACAD-12DE6327C48E}" presName="arrowAndChildren" presStyleCnt="0"/>
      <dgm:spPr/>
    </dgm:pt>
    <dgm:pt modelId="{86E22264-3549-D646-93D7-848E4907F461}" type="pres">
      <dgm:prSet presAssocID="{EB098CA8-EAD6-4849-ACAD-12DE6327C48E}" presName="parentTextArrow" presStyleLbl="node1" presStyleIdx="0" presStyleCnt="2"/>
      <dgm:spPr/>
    </dgm:pt>
    <dgm:pt modelId="{9C179F44-F51F-8542-9336-DEF5BEA4B23C}" type="pres">
      <dgm:prSet presAssocID="{EB098CA8-EAD6-4849-ACAD-12DE6327C48E}" presName="arrow" presStyleLbl="node1" presStyleIdx="1" presStyleCnt="2"/>
      <dgm:spPr/>
    </dgm:pt>
    <dgm:pt modelId="{346F29ED-E828-5345-98C6-A6654C830448}" type="pres">
      <dgm:prSet presAssocID="{EB098CA8-EAD6-4849-ACAD-12DE6327C48E}" presName="descendantArrow" presStyleCnt="0"/>
      <dgm:spPr/>
    </dgm:pt>
    <dgm:pt modelId="{A01952E9-EA34-3F46-B4B3-DBB7C9ADE429}" type="pres">
      <dgm:prSet presAssocID="{659BAD12-C987-4023-958B-BB63443E8F59}" presName="childTextArrow" presStyleLbl="fgAccFollowNode1" presStyleIdx="0" presStyleCnt="2">
        <dgm:presLayoutVars>
          <dgm:bulletEnabled val="1"/>
        </dgm:presLayoutVars>
      </dgm:prSet>
      <dgm:spPr/>
    </dgm:pt>
    <dgm:pt modelId="{44AACF73-A6B0-B64D-9709-577154413DE7}" type="pres">
      <dgm:prSet presAssocID="{2BBC2BCD-52EE-C242-A2A4-5B90B341B72F}" presName="childTextArrow" presStyleLbl="fgAccFollowNode1" presStyleIdx="1" presStyleCnt="2">
        <dgm:presLayoutVars>
          <dgm:bulletEnabled val="1"/>
        </dgm:presLayoutVars>
      </dgm:prSet>
      <dgm:spPr/>
    </dgm:pt>
  </dgm:ptLst>
  <dgm:cxnLst>
    <dgm:cxn modelId="{E7C1D22C-6C4A-DF4E-942F-90AC13818896}" srcId="{EB098CA8-EAD6-4849-ACAD-12DE6327C48E}" destId="{2BBC2BCD-52EE-C242-A2A4-5B90B341B72F}" srcOrd="1" destOrd="0" parTransId="{874D884E-C227-AA4B-B578-C0E43E83A64A}" sibTransId="{0E97E327-D31C-7F42-A7FC-73DAC4752553}"/>
    <dgm:cxn modelId="{A4EC425D-D377-D14E-B75A-235BC1E7ACD7}" type="presOf" srcId="{659BAD12-C987-4023-958B-BB63443E8F59}" destId="{A01952E9-EA34-3F46-B4B3-DBB7C9ADE429}" srcOrd="0" destOrd="0" presId="urn:microsoft.com/office/officeart/2005/8/layout/process4"/>
    <dgm:cxn modelId="{B723CF77-8988-4998-B2E0-FDEFB7FF9DC2}" srcId="{4B6300ED-2805-4A0E-A0A2-772F2D761042}" destId="{EB098CA8-EAD6-4849-ACAD-12DE6327C48E}" srcOrd="0" destOrd="0" parTransId="{603CAD4F-2EAC-4153-A39A-72D7F8D31357}" sibTransId="{1591A2C7-9A7F-4226-BB22-2B49FDCEEF70}"/>
    <dgm:cxn modelId="{D845027A-58D9-7345-8074-A18318A788DE}" type="presOf" srcId="{EB098CA8-EAD6-4849-ACAD-12DE6327C48E}" destId="{9C179F44-F51F-8542-9336-DEF5BEA4B23C}" srcOrd="1" destOrd="0" presId="urn:microsoft.com/office/officeart/2005/8/layout/process4"/>
    <dgm:cxn modelId="{25A05E7D-9A9B-4776-A373-29B7299FFC1B}" srcId="{EB098CA8-EAD6-4849-ACAD-12DE6327C48E}" destId="{659BAD12-C987-4023-958B-BB63443E8F59}" srcOrd="0" destOrd="0" parTransId="{137FFF91-A1FD-4971-9B9F-D13A8579318E}" sibTransId="{CAF0BC23-3046-4D44-B3D2-5E06A22A3453}"/>
    <dgm:cxn modelId="{9FA99A81-CD9F-264C-ACA6-B67C6FB8BE57}" type="presOf" srcId="{2BBC2BCD-52EE-C242-A2A4-5B90B341B72F}" destId="{44AACF73-A6B0-B64D-9709-577154413DE7}" srcOrd="0" destOrd="0" presId="urn:microsoft.com/office/officeart/2005/8/layout/process4"/>
    <dgm:cxn modelId="{B8CC2ECF-019E-43D2-846E-9760B347602F}" srcId="{4B6300ED-2805-4A0E-A0A2-772F2D761042}" destId="{E1366B5E-3D7B-478B-BA0B-4CAC534D7C50}" srcOrd="1" destOrd="0" parTransId="{7FCC875A-0696-4336-B470-2379D2CA2853}" sibTransId="{5D618E61-A72C-4D8B-AF53-45BD2A8639FB}"/>
    <dgm:cxn modelId="{15DB29D9-FF25-534C-849A-E97DF42D6A18}" type="presOf" srcId="{E1366B5E-3D7B-478B-BA0B-4CAC534D7C50}" destId="{D7F3AA9C-8CCB-6445-AFE1-0FB4926AA6AB}" srcOrd="0" destOrd="0" presId="urn:microsoft.com/office/officeart/2005/8/layout/process4"/>
    <dgm:cxn modelId="{E0C53CDC-C244-324E-AFC7-64CC97426367}" type="presOf" srcId="{EB098CA8-EAD6-4849-ACAD-12DE6327C48E}" destId="{86E22264-3549-D646-93D7-848E4907F461}" srcOrd="0" destOrd="0" presId="urn:microsoft.com/office/officeart/2005/8/layout/process4"/>
    <dgm:cxn modelId="{8262FDE0-A0F7-1B41-8B07-9BFCCC9E9655}" type="presOf" srcId="{4B6300ED-2805-4A0E-A0A2-772F2D761042}" destId="{EA944A9C-95B4-C540-AC8F-16D3B914F96D}" srcOrd="0" destOrd="0" presId="urn:microsoft.com/office/officeart/2005/8/layout/process4"/>
    <dgm:cxn modelId="{040AACFE-2EA3-CA4E-907C-8B384671B2FA}" type="presParOf" srcId="{EA944A9C-95B4-C540-AC8F-16D3B914F96D}" destId="{A6768376-9976-464A-B63B-06667D42794C}" srcOrd="0" destOrd="0" presId="urn:microsoft.com/office/officeart/2005/8/layout/process4"/>
    <dgm:cxn modelId="{89CAAED7-4748-114A-BB93-255B1FBC4C98}" type="presParOf" srcId="{A6768376-9976-464A-B63B-06667D42794C}" destId="{D7F3AA9C-8CCB-6445-AFE1-0FB4926AA6AB}" srcOrd="0" destOrd="0" presId="urn:microsoft.com/office/officeart/2005/8/layout/process4"/>
    <dgm:cxn modelId="{B67E13AB-6299-4144-882E-94A3171B6D84}" type="presParOf" srcId="{EA944A9C-95B4-C540-AC8F-16D3B914F96D}" destId="{CB69F24E-5973-1D4C-A7A0-930CDD00B6D9}" srcOrd="1" destOrd="0" presId="urn:microsoft.com/office/officeart/2005/8/layout/process4"/>
    <dgm:cxn modelId="{E6916C1A-83FE-C34C-8797-5B63B7AA8754}" type="presParOf" srcId="{EA944A9C-95B4-C540-AC8F-16D3B914F96D}" destId="{E8305DFF-7AAA-6042-9FA3-23EFA6B8A833}" srcOrd="2" destOrd="0" presId="urn:microsoft.com/office/officeart/2005/8/layout/process4"/>
    <dgm:cxn modelId="{AF8E2F40-228F-FE40-B214-5D46945A250A}" type="presParOf" srcId="{E8305DFF-7AAA-6042-9FA3-23EFA6B8A833}" destId="{86E22264-3549-D646-93D7-848E4907F461}" srcOrd="0" destOrd="0" presId="urn:microsoft.com/office/officeart/2005/8/layout/process4"/>
    <dgm:cxn modelId="{617C1A30-A344-E941-B290-C90C87F392BF}" type="presParOf" srcId="{E8305DFF-7AAA-6042-9FA3-23EFA6B8A833}" destId="{9C179F44-F51F-8542-9336-DEF5BEA4B23C}" srcOrd="1" destOrd="0" presId="urn:microsoft.com/office/officeart/2005/8/layout/process4"/>
    <dgm:cxn modelId="{151C367B-4F05-A140-9364-744D2AC5D641}" type="presParOf" srcId="{E8305DFF-7AAA-6042-9FA3-23EFA6B8A833}" destId="{346F29ED-E828-5345-98C6-A6654C830448}" srcOrd="2" destOrd="0" presId="urn:microsoft.com/office/officeart/2005/8/layout/process4"/>
    <dgm:cxn modelId="{D26FF544-8A1D-174B-B938-795BC872C3C6}" type="presParOf" srcId="{346F29ED-E828-5345-98C6-A6654C830448}" destId="{A01952E9-EA34-3F46-B4B3-DBB7C9ADE429}" srcOrd="0" destOrd="0" presId="urn:microsoft.com/office/officeart/2005/8/layout/process4"/>
    <dgm:cxn modelId="{15AC1629-5E97-7445-B437-24901281BE9B}" type="presParOf" srcId="{346F29ED-E828-5345-98C6-A6654C830448}" destId="{44AACF73-A6B0-B64D-9709-577154413DE7}" srcOrd="1" destOrd="0" presId="urn:microsoft.com/office/officeart/2005/8/layout/process4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3.xml><?xml version="1.0" encoding="utf-8"?>
<dgm:dataModel xmlns:dgm="http://schemas.openxmlformats.org/drawingml/2006/diagram" xmlns:a="http://schemas.openxmlformats.org/drawingml/2006/main">
  <dgm:ptLst>
    <dgm:pt modelId="{ADDBF75A-AA21-4E30-99FA-BAAFEC19F654}" type="doc">
      <dgm:prSet loTypeId="urn:microsoft.com/office/officeart/2005/8/layout/list1" loCatId="list" qsTypeId="urn:microsoft.com/office/officeart/2005/8/quickstyle/simple1" qsCatId="simple" csTypeId="urn:microsoft.com/office/officeart/2005/8/colors/colorful5" csCatId="colorful" phldr="1"/>
      <dgm:spPr/>
      <dgm:t>
        <a:bodyPr/>
        <a:lstStyle/>
        <a:p>
          <a:endParaRPr lang="en-US"/>
        </a:p>
      </dgm:t>
    </dgm:pt>
    <dgm:pt modelId="{B3C4969C-E6CC-42DB-AA87-484BB8650720}">
      <dgm:prSet/>
      <dgm:spPr>
        <a:solidFill>
          <a:schemeClr val="accent5"/>
        </a:solidFill>
      </dgm:spPr>
      <dgm:t>
        <a:bodyPr/>
        <a:lstStyle/>
        <a:p>
          <a:r>
            <a:rPr lang="en-US" b="1" dirty="0">
              <a:latin typeface="Arial" panose="020B0604020202020204" pitchFamily="34" charset="0"/>
              <a:cs typeface="Arial" panose="020B0604020202020204" pitchFamily="34" charset="0"/>
            </a:rPr>
            <a:t>Chemotherapy</a:t>
          </a:r>
        </a:p>
      </dgm:t>
    </dgm:pt>
    <dgm:pt modelId="{E338B6A1-3A17-4835-B05B-7B85CFBEA095}" type="parTrans" cxnId="{CA4F85E5-3EBC-42D5-AA05-502B6709A357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7124CB2-EC6B-4F17-A4CF-23BA20BDA75E}" type="sibTrans" cxnId="{CA4F85E5-3EBC-42D5-AA05-502B6709A357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07BE011-7AB3-4EE1-833D-4AB24615F32B}">
      <dgm:prSet/>
      <dgm:spPr>
        <a:solidFill>
          <a:schemeClr val="accent1"/>
        </a:solidFill>
      </dgm:spPr>
      <dgm:t>
        <a:bodyPr/>
        <a:lstStyle/>
        <a:p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Radiation therapy</a:t>
          </a:r>
        </a:p>
      </dgm:t>
    </dgm:pt>
    <dgm:pt modelId="{1703A0D0-2EF1-4D57-A687-BF8067104066}" type="parTrans" cxnId="{4C48EC11-92D6-4E1F-84D6-5327F2852EE4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BFF5613-749F-4C42-B5E7-FEC928CC4BE3}" type="sibTrans" cxnId="{4C48EC11-92D6-4E1F-84D6-5327F2852EE4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F8108A5-18C1-4EFD-A385-E05E71DD9C77}">
      <dgm:prSet/>
      <dgm:spPr>
        <a:solidFill>
          <a:schemeClr val="accent6"/>
        </a:solidFill>
      </dgm:spPr>
      <dgm:t>
        <a:bodyPr/>
        <a:lstStyle/>
        <a:p>
          <a:r>
            <a:rPr lang="en-US" b="1">
              <a:latin typeface="Arial" panose="020B0604020202020204" pitchFamily="34" charset="0"/>
              <a:cs typeface="Arial" panose="020B0604020202020204" pitchFamily="34" charset="0"/>
            </a:rPr>
            <a:t>Surgery</a:t>
          </a:r>
        </a:p>
      </dgm:t>
    </dgm:pt>
    <dgm:pt modelId="{71DE7957-E458-4C7A-8D32-EB6D94C3C0F2}" type="parTrans" cxnId="{A79E6E24-E6C2-425A-90C4-98DFF1FA743D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B6E49B6-6B4A-443E-ABA4-E2AA3602315E}" type="sibTrans" cxnId="{A79E6E24-E6C2-425A-90C4-98DFF1FA743D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F1B5BD3-2142-4D08-A5B6-14A485EF98E4}">
      <dgm:prSet/>
      <dgm:spPr>
        <a:solidFill>
          <a:schemeClr val="accent4"/>
        </a:solidFill>
      </dgm:spPr>
      <dgm:t>
        <a:bodyPr/>
        <a:lstStyle/>
        <a:p>
          <a:r>
            <a:rPr lang="en-US" b="1" dirty="0">
              <a:latin typeface="Arial" panose="020B0604020202020204" pitchFamily="34" charset="0"/>
              <a:cs typeface="Arial" panose="020B0604020202020204" pitchFamily="34" charset="0"/>
            </a:rPr>
            <a:t>Stem Cell Transplant</a:t>
          </a:r>
        </a:p>
      </dgm:t>
    </dgm:pt>
    <dgm:pt modelId="{EF9DACE1-802E-433D-87E4-C047EB796480}" type="parTrans" cxnId="{7B7B6A54-9D22-4DB6-A39E-8296E969F83A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7E43F1F-28C8-41A7-9F7F-C280D2F94DDC}" type="sibTrans" cxnId="{7B7B6A54-9D22-4DB6-A39E-8296E969F83A}">
      <dgm:prSet/>
      <dgm:spPr/>
      <dgm:t>
        <a:bodyPr/>
        <a:lstStyle/>
        <a:p>
          <a:endParaRPr lang="en-US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9FE3653-6D5A-1A48-89B8-612C46762120}" type="pres">
      <dgm:prSet presAssocID="{ADDBF75A-AA21-4E30-99FA-BAAFEC19F654}" presName="linear" presStyleCnt="0">
        <dgm:presLayoutVars>
          <dgm:dir/>
          <dgm:animLvl val="lvl"/>
          <dgm:resizeHandles val="exact"/>
        </dgm:presLayoutVars>
      </dgm:prSet>
      <dgm:spPr/>
    </dgm:pt>
    <dgm:pt modelId="{2F573B46-1F44-4442-B907-E14DB3893163}" type="pres">
      <dgm:prSet presAssocID="{B3C4969C-E6CC-42DB-AA87-484BB8650720}" presName="parentLin" presStyleCnt="0"/>
      <dgm:spPr/>
    </dgm:pt>
    <dgm:pt modelId="{E3140E4E-13CC-4A47-BEEB-78400898EDB5}" type="pres">
      <dgm:prSet presAssocID="{B3C4969C-E6CC-42DB-AA87-484BB8650720}" presName="parentLeftMargin" presStyleLbl="node1" presStyleIdx="0" presStyleCnt="4"/>
      <dgm:spPr/>
    </dgm:pt>
    <dgm:pt modelId="{CE1E9BBF-A742-094F-908F-7EBB98EAF9C3}" type="pres">
      <dgm:prSet presAssocID="{B3C4969C-E6CC-42DB-AA87-484BB8650720}" presName="parentText" presStyleLbl="node1" presStyleIdx="0" presStyleCnt="4">
        <dgm:presLayoutVars>
          <dgm:chMax val="0"/>
          <dgm:bulletEnabled val="1"/>
        </dgm:presLayoutVars>
      </dgm:prSet>
      <dgm:spPr/>
    </dgm:pt>
    <dgm:pt modelId="{5DD1D25E-6F5A-3C48-8A84-4143A3CB6284}" type="pres">
      <dgm:prSet presAssocID="{B3C4969C-E6CC-42DB-AA87-484BB8650720}" presName="negativeSpace" presStyleCnt="0"/>
      <dgm:spPr/>
    </dgm:pt>
    <dgm:pt modelId="{10E5260F-A9DF-AF42-A45C-E2517F7330BD}" type="pres">
      <dgm:prSet presAssocID="{B3C4969C-E6CC-42DB-AA87-484BB8650720}" presName="childText" presStyleLbl="conFgAcc1" presStyleIdx="0" presStyleCnt="4">
        <dgm:presLayoutVars>
          <dgm:bulletEnabled val="1"/>
        </dgm:presLayoutVars>
      </dgm:prSet>
      <dgm:spPr/>
    </dgm:pt>
    <dgm:pt modelId="{B4F6EC57-54F7-374E-BDD8-EB0D868330D3}" type="pres">
      <dgm:prSet presAssocID="{97124CB2-EC6B-4F17-A4CF-23BA20BDA75E}" presName="spaceBetweenRectangles" presStyleCnt="0"/>
      <dgm:spPr/>
    </dgm:pt>
    <dgm:pt modelId="{02F27C9B-59D1-AD4C-B1F9-AB3014A0CFF0}" type="pres">
      <dgm:prSet presAssocID="{E07BE011-7AB3-4EE1-833D-4AB24615F32B}" presName="parentLin" presStyleCnt="0"/>
      <dgm:spPr/>
    </dgm:pt>
    <dgm:pt modelId="{42C07204-201D-E347-AA24-D0ED8A071681}" type="pres">
      <dgm:prSet presAssocID="{E07BE011-7AB3-4EE1-833D-4AB24615F32B}" presName="parentLeftMargin" presStyleLbl="node1" presStyleIdx="0" presStyleCnt="4"/>
      <dgm:spPr/>
    </dgm:pt>
    <dgm:pt modelId="{9B6CC211-C3C8-CE48-AA82-956BCC012DA2}" type="pres">
      <dgm:prSet presAssocID="{E07BE011-7AB3-4EE1-833D-4AB24615F32B}" presName="parentText" presStyleLbl="node1" presStyleIdx="1" presStyleCnt="4">
        <dgm:presLayoutVars>
          <dgm:chMax val="0"/>
          <dgm:bulletEnabled val="1"/>
        </dgm:presLayoutVars>
      </dgm:prSet>
      <dgm:spPr/>
    </dgm:pt>
    <dgm:pt modelId="{FAE5F664-35B4-2142-A519-094AAB9152CC}" type="pres">
      <dgm:prSet presAssocID="{E07BE011-7AB3-4EE1-833D-4AB24615F32B}" presName="negativeSpace" presStyleCnt="0"/>
      <dgm:spPr/>
    </dgm:pt>
    <dgm:pt modelId="{75B5D703-74D8-F54B-BEFB-FF5D160AA5DF}" type="pres">
      <dgm:prSet presAssocID="{E07BE011-7AB3-4EE1-833D-4AB24615F32B}" presName="childText" presStyleLbl="conFgAcc1" presStyleIdx="1" presStyleCnt="4">
        <dgm:presLayoutVars>
          <dgm:bulletEnabled val="1"/>
        </dgm:presLayoutVars>
      </dgm:prSet>
      <dgm:spPr/>
    </dgm:pt>
    <dgm:pt modelId="{96972966-E32A-0149-BFCB-FFDF43AD4BEE}" type="pres">
      <dgm:prSet presAssocID="{CBFF5613-749F-4C42-B5E7-FEC928CC4BE3}" presName="spaceBetweenRectangles" presStyleCnt="0"/>
      <dgm:spPr/>
    </dgm:pt>
    <dgm:pt modelId="{2E658B82-3C81-2C48-8973-A458D05A0D51}" type="pres">
      <dgm:prSet presAssocID="{DF8108A5-18C1-4EFD-A385-E05E71DD9C77}" presName="parentLin" presStyleCnt="0"/>
      <dgm:spPr/>
    </dgm:pt>
    <dgm:pt modelId="{76E32075-C2C9-5145-B36D-A89A0E3E4572}" type="pres">
      <dgm:prSet presAssocID="{DF8108A5-18C1-4EFD-A385-E05E71DD9C77}" presName="parentLeftMargin" presStyleLbl="node1" presStyleIdx="1" presStyleCnt="4"/>
      <dgm:spPr/>
    </dgm:pt>
    <dgm:pt modelId="{085AF877-0F36-FB42-8A84-0B7B335F41CC}" type="pres">
      <dgm:prSet presAssocID="{DF8108A5-18C1-4EFD-A385-E05E71DD9C77}" presName="parentText" presStyleLbl="node1" presStyleIdx="2" presStyleCnt="4">
        <dgm:presLayoutVars>
          <dgm:chMax val="0"/>
          <dgm:bulletEnabled val="1"/>
        </dgm:presLayoutVars>
      </dgm:prSet>
      <dgm:spPr/>
    </dgm:pt>
    <dgm:pt modelId="{44E75AF2-9FFD-2145-A22C-34D0456EE229}" type="pres">
      <dgm:prSet presAssocID="{DF8108A5-18C1-4EFD-A385-E05E71DD9C77}" presName="negativeSpace" presStyleCnt="0"/>
      <dgm:spPr/>
    </dgm:pt>
    <dgm:pt modelId="{F91E113B-D7E4-F24C-9874-27DDFC6F8DBD}" type="pres">
      <dgm:prSet presAssocID="{DF8108A5-18C1-4EFD-A385-E05E71DD9C77}" presName="childText" presStyleLbl="conFgAcc1" presStyleIdx="2" presStyleCnt="4">
        <dgm:presLayoutVars>
          <dgm:bulletEnabled val="1"/>
        </dgm:presLayoutVars>
      </dgm:prSet>
      <dgm:spPr/>
    </dgm:pt>
    <dgm:pt modelId="{BD85C203-31B9-E84F-B5AE-DD5050927B28}" type="pres">
      <dgm:prSet presAssocID="{CB6E49B6-6B4A-443E-ABA4-E2AA3602315E}" presName="spaceBetweenRectangles" presStyleCnt="0"/>
      <dgm:spPr/>
    </dgm:pt>
    <dgm:pt modelId="{81873C9F-DB05-574A-8304-849FDEBFE673}" type="pres">
      <dgm:prSet presAssocID="{5F1B5BD3-2142-4D08-A5B6-14A485EF98E4}" presName="parentLin" presStyleCnt="0"/>
      <dgm:spPr/>
    </dgm:pt>
    <dgm:pt modelId="{EAEB41F3-0541-6A4C-9D4C-254F79398324}" type="pres">
      <dgm:prSet presAssocID="{5F1B5BD3-2142-4D08-A5B6-14A485EF98E4}" presName="parentLeftMargin" presStyleLbl="node1" presStyleIdx="2" presStyleCnt="4"/>
      <dgm:spPr/>
    </dgm:pt>
    <dgm:pt modelId="{BE949D84-28BB-5046-A081-84588AEAD4CD}" type="pres">
      <dgm:prSet presAssocID="{5F1B5BD3-2142-4D08-A5B6-14A485EF98E4}" presName="parentText" presStyleLbl="node1" presStyleIdx="3" presStyleCnt="4">
        <dgm:presLayoutVars>
          <dgm:chMax val="0"/>
          <dgm:bulletEnabled val="1"/>
        </dgm:presLayoutVars>
      </dgm:prSet>
      <dgm:spPr/>
    </dgm:pt>
    <dgm:pt modelId="{2AFD66A8-E0F6-184F-94F6-D95282442849}" type="pres">
      <dgm:prSet presAssocID="{5F1B5BD3-2142-4D08-A5B6-14A485EF98E4}" presName="negativeSpace" presStyleCnt="0"/>
      <dgm:spPr/>
    </dgm:pt>
    <dgm:pt modelId="{74D09C93-6383-0A40-92AD-84FA2ABA5B50}" type="pres">
      <dgm:prSet presAssocID="{5F1B5BD3-2142-4D08-A5B6-14A485EF98E4}" presName="childText" presStyleLbl="conFgAcc1" presStyleIdx="3" presStyleCnt="4">
        <dgm:presLayoutVars>
          <dgm:bulletEnabled val="1"/>
        </dgm:presLayoutVars>
      </dgm:prSet>
      <dgm:spPr/>
    </dgm:pt>
  </dgm:ptLst>
  <dgm:cxnLst>
    <dgm:cxn modelId="{D6A64B11-457E-1F40-960E-1DADD7F615C8}" type="presOf" srcId="{ADDBF75A-AA21-4E30-99FA-BAAFEC19F654}" destId="{69FE3653-6D5A-1A48-89B8-612C46762120}" srcOrd="0" destOrd="0" presId="urn:microsoft.com/office/officeart/2005/8/layout/list1"/>
    <dgm:cxn modelId="{4C48EC11-92D6-4E1F-84D6-5327F2852EE4}" srcId="{ADDBF75A-AA21-4E30-99FA-BAAFEC19F654}" destId="{E07BE011-7AB3-4EE1-833D-4AB24615F32B}" srcOrd="1" destOrd="0" parTransId="{1703A0D0-2EF1-4D57-A687-BF8067104066}" sibTransId="{CBFF5613-749F-4C42-B5E7-FEC928CC4BE3}"/>
    <dgm:cxn modelId="{A79E6E24-E6C2-425A-90C4-98DFF1FA743D}" srcId="{ADDBF75A-AA21-4E30-99FA-BAAFEC19F654}" destId="{DF8108A5-18C1-4EFD-A385-E05E71DD9C77}" srcOrd="2" destOrd="0" parTransId="{71DE7957-E458-4C7A-8D32-EB6D94C3C0F2}" sibTransId="{CB6E49B6-6B4A-443E-ABA4-E2AA3602315E}"/>
    <dgm:cxn modelId="{A125CC33-DADB-6843-8BEA-693BC6709A3C}" type="presOf" srcId="{5F1B5BD3-2142-4D08-A5B6-14A485EF98E4}" destId="{BE949D84-28BB-5046-A081-84588AEAD4CD}" srcOrd="1" destOrd="0" presId="urn:microsoft.com/office/officeart/2005/8/layout/list1"/>
    <dgm:cxn modelId="{1F6E5334-97C5-B74D-B25E-C517A34E5B36}" type="presOf" srcId="{5F1B5BD3-2142-4D08-A5B6-14A485EF98E4}" destId="{EAEB41F3-0541-6A4C-9D4C-254F79398324}" srcOrd="0" destOrd="0" presId="urn:microsoft.com/office/officeart/2005/8/layout/list1"/>
    <dgm:cxn modelId="{FE967365-12E4-4649-8CCF-D52D68FBE0CF}" type="presOf" srcId="{DF8108A5-18C1-4EFD-A385-E05E71DD9C77}" destId="{085AF877-0F36-FB42-8A84-0B7B335F41CC}" srcOrd="1" destOrd="0" presId="urn:microsoft.com/office/officeart/2005/8/layout/list1"/>
    <dgm:cxn modelId="{5115ED70-0286-E448-8F35-B1DD4B10C003}" type="presOf" srcId="{DF8108A5-18C1-4EFD-A385-E05E71DD9C77}" destId="{76E32075-C2C9-5145-B36D-A89A0E3E4572}" srcOrd="0" destOrd="0" presId="urn:microsoft.com/office/officeart/2005/8/layout/list1"/>
    <dgm:cxn modelId="{7B7B6A54-9D22-4DB6-A39E-8296E969F83A}" srcId="{ADDBF75A-AA21-4E30-99FA-BAAFEC19F654}" destId="{5F1B5BD3-2142-4D08-A5B6-14A485EF98E4}" srcOrd="3" destOrd="0" parTransId="{EF9DACE1-802E-433D-87E4-C047EB796480}" sibTransId="{77E43F1F-28C8-41A7-9F7F-C280D2F94DDC}"/>
    <dgm:cxn modelId="{BF15C58A-1CB4-5C4C-94CF-CB7F33AC0922}" type="presOf" srcId="{B3C4969C-E6CC-42DB-AA87-484BB8650720}" destId="{CE1E9BBF-A742-094F-908F-7EBB98EAF9C3}" srcOrd="1" destOrd="0" presId="urn:microsoft.com/office/officeart/2005/8/layout/list1"/>
    <dgm:cxn modelId="{E9D117A1-4273-B941-BD4B-087DFC74F88D}" type="presOf" srcId="{E07BE011-7AB3-4EE1-833D-4AB24615F32B}" destId="{42C07204-201D-E347-AA24-D0ED8A071681}" srcOrd="0" destOrd="0" presId="urn:microsoft.com/office/officeart/2005/8/layout/list1"/>
    <dgm:cxn modelId="{E667EBCB-DEA9-044D-874F-F795B8CC598E}" type="presOf" srcId="{B3C4969C-E6CC-42DB-AA87-484BB8650720}" destId="{E3140E4E-13CC-4A47-BEEB-78400898EDB5}" srcOrd="0" destOrd="0" presId="urn:microsoft.com/office/officeart/2005/8/layout/list1"/>
    <dgm:cxn modelId="{8559DAE2-45FB-0642-B8C8-4F78BF92EC05}" type="presOf" srcId="{E07BE011-7AB3-4EE1-833D-4AB24615F32B}" destId="{9B6CC211-C3C8-CE48-AA82-956BCC012DA2}" srcOrd="1" destOrd="0" presId="urn:microsoft.com/office/officeart/2005/8/layout/list1"/>
    <dgm:cxn modelId="{CA4F85E5-3EBC-42D5-AA05-502B6709A357}" srcId="{ADDBF75A-AA21-4E30-99FA-BAAFEC19F654}" destId="{B3C4969C-E6CC-42DB-AA87-484BB8650720}" srcOrd="0" destOrd="0" parTransId="{E338B6A1-3A17-4835-B05B-7B85CFBEA095}" sibTransId="{97124CB2-EC6B-4F17-A4CF-23BA20BDA75E}"/>
    <dgm:cxn modelId="{02324879-9565-F547-8C20-75F2F0E2D181}" type="presParOf" srcId="{69FE3653-6D5A-1A48-89B8-612C46762120}" destId="{2F573B46-1F44-4442-B907-E14DB3893163}" srcOrd="0" destOrd="0" presId="urn:microsoft.com/office/officeart/2005/8/layout/list1"/>
    <dgm:cxn modelId="{C6C82641-2D12-C741-A441-8BAA0D57A956}" type="presParOf" srcId="{2F573B46-1F44-4442-B907-E14DB3893163}" destId="{E3140E4E-13CC-4A47-BEEB-78400898EDB5}" srcOrd="0" destOrd="0" presId="urn:microsoft.com/office/officeart/2005/8/layout/list1"/>
    <dgm:cxn modelId="{534FE131-6CD9-E743-842E-DAAC462E550F}" type="presParOf" srcId="{2F573B46-1F44-4442-B907-E14DB3893163}" destId="{CE1E9BBF-A742-094F-908F-7EBB98EAF9C3}" srcOrd="1" destOrd="0" presId="urn:microsoft.com/office/officeart/2005/8/layout/list1"/>
    <dgm:cxn modelId="{31D1591F-18DE-CB42-9533-29188D0E1F1E}" type="presParOf" srcId="{69FE3653-6D5A-1A48-89B8-612C46762120}" destId="{5DD1D25E-6F5A-3C48-8A84-4143A3CB6284}" srcOrd="1" destOrd="0" presId="urn:microsoft.com/office/officeart/2005/8/layout/list1"/>
    <dgm:cxn modelId="{A156F630-178C-7348-B50D-D32D321FC100}" type="presParOf" srcId="{69FE3653-6D5A-1A48-89B8-612C46762120}" destId="{10E5260F-A9DF-AF42-A45C-E2517F7330BD}" srcOrd="2" destOrd="0" presId="urn:microsoft.com/office/officeart/2005/8/layout/list1"/>
    <dgm:cxn modelId="{62D3DB72-F072-8B4F-843A-3881AC165E12}" type="presParOf" srcId="{69FE3653-6D5A-1A48-89B8-612C46762120}" destId="{B4F6EC57-54F7-374E-BDD8-EB0D868330D3}" srcOrd="3" destOrd="0" presId="urn:microsoft.com/office/officeart/2005/8/layout/list1"/>
    <dgm:cxn modelId="{257A699E-619E-0448-B775-6D1AD0408078}" type="presParOf" srcId="{69FE3653-6D5A-1A48-89B8-612C46762120}" destId="{02F27C9B-59D1-AD4C-B1F9-AB3014A0CFF0}" srcOrd="4" destOrd="0" presId="urn:microsoft.com/office/officeart/2005/8/layout/list1"/>
    <dgm:cxn modelId="{82187604-1932-904E-BF6E-0AC3ED93DD36}" type="presParOf" srcId="{02F27C9B-59D1-AD4C-B1F9-AB3014A0CFF0}" destId="{42C07204-201D-E347-AA24-D0ED8A071681}" srcOrd="0" destOrd="0" presId="urn:microsoft.com/office/officeart/2005/8/layout/list1"/>
    <dgm:cxn modelId="{2C3B0B56-433D-3F40-99D7-14B8D12AE4E2}" type="presParOf" srcId="{02F27C9B-59D1-AD4C-B1F9-AB3014A0CFF0}" destId="{9B6CC211-C3C8-CE48-AA82-956BCC012DA2}" srcOrd="1" destOrd="0" presId="urn:microsoft.com/office/officeart/2005/8/layout/list1"/>
    <dgm:cxn modelId="{BB7ABE0C-D241-DD4C-8DA6-DFE2BB30846F}" type="presParOf" srcId="{69FE3653-6D5A-1A48-89B8-612C46762120}" destId="{FAE5F664-35B4-2142-A519-094AAB9152CC}" srcOrd="5" destOrd="0" presId="urn:microsoft.com/office/officeart/2005/8/layout/list1"/>
    <dgm:cxn modelId="{F6483BFA-A1D3-2246-9B78-86C896A73A22}" type="presParOf" srcId="{69FE3653-6D5A-1A48-89B8-612C46762120}" destId="{75B5D703-74D8-F54B-BEFB-FF5D160AA5DF}" srcOrd="6" destOrd="0" presId="urn:microsoft.com/office/officeart/2005/8/layout/list1"/>
    <dgm:cxn modelId="{4F74814E-00A2-7A4A-8922-F9F15B4689B5}" type="presParOf" srcId="{69FE3653-6D5A-1A48-89B8-612C46762120}" destId="{96972966-E32A-0149-BFCB-FFDF43AD4BEE}" srcOrd="7" destOrd="0" presId="urn:microsoft.com/office/officeart/2005/8/layout/list1"/>
    <dgm:cxn modelId="{AD4285B0-BE32-A340-BB12-A69F6AC13DED}" type="presParOf" srcId="{69FE3653-6D5A-1A48-89B8-612C46762120}" destId="{2E658B82-3C81-2C48-8973-A458D05A0D51}" srcOrd="8" destOrd="0" presId="urn:microsoft.com/office/officeart/2005/8/layout/list1"/>
    <dgm:cxn modelId="{36877022-D583-B54B-B284-D7958C124EDF}" type="presParOf" srcId="{2E658B82-3C81-2C48-8973-A458D05A0D51}" destId="{76E32075-C2C9-5145-B36D-A89A0E3E4572}" srcOrd="0" destOrd="0" presId="urn:microsoft.com/office/officeart/2005/8/layout/list1"/>
    <dgm:cxn modelId="{1DEC249E-AA3F-C34D-9E42-BF76B0EC91E8}" type="presParOf" srcId="{2E658B82-3C81-2C48-8973-A458D05A0D51}" destId="{085AF877-0F36-FB42-8A84-0B7B335F41CC}" srcOrd="1" destOrd="0" presId="urn:microsoft.com/office/officeart/2005/8/layout/list1"/>
    <dgm:cxn modelId="{913CC785-5544-3C4C-99C4-4BFB12175D72}" type="presParOf" srcId="{69FE3653-6D5A-1A48-89B8-612C46762120}" destId="{44E75AF2-9FFD-2145-A22C-34D0456EE229}" srcOrd="9" destOrd="0" presId="urn:microsoft.com/office/officeart/2005/8/layout/list1"/>
    <dgm:cxn modelId="{8CB33581-E434-E744-9BB9-7442A1CF3139}" type="presParOf" srcId="{69FE3653-6D5A-1A48-89B8-612C46762120}" destId="{F91E113B-D7E4-F24C-9874-27DDFC6F8DBD}" srcOrd="10" destOrd="0" presId="urn:microsoft.com/office/officeart/2005/8/layout/list1"/>
    <dgm:cxn modelId="{A019DB44-559A-5F45-AD4E-B27F73A1A183}" type="presParOf" srcId="{69FE3653-6D5A-1A48-89B8-612C46762120}" destId="{BD85C203-31B9-E84F-B5AE-DD5050927B28}" srcOrd="11" destOrd="0" presId="urn:microsoft.com/office/officeart/2005/8/layout/list1"/>
    <dgm:cxn modelId="{E57EC70B-D3A0-CA49-94B7-E680D0E1CBFF}" type="presParOf" srcId="{69FE3653-6D5A-1A48-89B8-612C46762120}" destId="{81873C9F-DB05-574A-8304-849FDEBFE673}" srcOrd="12" destOrd="0" presId="urn:microsoft.com/office/officeart/2005/8/layout/list1"/>
    <dgm:cxn modelId="{9ED32539-E83A-D748-840E-DC47ADE0EF83}" type="presParOf" srcId="{81873C9F-DB05-574A-8304-849FDEBFE673}" destId="{EAEB41F3-0541-6A4C-9D4C-254F79398324}" srcOrd="0" destOrd="0" presId="urn:microsoft.com/office/officeart/2005/8/layout/list1"/>
    <dgm:cxn modelId="{6EB6D5EC-84D2-D243-89BB-EE4B0786796C}" type="presParOf" srcId="{81873C9F-DB05-574A-8304-849FDEBFE673}" destId="{BE949D84-28BB-5046-A081-84588AEAD4CD}" srcOrd="1" destOrd="0" presId="urn:microsoft.com/office/officeart/2005/8/layout/list1"/>
    <dgm:cxn modelId="{3A75FBA2-F0F1-7041-94AF-842BD8DCB61E}" type="presParOf" srcId="{69FE3653-6D5A-1A48-89B8-612C46762120}" destId="{2AFD66A8-E0F6-184F-94F6-D95282442849}" srcOrd="13" destOrd="0" presId="urn:microsoft.com/office/officeart/2005/8/layout/list1"/>
    <dgm:cxn modelId="{8FB7EA11-AA79-244D-A481-9096E0F85BF6}" type="presParOf" srcId="{69FE3653-6D5A-1A48-89B8-612C46762120}" destId="{74D09C93-6383-0A40-92AD-84FA2ABA5B50}" srcOrd="14" destOrd="0" presId="urn:microsoft.com/office/officeart/2005/8/layout/list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4.xml><?xml version="1.0" encoding="utf-8"?>
<dgm:dataModel xmlns:dgm="http://schemas.openxmlformats.org/drawingml/2006/diagram" xmlns:a="http://schemas.openxmlformats.org/drawingml/2006/main">
  <dgm:ptLst>
    <dgm:pt modelId="{6DD97C94-22D6-4613-AAEF-2BCD18F10BDA}" type="doc">
      <dgm:prSet loTypeId="urn:microsoft.com/office/officeart/2005/8/layout/list1" loCatId="list" qsTypeId="urn:microsoft.com/office/officeart/2005/8/quickstyle/simple1" qsCatId="simple" csTypeId="urn:microsoft.com/office/officeart/2005/8/colors/accent0_3" csCatId="mainScheme" phldr="1"/>
      <dgm:spPr/>
      <dgm:t>
        <a:bodyPr/>
        <a:lstStyle/>
        <a:p>
          <a:endParaRPr lang="en-US"/>
        </a:p>
      </dgm:t>
    </dgm:pt>
    <dgm:pt modelId="{E0437985-FC50-4E59-BC85-251E3E463D55}">
      <dgm:prSet custT="1"/>
      <dgm:spPr>
        <a:solidFill>
          <a:schemeClr val="accent2">
            <a:lumMod val="40000"/>
            <a:lumOff val="60000"/>
          </a:schemeClr>
        </a:solidFill>
      </dgm:spPr>
      <dgm:t>
        <a:bodyPr/>
        <a:lstStyle/>
        <a:p>
          <a:r>
            <a:rPr lang="en-US" sz="3200" b="1" dirty="0">
              <a:solidFill>
                <a:schemeClr val="accent2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rPr>
            <a:t>External Beam</a:t>
          </a:r>
        </a:p>
      </dgm:t>
    </dgm:pt>
    <dgm:pt modelId="{9D0BF61D-61B6-42BF-873B-25F2647A9C31}" type="parTrans" cxnId="{57998848-6913-4A84-86B7-7992A34D26D7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C5BCCD1-CBD7-48E7-99A8-015EBCEADDF5}" type="sibTrans" cxnId="{57998848-6913-4A84-86B7-7992A34D26D7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C8CC86A-4C77-4A85-BDAF-6C920C64F125}">
      <dgm:prSet/>
      <dgm:spPr>
        <a:solidFill>
          <a:schemeClr val="bg1">
            <a:alpha val="90000"/>
          </a:schemeClr>
        </a:solidFill>
        <a:ln>
          <a:solidFill>
            <a:schemeClr val="accent2">
              <a:lumMod val="50000"/>
            </a:schemeClr>
          </a:solidFill>
        </a:ln>
      </dgm:spPr>
      <dgm:t>
        <a:bodyPr/>
        <a:lstStyle/>
        <a:p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A machine sends radiation into the cancerous area of the body from many directions without touching the patient.</a:t>
          </a:r>
        </a:p>
      </dgm:t>
    </dgm:pt>
    <dgm:pt modelId="{6746CF2C-A81F-4FC1-A921-0DDC7F19326A}" type="parTrans" cxnId="{65907728-020A-410A-86F8-A8C6153CAF8B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3CA4623-7E49-4430-B7A2-DCACF807A4B8}" type="sibTrans" cxnId="{65907728-020A-410A-86F8-A8C6153CAF8B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622279B-1FBF-4F4C-9425-76A20B37ED13}">
      <dgm:prSet custT="1"/>
      <dgm:spPr>
        <a:solidFill>
          <a:schemeClr val="accent5">
            <a:lumMod val="40000"/>
            <a:lumOff val="60000"/>
          </a:schemeClr>
        </a:solidFill>
      </dgm:spPr>
      <dgm:t>
        <a:bodyPr/>
        <a:lstStyle/>
        <a:p>
          <a:r>
            <a:rPr lang="en-US" sz="3200" b="1" dirty="0">
              <a:solidFill>
                <a:schemeClr val="accent5"/>
              </a:solidFill>
              <a:latin typeface="Arial" panose="020B0604020202020204" pitchFamily="34" charset="0"/>
              <a:cs typeface="Arial" panose="020B0604020202020204" pitchFamily="34" charset="0"/>
            </a:rPr>
            <a:t>Internal Beam</a:t>
          </a:r>
        </a:p>
      </dgm:t>
    </dgm:pt>
    <dgm:pt modelId="{E6100551-031C-440A-9375-B61FDCE27A55}" type="parTrans" cxnId="{2B152BA7-CB79-4DDD-AAC8-1F92AEBDD377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F5C7B6E-2C91-4662-9B98-BA57AA556E70}" type="sibTrans" cxnId="{2B152BA7-CB79-4DDD-AAC8-1F92AEBDD377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E38B44B-575A-4E27-9923-998FA5828DBA}">
      <dgm:prSet/>
      <dgm:spPr>
        <a:solidFill>
          <a:schemeClr val="bg1">
            <a:alpha val="90000"/>
          </a:schemeClr>
        </a:solidFill>
        <a:ln>
          <a:solidFill>
            <a:schemeClr val="accent5"/>
          </a:solidFill>
        </a:ln>
      </dgm:spPr>
      <dgm:t>
        <a:bodyPr/>
        <a:lstStyle/>
        <a:p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Radiation is put inside the body through an IV and targets the area near the tumor.</a:t>
          </a:r>
        </a:p>
      </dgm:t>
    </dgm:pt>
    <dgm:pt modelId="{30046D9F-E96D-4CD7-BF0F-0472BB1FDDB6}" type="parTrans" cxnId="{07527997-C971-4A80-A473-775817361F9F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825C742-DFC4-4680-B574-889A5691410A}" type="sibTrans" cxnId="{07527997-C971-4A80-A473-775817361F9F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8D2E754-D4D6-344C-AF7A-394B116CF6A2}" type="pres">
      <dgm:prSet presAssocID="{6DD97C94-22D6-4613-AAEF-2BCD18F10BDA}" presName="linear" presStyleCnt="0">
        <dgm:presLayoutVars>
          <dgm:dir/>
          <dgm:animLvl val="lvl"/>
          <dgm:resizeHandles val="exact"/>
        </dgm:presLayoutVars>
      </dgm:prSet>
      <dgm:spPr/>
    </dgm:pt>
    <dgm:pt modelId="{21BC2556-3693-CC4D-B60A-D045467B064A}" type="pres">
      <dgm:prSet presAssocID="{E0437985-FC50-4E59-BC85-251E3E463D55}" presName="parentLin" presStyleCnt="0"/>
      <dgm:spPr/>
    </dgm:pt>
    <dgm:pt modelId="{A379BC97-E483-B94B-AFD2-64A19120FD3D}" type="pres">
      <dgm:prSet presAssocID="{E0437985-FC50-4E59-BC85-251E3E463D55}" presName="parentLeftMargin" presStyleLbl="node1" presStyleIdx="0" presStyleCnt="2"/>
      <dgm:spPr/>
    </dgm:pt>
    <dgm:pt modelId="{4732F60F-0B29-A648-80A0-156E35812600}" type="pres">
      <dgm:prSet presAssocID="{E0437985-FC50-4E59-BC85-251E3E463D55}" presName="parentText" presStyleLbl="node1" presStyleIdx="0" presStyleCnt="2">
        <dgm:presLayoutVars>
          <dgm:chMax val="0"/>
          <dgm:bulletEnabled val="1"/>
        </dgm:presLayoutVars>
      </dgm:prSet>
      <dgm:spPr/>
    </dgm:pt>
    <dgm:pt modelId="{C72451AA-65B8-7945-853D-95E0679CA079}" type="pres">
      <dgm:prSet presAssocID="{E0437985-FC50-4E59-BC85-251E3E463D55}" presName="negativeSpace" presStyleCnt="0"/>
      <dgm:spPr/>
    </dgm:pt>
    <dgm:pt modelId="{23AC1D09-ECF8-5D4D-9BCE-30F3A46581BB}" type="pres">
      <dgm:prSet presAssocID="{E0437985-FC50-4E59-BC85-251E3E463D55}" presName="childText" presStyleLbl="conFgAcc1" presStyleIdx="0" presStyleCnt="2">
        <dgm:presLayoutVars>
          <dgm:bulletEnabled val="1"/>
        </dgm:presLayoutVars>
      </dgm:prSet>
      <dgm:spPr/>
    </dgm:pt>
    <dgm:pt modelId="{AC72DE5C-5876-E844-B937-1BDDAB13A9ED}" type="pres">
      <dgm:prSet presAssocID="{AC5BCCD1-CBD7-48E7-99A8-015EBCEADDF5}" presName="spaceBetweenRectangles" presStyleCnt="0"/>
      <dgm:spPr/>
    </dgm:pt>
    <dgm:pt modelId="{6B7195BE-31A9-3C4A-8719-45B3D010C1AF}" type="pres">
      <dgm:prSet presAssocID="{7622279B-1FBF-4F4C-9425-76A20B37ED13}" presName="parentLin" presStyleCnt="0"/>
      <dgm:spPr/>
    </dgm:pt>
    <dgm:pt modelId="{4649594E-824C-3745-B5FA-552497997EDD}" type="pres">
      <dgm:prSet presAssocID="{7622279B-1FBF-4F4C-9425-76A20B37ED13}" presName="parentLeftMargin" presStyleLbl="node1" presStyleIdx="0" presStyleCnt="2"/>
      <dgm:spPr/>
    </dgm:pt>
    <dgm:pt modelId="{5B776D8C-BCB9-B443-9292-E8440C1DE1C6}" type="pres">
      <dgm:prSet presAssocID="{7622279B-1FBF-4F4C-9425-76A20B37ED13}" presName="parentText" presStyleLbl="node1" presStyleIdx="1" presStyleCnt="2">
        <dgm:presLayoutVars>
          <dgm:chMax val="0"/>
          <dgm:bulletEnabled val="1"/>
        </dgm:presLayoutVars>
      </dgm:prSet>
      <dgm:spPr/>
    </dgm:pt>
    <dgm:pt modelId="{D2695C69-725C-8448-AD82-21AC52369D1B}" type="pres">
      <dgm:prSet presAssocID="{7622279B-1FBF-4F4C-9425-76A20B37ED13}" presName="negativeSpace" presStyleCnt="0"/>
      <dgm:spPr/>
    </dgm:pt>
    <dgm:pt modelId="{A753E3B0-CFCE-424E-BD31-7D0796400390}" type="pres">
      <dgm:prSet presAssocID="{7622279B-1FBF-4F4C-9425-76A20B37ED13}" presName="childText" presStyleLbl="conFgAcc1" presStyleIdx="1" presStyleCnt="2">
        <dgm:presLayoutVars>
          <dgm:bulletEnabled val="1"/>
        </dgm:presLayoutVars>
      </dgm:prSet>
      <dgm:spPr/>
    </dgm:pt>
  </dgm:ptLst>
  <dgm:cxnLst>
    <dgm:cxn modelId="{36EBE227-5EC9-F14F-98E7-5EABB617A563}" type="presOf" srcId="{7622279B-1FBF-4F4C-9425-76A20B37ED13}" destId="{4649594E-824C-3745-B5FA-552497997EDD}" srcOrd="0" destOrd="0" presId="urn:microsoft.com/office/officeart/2005/8/layout/list1"/>
    <dgm:cxn modelId="{65907728-020A-410A-86F8-A8C6153CAF8B}" srcId="{E0437985-FC50-4E59-BC85-251E3E463D55}" destId="{5C8CC86A-4C77-4A85-BDAF-6C920C64F125}" srcOrd="0" destOrd="0" parTransId="{6746CF2C-A81F-4FC1-A921-0DDC7F19326A}" sibTransId="{C3CA4623-7E49-4430-B7A2-DCACF807A4B8}"/>
    <dgm:cxn modelId="{8AFEAB2C-7E5F-4447-BDE4-D9CE12DA97B9}" type="presOf" srcId="{7622279B-1FBF-4F4C-9425-76A20B37ED13}" destId="{5B776D8C-BCB9-B443-9292-E8440C1DE1C6}" srcOrd="1" destOrd="0" presId="urn:microsoft.com/office/officeart/2005/8/layout/list1"/>
    <dgm:cxn modelId="{64C9635B-295B-7E48-BA2E-F6ECFAC4FE0E}" type="presOf" srcId="{E0437985-FC50-4E59-BC85-251E3E463D55}" destId="{4732F60F-0B29-A648-80A0-156E35812600}" srcOrd="1" destOrd="0" presId="urn:microsoft.com/office/officeart/2005/8/layout/list1"/>
    <dgm:cxn modelId="{B2E1B55B-AF37-7E48-B137-52DFEFAEA2A6}" type="presOf" srcId="{7E38B44B-575A-4E27-9923-998FA5828DBA}" destId="{A753E3B0-CFCE-424E-BD31-7D0796400390}" srcOrd="0" destOrd="0" presId="urn:microsoft.com/office/officeart/2005/8/layout/list1"/>
    <dgm:cxn modelId="{57998848-6913-4A84-86B7-7992A34D26D7}" srcId="{6DD97C94-22D6-4613-AAEF-2BCD18F10BDA}" destId="{E0437985-FC50-4E59-BC85-251E3E463D55}" srcOrd="0" destOrd="0" parTransId="{9D0BF61D-61B6-42BF-873B-25F2647A9C31}" sibTransId="{AC5BCCD1-CBD7-48E7-99A8-015EBCEADDF5}"/>
    <dgm:cxn modelId="{60473387-B2C4-3743-9A6B-0926D7F6724C}" type="presOf" srcId="{6DD97C94-22D6-4613-AAEF-2BCD18F10BDA}" destId="{C8D2E754-D4D6-344C-AF7A-394B116CF6A2}" srcOrd="0" destOrd="0" presId="urn:microsoft.com/office/officeart/2005/8/layout/list1"/>
    <dgm:cxn modelId="{07527997-C971-4A80-A473-775817361F9F}" srcId="{7622279B-1FBF-4F4C-9425-76A20B37ED13}" destId="{7E38B44B-575A-4E27-9923-998FA5828DBA}" srcOrd="0" destOrd="0" parTransId="{30046D9F-E96D-4CD7-BF0F-0472BB1FDDB6}" sibTransId="{9825C742-DFC4-4680-B574-889A5691410A}"/>
    <dgm:cxn modelId="{2B152BA7-CB79-4DDD-AAC8-1F92AEBDD377}" srcId="{6DD97C94-22D6-4613-AAEF-2BCD18F10BDA}" destId="{7622279B-1FBF-4F4C-9425-76A20B37ED13}" srcOrd="1" destOrd="0" parTransId="{E6100551-031C-440A-9375-B61FDCE27A55}" sibTransId="{DF5C7B6E-2C91-4662-9B98-BA57AA556E70}"/>
    <dgm:cxn modelId="{BE2D4BAF-F3C6-7D44-8A06-19D00D7AE45E}" type="presOf" srcId="{E0437985-FC50-4E59-BC85-251E3E463D55}" destId="{A379BC97-E483-B94B-AFD2-64A19120FD3D}" srcOrd="0" destOrd="0" presId="urn:microsoft.com/office/officeart/2005/8/layout/list1"/>
    <dgm:cxn modelId="{D83413C5-8E11-3E4B-A621-55767B930EE0}" type="presOf" srcId="{5C8CC86A-4C77-4A85-BDAF-6C920C64F125}" destId="{23AC1D09-ECF8-5D4D-9BCE-30F3A46581BB}" srcOrd="0" destOrd="0" presId="urn:microsoft.com/office/officeart/2005/8/layout/list1"/>
    <dgm:cxn modelId="{A671387C-3D47-664C-A9F3-B630609247A5}" type="presParOf" srcId="{C8D2E754-D4D6-344C-AF7A-394B116CF6A2}" destId="{21BC2556-3693-CC4D-B60A-D045467B064A}" srcOrd="0" destOrd="0" presId="urn:microsoft.com/office/officeart/2005/8/layout/list1"/>
    <dgm:cxn modelId="{D15960DA-6003-B944-98BB-330C08A4B6F6}" type="presParOf" srcId="{21BC2556-3693-CC4D-B60A-D045467B064A}" destId="{A379BC97-E483-B94B-AFD2-64A19120FD3D}" srcOrd="0" destOrd="0" presId="urn:microsoft.com/office/officeart/2005/8/layout/list1"/>
    <dgm:cxn modelId="{62CEA5B2-68C3-904A-94A6-DC1D044A275C}" type="presParOf" srcId="{21BC2556-3693-CC4D-B60A-D045467B064A}" destId="{4732F60F-0B29-A648-80A0-156E35812600}" srcOrd="1" destOrd="0" presId="urn:microsoft.com/office/officeart/2005/8/layout/list1"/>
    <dgm:cxn modelId="{773955EF-F169-AE49-95DF-840FC59E625C}" type="presParOf" srcId="{C8D2E754-D4D6-344C-AF7A-394B116CF6A2}" destId="{C72451AA-65B8-7945-853D-95E0679CA079}" srcOrd="1" destOrd="0" presId="urn:microsoft.com/office/officeart/2005/8/layout/list1"/>
    <dgm:cxn modelId="{513FC737-62CF-C141-90AB-41E515C08F18}" type="presParOf" srcId="{C8D2E754-D4D6-344C-AF7A-394B116CF6A2}" destId="{23AC1D09-ECF8-5D4D-9BCE-30F3A46581BB}" srcOrd="2" destOrd="0" presId="urn:microsoft.com/office/officeart/2005/8/layout/list1"/>
    <dgm:cxn modelId="{8563A93B-BA5B-4D45-A0D4-21F73BACB2A0}" type="presParOf" srcId="{C8D2E754-D4D6-344C-AF7A-394B116CF6A2}" destId="{AC72DE5C-5876-E844-B937-1BDDAB13A9ED}" srcOrd="3" destOrd="0" presId="urn:microsoft.com/office/officeart/2005/8/layout/list1"/>
    <dgm:cxn modelId="{48733D54-9EE5-3B49-8682-404C72BB2E76}" type="presParOf" srcId="{C8D2E754-D4D6-344C-AF7A-394B116CF6A2}" destId="{6B7195BE-31A9-3C4A-8719-45B3D010C1AF}" srcOrd="4" destOrd="0" presId="urn:microsoft.com/office/officeart/2005/8/layout/list1"/>
    <dgm:cxn modelId="{119F10CF-AC38-E641-82E1-32D42EDB16E6}" type="presParOf" srcId="{6B7195BE-31A9-3C4A-8719-45B3D010C1AF}" destId="{4649594E-824C-3745-B5FA-552497997EDD}" srcOrd="0" destOrd="0" presId="urn:microsoft.com/office/officeart/2005/8/layout/list1"/>
    <dgm:cxn modelId="{FFF79730-9B48-6848-979A-B9013F6007AA}" type="presParOf" srcId="{6B7195BE-31A9-3C4A-8719-45B3D010C1AF}" destId="{5B776D8C-BCB9-B443-9292-E8440C1DE1C6}" srcOrd="1" destOrd="0" presId="urn:microsoft.com/office/officeart/2005/8/layout/list1"/>
    <dgm:cxn modelId="{5A52F85F-1869-054C-8AAC-896BBF19B643}" type="presParOf" srcId="{C8D2E754-D4D6-344C-AF7A-394B116CF6A2}" destId="{D2695C69-725C-8448-AD82-21AC52369D1B}" srcOrd="5" destOrd="0" presId="urn:microsoft.com/office/officeart/2005/8/layout/list1"/>
    <dgm:cxn modelId="{466D6843-4978-DB42-8F5E-DEE958111D47}" type="presParOf" srcId="{C8D2E754-D4D6-344C-AF7A-394B116CF6A2}" destId="{A753E3B0-CFCE-424E-BD31-7D0796400390}" srcOrd="6" destOrd="0" presId="urn:microsoft.com/office/officeart/2005/8/layout/list1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5.xml><?xml version="1.0" encoding="utf-8"?>
<dgm:dataModel xmlns:dgm="http://schemas.openxmlformats.org/drawingml/2006/diagram" xmlns:a="http://schemas.openxmlformats.org/drawingml/2006/main">
  <dgm:ptLst>
    <dgm:pt modelId="{B76EB66E-F684-4A24-9C77-A7517CC42C28}" type="doc">
      <dgm:prSet loTypeId="urn:microsoft.com/office/officeart/2005/8/layout/process4" loCatId="process" qsTypeId="urn:microsoft.com/office/officeart/2005/8/quickstyle/simple1" qsCatId="simple" csTypeId="urn:microsoft.com/office/officeart/2005/8/colors/colorful2" csCatId="colorful" phldr="1"/>
      <dgm:spPr/>
      <dgm:t>
        <a:bodyPr/>
        <a:lstStyle/>
        <a:p>
          <a:endParaRPr lang="en-US"/>
        </a:p>
      </dgm:t>
    </dgm:pt>
    <dgm:pt modelId="{1918BCFA-3BE9-4448-BA23-1767AB70B230}">
      <dgm:prSet/>
      <dgm:spPr>
        <a:solidFill>
          <a:schemeClr val="accent1"/>
        </a:solidFill>
      </dgm:spPr>
      <dgm:t>
        <a:bodyPr/>
        <a:lstStyle/>
        <a:p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Like chemotherapy, it causes damage to health cells near the treatment area.</a:t>
          </a:r>
        </a:p>
      </dgm:t>
    </dgm:pt>
    <dgm:pt modelId="{8530C419-3FC5-4B78-ACF0-08845AC7A8F5}" type="parTrans" cxnId="{9058FCB5-D5A2-45B2-962B-29820C7EC127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253E864-B30B-4D1C-9F1C-221D07BCD987}" type="sibTrans" cxnId="{9058FCB5-D5A2-45B2-962B-29820C7EC127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0FC6B74-9E33-421C-AA2A-2BED4600E65B}">
      <dgm:prSet/>
      <dgm:spPr>
        <a:solidFill>
          <a:schemeClr val="accent2"/>
        </a:solidFill>
      </dgm:spPr>
      <dgm:t>
        <a:bodyPr/>
        <a:lstStyle/>
        <a:p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Has many similar side effects to chemotherapy, but has site-specific side effects:</a:t>
          </a:r>
        </a:p>
      </dgm:t>
    </dgm:pt>
    <dgm:pt modelId="{29F31BD0-94CE-43AF-B1D4-2B58507AD1F3}" type="parTrans" cxnId="{7FE406B3-1565-40C4-8F61-6D7209281D56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0AB5C97-8D14-4213-9B7E-11CF5F21DE3B}" type="sibTrans" cxnId="{7FE406B3-1565-40C4-8F61-6D7209281D56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1B80899-7C7D-418B-A9EF-4C5755732163}">
      <dgm:prSet/>
      <dgm:spPr/>
      <dgm:t>
        <a:bodyPr/>
        <a:lstStyle/>
        <a:p>
          <a:r>
            <a:rPr lang="en-US">
              <a:latin typeface="Arial" panose="020B0604020202020204" pitchFamily="34" charset="0"/>
              <a:cs typeface="Arial" panose="020B0604020202020204" pitchFamily="34" charset="0"/>
            </a:rPr>
            <a:t>Dry mouth and tooth decay in head and neck radiation</a:t>
          </a:r>
        </a:p>
      </dgm:t>
    </dgm:pt>
    <dgm:pt modelId="{CAFF1E13-C25B-4B0D-9EA9-DAEFE62C4DF9}" type="parTrans" cxnId="{68A2C260-852B-4EB2-BAE7-B01BBDBCB414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D0C6CBF-BC29-4155-BCF7-F2796C2CA0F2}" type="sibTrans" cxnId="{68A2C260-852B-4EB2-BAE7-B01BBDBCB414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95D2DA1-5B02-4A3D-BD9D-D2942BBBBC65}">
      <dgm:prSet/>
      <dgm:spPr/>
      <dgm:t>
        <a:bodyPr/>
        <a:lstStyle/>
        <a:p>
          <a:r>
            <a:rPr lang="en-US">
              <a:latin typeface="Arial" panose="020B0604020202020204" pitchFamily="34" charset="0"/>
              <a:cs typeface="Arial" panose="020B0604020202020204" pitchFamily="34" charset="0"/>
            </a:rPr>
            <a:t>Nausea and diarrhea in stomach and abdomen radiation</a:t>
          </a:r>
        </a:p>
      </dgm:t>
    </dgm:pt>
    <dgm:pt modelId="{67E93397-8E2F-4C08-BCEC-AEA28A243BC2}" type="parTrans" cxnId="{6E3F5E6D-2541-41E8-BB68-7B9F1DD30277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FCA1B75-6739-4C49-BCD7-6B9004714711}" type="sibTrans" cxnId="{6E3F5E6D-2541-41E8-BB68-7B9F1DD30277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D6ECA2F-8C3B-F241-B7DF-F9A24226B157}" type="pres">
      <dgm:prSet presAssocID="{B76EB66E-F684-4A24-9C77-A7517CC42C28}" presName="Name0" presStyleCnt="0">
        <dgm:presLayoutVars>
          <dgm:dir/>
          <dgm:animLvl val="lvl"/>
          <dgm:resizeHandles val="exact"/>
        </dgm:presLayoutVars>
      </dgm:prSet>
      <dgm:spPr/>
    </dgm:pt>
    <dgm:pt modelId="{54A15B16-EF88-1445-A519-BE48F1F0076A}" type="pres">
      <dgm:prSet presAssocID="{70FC6B74-9E33-421C-AA2A-2BED4600E65B}" presName="boxAndChildren" presStyleCnt="0"/>
      <dgm:spPr/>
    </dgm:pt>
    <dgm:pt modelId="{D1F33599-0F7A-D349-857A-01199D4275F5}" type="pres">
      <dgm:prSet presAssocID="{70FC6B74-9E33-421C-AA2A-2BED4600E65B}" presName="parentTextBox" presStyleLbl="node1" presStyleIdx="0" presStyleCnt="2"/>
      <dgm:spPr/>
    </dgm:pt>
    <dgm:pt modelId="{067ABE44-01B2-0B4C-969D-139B3E2D1AE8}" type="pres">
      <dgm:prSet presAssocID="{70FC6B74-9E33-421C-AA2A-2BED4600E65B}" presName="entireBox" presStyleLbl="node1" presStyleIdx="0" presStyleCnt="2"/>
      <dgm:spPr/>
    </dgm:pt>
    <dgm:pt modelId="{150CB860-A0C7-3849-9C61-30CC7BE2657F}" type="pres">
      <dgm:prSet presAssocID="{70FC6B74-9E33-421C-AA2A-2BED4600E65B}" presName="descendantBox" presStyleCnt="0"/>
      <dgm:spPr/>
    </dgm:pt>
    <dgm:pt modelId="{68B9A670-3848-1242-820F-A83CF524B207}" type="pres">
      <dgm:prSet presAssocID="{91B80899-7C7D-418B-A9EF-4C5755732163}" presName="childTextBox" presStyleLbl="fgAccFollowNode1" presStyleIdx="0" presStyleCnt="2">
        <dgm:presLayoutVars>
          <dgm:bulletEnabled val="1"/>
        </dgm:presLayoutVars>
      </dgm:prSet>
      <dgm:spPr/>
    </dgm:pt>
    <dgm:pt modelId="{BDE82B9E-5B64-034A-BE43-5547F93EC50A}" type="pres">
      <dgm:prSet presAssocID="{A95D2DA1-5B02-4A3D-BD9D-D2942BBBBC65}" presName="childTextBox" presStyleLbl="fgAccFollowNode1" presStyleIdx="1" presStyleCnt="2">
        <dgm:presLayoutVars>
          <dgm:bulletEnabled val="1"/>
        </dgm:presLayoutVars>
      </dgm:prSet>
      <dgm:spPr/>
    </dgm:pt>
    <dgm:pt modelId="{ED53C76F-C050-A240-BF46-121C06ABA5C5}" type="pres">
      <dgm:prSet presAssocID="{B253E864-B30B-4D1C-9F1C-221D07BCD987}" presName="sp" presStyleCnt="0"/>
      <dgm:spPr/>
    </dgm:pt>
    <dgm:pt modelId="{502A1B36-64B7-A148-9DCA-979895447733}" type="pres">
      <dgm:prSet presAssocID="{1918BCFA-3BE9-4448-BA23-1767AB70B230}" presName="arrowAndChildren" presStyleCnt="0"/>
      <dgm:spPr/>
    </dgm:pt>
    <dgm:pt modelId="{2F32C912-591E-C242-A05E-99E69D590796}" type="pres">
      <dgm:prSet presAssocID="{1918BCFA-3BE9-4448-BA23-1767AB70B230}" presName="parentTextArrow" presStyleLbl="node1" presStyleIdx="1" presStyleCnt="2" custScaleY="27077"/>
      <dgm:spPr/>
    </dgm:pt>
  </dgm:ptLst>
  <dgm:cxnLst>
    <dgm:cxn modelId="{68A2C260-852B-4EB2-BAE7-B01BBDBCB414}" srcId="{70FC6B74-9E33-421C-AA2A-2BED4600E65B}" destId="{91B80899-7C7D-418B-A9EF-4C5755732163}" srcOrd="0" destOrd="0" parTransId="{CAFF1E13-C25B-4B0D-9EA9-DAEFE62C4DF9}" sibTransId="{8D0C6CBF-BC29-4155-BCF7-F2796C2CA0F2}"/>
    <dgm:cxn modelId="{D0700145-1C62-E540-9B94-E7810561947A}" type="presOf" srcId="{91B80899-7C7D-418B-A9EF-4C5755732163}" destId="{68B9A670-3848-1242-820F-A83CF524B207}" srcOrd="0" destOrd="0" presId="urn:microsoft.com/office/officeart/2005/8/layout/process4"/>
    <dgm:cxn modelId="{6E3F5E6D-2541-41E8-BB68-7B9F1DD30277}" srcId="{70FC6B74-9E33-421C-AA2A-2BED4600E65B}" destId="{A95D2DA1-5B02-4A3D-BD9D-D2942BBBBC65}" srcOrd="1" destOrd="0" parTransId="{67E93397-8E2F-4C08-BCEC-AEA28A243BC2}" sibTransId="{6FCA1B75-6739-4C49-BCD7-6B9004714711}"/>
    <dgm:cxn modelId="{E6692196-0117-3F43-B8AB-48E53A30787E}" type="presOf" srcId="{70FC6B74-9E33-421C-AA2A-2BED4600E65B}" destId="{D1F33599-0F7A-D349-857A-01199D4275F5}" srcOrd="0" destOrd="0" presId="urn:microsoft.com/office/officeart/2005/8/layout/process4"/>
    <dgm:cxn modelId="{F4F326A4-34FB-034E-A5DF-B09AEC968B38}" type="presOf" srcId="{A95D2DA1-5B02-4A3D-BD9D-D2942BBBBC65}" destId="{BDE82B9E-5B64-034A-BE43-5547F93EC50A}" srcOrd="0" destOrd="0" presId="urn:microsoft.com/office/officeart/2005/8/layout/process4"/>
    <dgm:cxn modelId="{1DE7E7AC-FBED-5A48-942F-87295ECBFE04}" type="presOf" srcId="{B76EB66E-F684-4A24-9C77-A7517CC42C28}" destId="{DD6ECA2F-8C3B-F241-B7DF-F9A24226B157}" srcOrd="0" destOrd="0" presId="urn:microsoft.com/office/officeart/2005/8/layout/process4"/>
    <dgm:cxn modelId="{7FE406B3-1565-40C4-8F61-6D7209281D56}" srcId="{B76EB66E-F684-4A24-9C77-A7517CC42C28}" destId="{70FC6B74-9E33-421C-AA2A-2BED4600E65B}" srcOrd="1" destOrd="0" parTransId="{29F31BD0-94CE-43AF-B1D4-2B58507AD1F3}" sibTransId="{10AB5C97-8D14-4213-9B7E-11CF5F21DE3B}"/>
    <dgm:cxn modelId="{9058FCB5-D5A2-45B2-962B-29820C7EC127}" srcId="{B76EB66E-F684-4A24-9C77-A7517CC42C28}" destId="{1918BCFA-3BE9-4448-BA23-1767AB70B230}" srcOrd="0" destOrd="0" parTransId="{8530C419-3FC5-4B78-ACF0-08845AC7A8F5}" sibTransId="{B253E864-B30B-4D1C-9F1C-221D07BCD987}"/>
    <dgm:cxn modelId="{CB81FAE2-5283-D84F-A2A4-966E0A108D49}" type="presOf" srcId="{1918BCFA-3BE9-4448-BA23-1767AB70B230}" destId="{2F32C912-591E-C242-A05E-99E69D590796}" srcOrd="0" destOrd="0" presId="urn:microsoft.com/office/officeart/2005/8/layout/process4"/>
    <dgm:cxn modelId="{ED2303E9-A665-514E-89AD-0BF931DA818F}" type="presOf" srcId="{70FC6B74-9E33-421C-AA2A-2BED4600E65B}" destId="{067ABE44-01B2-0B4C-969D-139B3E2D1AE8}" srcOrd="1" destOrd="0" presId="urn:microsoft.com/office/officeart/2005/8/layout/process4"/>
    <dgm:cxn modelId="{4610F0EF-6FFF-8847-A0EA-CCAC4C156561}" type="presParOf" srcId="{DD6ECA2F-8C3B-F241-B7DF-F9A24226B157}" destId="{54A15B16-EF88-1445-A519-BE48F1F0076A}" srcOrd="0" destOrd="0" presId="urn:microsoft.com/office/officeart/2005/8/layout/process4"/>
    <dgm:cxn modelId="{8D904B74-7F8E-704F-963A-8C79E8F205FA}" type="presParOf" srcId="{54A15B16-EF88-1445-A519-BE48F1F0076A}" destId="{D1F33599-0F7A-D349-857A-01199D4275F5}" srcOrd="0" destOrd="0" presId="urn:microsoft.com/office/officeart/2005/8/layout/process4"/>
    <dgm:cxn modelId="{A338C293-A432-D049-8F47-AF14ABE24194}" type="presParOf" srcId="{54A15B16-EF88-1445-A519-BE48F1F0076A}" destId="{067ABE44-01B2-0B4C-969D-139B3E2D1AE8}" srcOrd="1" destOrd="0" presId="urn:microsoft.com/office/officeart/2005/8/layout/process4"/>
    <dgm:cxn modelId="{5B8AF2B1-09D3-CF44-B7E5-A314667BD008}" type="presParOf" srcId="{54A15B16-EF88-1445-A519-BE48F1F0076A}" destId="{150CB860-A0C7-3849-9C61-30CC7BE2657F}" srcOrd="2" destOrd="0" presId="urn:microsoft.com/office/officeart/2005/8/layout/process4"/>
    <dgm:cxn modelId="{C85A2FA6-B704-0B45-85ED-F3FD8E37726E}" type="presParOf" srcId="{150CB860-A0C7-3849-9C61-30CC7BE2657F}" destId="{68B9A670-3848-1242-820F-A83CF524B207}" srcOrd="0" destOrd="0" presId="urn:microsoft.com/office/officeart/2005/8/layout/process4"/>
    <dgm:cxn modelId="{0DB13659-77AF-1C47-BF43-5A81A4B8E300}" type="presParOf" srcId="{150CB860-A0C7-3849-9C61-30CC7BE2657F}" destId="{BDE82B9E-5B64-034A-BE43-5547F93EC50A}" srcOrd="1" destOrd="0" presId="urn:microsoft.com/office/officeart/2005/8/layout/process4"/>
    <dgm:cxn modelId="{F0FF023E-7BCC-B648-9012-2AB919DC9910}" type="presParOf" srcId="{DD6ECA2F-8C3B-F241-B7DF-F9A24226B157}" destId="{ED53C76F-C050-A240-BF46-121C06ABA5C5}" srcOrd="1" destOrd="0" presId="urn:microsoft.com/office/officeart/2005/8/layout/process4"/>
    <dgm:cxn modelId="{A4085066-057E-7F40-AF8E-409D52364CD7}" type="presParOf" srcId="{DD6ECA2F-8C3B-F241-B7DF-F9A24226B157}" destId="{502A1B36-64B7-A148-9DCA-979895447733}" srcOrd="2" destOrd="0" presId="urn:microsoft.com/office/officeart/2005/8/layout/process4"/>
    <dgm:cxn modelId="{23D5212B-CD86-5446-975A-5EF1048171AF}" type="presParOf" srcId="{502A1B36-64B7-A148-9DCA-979895447733}" destId="{2F32C912-591E-C242-A05E-99E69D590796}" srcOrd="0" destOrd="0" presId="urn:microsoft.com/office/officeart/2005/8/layout/process4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6.xml><?xml version="1.0" encoding="utf-8"?>
<dgm:dataModel xmlns:dgm="http://schemas.openxmlformats.org/drawingml/2006/diagram" xmlns:a="http://schemas.openxmlformats.org/drawingml/2006/main">
  <dgm:ptLst>
    <dgm:pt modelId="{8FAC6188-475B-4175-8E51-A42CBA2F151A}" type="doc">
      <dgm:prSet loTypeId="urn:microsoft.com/office/officeart/2005/8/layout/vList5" loCatId="list" qsTypeId="urn:microsoft.com/office/officeart/2005/8/quickstyle/simple1" qsCatId="simple" csTypeId="urn:microsoft.com/office/officeart/2005/8/colors/colorful5" csCatId="colorful" phldr="1"/>
      <dgm:spPr/>
      <dgm:t>
        <a:bodyPr/>
        <a:lstStyle/>
        <a:p>
          <a:endParaRPr lang="en-US"/>
        </a:p>
      </dgm:t>
    </dgm:pt>
    <dgm:pt modelId="{1058AD5B-F84F-49D0-B3AA-5E2F30509F1E}">
      <dgm:prSet custT="1"/>
      <dgm:spPr>
        <a:solidFill>
          <a:schemeClr val="accent1"/>
        </a:solidFill>
      </dgm:spPr>
      <dgm:t>
        <a:bodyPr/>
        <a:lstStyle/>
        <a:p>
          <a:r>
            <a:rPr lang="en-US" sz="3200" b="1" dirty="0">
              <a:latin typeface="Arial" panose="020B0604020202020204" pitchFamily="34" charset="0"/>
              <a:cs typeface="Arial" panose="020B0604020202020204" pitchFamily="34" charset="0"/>
            </a:rPr>
            <a:t>Open Surgery</a:t>
          </a:r>
        </a:p>
      </dgm:t>
    </dgm:pt>
    <dgm:pt modelId="{61C176A8-C96F-48F3-9406-A196DD354BA5}" type="parTrans" cxnId="{A953B07E-0D8C-46F8-AD26-E4682F22132D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A948439-DC77-404D-B7B6-B202BC20E53F}" type="sibTrans" cxnId="{A953B07E-0D8C-46F8-AD26-E4682F22132D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CFBEA8C-C1F0-4D35-8636-8799352D0213}">
      <dgm:prSet/>
      <dgm:spPr>
        <a:solidFill>
          <a:schemeClr val="tx2">
            <a:lumMod val="40000"/>
            <a:lumOff val="60000"/>
            <a:alpha val="90000"/>
          </a:schemeClr>
        </a:solidFill>
        <a:ln>
          <a:solidFill>
            <a:schemeClr val="tx2">
              <a:lumMod val="60000"/>
              <a:lumOff val="40000"/>
              <a:alpha val="90000"/>
            </a:schemeClr>
          </a:solidFill>
        </a:ln>
      </dgm:spPr>
      <dgm:t>
        <a:bodyPr/>
        <a:lstStyle/>
        <a:p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Surgeon makes one large cut to remove the tumor and surrounding area.</a:t>
          </a:r>
        </a:p>
      </dgm:t>
    </dgm:pt>
    <dgm:pt modelId="{E6D06D62-ADB2-452E-9D44-C00340FF992E}" type="parTrans" cxnId="{C3BDB42E-24E1-40F5-BED6-EA6FA12573D9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E8730F5-BEB5-4918-A170-256C3FE166D2}" type="sibTrans" cxnId="{C3BDB42E-24E1-40F5-BED6-EA6FA12573D9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606F3A0-3D01-4B9F-B864-8964FC42E41B}">
      <dgm:prSet custT="1"/>
      <dgm:spPr/>
      <dgm:t>
        <a:bodyPr/>
        <a:lstStyle/>
        <a:p>
          <a:pPr marL="0" lvl="0" indent="0" algn="ctr" defTabSz="1422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200" b="1" kern="1200" dirty="0">
              <a:solidFill>
                <a:srgbClr val="FFFFFF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rPr>
            <a:t>Minimally Invasive Surgery</a:t>
          </a:r>
        </a:p>
      </dgm:t>
    </dgm:pt>
    <dgm:pt modelId="{6BFD9836-EB89-4DA0-AFA9-707932618BA1}" type="parTrans" cxnId="{7CC465BA-B18F-4050-8064-52CD9A2DD357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A9671B0-F5F9-4301-AECD-FE64B0DF0936}" type="sibTrans" cxnId="{7CC465BA-B18F-4050-8064-52CD9A2DD357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96CA5C4-82E2-49C5-ACBD-24DAF10E6A4A}">
      <dgm:prSet/>
      <dgm:spPr/>
      <dgm:t>
        <a:bodyPr/>
        <a:lstStyle/>
        <a:p>
          <a:r>
            <a:rPr lang="en-US">
              <a:latin typeface="Arial" panose="020B0604020202020204" pitchFamily="34" charset="0"/>
              <a:cs typeface="Arial" panose="020B0604020202020204" pitchFamily="34" charset="0"/>
            </a:rPr>
            <a:t>Surgeon makes a few small cuts to insert a small camera (laparoscope). The surgeon uses the camera projections to remove the tumor and surrounding area. </a:t>
          </a:r>
        </a:p>
      </dgm:t>
    </dgm:pt>
    <dgm:pt modelId="{46299F17-3E66-40C6-887E-47ABCBDC8A36}" type="parTrans" cxnId="{E39E8651-3F6A-4AD0-9A44-C6FF57A932A7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600A520-B3AA-420E-9893-DE6F474F3D5C}" type="sibTrans" cxnId="{E39E8651-3F6A-4AD0-9A44-C6FF57A932A7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FE23644C-B0C8-E340-97CF-F774EAFE7588}" type="pres">
      <dgm:prSet presAssocID="{8FAC6188-475B-4175-8E51-A42CBA2F151A}" presName="Name0" presStyleCnt="0">
        <dgm:presLayoutVars>
          <dgm:dir/>
          <dgm:animLvl val="lvl"/>
          <dgm:resizeHandles val="exact"/>
        </dgm:presLayoutVars>
      </dgm:prSet>
      <dgm:spPr/>
    </dgm:pt>
    <dgm:pt modelId="{CA25D7C6-24EF-5748-96D4-97657FF3E4CA}" type="pres">
      <dgm:prSet presAssocID="{1058AD5B-F84F-49D0-B3AA-5E2F30509F1E}" presName="linNode" presStyleCnt="0"/>
      <dgm:spPr/>
    </dgm:pt>
    <dgm:pt modelId="{0ED64627-97A2-F044-A7AA-EA03E621E646}" type="pres">
      <dgm:prSet presAssocID="{1058AD5B-F84F-49D0-B3AA-5E2F30509F1E}" presName="parentText" presStyleLbl="node1" presStyleIdx="0" presStyleCnt="2">
        <dgm:presLayoutVars>
          <dgm:chMax val="1"/>
          <dgm:bulletEnabled val="1"/>
        </dgm:presLayoutVars>
      </dgm:prSet>
      <dgm:spPr/>
    </dgm:pt>
    <dgm:pt modelId="{8142CB6C-9444-8843-AF70-BC8EA83ABE94}" type="pres">
      <dgm:prSet presAssocID="{1058AD5B-F84F-49D0-B3AA-5E2F30509F1E}" presName="descendantText" presStyleLbl="alignAccFollowNode1" presStyleIdx="0" presStyleCnt="2">
        <dgm:presLayoutVars>
          <dgm:bulletEnabled val="1"/>
        </dgm:presLayoutVars>
      </dgm:prSet>
      <dgm:spPr/>
    </dgm:pt>
    <dgm:pt modelId="{A2F3889E-7C70-3944-8AF7-CB1A5723B3F7}" type="pres">
      <dgm:prSet presAssocID="{DA948439-DC77-404D-B7B6-B202BC20E53F}" presName="sp" presStyleCnt="0"/>
      <dgm:spPr/>
    </dgm:pt>
    <dgm:pt modelId="{A274461E-335A-E04D-B813-9C50CDC2E4CD}" type="pres">
      <dgm:prSet presAssocID="{8606F3A0-3D01-4B9F-B864-8964FC42E41B}" presName="linNode" presStyleCnt="0"/>
      <dgm:spPr/>
    </dgm:pt>
    <dgm:pt modelId="{AA8947CB-D5B4-8342-93A6-F3789681D9CA}" type="pres">
      <dgm:prSet presAssocID="{8606F3A0-3D01-4B9F-B864-8964FC42E41B}" presName="parentText" presStyleLbl="node1" presStyleIdx="1" presStyleCnt="2">
        <dgm:presLayoutVars>
          <dgm:chMax val="1"/>
          <dgm:bulletEnabled val="1"/>
        </dgm:presLayoutVars>
      </dgm:prSet>
      <dgm:spPr/>
    </dgm:pt>
    <dgm:pt modelId="{98AC9556-B53C-FD4C-91E1-07B1B6D49274}" type="pres">
      <dgm:prSet presAssocID="{8606F3A0-3D01-4B9F-B864-8964FC42E41B}" presName="descendantText" presStyleLbl="alignAccFollowNode1" presStyleIdx="1" presStyleCnt="2">
        <dgm:presLayoutVars>
          <dgm:bulletEnabled val="1"/>
        </dgm:presLayoutVars>
      </dgm:prSet>
      <dgm:spPr/>
    </dgm:pt>
  </dgm:ptLst>
  <dgm:cxnLst>
    <dgm:cxn modelId="{C3BDB42E-24E1-40F5-BED6-EA6FA12573D9}" srcId="{1058AD5B-F84F-49D0-B3AA-5E2F30509F1E}" destId="{1CFBEA8C-C1F0-4D35-8636-8799352D0213}" srcOrd="0" destOrd="0" parTransId="{E6D06D62-ADB2-452E-9D44-C00340FF992E}" sibTransId="{2E8730F5-BEB5-4918-A170-256C3FE166D2}"/>
    <dgm:cxn modelId="{95833533-D56A-BF4D-AFEC-2510511DA177}" type="presOf" srcId="{596CA5C4-82E2-49C5-ACBD-24DAF10E6A4A}" destId="{98AC9556-B53C-FD4C-91E1-07B1B6D49274}" srcOrd="0" destOrd="0" presId="urn:microsoft.com/office/officeart/2005/8/layout/vList5"/>
    <dgm:cxn modelId="{69BDE66A-A90D-4E4C-9BCA-76149824FCEB}" type="presOf" srcId="{8606F3A0-3D01-4B9F-B864-8964FC42E41B}" destId="{AA8947CB-D5B4-8342-93A6-F3789681D9CA}" srcOrd="0" destOrd="0" presId="urn:microsoft.com/office/officeart/2005/8/layout/vList5"/>
    <dgm:cxn modelId="{E39E8651-3F6A-4AD0-9A44-C6FF57A932A7}" srcId="{8606F3A0-3D01-4B9F-B864-8964FC42E41B}" destId="{596CA5C4-82E2-49C5-ACBD-24DAF10E6A4A}" srcOrd="0" destOrd="0" parTransId="{46299F17-3E66-40C6-887E-47ABCBDC8A36}" sibTransId="{8600A520-B3AA-420E-9893-DE6F474F3D5C}"/>
    <dgm:cxn modelId="{A0F18A51-D43F-7A42-AC16-7E1673F47603}" type="presOf" srcId="{1058AD5B-F84F-49D0-B3AA-5E2F30509F1E}" destId="{0ED64627-97A2-F044-A7AA-EA03E621E646}" srcOrd="0" destOrd="0" presId="urn:microsoft.com/office/officeart/2005/8/layout/vList5"/>
    <dgm:cxn modelId="{A953B07E-0D8C-46F8-AD26-E4682F22132D}" srcId="{8FAC6188-475B-4175-8E51-A42CBA2F151A}" destId="{1058AD5B-F84F-49D0-B3AA-5E2F30509F1E}" srcOrd="0" destOrd="0" parTransId="{61C176A8-C96F-48F3-9406-A196DD354BA5}" sibTransId="{DA948439-DC77-404D-B7B6-B202BC20E53F}"/>
    <dgm:cxn modelId="{7CC465BA-B18F-4050-8064-52CD9A2DD357}" srcId="{8FAC6188-475B-4175-8E51-A42CBA2F151A}" destId="{8606F3A0-3D01-4B9F-B864-8964FC42E41B}" srcOrd="1" destOrd="0" parTransId="{6BFD9836-EB89-4DA0-AFA9-707932618BA1}" sibTransId="{3A9671B0-F5F9-4301-AECD-FE64B0DF0936}"/>
    <dgm:cxn modelId="{728E14BF-94CE-2942-9C46-6172C84BC8BE}" type="presOf" srcId="{8FAC6188-475B-4175-8E51-A42CBA2F151A}" destId="{FE23644C-B0C8-E340-97CF-F774EAFE7588}" srcOrd="0" destOrd="0" presId="urn:microsoft.com/office/officeart/2005/8/layout/vList5"/>
    <dgm:cxn modelId="{BD0881F3-FDEF-DF43-B773-9F28DC44D8A6}" type="presOf" srcId="{1CFBEA8C-C1F0-4D35-8636-8799352D0213}" destId="{8142CB6C-9444-8843-AF70-BC8EA83ABE94}" srcOrd="0" destOrd="0" presId="urn:microsoft.com/office/officeart/2005/8/layout/vList5"/>
    <dgm:cxn modelId="{48D496E0-73D8-2F45-832E-D5CB5A19AB8C}" type="presParOf" srcId="{FE23644C-B0C8-E340-97CF-F774EAFE7588}" destId="{CA25D7C6-24EF-5748-96D4-97657FF3E4CA}" srcOrd="0" destOrd="0" presId="urn:microsoft.com/office/officeart/2005/8/layout/vList5"/>
    <dgm:cxn modelId="{510C1267-DD4C-0B4C-9AAD-0911D341193A}" type="presParOf" srcId="{CA25D7C6-24EF-5748-96D4-97657FF3E4CA}" destId="{0ED64627-97A2-F044-A7AA-EA03E621E646}" srcOrd="0" destOrd="0" presId="urn:microsoft.com/office/officeart/2005/8/layout/vList5"/>
    <dgm:cxn modelId="{456C5D57-A5BE-8640-873A-7F06334311F0}" type="presParOf" srcId="{CA25D7C6-24EF-5748-96D4-97657FF3E4CA}" destId="{8142CB6C-9444-8843-AF70-BC8EA83ABE94}" srcOrd="1" destOrd="0" presId="urn:microsoft.com/office/officeart/2005/8/layout/vList5"/>
    <dgm:cxn modelId="{9941EAB6-906E-C348-A90B-96BA26E24CC5}" type="presParOf" srcId="{FE23644C-B0C8-E340-97CF-F774EAFE7588}" destId="{A2F3889E-7C70-3944-8AF7-CB1A5723B3F7}" srcOrd="1" destOrd="0" presId="urn:microsoft.com/office/officeart/2005/8/layout/vList5"/>
    <dgm:cxn modelId="{47FA2028-6844-F949-9E6C-57283D3048F1}" type="presParOf" srcId="{FE23644C-B0C8-E340-97CF-F774EAFE7588}" destId="{A274461E-335A-E04D-B813-9C50CDC2E4CD}" srcOrd="2" destOrd="0" presId="urn:microsoft.com/office/officeart/2005/8/layout/vList5"/>
    <dgm:cxn modelId="{DE8A219B-1314-A942-A10B-17C61CD5F625}" type="presParOf" srcId="{A274461E-335A-E04D-B813-9C50CDC2E4CD}" destId="{AA8947CB-D5B4-8342-93A6-F3789681D9CA}" srcOrd="0" destOrd="0" presId="urn:microsoft.com/office/officeart/2005/8/layout/vList5"/>
    <dgm:cxn modelId="{4ED56120-314A-7A4B-BBAB-781DB678FF26}" type="presParOf" srcId="{A274461E-335A-E04D-B813-9C50CDC2E4CD}" destId="{98AC9556-B53C-FD4C-91E1-07B1B6D49274}" srcOrd="1" destOrd="0" presId="urn:microsoft.com/office/officeart/2005/8/layout/vList5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7.xml><?xml version="1.0" encoding="utf-8"?>
<dgm:dataModel xmlns:dgm="http://schemas.openxmlformats.org/drawingml/2006/diagram" xmlns:a="http://schemas.openxmlformats.org/drawingml/2006/main">
  <dgm:ptLst>
    <dgm:pt modelId="{71DE1CFA-6C80-4303-B72B-8CC6B23F4679}" type="doc">
      <dgm:prSet loTypeId="urn:microsoft.com/office/officeart/2005/8/layout/list1" loCatId="list" qsTypeId="urn:microsoft.com/office/officeart/2005/8/quickstyle/simple1" qsCatId="simple" csTypeId="urn:microsoft.com/office/officeart/2005/8/colors/accent0_3" csCatId="mainScheme" phldr="1"/>
      <dgm:spPr/>
      <dgm:t>
        <a:bodyPr/>
        <a:lstStyle/>
        <a:p>
          <a:endParaRPr lang="en-US"/>
        </a:p>
      </dgm:t>
    </dgm:pt>
    <dgm:pt modelId="{F197ED87-B75C-4093-84D2-0A9FE2DE1942}">
      <dgm:prSet custT="1"/>
      <dgm:spPr>
        <a:solidFill>
          <a:schemeClr val="accent1"/>
        </a:solidFill>
      </dgm:spPr>
      <dgm:t>
        <a:bodyPr/>
        <a:lstStyle/>
        <a:p>
          <a:r>
            <a:rPr lang="en-US" sz="2000" b="1">
              <a:latin typeface="Arial" panose="020B0604020202020204" pitchFamily="34" charset="0"/>
              <a:cs typeface="Arial" panose="020B0604020202020204" pitchFamily="34" charset="0"/>
            </a:rPr>
            <a:t>Autologous stem cell transplants</a:t>
          </a:r>
        </a:p>
      </dgm:t>
    </dgm:pt>
    <dgm:pt modelId="{A6AD3857-0B3F-49B3-BC29-BABD5DCA4F67}" type="parTrans" cxnId="{21A0B9B3-103F-4D8B-9091-41C5BA2207AA}">
      <dgm:prSet/>
      <dgm:spPr/>
      <dgm:t>
        <a:bodyPr/>
        <a:lstStyle/>
        <a:p>
          <a:endParaRPr lang="en-US" sz="16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7C41E59-7084-4E6A-BE2C-ACABF064A596}" type="sibTrans" cxnId="{21A0B9B3-103F-4D8B-9091-41C5BA2207AA}">
      <dgm:prSet/>
      <dgm:spPr/>
      <dgm:t>
        <a:bodyPr/>
        <a:lstStyle/>
        <a:p>
          <a:endParaRPr lang="en-US" sz="16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6293B09-C373-4C43-97D3-5510617AD2B7}">
      <dgm:prSet custT="1"/>
      <dgm:spPr>
        <a:noFill/>
        <a:ln>
          <a:solidFill>
            <a:schemeClr val="accent1"/>
          </a:solidFill>
        </a:ln>
      </dgm:spPr>
      <dgm:t>
        <a:bodyPr/>
        <a:lstStyle/>
        <a:p>
          <a:r>
            <a:rPr lang="en-US" sz="2000" dirty="0">
              <a:latin typeface="Arial" panose="020B0604020202020204" pitchFamily="34" charset="0"/>
              <a:cs typeface="Arial" panose="020B0604020202020204" pitchFamily="34" charset="0"/>
            </a:rPr>
            <a:t>Stem cell donor is the patient themselves (taken from other areas of the body).</a:t>
          </a:r>
        </a:p>
      </dgm:t>
    </dgm:pt>
    <dgm:pt modelId="{438DC1D1-9063-4CD1-A72E-284378E2DBBA}" type="parTrans" cxnId="{54BEEF6E-4B0E-4444-9543-786CBCB273DE}">
      <dgm:prSet/>
      <dgm:spPr/>
      <dgm:t>
        <a:bodyPr/>
        <a:lstStyle/>
        <a:p>
          <a:endParaRPr lang="en-US" sz="16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F3FFB380-E216-43CD-A120-9FF55DBE0DC2}" type="sibTrans" cxnId="{54BEEF6E-4B0E-4444-9543-786CBCB273DE}">
      <dgm:prSet/>
      <dgm:spPr/>
      <dgm:t>
        <a:bodyPr/>
        <a:lstStyle/>
        <a:p>
          <a:endParaRPr lang="en-US" sz="16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9433FF2-9A2F-487A-B349-9AF8EE86B7B8}">
      <dgm:prSet custT="1"/>
      <dgm:spPr>
        <a:solidFill>
          <a:schemeClr val="accent5"/>
        </a:solidFill>
      </dgm:spPr>
      <dgm:t>
        <a:bodyPr/>
        <a:lstStyle/>
        <a:p>
          <a:r>
            <a:rPr lang="en-US" sz="2000" b="1">
              <a:latin typeface="Arial" panose="020B0604020202020204" pitchFamily="34" charset="0"/>
              <a:cs typeface="Arial" panose="020B0604020202020204" pitchFamily="34" charset="0"/>
            </a:rPr>
            <a:t>Allogeneic stem cell transplants</a:t>
          </a:r>
        </a:p>
      </dgm:t>
    </dgm:pt>
    <dgm:pt modelId="{D2E56573-4022-450C-9B50-9F9561DC8076}" type="parTrans" cxnId="{73498FE9-9983-42D1-B66E-6505E87DE4E2}">
      <dgm:prSet/>
      <dgm:spPr/>
      <dgm:t>
        <a:bodyPr/>
        <a:lstStyle/>
        <a:p>
          <a:endParaRPr lang="en-US" sz="16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26A8144-7E63-4A2D-A758-E8ACB22E3274}" type="sibTrans" cxnId="{73498FE9-9983-42D1-B66E-6505E87DE4E2}">
      <dgm:prSet/>
      <dgm:spPr/>
      <dgm:t>
        <a:bodyPr/>
        <a:lstStyle/>
        <a:p>
          <a:endParaRPr lang="en-US" sz="16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603C113-59B6-40FC-85B6-B6D9037BA8B7}">
      <dgm:prSet custT="1"/>
      <dgm:spPr>
        <a:noFill/>
        <a:ln>
          <a:solidFill>
            <a:schemeClr val="accent5"/>
          </a:solidFill>
        </a:ln>
      </dgm:spPr>
      <dgm:t>
        <a:bodyPr/>
        <a:lstStyle/>
        <a:p>
          <a:r>
            <a:rPr lang="en-US" sz="2000" dirty="0">
              <a:latin typeface="Arial" panose="020B0604020202020204" pitchFamily="34" charset="0"/>
              <a:cs typeface="Arial" panose="020B0604020202020204" pitchFamily="34" charset="0"/>
            </a:rPr>
            <a:t>Stem cell donor is someone else (normally a relative).</a:t>
          </a:r>
        </a:p>
      </dgm:t>
    </dgm:pt>
    <dgm:pt modelId="{896B1A20-9C73-4EF1-B645-228BD91A4C2C}" type="parTrans" cxnId="{0715F454-42AF-414C-936F-068623B4E424}">
      <dgm:prSet/>
      <dgm:spPr/>
      <dgm:t>
        <a:bodyPr/>
        <a:lstStyle/>
        <a:p>
          <a:endParaRPr lang="en-US" sz="16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D630A44-29AC-453C-9CAD-8AAD6E54E78C}" type="sibTrans" cxnId="{0715F454-42AF-414C-936F-068623B4E424}">
      <dgm:prSet/>
      <dgm:spPr/>
      <dgm:t>
        <a:bodyPr/>
        <a:lstStyle/>
        <a:p>
          <a:endParaRPr lang="en-US" sz="16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954EFE6-3719-4A0F-A6C9-2F0095F55616}">
      <dgm:prSet custT="1"/>
      <dgm:spPr>
        <a:solidFill>
          <a:schemeClr val="accent6"/>
        </a:solidFill>
      </dgm:spPr>
      <dgm:t>
        <a:bodyPr/>
        <a:lstStyle/>
        <a:p>
          <a:r>
            <a:rPr lang="en-US" sz="2000" b="1" dirty="0">
              <a:latin typeface="Arial" panose="020B0604020202020204" pitchFamily="34" charset="0"/>
              <a:cs typeface="Arial" panose="020B0604020202020204" pitchFamily="34" charset="0"/>
            </a:rPr>
            <a:t>Syngeneic stem cell transplants</a:t>
          </a:r>
        </a:p>
      </dgm:t>
    </dgm:pt>
    <dgm:pt modelId="{187C2B99-193B-4307-8463-0364F8DB1478}" type="parTrans" cxnId="{ED745F91-4CFD-4193-B9FE-B02CF1686D0B}">
      <dgm:prSet/>
      <dgm:spPr/>
      <dgm:t>
        <a:bodyPr/>
        <a:lstStyle/>
        <a:p>
          <a:endParaRPr lang="en-US" sz="16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651DA8F-E236-406F-B7AE-18BBFB11F0C8}" type="sibTrans" cxnId="{ED745F91-4CFD-4193-B9FE-B02CF1686D0B}">
      <dgm:prSet/>
      <dgm:spPr/>
      <dgm:t>
        <a:bodyPr/>
        <a:lstStyle/>
        <a:p>
          <a:endParaRPr lang="en-US" sz="16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30F7AC2-0962-4C22-AA59-E225F5D9AEA4}">
      <dgm:prSet custT="1"/>
      <dgm:spPr>
        <a:noFill/>
        <a:ln>
          <a:solidFill>
            <a:schemeClr val="accent6"/>
          </a:solidFill>
        </a:ln>
      </dgm:spPr>
      <dgm:t>
        <a:bodyPr/>
        <a:lstStyle/>
        <a:p>
          <a:r>
            <a:rPr lang="en-US" sz="2000" dirty="0">
              <a:latin typeface="Arial" panose="020B0604020202020204" pitchFamily="34" charset="0"/>
              <a:cs typeface="Arial" panose="020B0604020202020204" pitchFamily="34" charset="0"/>
            </a:rPr>
            <a:t>Stem cell donor is an identical twin.</a:t>
          </a:r>
        </a:p>
      </dgm:t>
    </dgm:pt>
    <dgm:pt modelId="{FD1C143F-B663-4274-A3FD-CD4614F47278}" type="parTrans" cxnId="{F3E5DD4E-C61F-4AAA-9259-242011B674CA}">
      <dgm:prSet/>
      <dgm:spPr/>
      <dgm:t>
        <a:bodyPr/>
        <a:lstStyle/>
        <a:p>
          <a:endParaRPr lang="en-US" sz="16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A728124-1243-402F-8440-73736E0E4AA2}" type="sibTrans" cxnId="{F3E5DD4E-C61F-4AAA-9259-242011B674CA}">
      <dgm:prSet/>
      <dgm:spPr/>
      <dgm:t>
        <a:bodyPr/>
        <a:lstStyle/>
        <a:p>
          <a:endParaRPr lang="en-US" sz="16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F2B7505-7252-0E48-A74D-9935A7628026}" type="pres">
      <dgm:prSet presAssocID="{71DE1CFA-6C80-4303-B72B-8CC6B23F4679}" presName="linear" presStyleCnt="0">
        <dgm:presLayoutVars>
          <dgm:dir/>
          <dgm:animLvl val="lvl"/>
          <dgm:resizeHandles val="exact"/>
        </dgm:presLayoutVars>
      </dgm:prSet>
      <dgm:spPr/>
    </dgm:pt>
    <dgm:pt modelId="{3BC46041-FE11-6048-BB75-2B54F13A9AD8}" type="pres">
      <dgm:prSet presAssocID="{F197ED87-B75C-4093-84D2-0A9FE2DE1942}" presName="parentLin" presStyleCnt="0"/>
      <dgm:spPr/>
    </dgm:pt>
    <dgm:pt modelId="{576E1AB8-CA64-C147-B0C5-F4F10C01C395}" type="pres">
      <dgm:prSet presAssocID="{F197ED87-B75C-4093-84D2-0A9FE2DE1942}" presName="parentLeftMargin" presStyleLbl="node1" presStyleIdx="0" presStyleCnt="3"/>
      <dgm:spPr/>
    </dgm:pt>
    <dgm:pt modelId="{AC7EECF9-DD94-EF4F-8512-2A61C7A689C8}" type="pres">
      <dgm:prSet presAssocID="{F197ED87-B75C-4093-84D2-0A9FE2DE1942}" presName="parentText" presStyleLbl="node1" presStyleIdx="0" presStyleCnt="3" custScaleX="112493">
        <dgm:presLayoutVars>
          <dgm:chMax val="0"/>
          <dgm:bulletEnabled val="1"/>
        </dgm:presLayoutVars>
      </dgm:prSet>
      <dgm:spPr/>
    </dgm:pt>
    <dgm:pt modelId="{7B41E5F5-676F-F54F-ACC9-1E92FD2C1B96}" type="pres">
      <dgm:prSet presAssocID="{F197ED87-B75C-4093-84D2-0A9FE2DE1942}" presName="negativeSpace" presStyleCnt="0"/>
      <dgm:spPr/>
    </dgm:pt>
    <dgm:pt modelId="{2D2F842E-BC1B-4049-8D33-AB32348BD6A8}" type="pres">
      <dgm:prSet presAssocID="{F197ED87-B75C-4093-84D2-0A9FE2DE1942}" presName="childText" presStyleLbl="conFgAcc1" presStyleIdx="0" presStyleCnt="3">
        <dgm:presLayoutVars>
          <dgm:bulletEnabled val="1"/>
        </dgm:presLayoutVars>
      </dgm:prSet>
      <dgm:spPr/>
    </dgm:pt>
    <dgm:pt modelId="{D35823C7-084E-A049-B068-C7A357ADE496}" type="pres">
      <dgm:prSet presAssocID="{27C41E59-7084-4E6A-BE2C-ACABF064A596}" presName="spaceBetweenRectangles" presStyleCnt="0"/>
      <dgm:spPr/>
    </dgm:pt>
    <dgm:pt modelId="{E565A8BF-21E2-5B4C-AF8D-E2C6FE100514}" type="pres">
      <dgm:prSet presAssocID="{19433FF2-9A2F-487A-B349-9AF8EE86B7B8}" presName="parentLin" presStyleCnt="0"/>
      <dgm:spPr/>
    </dgm:pt>
    <dgm:pt modelId="{FF4C93D1-EFBC-6D43-AFC5-4503F93C60F9}" type="pres">
      <dgm:prSet presAssocID="{19433FF2-9A2F-487A-B349-9AF8EE86B7B8}" presName="parentLeftMargin" presStyleLbl="node1" presStyleIdx="0" presStyleCnt="3"/>
      <dgm:spPr/>
    </dgm:pt>
    <dgm:pt modelId="{1855111B-9FCD-494A-BA67-DC2F59F9226C}" type="pres">
      <dgm:prSet presAssocID="{19433FF2-9A2F-487A-B349-9AF8EE86B7B8}" presName="parentText" presStyleLbl="node1" presStyleIdx="1" presStyleCnt="3" custScaleX="112081">
        <dgm:presLayoutVars>
          <dgm:chMax val="0"/>
          <dgm:bulletEnabled val="1"/>
        </dgm:presLayoutVars>
      </dgm:prSet>
      <dgm:spPr/>
    </dgm:pt>
    <dgm:pt modelId="{6049029B-4B2B-8E42-8D04-2080AAC177F3}" type="pres">
      <dgm:prSet presAssocID="{19433FF2-9A2F-487A-B349-9AF8EE86B7B8}" presName="negativeSpace" presStyleCnt="0"/>
      <dgm:spPr/>
    </dgm:pt>
    <dgm:pt modelId="{55F9A40C-6A61-8E49-90C0-B6152AE87DAB}" type="pres">
      <dgm:prSet presAssocID="{19433FF2-9A2F-487A-B349-9AF8EE86B7B8}" presName="childText" presStyleLbl="conFgAcc1" presStyleIdx="1" presStyleCnt="3">
        <dgm:presLayoutVars>
          <dgm:bulletEnabled val="1"/>
        </dgm:presLayoutVars>
      </dgm:prSet>
      <dgm:spPr/>
    </dgm:pt>
    <dgm:pt modelId="{44A98AD4-2A08-3249-A9AF-453A96449561}" type="pres">
      <dgm:prSet presAssocID="{E26A8144-7E63-4A2D-A758-E8ACB22E3274}" presName="spaceBetweenRectangles" presStyleCnt="0"/>
      <dgm:spPr/>
    </dgm:pt>
    <dgm:pt modelId="{C1DAEC0A-AC17-0D46-9EFD-FF6F9DCE36CD}" type="pres">
      <dgm:prSet presAssocID="{2954EFE6-3719-4A0F-A6C9-2F0095F55616}" presName="parentLin" presStyleCnt="0"/>
      <dgm:spPr/>
    </dgm:pt>
    <dgm:pt modelId="{5CFC8520-4EDD-DF47-8B69-3C60ED5E4940}" type="pres">
      <dgm:prSet presAssocID="{2954EFE6-3719-4A0F-A6C9-2F0095F55616}" presName="parentLeftMargin" presStyleLbl="node1" presStyleIdx="1" presStyleCnt="3"/>
      <dgm:spPr/>
    </dgm:pt>
    <dgm:pt modelId="{74FD4929-3438-5241-BCE3-1AB7408BC663}" type="pres">
      <dgm:prSet presAssocID="{2954EFE6-3719-4A0F-A6C9-2F0095F55616}" presName="parentText" presStyleLbl="node1" presStyleIdx="2" presStyleCnt="3" custScaleX="115378">
        <dgm:presLayoutVars>
          <dgm:chMax val="0"/>
          <dgm:bulletEnabled val="1"/>
        </dgm:presLayoutVars>
      </dgm:prSet>
      <dgm:spPr/>
    </dgm:pt>
    <dgm:pt modelId="{DD957D27-23FA-5D45-A0C0-D977736AE378}" type="pres">
      <dgm:prSet presAssocID="{2954EFE6-3719-4A0F-A6C9-2F0095F55616}" presName="negativeSpace" presStyleCnt="0"/>
      <dgm:spPr/>
    </dgm:pt>
    <dgm:pt modelId="{E3726B08-3C9B-2B4B-A103-69C8F8E0DD7A}" type="pres">
      <dgm:prSet presAssocID="{2954EFE6-3719-4A0F-A6C9-2F0095F55616}" presName="childText" presStyleLbl="conFgAcc1" presStyleIdx="2" presStyleCnt="3">
        <dgm:presLayoutVars>
          <dgm:bulletEnabled val="1"/>
        </dgm:presLayoutVars>
      </dgm:prSet>
      <dgm:spPr/>
    </dgm:pt>
  </dgm:ptLst>
  <dgm:cxnLst>
    <dgm:cxn modelId="{EF28B361-F62C-A146-9B92-81B28CF860DC}" type="presOf" srcId="{4603C113-59B6-40FC-85B6-B6D9037BA8B7}" destId="{55F9A40C-6A61-8E49-90C0-B6152AE87DAB}" srcOrd="0" destOrd="0" presId="urn:microsoft.com/office/officeart/2005/8/layout/list1"/>
    <dgm:cxn modelId="{3C51A062-69CD-CA41-B923-9D4C3B4E51B0}" type="presOf" srcId="{2954EFE6-3719-4A0F-A6C9-2F0095F55616}" destId="{5CFC8520-4EDD-DF47-8B69-3C60ED5E4940}" srcOrd="0" destOrd="0" presId="urn:microsoft.com/office/officeart/2005/8/layout/list1"/>
    <dgm:cxn modelId="{268D706E-7A50-6841-823E-7C2C913961E0}" type="presOf" srcId="{19433FF2-9A2F-487A-B349-9AF8EE86B7B8}" destId="{FF4C93D1-EFBC-6D43-AFC5-4503F93C60F9}" srcOrd="0" destOrd="0" presId="urn:microsoft.com/office/officeart/2005/8/layout/list1"/>
    <dgm:cxn modelId="{F3E5DD4E-C61F-4AAA-9259-242011B674CA}" srcId="{2954EFE6-3719-4A0F-A6C9-2F0095F55616}" destId="{A30F7AC2-0962-4C22-AA59-E225F5D9AEA4}" srcOrd="0" destOrd="0" parTransId="{FD1C143F-B663-4274-A3FD-CD4614F47278}" sibTransId="{BA728124-1243-402F-8440-73736E0E4AA2}"/>
    <dgm:cxn modelId="{54BEEF6E-4B0E-4444-9543-786CBCB273DE}" srcId="{F197ED87-B75C-4093-84D2-0A9FE2DE1942}" destId="{16293B09-C373-4C43-97D3-5510617AD2B7}" srcOrd="0" destOrd="0" parTransId="{438DC1D1-9063-4CD1-A72E-284378E2DBBA}" sibTransId="{F3FFB380-E216-43CD-A120-9FF55DBE0DC2}"/>
    <dgm:cxn modelId="{0715F454-42AF-414C-936F-068623B4E424}" srcId="{19433FF2-9A2F-487A-B349-9AF8EE86B7B8}" destId="{4603C113-59B6-40FC-85B6-B6D9037BA8B7}" srcOrd="0" destOrd="0" parTransId="{896B1A20-9C73-4EF1-B645-228BD91A4C2C}" sibTransId="{8D630A44-29AC-453C-9CAD-8AAD6E54E78C}"/>
    <dgm:cxn modelId="{ED745F91-4CFD-4193-B9FE-B02CF1686D0B}" srcId="{71DE1CFA-6C80-4303-B72B-8CC6B23F4679}" destId="{2954EFE6-3719-4A0F-A6C9-2F0095F55616}" srcOrd="2" destOrd="0" parTransId="{187C2B99-193B-4307-8463-0364F8DB1478}" sibTransId="{6651DA8F-E236-406F-B7AE-18BBFB11F0C8}"/>
    <dgm:cxn modelId="{98C9FD91-6781-1141-88B3-26E3350D0528}" type="presOf" srcId="{F197ED87-B75C-4093-84D2-0A9FE2DE1942}" destId="{AC7EECF9-DD94-EF4F-8512-2A61C7A689C8}" srcOrd="1" destOrd="0" presId="urn:microsoft.com/office/officeart/2005/8/layout/list1"/>
    <dgm:cxn modelId="{A109B496-673B-9C48-973F-FADD4DCF87E3}" type="presOf" srcId="{16293B09-C373-4C43-97D3-5510617AD2B7}" destId="{2D2F842E-BC1B-4049-8D33-AB32348BD6A8}" srcOrd="0" destOrd="0" presId="urn:microsoft.com/office/officeart/2005/8/layout/list1"/>
    <dgm:cxn modelId="{1C0280AA-1123-054D-A36A-4DFD67A48331}" type="presOf" srcId="{2954EFE6-3719-4A0F-A6C9-2F0095F55616}" destId="{74FD4929-3438-5241-BCE3-1AB7408BC663}" srcOrd="1" destOrd="0" presId="urn:microsoft.com/office/officeart/2005/8/layout/list1"/>
    <dgm:cxn modelId="{21A0B9B3-103F-4D8B-9091-41C5BA2207AA}" srcId="{71DE1CFA-6C80-4303-B72B-8CC6B23F4679}" destId="{F197ED87-B75C-4093-84D2-0A9FE2DE1942}" srcOrd="0" destOrd="0" parTransId="{A6AD3857-0B3F-49B3-BC29-BABD5DCA4F67}" sibTransId="{27C41E59-7084-4E6A-BE2C-ACABF064A596}"/>
    <dgm:cxn modelId="{E07DA3D2-92B3-C942-90C7-0DD80D14CB17}" type="presOf" srcId="{F197ED87-B75C-4093-84D2-0A9FE2DE1942}" destId="{576E1AB8-CA64-C147-B0C5-F4F10C01C395}" srcOrd="0" destOrd="0" presId="urn:microsoft.com/office/officeart/2005/8/layout/list1"/>
    <dgm:cxn modelId="{A83349E8-BB13-9047-A068-7504896EDF9F}" type="presOf" srcId="{19433FF2-9A2F-487A-B349-9AF8EE86B7B8}" destId="{1855111B-9FCD-494A-BA67-DC2F59F9226C}" srcOrd="1" destOrd="0" presId="urn:microsoft.com/office/officeart/2005/8/layout/list1"/>
    <dgm:cxn modelId="{73498FE9-9983-42D1-B66E-6505E87DE4E2}" srcId="{71DE1CFA-6C80-4303-B72B-8CC6B23F4679}" destId="{19433FF2-9A2F-487A-B349-9AF8EE86B7B8}" srcOrd="1" destOrd="0" parTransId="{D2E56573-4022-450C-9B50-9F9561DC8076}" sibTransId="{E26A8144-7E63-4A2D-A758-E8ACB22E3274}"/>
    <dgm:cxn modelId="{938ACCF0-D662-5F49-B6CB-2E0B6957D9C7}" type="presOf" srcId="{71DE1CFA-6C80-4303-B72B-8CC6B23F4679}" destId="{1F2B7505-7252-0E48-A74D-9935A7628026}" srcOrd="0" destOrd="0" presId="urn:microsoft.com/office/officeart/2005/8/layout/list1"/>
    <dgm:cxn modelId="{282D15FF-D4C1-F84C-ADB1-6C667E233F39}" type="presOf" srcId="{A30F7AC2-0962-4C22-AA59-E225F5D9AEA4}" destId="{E3726B08-3C9B-2B4B-A103-69C8F8E0DD7A}" srcOrd="0" destOrd="0" presId="urn:microsoft.com/office/officeart/2005/8/layout/list1"/>
    <dgm:cxn modelId="{95FDC835-F9AE-E846-94F4-94AA571B1255}" type="presParOf" srcId="{1F2B7505-7252-0E48-A74D-9935A7628026}" destId="{3BC46041-FE11-6048-BB75-2B54F13A9AD8}" srcOrd="0" destOrd="0" presId="urn:microsoft.com/office/officeart/2005/8/layout/list1"/>
    <dgm:cxn modelId="{3F77E2EE-79E4-774C-BAE1-9394D0326173}" type="presParOf" srcId="{3BC46041-FE11-6048-BB75-2B54F13A9AD8}" destId="{576E1AB8-CA64-C147-B0C5-F4F10C01C395}" srcOrd="0" destOrd="0" presId="urn:microsoft.com/office/officeart/2005/8/layout/list1"/>
    <dgm:cxn modelId="{7E7CB331-A7C2-B442-B3B8-AEC1719CFC79}" type="presParOf" srcId="{3BC46041-FE11-6048-BB75-2B54F13A9AD8}" destId="{AC7EECF9-DD94-EF4F-8512-2A61C7A689C8}" srcOrd="1" destOrd="0" presId="urn:microsoft.com/office/officeart/2005/8/layout/list1"/>
    <dgm:cxn modelId="{E4C4A800-47E4-484E-A69D-FF0A80D8B5B9}" type="presParOf" srcId="{1F2B7505-7252-0E48-A74D-9935A7628026}" destId="{7B41E5F5-676F-F54F-ACC9-1E92FD2C1B96}" srcOrd="1" destOrd="0" presId="urn:microsoft.com/office/officeart/2005/8/layout/list1"/>
    <dgm:cxn modelId="{A4D1FB5D-1D04-534A-8D1B-900BD94734D2}" type="presParOf" srcId="{1F2B7505-7252-0E48-A74D-9935A7628026}" destId="{2D2F842E-BC1B-4049-8D33-AB32348BD6A8}" srcOrd="2" destOrd="0" presId="urn:microsoft.com/office/officeart/2005/8/layout/list1"/>
    <dgm:cxn modelId="{D2953BF8-7583-5A45-98B8-3C53892CF10B}" type="presParOf" srcId="{1F2B7505-7252-0E48-A74D-9935A7628026}" destId="{D35823C7-084E-A049-B068-C7A357ADE496}" srcOrd="3" destOrd="0" presId="urn:microsoft.com/office/officeart/2005/8/layout/list1"/>
    <dgm:cxn modelId="{12FDAED6-DDFB-874E-900A-7DC8F1467268}" type="presParOf" srcId="{1F2B7505-7252-0E48-A74D-9935A7628026}" destId="{E565A8BF-21E2-5B4C-AF8D-E2C6FE100514}" srcOrd="4" destOrd="0" presId="urn:microsoft.com/office/officeart/2005/8/layout/list1"/>
    <dgm:cxn modelId="{117ABEA3-3478-934F-94E4-5CE385DA675C}" type="presParOf" srcId="{E565A8BF-21E2-5B4C-AF8D-E2C6FE100514}" destId="{FF4C93D1-EFBC-6D43-AFC5-4503F93C60F9}" srcOrd="0" destOrd="0" presId="urn:microsoft.com/office/officeart/2005/8/layout/list1"/>
    <dgm:cxn modelId="{DDCD7EA8-622B-E449-A22F-BBEDBC14E5AA}" type="presParOf" srcId="{E565A8BF-21E2-5B4C-AF8D-E2C6FE100514}" destId="{1855111B-9FCD-494A-BA67-DC2F59F9226C}" srcOrd="1" destOrd="0" presId="urn:microsoft.com/office/officeart/2005/8/layout/list1"/>
    <dgm:cxn modelId="{25E75C33-EE46-264B-9A83-F5A1DFAD844E}" type="presParOf" srcId="{1F2B7505-7252-0E48-A74D-9935A7628026}" destId="{6049029B-4B2B-8E42-8D04-2080AAC177F3}" srcOrd="5" destOrd="0" presId="urn:microsoft.com/office/officeart/2005/8/layout/list1"/>
    <dgm:cxn modelId="{D8D27699-8B04-A34F-A295-269130FBD08D}" type="presParOf" srcId="{1F2B7505-7252-0E48-A74D-9935A7628026}" destId="{55F9A40C-6A61-8E49-90C0-B6152AE87DAB}" srcOrd="6" destOrd="0" presId="urn:microsoft.com/office/officeart/2005/8/layout/list1"/>
    <dgm:cxn modelId="{FC6EF556-A324-E44D-91F1-D17C69BB3B5C}" type="presParOf" srcId="{1F2B7505-7252-0E48-A74D-9935A7628026}" destId="{44A98AD4-2A08-3249-A9AF-453A96449561}" srcOrd="7" destOrd="0" presId="urn:microsoft.com/office/officeart/2005/8/layout/list1"/>
    <dgm:cxn modelId="{72F67D20-79DE-8D4A-A356-AFE5426D8DEB}" type="presParOf" srcId="{1F2B7505-7252-0E48-A74D-9935A7628026}" destId="{C1DAEC0A-AC17-0D46-9EFD-FF6F9DCE36CD}" srcOrd="8" destOrd="0" presId="urn:microsoft.com/office/officeart/2005/8/layout/list1"/>
    <dgm:cxn modelId="{1CE14DEC-624E-C246-AD6B-7B598CAFC4F6}" type="presParOf" srcId="{C1DAEC0A-AC17-0D46-9EFD-FF6F9DCE36CD}" destId="{5CFC8520-4EDD-DF47-8B69-3C60ED5E4940}" srcOrd="0" destOrd="0" presId="urn:microsoft.com/office/officeart/2005/8/layout/list1"/>
    <dgm:cxn modelId="{1348222B-2D15-F94D-855F-1344C3230000}" type="presParOf" srcId="{C1DAEC0A-AC17-0D46-9EFD-FF6F9DCE36CD}" destId="{74FD4929-3438-5241-BCE3-1AB7408BC663}" srcOrd="1" destOrd="0" presId="urn:microsoft.com/office/officeart/2005/8/layout/list1"/>
    <dgm:cxn modelId="{461F978B-D82A-6E42-B42B-7D0F14AC8739}" type="presParOf" srcId="{1F2B7505-7252-0E48-A74D-9935A7628026}" destId="{DD957D27-23FA-5D45-A0C0-D977736AE378}" srcOrd="9" destOrd="0" presId="urn:microsoft.com/office/officeart/2005/8/layout/list1"/>
    <dgm:cxn modelId="{5A00978A-027C-2F4F-8F4B-DEABC41F5B7A}" type="presParOf" srcId="{1F2B7505-7252-0E48-A74D-9935A7628026}" destId="{E3726B08-3C9B-2B4B-A103-69C8F8E0DD7A}" srcOrd="10" destOrd="0" presId="urn:microsoft.com/office/officeart/2005/8/layout/list1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3FD4148D-6B49-AD41-90C5-41DD662864F5}">
      <dsp:nvSpPr>
        <dsp:cNvPr id="0" name=""/>
        <dsp:cNvSpPr/>
      </dsp:nvSpPr>
      <dsp:spPr>
        <a:xfrm>
          <a:off x="0" y="3216432"/>
          <a:ext cx="5710450" cy="2110327"/>
        </a:xfrm>
        <a:prstGeom prst="rect">
          <a:avLst/>
        </a:prstGeom>
        <a:solidFill>
          <a:schemeClr val="accent2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99136" tIns="199136" rIns="199136" bIns="199136" numCol="1" spcCol="1270" anchor="ctr" anchorCtr="0">
          <a:noAutofit/>
        </a:bodyPr>
        <a:lstStyle/>
        <a:p>
          <a:pPr marL="0" lvl="0" indent="0" algn="ctr" defTabSz="1244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800" b="1" kern="12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rPr>
            <a:t>Early detection improves a patient’s chances of surviving!</a:t>
          </a:r>
        </a:p>
      </dsp:txBody>
      <dsp:txXfrm>
        <a:off x="0" y="3216432"/>
        <a:ext cx="5710450" cy="2110327"/>
      </dsp:txXfrm>
    </dsp:sp>
    <dsp:sp modelId="{AF89BADF-58C8-5842-94ED-CAA8DF6F236A}">
      <dsp:nvSpPr>
        <dsp:cNvPr id="0" name=""/>
        <dsp:cNvSpPr/>
      </dsp:nvSpPr>
      <dsp:spPr>
        <a:xfrm rot="10800000">
          <a:off x="0" y="2403"/>
          <a:ext cx="5710450" cy="3245684"/>
        </a:xfrm>
        <a:prstGeom prst="upArrowCallout">
          <a:avLst/>
        </a:prstGeom>
        <a:solidFill>
          <a:schemeClr val="accent2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99136" tIns="199136" rIns="199136" bIns="199136" numCol="1" spcCol="1270" anchor="ctr" anchorCtr="0">
          <a:noAutofit/>
        </a:bodyPr>
        <a:lstStyle/>
        <a:p>
          <a:pPr marL="0" lvl="0" indent="0" algn="ctr" defTabSz="1244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800" b="1" kern="12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rPr>
            <a:t>Which cancer is easier to cure?</a:t>
          </a:r>
        </a:p>
      </dsp:txBody>
      <dsp:txXfrm rot="-10800000">
        <a:off x="0" y="2403"/>
        <a:ext cx="5710450" cy="1139235"/>
      </dsp:txXfrm>
    </dsp:sp>
    <dsp:sp modelId="{554077BE-745F-CE46-8CF0-A0266077A8ED}">
      <dsp:nvSpPr>
        <dsp:cNvPr id="0" name=""/>
        <dsp:cNvSpPr/>
      </dsp:nvSpPr>
      <dsp:spPr>
        <a:xfrm>
          <a:off x="0" y="1141638"/>
          <a:ext cx="2855225" cy="970459"/>
        </a:xfrm>
        <a:prstGeom prst="rect">
          <a:avLst/>
        </a:prstGeom>
        <a:solidFill>
          <a:schemeClr val="accent2">
            <a:tint val="40000"/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2">
              <a:tint val="40000"/>
              <a:alpha val="9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8016" tIns="22860" rIns="128016" bIns="22860" numCol="1" spcCol="1270" anchor="ctr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800" kern="1200" dirty="0">
              <a:latin typeface="Arial" panose="020B0604020202020204" pitchFamily="34" charset="0"/>
              <a:cs typeface="Arial" panose="020B0604020202020204" pitchFamily="34" charset="0"/>
            </a:rPr>
            <a:t>A cancer that is large and has spread to different areas of the body.</a:t>
          </a:r>
        </a:p>
      </dsp:txBody>
      <dsp:txXfrm>
        <a:off x="0" y="1141638"/>
        <a:ext cx="2855225" cy="970459"/>
      </dsp:txXfrm>
    </dsp:sp>
    <dsp:sp modelId="{4BB81CE8-84EC-AD49-BE35-941A71871F12}">
      <dsp:nvSpPr>
        <dsp:cNvPr id="0" name=""/>
        <dsp:cNvSpPr/>
      </dsp:nvSpPr>
      <dsp:spPr>
        <a:xfrm>
          <a:off x="2855225" y="1141638"/>
          <a:ext cx="2855225" cy="970459"/>
        </a:xfrm>
        <a:prstGeom prst="rect">
          <a:avLst/>
        </a:prstGeom>
        <a:solidFill>
          <a:schemeClr val="accent2">
            <a:tint val="40000"/>
            <a:alpha val="90000"/>
            <a:hueOff val="-11825480"/>
            <a:satOff val="-66453"/>
            <a:lumOff val="-1104"/>
            <a:alphaOff val="0"/>
          </a:schemeClr>
        </a:solidFill>
        <a:ln w="12700" cap="flat" cmpd="sng" algn="ctr">
          <a:solidFill>
            <a:schemeClr val="accent2">
              <a:tint val="40000"/>
              <a:alpha val="90000"/>
              <a:hueOff val="-11825480"/>
              <a:satOff val="-66453"/>
              <a:lumOff val="-1104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8016" tIns="22860" rIns="128016" bIns="22860" numCol="1" spcCol="1270" anchor="ctr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800" kern="1200" dirty="0">
              <a:latin typeface="Arial" panose="020B0604020202020204" pitchFamily="34" charset="0"/>
              <a:cs typeface="Arial" panose="020B0604020202020204" pitchFamily="34" charset="0"/>
            </a:rPr>
            <a:t>A cancer that is small and has not yet spread.</a:t>
          </a:r>
        </a:p>
      </dsp:txBody>
      <dsp:txXfrm>
        <a:off x="2855225" y="1141638"/>
        <a:ext cx="2855225" cy="970459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D7F3AA9C-8CCB-6445-AFE1-0FB4926AA6AB}">
      <dsp:nvSpPr>
        <dsp:cNvPr id="0" name=""/>
        <dsp:cNvSpPr/>
      </dsp:nvSpPr>
      <dsp:spPr>
        <a:xfrm>
          <a:off x="0" y="2571785"/>
          <a:ext cx="10515600" cy="1687369"/>
        </a:xfrm>
        <a:prstGeom prst="rect">
          <a:avLst/>
        </a:prstGeom>
        <a:solidFill>
          <a:schemeClr val="accent2">
            <a:lumMod val="75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91592" tIns="291592" rIns="291592" bIns="291592" numCol="1" spcCol="1270" anchor="ctr" anchorCtr="0">
          <a:noAutofit/>
        </a:bodyPr>
        <a:lstStyle/>
        <a:p>
          <a:pPr marL="0" lvl="0" indent="0" algn="ctr" defTabSz="18224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4100" b="1" kern="12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rPr>
            <a:t>Think: </a:t>
          </a:r>
          <a:r>
            <a:rPr lang="en-US" sz="4100" kern="1200" dirty="0">
              <a:latin typeface="Arial" panose="020B0604020202020204" pitchFamily="34" charset="0"/>
              <a:cs typeface="Arial" panose="020B0604020202020204" pitchFamily="34" charset="0"/>
            </a:rPr>
            <a:t>What areas of Kentucky may have limited access to cancer care?</a:t>
          </a:r>
        </a:p>
      </dsp:txBody>
      <dsp:txXfrm>
        <a:off x="0" y="2571785"/>
        <a:ext cx="10515600" cy="1687369"/>
      </dsp:txXfrm>
    </dsp:sp>
    <dsp:sp modelId="{9C179F44-F51F-8542-9336-DEF5BEA4B23C}">
      <dsp:nvSpPr>
        <dsp:cNvPr id="0" name=""/>
        <dsp:cNvSpPr/>
      </dsp:nvSpPr>
      <dsp:spPr>
        <a:xfrm rot="10800000">
          <a:off x="0" y="1921"/>
          <a:ext cx="10515600" cy="2595174"/>
        </a:xfrm>
        <a:prstGeom prst="upArrowCallout">
          <a:avLst/>
        </a:prstGeom>
        <a:solidFill>
          <a:schemeClr val="accent5">
            <a:lumMod val="60000"/>
            <a:lumOff val="4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99136" tIns="199136" rIns="199136" bIns="199136" numCol="1" spcCol="1270" anchor="ctr" anchorCtr="0">
          <a:noAutofit/>
        </a:bodyPr>
        <a:lstStyle/>
        <a:p>
          <a:pPr marL="0" lvl="0" indent="0" algn="ctr" defTabSz="1244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800" kern="1200" dirty="0">
              <a:solidFill>
                <a:schemeClr val="tx1">
                  <a:lumMod val="85000"/>
                  <a:lumOff val="1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rPr>
            <a:t>It is more common for patients living in rural areas to present with later stage cancers than those living in urban areas.</a:t>
          </a:r>
        </a:p>
      </dsp:txBody>
      <dsp:txXfrm rot="-10800000">
        <a:off x="0" y="1921"/>
        <a:ext cx="10515600" cy="910906"/>
      </dsp:txXfrm>
    </dsp:sp>
    <dsp:sp modelId="{A01952E9-EA34-3F46-B4B3-DBB7C9ADE429}">
      <dsp:nvSpPr>
        <dsp:cNvPr id="0" name=""/>
        <dsp:cNvSpPr/>
      </dsp:nvSpPr>
      <dsp:spPr>
        <a:xfrm>
          <a:off x="0" y="912827"/>
          <a:ext cx="5257799" cy="775957"/>
        </a:xfrm>
        <a:prstGeom prst="rect">
          <a:avLst/>
        </a:prstGeom>
        <a:solidFill>
          <a:schemeClr val="accent2">
            <a:lumMod val="60000"/>
            <a:lumOff val="40000"/>
            <a:alpha val="90000"/>
          </a:schemeClr>
        </a:solidFill>
        <a:ln w="12700" cap="flat" cmpd="sng" algn="ctr">
          <a:solidFill>
            <a:schemeClr val="accent2">
              <a:tint val="40000"/>
              <a:alpha val="9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42240" tIns="25400" rIns="142240" bIns="2540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kern="1200" dirty="0">
              <a:solidFill>
                <a:srgbClr val="000000">
                  <a:hueOff val="0"/>
                  <a:satOff val="0"/>
                  <a:lumOff val="0"/>
                  <a:alphaOff val="0"/>
                </a:srgb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rPr>
            <a:t>This</a:t>
          </a:r>
          <a:r>
            <a:rPr lang="en-US" sz="2400" kern="1200" dirty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n-US" sz="2000" kern="1200" dirty="0">
              <a:latin typeface="Arial" panose="020B0604020202020204" pitchFamily="34" charset="0"/>
              <a:cs typeface="Arial" panose="020B0604020202020204" pitchFamily="34" charset="0"/>
            </a:rPr>
            <a:t>may be caused by a lack of access to healthcare services.</a:t>
          </a:r>
          <a:endParaRPr lang="en-US" sz="24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0" y="912827"/>
        <a:ext cx="5257799" cy="775957"/>
      </dsp:txXfrm>
    </dsp:sp>
    <dsp:sp modelId="{44AACF73-A6B0-B64D-9709-577154413DE7}">
      <dsp:nvSpPr>
        <dsp:cNvPr id="0" name=""/>
        <dsp:cNvSpPr/>
      </dsp:nvSpPr>
      <dsp:spPr>
        <a:xfrm>
          <a:off x="5257800" y="912827"/>
          <a:ext cx="5257799" cy="775957"/>
        </a:xfrm>
        <a:prstGeom prst="rect">
          <a:avLst/>
        </a:prstGeom>
        <a:solidFill>
          <a:schemeClr val="accent2">
            <a:lumMod val="40000"/>
            <a:lumOff val="60000"/>
            <a:alpha val="90000"/>
          </a:schemeClr>
        </a:solidFill>
        <a:ln w="12700" cap="flat" cmpd="sng" algn="ctr">
          <a:solidFill>
            <a:schemeClr val="accent3">
              <a:tint val="40000"/>
              <a:alpha val="9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70688" tIns="30480" rIns="170688" bIns="30480" numCol="1" spcCol="1270" anchor="ctr" anchorCtr="0">
          <a:noAutofit/>
        </a:bodyPr>
        <a:lstStyle/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400" kern="1200" dirty="0">
              <a:latin typeface="Arial" panose="020B0604020202020204" pitchFamily="34" charset="0"/>
              <a:cs typeface="Arial" panose="020B0604020202020204" pitchFamily="34" charset="0"/>
            </a:rPr>
            <a:t>This can affect their treatment regimen.</a:t>
          </a:r>
        </a:p>
      </dsp:txBody>
      <dsp:txXfrm>
        <a:off x="5257800" y="912827"/>
        <a:ext cx="5257799" cy="775957"/>
      </dsp:txXfrm>
    </dsp:sp>
  </dsp:spTree>
</dsp:drawing>
</file>

<file path=ppt/diagrams/drawing3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10E5260F-A9DF-AF42-A45C-E2517F7330BD}">
      <dsp:nvSpPr>
        <dsp:cNvPr id="0" name=""/>
        <dsp:cNvSpPr/>
      </dsp:nvSpPr>
      <dsp:spPr>
        <a:xfrm>
          <a:off x="0" y="472139"/>
          <a:ext cx="6240668" cy="781200"/>
        </a:xfrm>
        <a:prstGeom prst="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CE1E9BBF-A742-094F-908F-7EBB98EAF9C3}">
      <dsp:nvSpPr>
        <dsp:cNvPr id="0" name=""/>
        <dsp:cNvSpPr/>
      </dsp:nvSpPr>
      <dsp:spPr>
        <a:xfrm>
          <a:off x="312033" y="14579"/>
          <a:ext cx="4368468" cy="915120"/>
        </a:xfrm>
        <a:prstGeom prst="roundRect">
          <a:avLst/>
        </a:prstGeom>
        <a:solidFill>
          <a:schemeClr val="accent5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65118" tIns="0" rIns="165118" bIns="0" numCol="1" spcCol="1270" anchor="ctr" anchorCtr="0">
          <a:noAutofit/>
        </a:bodyPr>
        <a:lstStyle/>
        <a:p>
          <a:pPr marL="0" lvl="0" indent="0" algn="l" defTabSz="1377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100" b="1" kern="1200" dirty="0">
              <a:latin typeface="Arial" panose="020B0604020202020204" pitchFamily="34" charset="0"/>
              <a:cs typeface="Arial" panose="020B0604020202020204" pitchFamily="34" charset="0"/>
            </a:rPr>
            <a:t>Chemotherapy</a:t>
          </a:r>
        </a:p>
      </dsp:txBody>
      <dsp:txXfrm>
        <a:off x="356705" y="59251"/>
        <a:ext cx="4279124" cy="825776"/>
      </dsp:txXfrm>
    </dsp:sp>
    <dsp:sp modelId="{75B5D703-74D8-F54B-BEFB-FF5D160AA5DF}">
      <dsp:nvSpPr>
        <dsp:cNvPr id="0" name=""/>
        <dsp:cNvSpPr/>
      </dsp:nvSpPr>
      <dsp:spPr>
        <a:xfrm>
          <a:off x="0" y="1878299"/>
          <a:ext cx="6240668" cy="781200"/>
        </a:xfrm>
        <a:prstGeom prst="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5">
              <a:hueOff val="-5300031"/>
              <a:satOff val="-12053"/>
              <a:lumOff val="-281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9B6CC211-C3C8-CE48-AA82-956BCC012DA2}">
      <dsp:nvSpPr>
        <dsp:cNvPr id="0" name=""/>
        <dsp:cNvSpPr/>
      </dsp:nvSpPr>
      <dsp:spPr>
        <a:xfrm>
          <a:off x="312033" y="1420739"/>
          <a:ext cx="4368468" cy="915120"/>
        </a:xfrm>
        <a:prstGeom prst="roundRect">
          <a:avLst/>
        </a:prstGeom>
        <a:solidFill>
          <a:schemeClr val="accent1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65118" tIns="0" rIns="165118" bIns="0" numCol="1" spcCol="1270" anchor="ctr" anchorCtr="0">
          <a:noAutofit/>
        </a:bodyPr>
        <a:lstStyle/>
        <a:p>
          <a:pPr marL="0" lvl="0" indent="0" algn="l" defTabSz="1377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100" b="1" kern="1200">
              <a:latin typeface="Arial" panose="020B0604020202020204" pitchFamily="34" charset="0"/>
              <a:cs typeface="Arial" panose="020B0604020202020204" pitchFamily="34" charset="0"/>
            </a:rPr>
            <a:t>Radiation therapy</a:t>
          </a:r>
        </a:p>
      </dsp:txBody>
      <dsp:txXfrm>
        <a:off x="356705" y="1465411"/>
        <a:ext cx="4279124" cy="825776"/>
      </dsp:txXfrm>
    </dsp:sp>
    <dsp:sp modelId="{F91E113B-D7E4-F24C-9874-27DDFC6F8DBD}">
      <dsp:nvSpPr>
        <dsp:cNvPr id="0" name=""/>
        <dsp:cNvSpPr/>
      </dsp:nvSpPr>
      <dsp:spPr>
        <a:xfrm>
          <a:off x="0" y="3284460"/>
          <a:ext cx="6240668" cy="781200"/>
        </a:xfrm>
        <a:prstGeom prst="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5">
              <a:hueOff val="-10600063"/>
              <a:satOff val="-24105"/>
              <a:lumOff val="-5621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085AF877-0F36-FB42-8A84-0B7B335F41CC}">
      <dsp:nvSpPr>
        <dsp:cNvPr id="0" name=""/>
        <dsp:cNvSpPr/>
      </dsp:nvSpPr>
      <dsp:spPr>
        <a:xfrm>
          <a:off x="312033" y="2826899"/>
          <a:ext cx="4368468" cy="915120"/>
        </a:xfrm>
        <a:prstGeom prst="roundRect">
          <a:avLst/>
        </a:prstGeom>
        <a:solidFill>
          <a:schemeClr val="accent6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65118" tIns="0" rIns="165118" bIns="0" numCol="1" spcCol="1270" anchor="ctr" anchorCtr="0">
          <a:noAutofit/>
        </a:bodyPr>
        <a:lstStyle/>
        <a:p>
          <a:pPr marL="0" lvl="0" indent="0" algn="l" defTabSz="1377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100" b="1" kern="1200">
              <a:latin typeface="Arial" panose="020B0604020202020204" pitchFamily="34" charset="0"/>
              <a:cs typeface="Arial" panose="020B0604020202020204" pitchFamily="34" charset="0"/>
            </a:rPr>
            <a:t>Surgery</a:t>
          </a:r>
        </a:p>
      </dsp:txBody>
      <dsp:txXfrm>
        <a:off x="356705" y="2871571"/>
        <a:ext cx="4279124" cy="825776"/>
      </dsp:txXfrm>
    </dsp:sp>
    <dsp:sp modelId="{74D09C93-6383-0A40-92AD-84FA2ABA5B50}">
      <dsp:nvSpPr>
        <dsp:cNvPr id="0" name=""/>
        <dsp:cNvSpPr/>
      </dsp:nvSpPr>
      <dsp:spPr>
        <a:xfrm>
          <a:off x="0" y="4690620"/>
          <a:ext cx="6240668" cy="781200"/>
        </a:xfrm>
        <a:prstGeom prst="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5">
              <a:hueOff val="-15900093"/>
              <a:satOff val="-36158"/>
              <a:lumOff val="-8431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BE949D84-28BB-5046-A081-84588AEAD4CD}">
      <dsp:nvSpPr>
        <dsp:cNvPr id="0" name=""/>
        <dsp:cNvSpPr/>
      </dsp:nvSpPr>
      <dsp:spPr>
        <a:xfrm>
          <a:off x="312033" y="4233060"/>
          <a:ext cx="4368468" cy="915120"/>
        </a:xfrm>
        <a:prstGeom prst="roundRect">
          <a:avLst/>
        </a:prstGeom>
        <a:solidFill>
          <a:schemeClr val="accent4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65118" tIns="0" rIns="165118" bIns="0" numCol="1" spcCol="1270" anchor="ctr" anchorCtr="0">
          <a:noAutofit/>
        </a:bodyPr>
        <a:lstStyle/>
        <a:p>
          <a:pPr marL="0" lvl="0" indent="0" algn="l" defTabSz="1377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100" b="1" kern="1200" dirty="0">
              <a:latin typeface="Arial" panose="020B0604020202020204" pitchFamily="34" charset="0"/>
              <a:cs typeface="Arial" panose="020B0604020202020204" pitchFamily="34" charset="0"/>
            </a:rPr>
            <a:t>Stem Cell Transplant</a:t>
          </a:r>
        </a:p>
      </dsp:txBody>
      <dsp:txXfrm>
        <a:off x="356705" y="4277732"/>
        <a:ext cx="4279124" cy="825776"/>
      </dsp:txXfrm>
    </dsp:sp>
  </dsp:spTree>
</dsp:drawing>
</file>

<file path=ppt/diagrams/drawing4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23AC1D09-ECF8-5D4D-9BCE-30F3A46581BB}">
      <dsp:nvSpPr>
        <dsp:cNvPr id="0" name=""/>
        <dsp:cNvSpPr/>
      </dsp:nvSpPr>
      <dsp:spPr>
        <a:xfrm>
          <a:off x="0" y="576312"/>
          <a:ext cx="5393367" cy="1965600"/>
        </a:xfrm>
        <a:prstGeom prst="rect">
          <a:avLst/>
        </a:prstGeom>
        <a:solidFill>
          <a:schemeClr val="bg1">
            <a:alpha val="90000"/>
          </a:schemeClr>
        </a:solidFill>
        <a:ln w="12700" cap="flat" cmpd="sng" algn="ctr">
          <a:solidFill>
            <a:schemeClr val="accent2">
              <a:lumMod val="5000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18585" tIns="499872" rIns="418585" bIns="170688" numCol="1" spcCol="1270" anchor="t" anchorCtr="0">
          <a:noAutofit/>
        </a:bodyPr>
        <a:lstStyle/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400" kern="1200" dirty="0">
              <a:latin typeface="Arial" panose="020B0604020202020204" pitchFamily="34" charset="0"/>
              <a:cs typeface="Arial" panose="020B0604020202020204" pitchFamily="34" charset="0"/>
            </a:rPr>
            <a:t>A machine sends radiation into the cancerous area of the body from many directions without touching the patient.</a:t>
          </a:r>
        </a:p>
      </dsp:txBody>
      <dsp:txXfrm>
        <a:off x="0" y="576312"/>
        <a:ext cx="5393367" cy="1965600"/>
      </dsp:txXfrm>
    </dsp:sp>
    <dsp:sp modelId="{4732F60F-0B29-A648-80A0-156E35812600}">
      <dsp:nvSpPr>
        <dsp:cNvPr id="0" name=""/>
        <dsp:cNvSpPr/>
      </dsp:nvSpPr>
      <dsp:spPr>
        <a:xfrm>
          <a:off x="269668" y="222072"/>
          <a:ext cx="3775356" cy="708480"/>
        </a:xfrm>
        <a:prstGeom prst="roundRect">
          <a:avLst/>
        </a:prstGeom>
        <a:solidFill>
          <a:schemeClr val="accent2">
            <a:lumMod val="40000"/>
            <a:lumOff val="60000"/>
          </a:schemeClr>
        </a:solidFill>
        <a:ln w="12700" cap="flat" cmpd="sng" algn="ctr">
          <a:solidFill>
            <a:schemeClr val="lt2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42700" tIns="0" rIns="142700" bIns="0" numCol="1" spcCol="1270" anchor="ctr" anchorCtr="0">
          <a:noAutofit/>
        </a:bodyPr>
        <a:lstStyle/>
        <a:p>
          <a:pPr marL="0" lvl="0" indent="0" algn="l" defTabSz="1422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200" b="1" kern="1200" dirty="0">
              <a:solidFill>
                <a:schemeClr val="accent2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rPr>
            <a:t>External Beam</a:t>
          </a:r>
        </a:p>
      </dsp:txBody>
      <dsp:txXfrm>
        <a:off x="304253" y="256657"/>
        <a:ext cx="3706186" cy="639310"/>
      </dsp:txXfrm>
    </dsp:sp>
    <dsp:sp modelId="{A753E3B0-CFCE-424E-BD31-7D0796400390}">
      <dsp:nvSpPr>
        <dsp:cNvPr id="0" name=""/>
        <dsp:cNvSpPr/>
      </dsp:nvSpPr>
      <dsp:spPr>
        <a:xfrm>
          <a:off x="0" y="3025752"/>
          <a:ext cx="5393367" cy="1625400"/>
        </a:xfrm>
        <a:prstGeom prst="rect">
          <a:avLst/>
        </a:prstGeom>
        <a:solidFill>
          <a:schemeClr val="bg1">
            <a:alpha val="90000"/>
          </a:schemeClr>
        </a:solidFill>
        <a:ln w="12700" cap="flat" cmpd="sng" algn="ctr">
          <a:solidFill>
            <a:schemeClr val="accent5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18585" tIns="499872" rIns="418585" bIns="170688" numCol="1" spcCol="1270" anchor="t" anchorCtr="0">
          <a:noAutofit/>
        </a:bodyPr>
        <a:lstStyle/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400" kern="1200" dirty="0">
              <a:latin typeface="Arial" panose="020B0604020202020204" pitchFamily="34" charset="0"/>
              <a:cs typeface="Arial" panose="020B0604020202020204" pitchFamily="34" charset="0"/>
            </a:rPr>
            <a:t>Radiation is put inside the body through an IV and targets the area near the tumor.</a:t>
          </a:r>
        </a:p>
      </dsp:txBody>
      <dsp:txXfrm>
        <a:off x="0" y="3025752"/>
        <a:ext cx="5393367" cy="1625400"/>
      </dsp:txXfrm>
    </dsp:sp>
    <dsp:sp modelId="{5B776D8C-BCB9-B443-9292-E8440C1DE1C6}">
      <dsp:nvSpPr>
        <dsp:cNvPr id="0" name=""/>
        <dsp:cNvSpPr/>
      </dsp:nvSpPr>
      <dsp:spPr>
        <a:xfrm>
          <a:off x="269668" y="2671512"/>
          <a:ext cx="3775356" cy="708480"/>
        </a:xfrm>
        <a:prstGeom prst="roundRect">
          <a:avLst/>
        </a:prstGeom>
        <a:solidFill>
          <a:schemeClr val="accent5">
            <a:lumMod val="40000"/>
            <a:lumOff val="60000"/>
          </a:schemeClr>
        </a:solidFill>
        <a:ln w="12700" cap="flat" cmpd="sng" algn="ctr">
          <a:solidFill>
            <a:schemeClr val="lt2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42700" tIns="0" rIns="142700" bIns="0" numCol="1" spcCol="1270" anchor="ctr" anchorCtr="0">
          <a:noAutofit/>
        </a:bodyPr>
        <a:lstStyle/>
        <a:p>
          <a:pPr marL="0" lvl="0" indent="0" algn="l" defTabSz="1422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200" b="1" kern="1200" dirty="0">
              <a:solidFill>
                <a:schemeClr val="accent5"/>
              </a:solidFill>
              <a:latin typeface="Arial" panose="020B0604020202020204" pitchFamily="34" charset="0"/>
              <a:cs typeface="Arial" panose="020B0604020202020204" pitchFamily="34" charset="0"/>
            </a:rPr>
            <a:t>Internal Beam</a:t>
          </a:r>
        </a:p>
      </dsp:txBody>
      <dsp:txXfrm>
        <a:off x="304253" y="2706097"/>
        <a:ext cx="3706186" cy="639310"/>
      </dsp:txXfrm>
    </dsp:sp>
  </dsp:spTree>
</dsp:drawing>
</file>

<file path=ppt/diagrams/drawing5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067ABE44-01B2-0B4C-969D-139B3E2D1AE8}">
      <dsp:nvSpPr>
        <dsp:cNvPr id="0" name=""/>
        <dsp:cNvSpPr/>
      </dsp:nvSpPr>
      <dsp:spPr>
        <a:xfrm>
          <a:off x="0" y="1572663"/>
          <a:ext cx="6240668" cy="3911203"/>
        </a:xfrm>
        <a:prstGeom prst="rect">
          <a:avLst/>
        </a:prstGeom>
        <a:solidFill>
          <a:schemeClr val="accent2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84912" tIns="184912" rIns="184912" bIns="184912" numCol="1" spcCol="1270" anchor="ctr" anchorCtr="0">
          <a:noAutofit/>
        </a:bodyPr>
        <a:lstStyle/>
        <a:p>
          <a:pPr marL="0" lvl="0" indent="0" algn="ctr" defTabSz="1155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600" kern="1200" dirty="0">
              <a:latin typeface="Arial" panose="020B0604020202020204" pitchFamily="34" charset="0"/>
              <a:cs typeface="Arial" panose="020B0604020202020204" pitchFamily="34" charset="0"/>
            </a:rPr>
            <a:t>Has many similar side effects to chemotherapy, but has site-specific side effects:</a:t>
          </a:r>
        </a:p>
      </dsp:txBody>
      <dsp:txXfrm>
        <a:off x="0" y="1572663"/>
        <a:ext cx="6240668" cy="2112049"/>
      </dsp:txXfrm>
    </dsp:sp>
    <dsp:sp modelId="{68B9A670-3848-1242-820F-A83CF524B207}">
      <dsp:nvSpPr>
        <dsp:cNvPr id="0" name=""/>
        <dsp:cNvSpPr/>
      </dsp:nvSpPr>
      <dsp:spPr>
        <a:xfrm>
          <a:off x="0" y="3606489"/>
          <a:ext cx="3120334" cy="1799153"/>
        </a:xfrm>
        <a:prstGeom prst="rect">
          <a:avLst/>
        </a:prstGeom>
        <a:solidFill>
          <a:schemeClr val="accent2">
            <a:tint val="40000"/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2">
              <a:tint val="40000"/>
              <a:alpha val="9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84912" tIns="33020" rIns="184912" bIns="33020" numCol="1" spcCol="1270" anchor="ctr" anchorCtr="0">
          <a:noAutofit/>
        </a:bodyPr>
        <a:lstStyle/>
        <a:p>
          <a:pPr marL="0" lvl="0" indent="0" algn="ctr" defTabSz="1155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600" kern="1200">
              <a:latin typeface="Arial" panose="020B0604020202020204" pitchFamily="34" charset="0"/>
              <a:cs typeface="Arial" panose="020B0604020202020204" pitchFamily="34" charset="0"/>
            </a:rPr>
            <a:t>Dry mouth and tooth decay in head and neck radiation</a:t>
          </a:r>
        </a:p>
      </dsp:txBody>
      <dsp:txXfrm>
        <a:off x="0" y="3606489"/>
        <a:ext cx="3120334" cy="1799153"/>
      </dsp:txXfrm>
    </dsp:sp>
    <dsp:sp modelId="{BDE82B9E-5B64-034A-BE43-5547F93EC50A}">
      <dsp:nvSpPr>
        <dsp:cNvPr id="0" name=""/>
        <dsp:cNvSpPr/>
      </dsp:nvSpPr>
      <dsp:spPr>
        <a:xfrm>
          <a:off x="3120334" y="3606489"/>
          <a:ext cx="3120334" cy="1799153"/>
        </a:xfrm>
        <a:prstGeom prst="rect">
          <a:avLst/>
        </a:prstGeom>
        <a:solidFill>
          <a:schemeClr val="accent2">
            <a:tint val="40000"/>
            <a:alpha val="90000"/>
            <a:hueOff val="-11825480"/>
            <a:satOff val="-66453"/>
            <a:lumOff val="-1104"/>
            <a:alphaOff val="0"/>
          </a:schemeClr>
        </a:solidFill>
        <a:ln w="12700" cap="flat" cmpd="sng" algn="ctr">
          <a:solidFill>
            <a:schemeClr val="accent2">
              <a:tint val="40000"/>
              <a:alpha val="90000"/>
              <a:hueOff val="-11825480"/>
              <a:satOff val="-66453"/>
              <a:lumOff val="-1104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84912" tIns="33020" rIns="184912" bIns="33020" numCol="1" spcCol="1270" anchor="ctr" anchorCtr="0">
          <a:noAutofit/>
        </a:bodyPr>
        <a:lstStyle/>
        <a:p>
          <a:pPr marL="0" lvl="0" indent="0" algn="ctr" defTabSz="1155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600" kern="1200">
              <a:latin typeface="Arial" panose="020B0604020202020204" pitchFamily="34" charset="0"/>
              <a:cs typeface="Arial" panose="020B0604020202020204" pitchFamily="34" charset="0"/>
            </a:rPr>
            <a:t>Nausea and diarrhea in stomach and abdomen radiation</a:t>
          </a:r>
        </a:p>
      </dsp:txBody>
      <dsp:txXfrm>
        <a:off x="3120334" y="3606489"/>
        <a:ext cx="3120334" cy="1799153"/>
      </dsp:txXfrm>
    </dsp:sp>
    <dsp:sp modelId="{2F32C912-591E-C242-A05E-99E69D590796}">
      <dsp:nvSpPr>
        <dsp:cNvPr id="0" name=""/>
        <dsp:cNvSpPr/>
      </dsp:nvSpPr>
      <dsp:spPr>
        <a:xfrm rot="10800000">
          <a:off x="0" y="2533"/>
          <a:ext cx="6240668" cy="1628798"/>
        </a:xfrm>
        <a:prstGeom prst="upArrowCallout">
          <a:avLst/>
        </a:prstGeom>
        <a:solidFill>
          <a:schemeClr val="accent1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84912" tIns="184912" rIns="184912" bIns="184912" numCol="1" spcCol="1270" anchor="ctr" anchorCtr="0">
          <a:noAutofit/>
        </a:bodyPr>
        <a:lstStyle/>
        <a:p>
          <a:pPr marL="0" lvl="0" indent="0" algn="ctr" defTabSz="1155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600" kern="1200" dirty="0">
              <a:latin typeface="Arial" panose="020B0604020202020204" pitchFamily="34" charset="0"/>
              <a:cs typeface="Arial" panose="020B0604020202020204" pitchFamily="34" charset="0"/>
            </a:rPr>
            <a:t>Like chemotherapy, it causes damage to health cells near the treatment area.</a:t>
          </a:r>
        </a:p>
      </dsp:txBody>
      <dsp:txXfrm rot="10800000">
        <a:off x="0" y="2533"/>
        <a:ext cx="6240668" cy="1058344"/>
      </dsp:txXfrm>
    </dsp:sp>
  </dsp:spTree>
</dsp:drawing>
</file>

<file path=ppt/diagrams/drawing6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8142CB6C-9444-8843-AF70-BC8EA83ABE94}">
      <dsp:nvSpPr>
        <dsp:cNvPr id="0" name=""/>
        <dsp:cNvSpPr/>
      </dsp:nvSpPr>
      <dsp:spPr>
        <a:xfrm rot="5400000">
          <a:off x="5695959" y="-2011471"/>
          <a:ext cx="1716489" cy="6168662"/>
        </a:xfrm>
        <a:prstGeom prst="round2SameRect">
          <a:avLst/>
        </a:prstGeom>
        <a:solidFill>
          <a:schemeClr val="tx2">
            <a:lumMod val="40000"/>
            <a:lumOff val="60000"/>
            <a:alpha val="90000"/>
          </a:schemeClr>
        </a:solidFill>
        <a:ln w="12700" cap="flat" cmpd="sng" algn="ctr">
          <a:solidFill>
            <a:schemeClr val="tx2">
              <a:lumMod val="60000"/>
              <a:lumOff val="40000"/>
              <a:alpha val="9000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1440" tIns="45720" rIns="91440" bIns="45720" numCol="1" spcCol="1270" anchor="ctr" anchorCtr="0">
          <a:noAutofit/>
        </a:bodyPr>
        <a:lstStyle/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400" kern="1200" dirty="0">
              <a:latin typeface="Arial" panose="020B0604020202020204" pitchFamily="34" charset="0"/>
              <a:cs typeface="Arial" panose="020B0604020202020204" pitchFamily="34" charset="0"/>
            </a:rPr>
            <a:t>Surgeon makes one large cut to remove the tumor and surrounding area.</a:t>
          </a:r>
        </a:p>
      </dsp:txBody>
      <dsp:txXfrm rot="-5400000">
        <a:off x="3469873" y="298407"/>
        <a:ext cx="6084870" cy="1548905"/>
      </dsp:txXfrm>
    </dsp:sp>
    <dsp:sp modelId="{0ED64627-97A2-F044-A7AA-EA03E621E646}">
      <dsp:nvSpPr>
        <dsp:cNvPr id="0" name=""/>
        <dsp:cNvSpPr/>
      </dsp:nvSpPr>
      <dsp:spPr>
        <a:xfrm>
          <a:off x="0" y="53"/>
          <a:ext cx="3469872" cy="2145611"/>
        </a:xfrm>
        <a:prstGeom prst="roundRect">
          <a:avLst/>
        </a:prstGeom>
        <a:solidFill>
          <a:schemeClr val="accent1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1920" tIns="60960" rIns="121920" bIns="60960" numCol="1" spcCol="1270" anchor="ctr" anchorCtr="0">
          <a:noAutofit/>
        </a:bodyPr>
        <a:lstStyle/>
        <a:p>
          <a:pPr marL="0" lvl="0" indent="0" algn="ctr" defTabSz="1422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200" b="1" kern="1200" dirty="0">
              <a:latin typeface="Arial" panose="020B0604020202020204" pitchFamily="34" charset="0"/>
              <a:cs typeface="Arial" panose="020B0604020202020204" pitchFamily="34" charset="0"/>
            </a:rPr>
            <a:t>Open Surgery</a:t>
          </a:r>
        </a:p>
      </dsp:txBody>
      <dsp:txXfrm>
        <a:off x="104740" y="104793"/>
        <a:ext cx="3260392" cy="1936131"/>
      </dsp:txXfrm>
    </dsp:sp>
    <dsp:sp modelId="{98AC9556-B53C-FD4C-91E1-07B1B6D49274}">
      <dsp:nvSpPr>
        <dsp:cNvPr id="0" name=""/>
        <dsp:cNvSpPr/>
      </dsp:nvSpPr>
      <dsp:spPr>
        <a:xfrm rot="5400000">
          <a:off x="5695959" y="241420"/>
          <a:ext cx="1716489" cy="6168662"/>
        </a:xfrm>
        <a:prstGeom prst="round2SameRect">
          <a:avLst/>
        </a:prstGeom>
        <a:solidFill>
          <a:schemeClr val="accent5">
            <a:tint val="40000"/>
            <a:alpha val="90000"/>
            <a:hueOff val="-15630516"/>
            <a:satOff val="-42662"/>
            <a:lumOff val="-3249"/>
            <a:alphaOff val="0"/>
          </a:schemeClr>
        </a:solidFill>
        <a:ln w="12700" cap="flat" cmpd="sng" algn="ctr">
          <a:solidFill>
            <a:schemeClr val="accent5">
              <a:tint val="40000"/>
              <a:alpha val="90000"/>
              <a:hueOff val="-15630516"/>
              <a:satOff val="-42662"/>
              <a:lumOff val="-3249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1440" tIns="45720" rIns="91440" bIns="45720" numCol="1" spcCol="1270" anchor="ctr" anchorCtr="0">
          <a:noAutofit/>
        </a:bodyPr>
        <a:lstStyle/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400" kern="1200">
              <a:latin typeface="Arial" panose="020B0604020202020204" pitchFamily="34" charset="0"/>
              <a:cs typeface="Arial" panose="020B0604020202020204" pitchFamily="34" charset="0"/>
            </a:rPr>
            <a:t>Surgeon makes a few small cuts to insert a small camera (laparoscope). The surgeon uses the camera projections to remove the tumor and surrounding area. </a:t>
          </a:r>
        </a:p>
      </dsp:txBody>
      <dsp:txXfrm rot="-5400000">
        <a:off x="3469873" y="2551298"/>
        <a:ext cx="6084870" cy="1548905"/>
      </dsp:txXfrm>
    </dsp:sp>
    <dsp:sp modelId="{AA8947CB-D5B4-8342-93A6-F3789681D9CA}">
      <dsp:nvSpPr>
        <dsp:cNvPr id="0" name=""/>
        <dsp:cNvSpPr/>
      </dsp:nvSpPr>
      <dsp:spPr>
        <a:xfrm>
          <a:off x="0" y="2252945"/>
          <a:ext cx="3469872" cy="2145611"/>
        </a:xfrm>
        <a:prstGeom prst="roundRect">
          <a:avLst/>
        </a:prstGeom>
        <a:solidFill>
          <a:schemeClr val="accent5">
            <a:hueOff val="-15900093"/>
            <a:satOff val="-36158"/>
            <a:lumOff val="-8431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1920" tIns="60960" rIns="121920" bIns="60960" numCol="1" spcCol="1270" anchor="ctr" anchorCtr="0">
          <a:noAutofit/>
        </a:bodyPr>
        <a:lstStyle/>
        <a:p>
          <a:pPr marL="0" lvl="0" indent="0" algn="ctr" defTabSz="1422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200" b="1" kern="1200" dirty="0">
              <a:solidFill>
                <a:srgbClr val="FFFFFF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rPr>
            <a:t>Minimally Invasive Surgery</a:t>
          </a:r>
        </a:p>
      </dsp:txBody>
      <dsp:txXfrm>
        <a:off x="104740" y="2357685"/>
        <a:ext cx="3260392" cy="1936131"/>
      </dsp:txXfrm>
    </dsp:sp>
  </dsp:spTree>
</dsp:drawing>
</file>

<file path=ppt/diagrams/drawing7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2D2F842E-BC1B-4049-8D33-AB32348BD6A8}">
      <dsp:nvSpPr>
        <dsp:cNvPr id="0" name=""/>
        <dsp:cNvSpPr/>
      </dsp:nvSpPr>
      <dsp:spPr>
        <a:xfrm>
          <a:off x="0" y="394670"/>
          <a:ext cx="5924386" cy="1228500"/>
        </a:xfrm>
        <a:prstGeom prst="rect">
          <a:avLst/>
        </a:prstGeom>
        <a:noFill/>
        <a:ln w="12700" cap="flat" cmpd="sng" algn="ctr">
          <a:solidFill>
            <a:schemeClr val="accent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9798" tIns="541528" rIns="459798" bIns="142240" numCol="1" spcCol="1270" anchor="t" anchorCtr="0">
          <a:noAutofit/>
        </a:bodyPr>
        <a:lstStyle/>
        <a:p>
          <a:pPr marL="228600" lvl="1" indent="-228600" algn="l" defTabSz="8890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000" kern="1200" dirty="0">
              <a:latin typeface="Arial" panose="020B0604020202020204" pitchFamily="34" charset="0"/>
              <a:cs typeface="Arial" panose="020B0604020202020204" pitchFamily="34" charset="0"/>
            </a:rPr>
            <a:t>Stem cell donor is the patient themselves (taken from other areas of the body).</a:t>
          </a:r>
        </a:p>
      </dsp:txBody>
      <dsp:txXfrm>
        <a:off x="0" y="394670"/>
        <a:ext cx="5924386" cy="1228500"/>
      </dsp:txXfrm>
    </dsp:sp>
    <dsp:sp modelId="{AC7EECF9-DD94-EF4F-8512-2A61C7A689C8}">
      <dsp:nvSpPr>
        <dsp:cNvPr id="0" name=""/>
        <dsp:cNvSpPr/>
      </dsp:nvSpPr>
      <dsp:spPr>
        <a:xfrm>
          <a:off x="296219" y="10910"/>
          <a:ext cx="4665164" cy="767520"/>
        </a:xfrm>
        <a:prstGeom prst="roundRect">
          <a:avLst/>
        </a:prstGeom>
        <a:solidFill>
          <a:schemeClr val="accent1"/>
        </a:solidFill>
        <a:ln w="12700" cap="flat" cmpd="sng" algn="ctr">
          <a:solidFill>
            <a:schemeClr val="lt2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56749" tIns="0" rIns="156749" bIns="0" numCol="1" spcCol="1270" anchor="ctr" anchorCtr="0">
          <a:noAutofit/>
        </a:bodyPr>
        <a:lstStyle/>
        <a:p>
          <a:pPr marL="0" lvl="0" indent="0" algn="l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b="1" kern="1200">
              <a:latin typeface="Arial" panose="020B0604020202020204" pitchFamily="34" charset="0"/>
              <a:cs typeface="Arial" panose="020B0604020202020204" pitchFamily="34" charset="0"/>
            </a:rPr>
            <a:t>Autologous stem cell transplants</a:t>
          </a:r>
        </a:p>
      </dsp:txBody>
      <dsp:txXfrm>
        <a:off x="333686" y="48377"/>
        <a:ext cx="4590230" cy="692586"/>
      </dsp:txXfrm>
    </dsp:sp>
    <dsp:sp modelId="{55F9A40C-6A61-8E49-90C0-B6152AE87DAB}">
      <dsp:nvSpPr>
        <dsp:cNvPr id="0" name=""/>
        <dsp:cNvSpPr/>
      </dsp:nvSpPr>
      <dsp:spPr>
        <a:xfrm>
          <a:off x="0" y="2147330"/>
          <a:ext cx="5924386" cy="1228500"/>
        </a:xfrm>
        <a:prstGeom prst="rect">
          <a:avLst/>
        </a:prstGeom>
        <a:noFill/>
        <a:ln w="12700" cap="flat" cmpd="sng" algn="ctr">
          <a:solidFill>
            <a:schemeClr val="accent5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9798" tIns="541528" rIns="459798" bIns="142240" numCol="1" spcCol="1270" anchor="t" anchorCtr="0">
          <a:noAutofit/>
        </a:bodyPr>
        <a:lstStyle/>
        <a:p>
          <a:pPr marL="228600" lvl="1" indent="-228600" algn="l" defTabSz="8890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000" kern="1200" dirty="0">
              <a:latin typeface="Arial" panose="020B0604020202020204" pitchFamily="34" charset="0"/>
              <a:cs typeface="Arial" panose="020B0604020202020204" pitchFamily="34" charset="0"/>
            </a:rPr>
            <a:t>Stem cell donor is someone else (normally a relative).</a:t>
          </a:r>
        </a:p>
      </dsp:txBody>
      <dsp:txXfrm>
        <a:off x="0" y="2147330"/>
        <a:ext cx="5924386" cy="1228500"/>
      </dsp:txXfrm>
    </dsp:sp>
    <dsp:sp modelId="{1855111B-9FCD-494A-BA67-DC2F59F9226C}">
      <dsp:nvSpPr>
        <dsp:cNvPr id="0" name=""/>
        <dsp:cNvSpPr/>
      </dsp:nvSpPr>
      <dsp:spPr>
        <a:xfrm>
          <a:off x="296219" y="1763570"/>
          <a:ext cx="4648078" cy="767520"/>
        </a:xfrm>
        <a:prstGeom prst="roundRect">
          <a:avLst/>
        </a:prstGeom>
        <a:solidFill>
          <a:schemeClr val="accent5"/>
        </a:solidFill>
        <a:ln w="12700" cap="flat" cmpd="sng" algn="ctr">
          <a:solidFill>
            <a:schemeClr val="lt2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56749" tIns="0" rIns="156749" bIns="0" numCol="1" spcCol="1270" anchor="ctr" anchorCtr="0">
          <a:noAutofit/>
        </a:bodyPr>
        <a:lstStyle/>
        <a:p>
          <a:pPr marL="0" lvl="0" indent="0" algn="l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b="1" kern="1200">
              <a:latin typeface="Arial" panose="020B0604020202020204" pitchFamily="34" charset="0"/>
              <a:cs typeface="Arial" panose="020B0604020202020204" pitchFamily="34" charset="0"/>
            </a:rPr>
            <a:t>Allogeneic stem cell transplants</a:t>
          </a:r>
        </a:p>
      </dsp:txBody>
      <dsp:txXfrm>
        <a:off x="333686" y="1801037"/>
        <a:ext cx="4573144" cy="692586"/>
      </dsp:txXfrm>
    </dsp:sp>
    <dsp:sp modelId="{E3726B08-3C9B-2B4B-A103-69C8F8E0DD7A}">
      <dsp:nvSpPr>
        <dsp:cNvPr id="0" name=""/>
        <dsp:cNvSpPr/>
      </dsp:nvSpPr>
      <dsp:spPr>
        <a:xfrm>
          <a:off x="0" y="3899990"/>
          <a:ext cx="5924386" cy="962325"/>
        </a:xfrm>
        <a:prstGeom prst="rect">
          <a:avLst/>
        </a:prstGeom>
        <a:noFill/>
        <a:ln w="12700" cap="flat" cmpd="sng" algn="ctr">
          <a:solidFill>
            <a:schemeClr val="accent6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9798" tIns="541528" rIns="459798" bIns="142240" numCol="1" spcCol="1270" anchor="t" anchorCtr="0">
          <a:noAutofit/>
        </a:bodyPr>
        <a:lstStyle/>
        <a:p>
          <a:pPr marL="228600" lvl="1" indent="-228600" algn="l" defTabSz="8890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000" kern="1200" dirty="0">
              <a:latin typeface="Arial" panose="020B0604020202020204" pitchFamily="34" charset="0"/>
              <a:cs typeface="Arial" panose="020B0604020202020204" pitchFamily="34" charset="0"/>
            </a:rPr>
            <a:t>Stem cell donor is an identical twin.</a:t>
          </a:r>
        </a:p>
      </dsp:txBody>
      <dsp:txXfrm>
        <a:off x="0" y="3899990"/>
        <a:ext cx="5924386" cy="962325"/>
      </dsp:txXfrm>
    </dsp:sp>
    <dsp:sp modelId="{74FD4929-3438-5241-BCE3-1AB7408BC663}">
      <dsp:nvSpPr>
        <dsp:cNvPr id="0" name=""/>
        <dsp:cNvSpPr/>
      </dsp:nvSpPr>
      <dsp:spPr>
        <a:xfrm>
          <a:off x="296219" y="3516230"/>
          <a:ext cx="4784807" cy="767520"/>
        </a:xfrm>
        <a:prstGeom prst="roundRect">
          <a:avLst/>
        </a:prstGeom>
        <a:solidFill>
          <a:schemeClr val="accent6"/>
        </a:solidFill>
        <a:ln w="12700" cap="flat" cmpd="sng" algn="ctr">
          <a:solidFill>
            <a:schemeClr val="lt2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56749" tIns="0" rIns="156749" bIns="0" numCol="1" spcCol="1270" anchor="ctr" anchorCtr="0">
          <a:noAutofit/>
        </a:bodyPr>
        <a:lstStyle/>
        <a:p>
          <a:pPr marL="0" lvl="0" indent="0" algn="l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b="1" kern="1200" dirty="0">
              <a:latin typeface="Arial" panose="020B0604020202020204" pitchFamily="34" charset="0"/>
              <a:cs typeface="Arial" panose="020B0604020202020204" pitchFamily="34" charset="0"/>
            </a:rPr>
            <a:t>Syngeneic stem cell transplants</a:t>
          </a:r>
        </a:p>
      </dsp:txBody>
      <dsp:txXfrm>
        <a:off x="333686" y="3553697"/>
        <a:ext cx="4709873" cy="692586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process4">
  <dgm:title val=""/>
  <dgm:desc val=""/>
  <dgm:catLst>
    <dgm:cat type="process" pri="16000"/>
    <dgm:cat type="list" pri="20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Name0">
    <dgm:varLst>
      <dgm:dir/>
      <dgm:animLvl val="lvl"/>
      <dgm:resizeHandles val="exact"/>
    </dgm:varLst>
    <dgm:alg type="lin">
      <dgm:param type="linDir" val="fromB"/>
    </dgm:alg>
    <dgm:shape xmlns:r="http://schemas.openxmlformats.org/officeDocument/2006/relationships" r:blip="">
      <dgm:adjLst/>
    </dgm:shape>
    <dgm:presOf/>
    <dgm:constrLst>
      <dgm:constr type="h" for="ch" forName="boxAndChildren" refType="h"/>
      <dgm:constr type="h" for="ch" forName="arrowAndChildren" refType="h" refFor="ch" refForName="boxAndChildren" op="equ" fact="1.538"/>
      <dgm:constr type="w" for="ch" forName="arrowAndChildren" refType="w"/>
      <dgm:constr type="w" for="ch" forName="boxAndChildren" refType="w"/>
      <dgm:constr type="h" for="ch" forName="sp" refType="h" fact="-0.015"/>
      <dgm:constr type="primFontSz" for="des" forName="parentTextBox" val="65"/>
      <dgm:constr type="primFontSz" for="des" forName="parentTextArrow" refType="primFontSz" refFor="des" refForName="parentTextBox" op="equ"/>
      <dgm:constr type="primFontSz" for="des" forName="childTextArrow" val="65"/>
      <dgm:constr type="primFontSz" for="des" forName="childTextBox" refType="primFontSz" refFor="des" refForName="childTextArrow" op="equ"/>
    </dgm:constrLst>
    <dgm:ruleLst/>
    <dgm:forEach name="Name1" axis="ch" ptType="node" st="-1" step="-1">
      <dgm:choose name="Name2">
        <dgm:if name="Name3" axis="self" ptType="node" func="revPos" op="equ" val="1">
          <dgm:layoutNode name="boxAndChildren">
            <dgm:alg type="composite"/>
            <dgm:shape xmlns:r="http://schemas.openxmlformats.org/officeDocument/2006/relationships" r:blip="">
              <dgm:adjLst/>
            </dgm:shape>
            <dgm:presOf/>
            <dgm:choose name="Name4">
              <dgm:if name="Name5" axis="ch" ptType="node" func="cnt" op="gte" val="1">
                <dgm:constrLst>
                  <dgm:constr type="w" for="ch" forName="parentTextBox" refType="w"/>
                  <dgm:constr type="h" for="ch" forName="parentTextBox" refType="h" fact="0.54"/>
                  <dgm:constr type="t" for="ch" forName="parentTextBox"/>
                  <dgm:constr type="w" for="ch" forName="entireBox" refType="w"/>
                  <dgm:constr type="h" for="ch" forName="entireBox" refType="h"/>
                  <dgm:constr type="w" for="ch" forName="descendantBox" refType="w"/>
                  <dgm:constr type="b" for="ch" forName="descendantBox" refType="h" fact="0.98"/>
                  <dgm:constr type="h" for="ch" forName="descendantBox" refType="h" fact="0.46"/>
                </dgm:constrLst>
              </dgm:if>
              <dgm:else name="Name6">
                <dgm:constrLst>
                  <dgm:constr type="w" for="ch" forName="parentTextBox" refType="w"/>
                  <dgm:constr type="h" for="ch" forName="parentTextBox" refType="h"/>
                </dgm:constrLst>
              </dgm:else>
            </dgm:choose>
            <dgm:ruleLst/>
            <dgm:layoutNode name="parentTextBox">
              <dgm:alg type="tx"/>
              <dgm:choose name="Name7">
                <dgm:if name="Name8" axis="ch" ptType="node" func="cnt" op="gte" val="1">
                  <dgm:shape xmlns:r="http://schemas.openxmlformats.org/officeDocument/2006/relationships" type="rect" r:blip="" zOrderOff="1" hideGeom="1">
                    <dgm:adjLst/>
                  </dgm:shape>
                </dgm:if>
                <dgm:else name="Name9">
                  <dgm:shape xmlns:r="http://schemas.openxmlformats.org/officeDocument/2006/relationships" type="rect" r:blip="">
                    <dgm:adjLst/>
                  </dgm:shape>
                </dgm:else>
              </dgm:choose>
              <dgm:presOf axis="self"/>
              <dgm:constrLst/>
              <dgm:ruleLst>
                <dgm:rule type="primFontSz" val="5" fact="NaN" max="NaN"/>
              </dgm:ruleLst>
            </dgm:layoutNode>
            <dgm:choose name="Name10">
              <dgm:if name="Name11" axis="ch" ptType="node" func="cnt" op="gte" val="1">
                <dgm:layoutNode name="entireBox">
                  <dgm:alg type="sp"/>
                  <dgm:shape xmlns:r="http://schemas.openxmlformats.org/officeDocument/2006/relationships" type="rect" r:blip="">
                    <dgm:adjLst/>
                  </dgm:shape>
                  <dgm:presOf axis="self"/>
                  <dgm:constrLst/>
                  <dgm:ruleLst/>
                </dgm:layoutNode>
                <dgm:layoutNode name="descendantBox" styleLbl="fgAccFollowNode1">
                  <dgm:choose name="Name12">
                    <dgm:if name="Name13" func="var" arg="dir" op="equ" val="norm">
                      <dgm:alg type="lin"/>
                    </dgm:if>
                    <dgm:else name="Name14">
                      <dgm:alg type="lin">
                        <dgm:param type="linDir" val="fromR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w" for="ch" forName="childTextBox" refType="w"/>
                    <dgm:constr type="h" for="ch" forName="childTextBox" refType="h"/>
                  </dgm:constrLst>
                  <dgm:ruleLst/>
                  <dgm:forEach name="Name15" axis="ch" ptType="node">
                    <dgm:layoutNode name="childTextBox" styleLbl="fgAccFollowNode1">
                      <dgm:varLst>
                        <dgm:bulletEnabled val="1"/>
                      </dgm:varLst>
                      <dgm:alg type="tx"/>
                      <dgm:shape xmlns:r="http://schemas.openxmlformats.org/officeDocument/2006/relationships" type="rect" r:blip="">
                        <dgm:adjLst/>
                      </dgm:shape>
                      <dgm:presOf axis="desOrSelf" ptType="node"/>
                      <dgm:constrLst>
                        <dgm:constr type="tMarg" refType="primFontSz" fact="0.1"/>
                        <dgm:constr type="bMarg" refType="primFontSz" fact="0.1"/>
                      </dgm:constrLst>
                      <dgm:ruleLst>
                        <dgm:rule type="primFontSz" val="5" fact="NaN" max="NaN"/>
                      </dgm:ruleLst>
                    </dgm:layoutNode>
                  </dgm:forEach>
                </dgm:layoutNode>
              </dgm:if>
              <dgm:else name="Name16"/>
            </dgm:choose>
          </dgm:layoutNode>
        </dgm:if>
        <dgm:else name="Name17">
          <dgm:layoutNode name="arrowAndChildren">
            <dgm:alg type="composite"/>
            <dgm:shape xmlns:r="http://schemas.openxmlformats.org/officeDocument/2006/relationships" r:blip="">
              <dgm:adjLst/>
            </dgm:shape>
            <dgm:presOf/>
            <dgm:choose name="Name18">
              <dgm:if name="Name19" axis="ch" ptType="node" func="cnt" op="gte" val="1">
                <dgm:constrLst>
                  <dgm:constr type="w" for="ch" forName="parentTextArrow" refType="w"/>
                  <dgm:constr type="t" for="ch" forName="parentTextArrow"/>
                  <dgm:constr type="h" for="ch" forName="parentTextArrow" refType="h" fact="0.351"/>
                  <dgm:constr type="w" for="ch" forName="arrow" refType="w"/>
                  <dgm:constr type="h" for="ch" forName="arrow" refType="h"/>
                  <dgm:constr type="w" for="ch" forName="descendantArrow" refType="w"/>
                  <dgm:constr type="b" for="ch" forName="descendantArrow" refType="h" fact="0.65"/>
                  <dgm:constr type="h" for="ch" forName="descendantArrow" refType="h" fact="0.299"/>
                </dgm:constrLst>
              </dgm:if>
              <dgm:else name="Name20">
                <dgm:constrLst>
                  <dgm:constr type="w" for="ch" forName="parentTextArrow" refType="w"/>
                  <dgm:constr type="h" for="ch" forName="parentTextArrow" refType="h"/>
                </dgm:constrLst>
              </dgm:else>
            </dgm:choose>
            <dgm:ruleLst/>
            <dgm:layoutNode name="parentTextArrow">
              <dgm:alg type="tx"/>
              <dgm:choose name="Name21">
                <dgm:if name="Name22" axis="ch" ptType="node" func="cnt" op="gte" val="1">
                  <dgm:shape xmlns:r="http://schemas.openxmlformats.org/officeDocument/2006/relationships" type="rect" r:blip="" zOrderOff="1" hideGeom="1">
                    <dgm:adjLst/>
                  </dgm:shape>
                </dgm:if>
                <dgm:else name="Name23">
                  <dgm:shape xmlns:r="http://schemas.openxmlformats.org/officeDocument/2006/relationships" rot="180" type="upArrowCallout" r:blip="">
                    <dgm:adjLst/>
                  </dgm:shape>
                </dgm:else>
              </dgm:choose>
              <dgm:presOf axis="self"/>
              <dgm:constrLst/>
              <dgm:ruleLst>
                <dgm:rule type="primFontSz" val="5" fact="NaN" max="NaN"/>
              </dgm:ruleLst>
            </dgm:layoutNode>
            <dgm:choose name="Name24">
              <dgm:if name="Name25" axis="ch" ptType="node" func="cnt" op="gte" val="1">
                <dgm:layoutNode name="arrow">
                  <dgm:alg type="sp"/>
                  <dgm:shape xmlns:r="http://schemas.openxmlformats.org/officeDocument/2006/relationships" rot="180" type="upArrowCallout" r:blip="">
                    <dgm:adjLst/>
                  </dgm:shape>
                  <dgm:presOf axis="self"/>
                  <dgm:constrLst/>
                  <dgm:ruleLst/>
                </dgm:layoutNode>
                <dgm:layoutNode name="descendantArrow">
                  <dgm:choose name="Name26">
                    <dgm:if name="Name27" func="var" arg="dir" op="equ" val="norm">
                      <dgm:alg type="lin"/>
                    </dgm:if>
                    <dgm:else name="Name28">
                      <dgm:alg type="lin">
                        <dgm:param type="linDir" val="fromR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w" for="ch" forName="childTextArrow" refType="w"/>
                    <dgm:constr type="h" for="ch" forName="childTextArrow" refType="h"/>
                  </dgm:constrLst>
                  <dgm:ruleLst/>
                  <dgm:forEach name="Name29" axis="ch" ptType="node">
                    <dgm:layoutNode name="childTextArrow" styleLbl="fgAccFollowNode1">
                      <dgm:varLst>
                        <dgm:bulletEnabled val="1"/>
                      </dgm:varLst>
                      <dgm:alg type="tx"/>
                      <dgm:shape xmlns:r="http://schemas.openxmlformats.org/officeDocument/2006/relationships" type="rect" r:blip="">
                        <dgm:adjLst/>
                      </dgm:shape>
                      <dgm:presOf axis="desOrSelf" ptType="node"/>
                      <dgm:constrLst>
                        <dgm:constr type="tMarg" refType="primFontSz" fact="0.1"/>
                        <dgm:constr type="bMarg" refType="primFontSz" fact="0.1"/>
                      </dgm:constrLst>
                      <dgm:ruleLst>
                        <dgm:rule type="primFontSz" val="5" fact="NaN" max="NaN"/>
                      </dgm:ruleLst>
                    </dgm:layoutNode>
                  </dgm:forEach>
                </dgm:layoutNode>
              </dgm:if>
              <dgm:else name="Name30"/>
            </dgm:choose>
          </dgm:layoutNode>
        </dgm:else>
      </dgm:choose>
      <dgm:forEach name="Name31" axis="precedSib" ptType="sibTrans" st="-1" cnt="1">
        <dgm:layoutNode name="sp">
          <dgm:alg type="sp"/>
          <dgm:shape xmlns:r="http://schemas.openxmlformats.org/officeDocument/2006/relationships" r:blip="">
            <dgm:adjLst/>
          </dgm:shape>
          <dgm:presOf axis="self"/>
          <dgm:constrLst/>
          <dgm:ruleLst/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process4">
  <dgm:title val=""/>
  <dgm:desc val=""/>
  <dgm:catLst>
    <dgm:cat type="process" pri="16000"/>
    <dgm:cat type="list" pri="20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Name0">
    <dgm:varLst>
      <dgm:dir/>
      <dgm:animLvl val="lvl"/>
      <dgm:resizeHandles val="exact"/>
    </dgm:varLst>
    <dgm:alg type="lin">
      <dgm:param type="linDir" val="fromB"/>
    </dgm:alg>
    <dgm:shape xmlns:r="http://schemas.openxmlformats.org/officeDocument/2006/relationships" r:blip="">
      <dgm:adjLst/>
    </dgm:shape>
    <dgm:presOf/>
    <dgm:constrLst>
      <dgm:constr type="h" for="ch" forName="boxAndChildren" refType="h"/>
      <dgm:constr type="h" for="ch" forName="arrowAndChildren" refType="h" refFor="ch" refForName="boxAndChildren" op="equ" fact="1.538"/>
      <dgm:constr type="w" for="ch" forName="arrowAndChildren" refType="w"/>
      <dgm:constr type="w" for="ch" forName="boxAndChildren" refType="w"/>
      <dgm:constr type="h" for="ch" forName="sp" refType="h" fact="-0.015"/>
      <dgm:constr type="primFontSz" for="des" forName="parentTextBox" val="65"/>
      <dgm:constr type="primFontSz" for="des" forName="parentTextArrow" refType="primFontSz" refFor="des" refForName="parentTextBox" op="equ"/>
      <dgm:constr type="primFontSz" for="des" forName="childTextArrow" val="65"/>
      <dgm:constr type="primFontSz" for="des" forName="childTextBox" refType="primFontSz" refFor="des" refForName="childTextArrow" op="equ"/>
    </dgm:constrLst>
    <dgm:ruleLst/>
    <dgm:forEach name="Name1" axis="ch" ptType="node" st="-1" step="-1">
      <dgm:choose name="Name2">
        <dgm:if name="Name3" axis="self" ptType="node" func="revPos" op="equ" val="1">
          <dgm:layoutNode name="boxAndChildren">
            <dgm:alg type="composite"/>
            <dgm:shape xmlns:r="http://schemas.openxmlformats.org/officeDocument/2006/relationships" r:blip="">
              <dgm:adjLst/>
            </dgm:shape>
            <dgm:presOf/>
            <dgm:choose name="Name4">
              <dgm:if name="Name5" axis="ch" ptType="node" func="cnt" op="gte" val="1">
                <dgm:constrLst>
                  <dgm:constr type="w" for="ch" forName="parentTextBox" refType="w"/>
                  <dgm:constr type="h" for="ch" forName="parentTextBox" refType="h" fact="0.54"/>
                  <dgm:constr type="t" for="ch" forName="parentTextBox"/>
                  <dgm:constr type="w" for="ch" forName="entireBox" refType="w"/>
                  <dgm:constr type="h" for="ch" forName="entireBox" refType="h"/>
                  <dgm:constr type="w" for="ch" forName="descendantBox" refType="w"/>
                  <dgm:constr type="b" for="ch" forName="descendantBox" refType="h" fact="0.98"/>
                  <dgm:constr type="h" for="ch" forName="descendantBox" refType="h" fact="0.46"/>
                </dgm:constrLst>
              </dgm:if>
              <dgm:else name="Name6">
                <dgm:constrLst>
                  <dgm:constr type="w" for="ch" forName="parentTextBox" refType="w"/>
                  <dgm:constr type="h" for="ch" forName="parentTextBox" refType="h"/>
                </dgm:constrLst>
              </dgm:else>
            </dgm:choose>
            <dgm:ruleLst/>
            <dgm:layoutNode name="parentTextBox">
              <dgm:alg type="tx"/>
              <dgm:choose name="Name7">
                <dgm:if name="Name8" axis="ch" ptType="node" func="cnt" op="gte" val="1">
                  <dgm:shape xmlns:r="http://schemas.openxmlformats.org/officeDocument/2006/relationships" type="rect" r:blip="" zOrderOff="1" hideGeom="1">
                    <dgm:adjLst/>
                  </dgm:shape>
                </dgm:if>
                <dgm:else name="Name9">
                  <dgm:shape xmlns:r="http://schemas.openxmlformats.org/officeDocument/2006/relationships" type="rect" r:blip="">
                    <dgm:adjLst/>
                  </dgm:shape>
                </dgm:else>
              </dgm:choose>
              <dgm:presOf axis="self"/>
              <dgm:constrLst/>
              <dgm:ruleLst>
                <dgm:rule type="primFontSz" val="5" fact="NaN" max="NaN"/>
              </dgm:ruleLst>
            </dgm:layoutNode>
            <dgm:choose name="Name10">
              <dgm:if name="Name11" axis="ch" ptType="node" func="cnt" op="gte" val="1">
                <dgm:layoutNode name="entireBox">
                  <dgm:alg type="sp"/>
                  <dgm:shape xmlns:r="http://schemas.openxmlformats.org/officeDocument/2006/relationships" type="rect" r:blip="">
                    <dgm:adjLst/>
                  </dgm:shape>
                  <dgm:presOf axis="self"/>
                  <dgm:constrLst/>
                  <dgm:ruleLst/>
                </dgm:layoutNode>
                <dgm:layoutNode name="descendantBox" styleLbl="fgAccFollowNode1">
                  <dgm:choose name="Name12">
                    <dgm:if name="Name13" func="var" arg="dir" op="equ" val="norm">
                      <dgm:alg type="lin"/>
                    </dgm:if>
                    <dgm:else name="Name14">
                      <dgm:alg type="lin">
                        <dgm:param type="linDir" val="fromR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w" for="ch" forName="childTextBox" refType="w"/>
                    <dgm:constr type="h" for="ch" forName="childTextBox" refType="h"/>
                  </dgm:constrLst>
                  <dgm:ruleLst/>
                  <dgm:forEach name="Name15" axis="ch" ptType="node">
                    <dgm:layoutNode name="childTextBox" styleLbl="fgAccFollowNode1">
                      <dgm:varLst>
                        <dgm:bulletEnabled val="1"/>
                      </dgm:varLst>
                      <dgm:alg type="tx"/>
                      <dgm:shape xmlns:r="http://schemas.openxmlformats.org/officeDocument/2006/relationships" type="rect" r:blip="">
                        <dgm:adjLst/>
                      </dgm:shape>
                      <dgm:presOf axis="desOrSelf" ptType="node"/>
                      <dgm:constrLst>
                        <dgm:constr type="tMarg" refType="primFontSz" fact="0.1"/>
                        <dgm:constr type="bMarg" refType="primFontSz" fact="0.1"/>
                      </dgm:constrLst>
                      <dgm:ruleLst>
                        <dgm:rule type="primFontSz" val="5" fact="NaN" max="NaN"/>
                      </dgm:ruleLst>
                    </dgm:layoutNode>
                  </dgm:forEach>
                </dgm:layoutNode>
              </dgm:if>
              <dgm:else name="Name16"/>
            </dgm:choose>
          </dgm:layoutNode>
        </dgm:if>
        <dgm:else name="Name17">
          <dgm:layoutNode name="arrowAndChildren">
            <dgm:alg type="composite"/>
            <dgm:shape xmlns:r="http://schemas.openxmlformats.org/officeDocument/2006/relationships" r:blip="">
              <dgm:adjLst/>
            </dgm:shape>
            <dgm:presOf/>
            <dgm:choose name="Name18">
              <dgm:if name="Name19" axis="ch" ptType="node" func="cnt" op="gte" val="1">
                <dgm:constrLst>
                  <dgm:constr type="w" for="ch" forName="parentTextArrow" refType="w"/>
                  <dgm:constr type="t" for="ch" forName="parentTextArrow"/>
                  <dgm:constr type="h" for="ch" forName="parentTextArrow" refType="h" fact="0.351"/>
                  <dgm:constr type="w" for="ch" forName="arrow" refType="w"/>
                  <dgm:constr type="h" for="ch" forName="arrow" refType="h"/>
                  <dgm:constr type="w" for="ch" forName="descendantArrow" refType="w"/>
                  <dgm:constr type="b" for="ch" forName="descendantArrow" refType="h" fact="0.65"/>
                  <dgm:constr type="h" for="ch" forName="descendantArrow" refType="h" fact="0.299"/>
                </dgm:constrLst>
              </dgm:if>
              <dgm:else name="Name20">
                <dgm:constrLst>
                  <dgm:constr type="w" for="ch" forName="parentTextArrow" refType="w"/>
                  <dgm:constr type="h" for="ch" forName="parentTextArrow" refType="h"/>
                </dgm:constrLst>
              </dgm:else>
            </dgm:choose>
            <dgm:ruleLst/>
            <dgm:layoutNode name="parentTextArrow">
              <dgm:alg type="tx"/>
              <dgm:choose name="Name21">
                <dgm:if name="Name22" axis="ch" ptType="node" func="cnt" op="gte" val="1">
                  <dgm:shape xmlns:r="http://schemas.openxmlformats.org/officeDocument/2006/relationships" type="rect" r:blip="" zOrderOff="1" hideGeom="1">
                    <dgm:adjLst/>
                  </dgm:shape>
                </dgm:if>
                <dgm:else name="Name23">
                  <dgm:shape xmlns:r="http://schemas.openxmlformats.org/officeDocument/2006/relationships" rot="180" type="upArrowCallout" r:blip="">
                    <dgm:adjLst/>
                  </dgm:shape>
                </dgm:else>
              </dgm:choose>
              <dgm:presOf axis="self"/>
              <dgm:constrLst/>
              <dgm:ruleLst>
                <dgm:rule type="primFontSz" val="5" fact="NaN" max="NaN"/>
              </dgm:ruleLst>
            </dgm:layoutNode>
            <dgm:choose name="Name24">
              <dgm:if name="Name25" axis="ch" ptType="node" func="cnt" op="gte" val="1">
                <dgm:layoutNode name="arrow">
                  <dgm:alg type="sp"/>
                  <dgm:shape xmlns:r="http://schemas.openxmlformats.org/officeDocument/2006/relationships" rot="180" type="upArrowCallout" r:blip="">
                    <dgm:adjLst/>
                  </dgm:shape>
                  <dgm:presOf axis="self"/>
                  <dgm:constrLst/>
                  <dgm:ruleLst/>
                </dgm:layoutNode>
                <dgm:layoutNode name="descendantArrow">
                  <dgm:choose name="Name26">
                    <dgm:if name="Name27" func="var" arg="dir" op="equ" val="norm">
                      <dgm:alg type="lin"/>
                    </dgm:if>
                    <dgm:else name="Name28">
                      <dgm:alg type="lin">
                        <dgm:param type="linDir" val="fromR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w" for="ch" forName="childTextArrow" refType="w"/>
                    <dgm:constr type="h" for="ch" forName="childTextArrow" refType="h"/>
                  </dgm:constrLst>
                  <dgm:ruleLst/>
                  <dgm:forEach name="Name29" axis="ch" ptType="node">
                    <dgm:layoutNode name="childTextArrow" styleLbl="fgAccFollowNode1">
                      <dgm:varLst>
                        <dgm:bulletEnabled val="1"/>
                      </dgm:varLst>
                      <dgm:alg type="tx"/>
                      <dgm:shape xmlns:r="http://schemas.openxmlformats.org/officeDocument/2006/relationships" type="rect" r:blip="">
                        <dgm:adjLst/>
                      </dgm:shape>
                      <dgm:presOf axis="desOrSelf" ptType="node"/>
                      <dgm:constrLst>
                        <dgm:constr type="tMarg" refType="primFontSz" fact="0.1"/>
                        <dgm:constr type="bMarg" refType="primFontSz" fact="0.1"/>
                      </dgm:constrLst>
                      <dgm:ruleLst>
                        <dgm:rule type="primFontSz" val="5" fact="NaN" max="NaN"/>
                      </dgm:ruleLst>
                    </dgm:layoutNode>
                  </dgm:forEach>
                </dgm:layoutNode>
              </dgm:if>
              <dgm:else name="Name30"/>
            </dgm:choose>
          </dgm:layoutNode>
        </dgm:else>
      </dgm:choose>
      <dgm:forEach name="Name31" axis="precedSib" ptType="sibTrans" st="-1" cnt="1">
        <dgm:layoutNode name="sp">
          <dgm:alg type="sp"/>
          <dgm:shape xmlns:r="http://schemas.openxmlformats.org/officeDocument/2006/relationships" r:blip="">
            <dgm:adjLst/>
          </dgm:shape>
          <dgm:presOf axis="self"/>
          <dgm:constrLst/>
          <dgm:ruleLst/>
        </dgm:layoutNode>
      </dgm:forEach>
    </dgm:forEach>
  </dgm:layoutNode>
</dgm:layoutDef>
</file>

<file path=ppt/diagrams/layout3.xml><?xml version="1.0" encoding="utf-8"?>
<dgm:layoutDef xmlns:dgm="http://schemas.openxmlformats.org/drawingml/2006/diagram" xmlns:a="http://schemas.openxmlformats.org/drawingml/2006/main" uniqueId="urn:microsoft.com/office/officeart/2005/8/layout/list1">
  <dgm:title val=""/>
  <dgm:desc val=""/>
  <dgm:catLst>
    <dgm:cat type="list" pri="4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4" srcId="0" destId="1" srcOrd="0" destOrd="0"/>
        <dgm:cxn modelId="5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linear">
    <dgm:varLst>
      <dgm:dir/>
      <dgm:animLvl val="lvl"/>
      <dgm:resizeHandles val="exact"/>
    </dgm:varLst>
    <dgm:choose name="Name0">
      <dgm:if name="Name1" func="var" arg="dir" op="equ" val="norm">
        <dgm:alg type="lin">
          <dgm:param type="linDir" val="fromT"/>
          <dgm:param type="vertAlign" val="mid"/>
          <dgm:param type="horzAlign" val="l"/>
          <dgm:param type="nodeHorzAlign" val="l"/>
        </dgm:alg>
      </dgm:if>
      <dgm:else name="Name2">
        <dgm:alg type="lin">
          <dgm:param type="linDir" val="fromT"/>
          <dgm:param type="vertAlign" val="mid"/>
          <dgm:param type="horzAlign" val="r"/>
          <dgm:param type="nodeHorzAlign" val="r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parentLin" refType="w"/>
      <dgm:constr type="h" for="ch" forName="parentLin" val="INF"/>
      <dgm:constr type="w" for="des" forName="parentLeftMargin" refType="w" fact="0.05"/>
      <dgm:constr type="w" for="des" forName="parentText" refType="w" fact="0.7"/>
      <dgm:constr type="h" for="des" forName="parentText" refType="primFontSz" refFor="des" refForName="parentText" fact="0.82"/>
      <dgm:constr type="h" for="ch" forName="negativeSpace" refType="primFontSz" refFor="des" refForName="parentText" fact="-0.41"/>
      <dgm:constr type="h" for="ch" forName="negativeSpace" refType="h" refFor="des" refForName="parentText" op="lte" fact="-0.82"/>
      <dgm:constr type="h" for="ch" forName="negativeSpace" refType="h" refFor="des" refForName="parentText" op="gte" fact="-0.82"/>
      <dgm:constr type="w" for="ch" forName="childText" refType="w"/>
      <dgm:constr type="h" for="ch" forName="childText" refType="primFontSz" refFor="des" refForName="parentText" fact="0.7"/>
      <dgm:constr type="primFontSz" for="des" forName="parentText" val="65"/>
      <dgm:constr type="primFontSz" for="ch" forName="childText" refType="primFontSz" refFor="des" refForName="parentText"/>
      <dgm:constr type="tMarg" for="ch" forName="childText" refType="primFontSz" refFor="des" refForName="parentText" fact="1.64"/>
      <dgm:constr type="tMarg" for="ch" forName="childText" refType="h" refFor="des" refForName="parentText" op="lte" fact="3.28"/>
      <dgm:constr type="tMarg" for="ch" forName="childText" refType="h" refFor="des" refForName="parentText" op="gte" fact="3.28"/>
      <dgm:constr type="lMarg" for="ch" forName="childText" refType="w" fact="0.22"/>
      <dgm:constr type="rMarg" for="ch" forName="childText" refType="lMarg" refFor="ch" refForName="childText"/>
      <dgm:constr type="lMarg" for="des" forName="parentText" refType="w" fact="0.075"/>
      <dgm:constr type="rMarg" for="des" forName="parentText" refType="lMarg" refFor="des" refForName="parentText"/>
      <dgm:constr type="h" for="ch" forName="spaceBetweenRectangles" refType="primFontSz" refFor="des" refForName="parentText" fact="0.15"/>
    </dgm:constrLst>
    <dgm:ruleLst>
      <dgm:rule type="primFontSz" for="des" forName="parentText" val="5" fact="NaN" max="NaN"/>
    </dgm:ruleLst>
    <dgm:forEach name="Name3" axis="ch" ptType="node">
      <dgm:layoutNode name="parentLin">
        <dgm:choose name="Name4">
          <dgm:if name="Name5" func="var" arg="dir" op="equ" val="norm">
            <dgm:alg type="lin">
              <dgm:param type="linDir" val="fromL"/>
              <dgm:param type="horzAlign" val="l"/>
              <dgm:param type="nodeHorzAlign" val="l"/>
            </dgm:alg>
          </dgm:if>
          <dgm:else name="Name6">
            <dgm:alg type="lin">
              <dgm:param type="linDir" val="fromR"/>
              <dgm:param type="horzAlign" val="r"/>
              <dgm:param type="nodeHorzAlign" val="r"/>
            </dgm:alg>
          </dgm:else>
        </dgm:choose>
        <dgm:shape xmlns:r="http://schemas.openxmlformats.org/officeDocument/2006/relationships" r:blip="">
          <dgm:adjLst/>
        </dgm:shape>
        <dgm:presOf/>
        <dgm:constrLst/>
        <dgm:ruleLst/>
        <dgm:layoutNode name="parentLeftMargin">
          <dgm:alg type="sp"/>
          <dgm:shape xmlns:r="http://schemas.openxmlformats.org/officeDocument/2006/relationships" type="rect" r:blip="" hideGeom="1">
            <dgm:adjLst/>
          </dgm:shape>
          <dgm:presOf axis="self"/>
          <dgm:constrLst>
            <dgm:constr type="h"/>
          </dgm:constrLst>
          <dgm:ruleLst/>
        </dgm:layoutNode>
        <dgm:layoutNode name="parentText" styleLbl="node1">
          <dgm:varLst>
            <dgm:chMax val="0"/>
            <dgm:bulletEnabled val="1"/>
          </dgm:varLst>
          <dgm:choose name="Name7">
            <dgm:if name="Name8" func="var" arg="dir" op="equ" val="norm">
              <dgm:alg type="tx">
                <dgm:param type="parTxLTRAlign" val="l"/>
                <dgm:param type="parTxRTLAlign" val="l"/>
              </dgm:alg>
            </dgm:if>
            <dgm:else name="Name9">
              <dgm:alg type="tx">
                <dgm:param type="parTxLTRAlign" val="r"/>
                <dgm:param type="parTxRTLAlign" val="r"/>
              </dgm:alg>
            </dgm:else>
          </dgm:choose>
          <dgm:shape xmlns:r="http://schemas.openxmlformats.org/officeDocument/2006/relationships" type="roundRect" r:blip="">
            <dgm:adjLst/>
          </dgm:shape>
          <dgm:presOf axis="self" ptType="node"/>
          <dgm:constrLst>
            <dgm:constr type="tMarg"/>
            <dgm:constr type="bMarg"/>
          </dgm:constrLst>
          <dgm:ruleLst/>
        </dgm:layoutNode>
      </dgm:layoutNode>
      <dgm:layoutNode name="negativeSpace">
        <dgm:alg type="sp"/>
        <dgm:shape xmlns:r="http://schemas.openxmlformats.org/officeDocument/2006/relationships" r:blip="">
          <dgm:adjLst/>
        </dgm:shape>
        <dgm:presOf/>
        <dgm:constrLst/>
        <dgm:ruleLst/>
      </dgm:layoutNode>
      <dgm:layoutNode name="childText" styleLbl="conFgAcc1">
        <dgm:varLst>
          <dgm:bulletEnabled val="1"/>
        </dgm:varLst>
        <dgm:alg type="tx">
          <dgm:param type="stBulletLvl" val="1"/>
        </dgm:alg>
        <dgm:shape xmlns:r="http://schemas.openxmlformats.org/officeDocument/2006/relationships" type="rect" r:blip="" zOrderOff="-2">
          <dgm:adjLst/>
        </dgm:shape>
        <dgm:presOf axis="des" ptType="node"/>
        <dgm:constrLst>
          <dgm:constr type="secFontSz" refType="primFontSz"/>
        </dgm:constrLst>
        <dgm:ruleLst>
          <dgm:rule type="h" val="INF" fact="NaN" max="NaN"/>
        </dgm:ruleLst>
      </dgm:layoutNode>
      <dgm:forEach name="Name10" axis="followSib" ptType="sibTrans" cnt="1">
        <dgm:layoutNode name="spaceBetweenRectangles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layout4.xml><?xml version="1.0" encoding="utf-8"?>
<dgm:layoutDef xmlns:dgm="http://schemas.openxmlformats.org/drawingml/2006/diagram" xmlns:a="http://schemas.openxmlformats.org/drawingml/2006/main" uniqueId="urn:microsoft.com/office/officeart/2005/8/layout/list1">
  <dgm:title val=""/>
  <dgm:desc val=""/>
  <dgm:catLst>
    <dgm:cat type="list" pri="4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4" srcId="0" destId="1" srcOrd="0" destOrd="0"/>
        <dgm:cxn modelId="5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linear">
    <dgm:varLst>
      <dgm:dir/>
      <dgm:animLvl val="lvl"/>
      <dgm:resizeHandles val="exact"/>
    </dgm:varLst>
    <dgm:choose name="Name0">
      <dgm:if name="Name1" func="var" arg="dir" op="equ" val="norm">
        <dgm:alg type="lin">
          <dgm:param type="linDir" val="fromT"/>
          <dgm:param type="vertAlign" val="mid"/>
          <dgm:param type="horzAlign" val="l"/>
          <dgm:param type="nodeHorzAlign" val="l"/>
        </dgm:alg>
      </dgm:if>
      <dgm:else name="Name2">
        <dgm:alg type="lin">
          <dgm:param type="linDir" val="fromT"/>
          <dgm:param type="vertAlign" val="mid"/>
          <dgm:param type="horzAlign" val="r"/>
          <dgm:param type="nodeHorzAlign" val="r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parentLin" refType="w"/>
      <dgm:constr type="h" for="ch" forName="parentLin" val="INF"/>
      <dgm:constr type="w" for="des" forName="parentLeftMargin" refType="w" fact="0.05"/>
      <dgm:constr type="w" for="des" forName="parentText" refType="w" fact="0.7"/>
      <dgm:constr type="h" for="des" forName="parentText" refType="primFontSz" refFor="des" refForName="parentText" fact="0.82"/>
      <dgm:constr type="h" for="ch" forName="negativeSpace" refType="primFontSz" refFor="des" refForName="parentText" fact="-0.41"/>
      <dgm:constr type="h" for="ch" forName="negativeSpace" refType="h" refFor="des" refForName="parentText" op="lte" fact="-0.82"/>
      <dgm:constr type="h" for="ch" forName="negativeSpace" refType="h" refFor="des" refForName="parentText" op="gte" fact="-0.82"/>
      <dgm:constr type="w" for="ch" forName="childText" refType="w"/>
      <dgm:constr type="h" for="ch" forName="childText" refType="primFontSz" refFor="des" refForName="parentText" fact="0.7"/>
      <dgm:constr type="primFontSz" for="des" forName="parentText" val="65"/>
      <dgm:constr type="primFontSz" for="ch" forName="childText" refType="primFontSz" refFor="des" refForName="parentText"/>
      <dgm:constr type="tMarg" for="ch" forName="childText" refType="primFontSz" refFor="des" refForName="parentText" fact="1.64"/>
      <dgm:constr type="tMarg" for="ch" forName="childText" refType="h" refFor="des" refForName="parentText" op="lte" fact="3.28"/>
      <dgm:constr type="tMarg" for="ch" forName="childText" refType="h" refFor="des" refForName="parentText" op="gte" fact="3.28"/>
      <dgm:constr type="lMarg" for="ch" forName="childText" refType="w" fact="0.22"/>
      <dgm:constr type="rMarg" for="ch" forName="childText" refType="lMarg" refFor="ch" refForName="childText"/>
      <dgm:constr type="lMarg" for="des" forName="parentText" refType="w" fact="0.075"/>
      <dgm:constr type="rMarg" for="des" forName="parentText" refType="lMarg" refFor="des" refForName="parentText"/>
      <dgm:constr type="h" for="ch" forName="spaceBetweenRectangles" refType="primFontSz" refFor="des" refForName="parentText" fact="0.15"/>
    </dgm:constrLst>
    <dgm:ruleLst>
      <dgm:rule type="primFontSz" for="des" forName="parentText" val="5" fact="NaN" max="NaN"/>
    </dgm:ruleLst>
    <dgm:forEach name="Name3" axis="ch" ptType="node">
      <dgm:layoutNode name="parentLin">
        <dgm:choose name="Name4">
          <dgm:if name="Name5" func="var" arg="dir" op="equ" val="norm">
            <dgm:alg type="lin">
              <dgm:param type="linDir" val="fromL"/>
              <dgm:param type="horzAlign" val="l"/>
              <dgm:param type="nodeHorzAlign" val="l"/>
            </dgm:alg>
          </dgm:if>
          <dgm:else name="Name6">
            <dgm:alg type="lin">
              <dgm:param type="linDir" val="fromR"/>
              <dgm:param type="horzAlign" val="r"/>
              <dgm:param type="nodeHorzAlign" val="r"/>
            </dgm:alg>
          </dgm:else>
        </dgm:choose>
        <dgm:shape xmlns:r="http://schemas.openxmlformats.org/officeDocument/2006/relationships" r:blip="">
          <dgm:adjLst/>
        </dgm:shape>
        <dgm:presOf/>
        <dgm:constrLst/>
        <dgm:ruleLst/>
        <dgm:layoutNode name="parentLeftMargin">
          <dgm:alg type="sp"/>
          <dgm:shape xmlns:r="http://schemas.openxmlformats.org/officeDocument/2006/relationships" type="rect" r:blip="" hideGeom="1">
            <dgm:adjLst/>
          </dgm:shape>
          <dgm:presOf axis="self"/>
          <dgm:constrLst>
            <dgm:constr type="h"/>
          </dgm:constrLst>
          <dgm:ruleLst/>
        </dgm:layoutNode>
        <dgm:layoutNode name="parentText" styleLbl="node1">
          <dgm:varLst>
            <dgm:chMax val="0"/>
            <dgm:bulletEnabled val="1"/>
          </dgm:varLst>
          <dgm:choose name="Name7">
            <dgm:if name="Name8" func="var" arg="dir" op="equ" val="norm">
              <dgm:alg type="tx">
                <dgm:param type="parTxLTRAlign" val="l"/>
                <dgm:param type="parTxRTLAlign" val="l"/>
              </dgm:alg>
            </dgm:if>
            <dgm:else name="Name9">
              <dgm:alg type="tx">
                <dgm:param type="parTxLTRAlign" val="r"/>
                <dgm:param type="parTxRTLAlign" val="r"/>
              </dgm:alg>
            </dgm:else>
          </dgm:choose>
          <dgm:shape xmlns:r="http://schemas.openxmlformats.org/officeDocument/2006/relationships" type="roundRect" r:blip="">
            <dgm:adjLst/>
          </dgm:shape>
          <dgm:presOf axis="self" ptType="node"/>
          <dgm:constrLst>
            <dgm:constr type="tMarg"/>
            <dgm:constr type="bMarg"/>
          </dgm:constrLst>
          <dgm:ruleLst/>
        </dgm:layoutNode>
      </dgm:layoutNode>
      <dgm:layoutNode name="negativeSpace">
        <dgm:alg type="sp"/>
        <dgm:shape xmlns:r="http://schemas.openxmlformats.org/officeDocument/2006/relationships" r:blip="">
          <dgm:adjLst/>
        </dgm:shape>
        <dgm:presOf/>
        <dgm:constrLst/>
        <dgm:ruleLst/>
      </dgm:layoutNode>
      <dgm:layoutNode name="childText" styleLbl="conFgAcc1">
        <dgm:varLst>
          <dgm:bulletEnabled val="1"/>
        </dgm:varLst>
        <dgm:alg type="tx">
          <dgm:param type="stBulletLvl" val="1"/>
        </dgm:alg>
        <dgm:shape xmlns:r="http://schemas.openxmlformats.org/officeDocument/2006/relationships" type="rect" r:blip="" zOrderOff="-2">
          <dgm:adjLst/>
        </dgm:shape>
        <dgm:presOf axis="des" ptType="node"/>
        <dgm:constrLst>
          <dgm:constr type="secFontSz" refType="primFontSz"/>
        </dgm:constrLst>
        <dgm:ruleLst>
          <dgm:rule type="h" val="INF" fact="NaN" max="NaN"/>
        </dgm:ruleLst>
      </dgm:layoutNode>
      <dgm:forEach name="Name10" axis="followSib" ptType="sibTrans" cnt="1">
        <dgm:layoutNode name="spaceBetweenRectangles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layout5.xml><?xml version="1.0" encoding="utf-8"?>
<dgm:layoutDef xmlns:dgm="http://schemas.openxmlformats.org/drawingml/2006/diagram" xmlns:a="http://schemas.openxmlformats.org/drawingml/2006/main" uniqueId="urn:microsoft.com/office/officeart/2005/8/layout/process4">
  <dgm:title val=""/>
  <dgm:desc val=""/>
  <dgm:catLst>
    <dgm:cat type="process" pri="16000"/>
    <dgm:cat type="list" pri="20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Name0">
    <dgm:varLst>
      <dgm:dir/>
      <dgm:animLvl val="lvl"/>
      <dgm:resizeHandles val="exact"/>
    </dgm:varLst>
    <dgm:alg type="lin">
      <dgm:param type="linDir" val="fromB"/>
    </dgm:alg>
    <dgm:shape xmlns:r="http://schemas.openxmlformats.org/officeDocument/2006/relationships" r:blip="">
      <dgm:adjLst/>
    </dgm:shape>
    <dgm:presOf/>
    <dgm:constrLst>
      <dgm:constr type="h" for="ch" forName="boxAndChildren" refType="h"/>
      <dgm:constr type="h" for="ch" forName="arrowAndChildren" refType="h" refFor="ch" refForName="boxAndChildren" op="equ" fact="1.538"/>
      <dgm:constr type="w" for="ch" forName="arrowAndChildren" refType="w"/>
      <dgm:constr type="w" for="ch" forName="boxAndChildren" refType="w"/>
      <dgm:constr type="h" for="ch" forName="sp" refType="h" fact="-0.015"/>
      <dgm:constr type="primFontSz" for="des" forName="parentTextBox" val="65"/>
      <dgm:constr type="primFontSz" for="des" forName="parentTextArrow" refType="primFontSz" refFor="des" refForName="parentTextBox" op="equ"/>
      <dgm:constr type="primFontSz" for="des" forName="childTextArrow" val="65"/>
      <dgm:constr type="primFontSz" for="des" forName="childTextBox" refType="primFontSz" refFor="des" refForName="childTextArrow" op="equ"/>
    </dgm:constrLst>
    <dgm:ruleLst/>
    <dgm:forEach name="Name1" axis="ch" ptType="node" st="-1" step="-1">
      <dgm:choose name="Name2">
        <dgm:if name="Name3" axis="self" ptType="node" func="revPos" op="equ" val="1">
          <dgm:layoutNode name="boxAndChildren">
            <dgm:alg type="composite"/>
            <dgm:shape xmlns:r="http://schemas.openxmlformats.org/officeDocument/2006/relationships" r:blip="">
              <dgm:adjLst/>
            </dgm:shape>
            <dgm:presOf/>
            <dgm:choose name="Name4">
              <dgm:if name="Name5" axis="ch" ptType="node" func="cnt" op="gte" val="1">
                <dgm:constrLst>
                  <dgm:constr type="w" for="ch" forName="parentTextBox" refType="w"/>
                  <dgm:constr type="h" for="ch" forName="parentTextBox" refType="h" fact="0.54"/>
                  <dgm:constr type="t" for="ch" forName="parentTextBox"/>
                  <dgm:constr type="w" for="ch" forName="entireBox" refType="w"/>
                  <dgm:constr type="h" for="ch" forName="entireBox" refType="h"/>
                  <dgm:constr type="w" for="ch" forName="descendantBox" refType="w"/>
                  <dgm:constr type="b" for="ch" forName="descendantBox" refType="h" fact="0.98"/>
                  <dgm:constr type="h" for="ch" forName="descendantBox" refType="h" fact="0.46"/>
                </dgm:constrLst>
              </dgm:if>
              <dgm:else name="Name6">
                <dgm:constrLst>
                  <dgm:constr type="w" for="ch" forName="parentTextBox" refType="w"/>
                  <dgm:constr type="h" for="ch" forName="parentTextBox" refType="h"/>
                </dgm:constrLst>
              </dgm:else>
            </dgm:choose>
            <dgm:ruleLst/>
            <dgm:layoutNode name="parentTextBox">
              <dgm:alg type="tx"/>
              <dgm:choose name="Name7">
                <dgm:if name="Name8" axis="ch" ptType="node" func="cnt" op="gte" val="1">
                  <dgm:shape xmlns:r="http://schemas.openxmlformats.org/officeDocument/2006/relationships" type="rect" r:blip="" zOrderOff="1" hideGeom="1">
                    <dgm:adjLst/>
                  </dgm:shape>
                </dgm:if>
                <dgm:else name="Name9">
                  <dgm:shape xmlns:r="http://schemas.openxmlformats.org/officeDocument/2006/relationships" type="rect" r:blip="">
                    <dgm:adjLst/>
                  </dgm:shape>
                </dgm:else>
              </dgm:choose>
              <dgm:presOf axis="self"/>
              <dgm:constrLst/>
              <dgm:ruleLst>
                <dgm:rule type="primFontSz" val="5" fact="NaN" max="NaN"/>
              </dgm:ruleLst>
            </dgm:layoutNode>
            <dgm:choose name="Name10">
              <dgm:if name="Name11" axis="ch" ptType="node" func="cnt" op="gte" val="1">
                <dgm:layoutNode name="entireBox">
                  <dgm:alg type="sp"/>
                  <dgm:shape xmlns:r="http://schemas.openxmlformats.org/officeDocument/2006/relationships" type="rect" r:blip="">
                    <dgm:adjLst/>
                  </dgm:shape>
                  <dgm:presOf axis="self"/>
                  <dgm:constrLst/>
                  <dgm:ruleLst/>
                </dgm:layoutNode>
                <dgm:layoutNode name="descendantBox" styleLbl="fgAccFollowNode1">
                  <dgm:choose name="Name12">
                    <dgm:if name="Name13" func="var" arg="dir" op="equ" val="norm">
                      <dgm:alg type="lin"/>
                    </dgm:if>
                    <dgm:else name="Name14">
                      <dgm:alg type="lin">
                        <dgm:param type="linDir" val="fromR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w" for="ch" forName="childTextBox" refType="w"/>
                    <dgm:constr type="h" for="ch" forName="childTextBox" refType="h"/>
                  </dgm:constrLst>
                  <dgm:ruleLst/>
                  <dgm:forEach name="Name15" axis="ch" ptType="node">
                    <dgm:layoutNode name="childTextBox" styleLbl="fgAccFollowNode1">
                      <dgm:varLst>
                        <dgm:bulletEnabled val="1"/>
                      </dgm:varLst>
                      <dgm:alg type="tx"/>
                      <dgm:shape xmlns:r="http://schemas.openxmlformats.org/officeDocument/2006/relationships" type="rect" r:blip="">
                        <dgm:adjLst/>
                      </dgm:shape>
                      <dgm:presOf axis="desOrSelf" ptType="node"/>
                      <dgm:constrLst>
                        <dgm:constr type="tMarg" refType="primFontSz" fact="0.1"/>
                        <dgm:constr type="bMarg" refType="primFontSz" fact="0.1"/>
                      </dgm:constrLst>
                      <dgm:ruleLst>
                        <dgm:rule type="primFontSz" val="5" fact="NaN" max="NaN"/>
                      </dgm:ruleLst>
                    </dgm:layoutNode>
                  </dgm:forEach>
                </dgm:layoutNode>
              </dgm:if>
              <dgm:else name="Name16"/>
            </dgm:choose>
          </dgm:layoutNode>
        </dgm:if>
        <dgm:else name="Name17">
          <dgm:layoutNode name="arrowAndChildren">
            <dgm:alg type="composite"/>
            <dgm:shape xmlns:r="http://schemas.openxmlformats.org/officeDocument/2006/relationships" r:blip="">
              <dgm:adjLst/>
            </dgm:shape>
            <dgm:presOf/>
            <dgm:choose name="Name18">
              <dgm:if name="Name19" axis="ch" ptType="node" func="cnt" op="gte" val="1">
                <dgm:constrLst>
                  <dgm:constr type="w" for="ch" forName="parentTextArrow" refType="w"/>
                  <dgm:constr type="t" for="ch" forName="parentTextArrow"/>
                  <dgm:constr type="h" for="ch" forName="parentTextArrow" refType="h" fact="0.351"/>
                  <dgm:constr type="w" for="ch" forName="arrow" refType="w"/>
                  <dgm:constr type="h" for="ch" forName="arrow" refType="h"/>
                  <dgm:constr type="w" for="ch" forName="descendantArrow" refType="w"/>
                  <dgm:constr type="b" for="ch" forName="descendantArrow" refType="h" fact="0.65"/>
                  <dgm:constr type="h" for="ch" forName="descendantArrow" refType="h" fact="0.299"/>
                </dgm:constrLst>
              </dgm:if>
              <dgm:else name="Name20">
                <dgm:constrLst>
                  <dgm:constr type="w" for="ch" forName="parentTextArrow" refType="w"/>
                  <dgm:constr type="h" for="ch" forName="parentTextArrow" refType="h"/>
                </dgm:constrLst>
              </dgm:else>
            </dgm:choose>
            <dgm:ruleLst/>
            <dgm:layoutNode name="parentTextArrow">
              <dgm:alg type="tx"/>
              <dgm:choose name="Name21">
                <dgm:if name="Name22" axis="ch" ptType="node" func="cnt" op="gte" val="1">
                  <dgm:shape xmlns:r="http://schemas.openxmlformats.org/officeDocument/2006/relationships" type="rect" r:blip="" zOrderOff="1" hideGeom="1">
                    <dgm:adjLst/>
                  </dgm:shape>
                </dgm:if>
                <dgm:else name="Name23">
                  <dgm:shape xmlns:r="http://schemas.openxmlformats.org/officeDocument/2006/relationships" rot="180" type="upArrowCallout" r:blip="">
                    <dgm:adjLst/>
                  </dgm:shape>
                </dgm:else>
              </dgm:choose>
              <dgm:presOf axis="self"/>
              <dgm:constrLst/>
              <dgm:ruleLst>
                <dgm:rule type="primFontSz" val="5" fact="NaN" max="NaN"/>
              </dgm:ruleLst>
            </dgm:layoutNode>
            <dgm:choose name="Name24">
              <dgm:if name="Name25" axis="ch" ptType="node" func="cnt" op="gte" val="1">
                <dgm:layoutNode name="arrow">
                  <dgm:alg type="sp"/>
                  <dgm:shape xmlns:r="http://schemas.openxmlformats.org/officeDocument/2006/relationships" rot="180" type="upArrowCallout" r:blip="">
                    <dgm:adjLst/>
                  </dgm:shape>
                  <dgm:presOf axis="self"/>
                  <dgm:constrLst/>
                  <dgm:ruleLst/>
                </dgm:layoutNode>
                <dgm:layoutNode name="descendantArrow">
                  <dgm:choose name="Name26">
                    <dgm:if name="Name27" func="var" arg="dir" op="equ" val="norm">
                      <dgm:alg type="lin"/>
                    </dgm:if>
                    <dgm:else name="Name28">
                      <dgm:alg type="lin">
                        <dgm:param type="linDir" val="fromR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w" for="ch" forName="childTextArrow" refType="w"/>
                    <dgm:constr type="h" for="ch" forName="childTextArrow" refType="h"/>
                  </dgm:constrLst>
                  <dgm:ruleLst/>
                  <dgm:forEach name="Name29" axis="ch" ptType="node">
                    <dgm:layoutNode name="childTextArrow" styleLbl="fgAccFollowNode1">
                      <dgm:varLst>
                        <dgm:bulletEnabled val="1"/>
                      </dgm:varLst>
                      <dgm:alg type="tx"/>
                      <dgm:shape xmlns:r="http://schemas.openxmlformats.org/officeDocument/2006/relationships" type="rect" r:blip="">
                        <dgm:adjLst/>
                      </dgm:shape>
                      <dgm:presOf axis="desOrSelf" ptType="node"/>
                      <dgm:constrLst>
                        <dgm:constr type="tMarg" refType="primFontSz" fact="0.1"/>
                        <dgm:constr type="bMarg" refType="primFontSz" fact="0.1"/>
                      </dgm:constrLst>
                      <dgm:ruleLst>
                        <dgm:rule type="primFontSz" val="5" fact="NaN" max="NaN"/>
                      </dgm:ruleLst>
                    </dgm:layoutNode>
                  </dgm:forEach>
                </dgm:layoutNode>
              </dgm:if>
              <dgm:else name="Name30"/>
            </dgm:choose>
          </dgm:layoutNode>
        </dgm:else>
      </dgm:choose>
      <dgm:forEach name="Name31" axis="precedSib" ptType="sibTrans" st="-1" cnt="1">
        <dgm:layoutNode name="sp">
          <dgm:alg type="sp"/>
          <dgm:shape xmlns:r="http://schemas.openxmlformats.org/officeDocument/2006/relationships" r:blip="">
            <dgm:adjLst/>
          </dgm:shape>
          <dgm:presOf axis="self"/>
          <dgm:constrLst/>
          <dgm:ruleLst/>
        </dgm:layoutNode>
      </dgm:forEach>
    </dgm:forEach>
  </dgm:layoutNode>
</dgm:layoutDef>
</file>

<file path=ppt/diagrams/layout6.xml><?xml version="1.0" encoding="utf-8"?>
<dgm:layoutDef xmlns:dgm="http://schemas.openxmlformats.org/drawingml/2006/diagram" xmlns:a="http://schemas.openxmlformats.org/drawingml/2006/main" uniqueId="urn:microsoft.com/office/officeart/2005/8/layout/vList5">
  <dgm:title val=""/>
  <dgm:desc val=""/>
  <dgm:catLst>
    <dgm:cat type="list" pri="15000"/>
    <dgm:cat type="convert" pri="2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Name0">
    <dgm:varLst>
      <dgm:dir/>
      <dgm:animLvl val="lvl"/>
      <dgm:resizeHandles val="exact"/>
    </dgm:varLst>
    <dgm:choose name="Name1">
      <dgm:if name="Name2" func="var" arg="dir" op="equ" val="norm">
        <dgm:alg type="lin">
          <dgm:param type="linDir" val="fromT"/>
          <dgm:param type="nodeHorzAlign" val="l"/>
        </dgm:alg>
      </dgm:if>
      <dgm:else name="Name3">
        <dgm:alg type="lin">
          <dgm:param type="linDir" val="fromT"/>
          <dgm:param type="nodeHorzAlign" val="r"/>
        </dgm:alg>
      </dgm:else>
    </dgm:choose>
    <dgm:shape xmlns:r="http://schemas.openxmlformats.org/officeDocument/2006/relationships" r:blip="">
      <dgm:adjLst/>
    </dgm:shape>
    <dgm:presOf/>
    <dgm:constrLst>
      <dgm:constr type="h" for="ch" forName="linNode" refType="h"/>
      <dgm:constr type="w" for="ch" forName="linNode" refType="w"/>
      <dgm:constr type="h" for="ch" forName="sp" refType="h" fact="0.05"/>
      <dgm:constr type="primFontSz" for="des" forName="parentText" op="equ" val="65"/>
      <dgm:constr type="secFontSz" for="des" forName="descendantText" op="equ"/>
    </dgm:constrLst>
    <dgm:ruleLst/>
    <dgm:forEach name="Name4" axis="ch" ptType="node">
      <dgm:layoutNode name="linNode">
        <dgm:choose name="Name5">
          <dgm:if name="Name6" func="var" arg="dir" op="equ" val="norm">
            <dgm:alg type="lin">
              <dgm:param type="linDir" val="fromL"/>
            </dgm:alg>
          </dgm:if>
          <dgm:else name="Name7">
            <dgm:alg type="lin">
              <dgm:param type="linDir" val="fromR"/>
            </dgm:alg>
          </dgm:else>
        </dgm:choose>
        <dgm:shape xmlns:r="http://schemas.openxmlformats.org/officeDocument/2006/relationships" r:blip="">
          <dgm:adjLst/>
        </dgm:shape>
        <dgm:presOf/>
        <dgm:constrLst>
          <dgm:constr type="w" for="ch" forName="parentText" refType="w" fact="0.36"/>
          <dgm:constr type="w" for="ch" forName="descendantText" refType="w" fact="0.64"/>
          <dgm:constr type="h" for="ch" forName="parentText" refType="h"/>
          <dgm:constr type="h" for="ch" forName="descendantText" refType="h" refFor="ch" refForName="parentText" fact="0.8"/>
        </dgm:constrLst>
        <dgm:ruleLst/>
        <dgm:layoutNode name="parentText">
          <dgm:varLst>
            <dgm:chMax val="1"/>
            <dgm:bulletEnabled val="1"/>
          </dgm:varLst>
          <dgm:alg type="tx"/>
          <dgm:shape xmlns:r="http://schemas.openxmlformats.org/officeDocument/2006/relationships" type="roundRect" r:blip="" zOrderOff="3">
            <dgm:adjLst/>
          </dgm:shape>
          <dgm:presOf axis="self" ptType="node"/>
          <dgm:constrLst>
            <dgm:constr type="tMarg" refType="primFontSz" fact="0.15"/>
            <dgm:constr type="bMarg" refType="primFontSz" fact="0.15"/>
            <dgm:constr type="lMarg" refType="primFontSz" fact="0.3"/>
            <dgm:constr type="rMarg" refType="primFontSz" fact="0.3"/>
          </dgm:constrLst>
          <dgm:ruleLst>
            <dgm:rule type="primFontSz" val="5" fact="NaN" max="NaN"/>
          </dgm:ruleLst>
        </dgm:layoutNode>
        <dgm:choose name="Name8">
          <dgm:if name="Name9" axis="ch" ptType="node" func="cnt" op="gte" val="1">
            <dgm:layoutNode name="descendantText" styleLbl="alignAccFollowNode1">
              <dgm:varLst>
                <dgm:bulletEnabled val="1"/>
              </dgm:varLst>
              <dgm:alg type="tx">
                <dgm:param type="stBulletLvl" val="1"/>
                <dgm:param type="txAnchorVertCh" val="mid"/>
              </dgm:alg>
              <dgm:choose name="Name10">
                <dgm:if name="Name11" func="var" arg="dir" op="equ" val="norm">
                  <dgm:shape xmlns:r="http://schemas.openxmlformats.org/officeDocument/2006/relationships" rot="90" type="round2SameRect" r:blip="">
                    <dgm:adjLst/>
                  </dgm:shape>
                </dgm:if>
                <dgm:else name="Name12">
                  <dgm:shape xmlns:r="http://schemas.openxmlformats.org/officeDocument/2006/relationships" rot="-90" type="round2SameRect" r:blip="">
                    <dgm:adjLst/>
                  </dgm:shape>
                </dgm:else>
              </dgm:choose>
              <dgm:presOf axis="des" ptType="node"/>
              <dgm:constrLst>
                <dgm:constr type="secFontSz" val="65"/>
                <dgm:constr type="primFontSz" refType="secFontSz"/>
                <dgm:constr type="lMarg" refType="secFontSz" fact="0.3"/>
                <dgm:constr type="rMarg" refType="secFontSz" fact="0.3"/>
                <dgm:constr type="tMarg" refType="secFontSz" fact="0.15"/>
                <dgm:constr type="bMarg" refType="secFontSz" fact="0.15"/>
              </dgm:constrLst>
              <dgm:ruleLst>
                <dgm:rule type="secFontSz" val="5" fact="NaN" max="NaN"/>
              </dgm:ruleLst>
            </dgm:layoutNode>
          </dgm:if>
          <dgm:else name="Name13"/>
        </dgm:choose>
      </dgm:layoutNode>
      <dgm:forEach name="Name14" axis="followSib" ptType="sibTrans" cnt="1">
        <dgm:layoutNode name="sp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layout7.xml><?xml version="1.0" encoding="utf-8"?>
<dgm:layoutDef xmlns:dgm="http://schemas.openxmlformats.org/drawingml/2006/diagram" xmlns:a="http://schemas.openxmlformats.org/drawingml/2006/main" uniqueId="urn:microsoft.com/office/officeart/2005/8/layout/list1">
  <dgm:title val=""/>
  <dgm:desc val=""/>
  <dgm:catLst>
    <dgm:cat type="list" pri="4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4" srcId="0" destId="1" srcOrd="0" destOrd="0"/>
        <dgm:cxn modelId="5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linear">
    <dgm:varLst>
      <dgm:dir/>
      <dgm:animLvl val="lvl"/>
      <dgm:resizeHandles val="exact"/>
    </dgm:varLst>
    <dgm:choose name="Name0">
      <dgm:if name="Name1" func="var" arg="dir" op="equ" val="norm">
        <dgm:alg type="lin">
          <dgm:param type="linDir" val="fromT"/>
          <dgm:param type="vertAlign" val="mid"/>
          <dgm:param type="horzAlign" val="l"/>
          <dgm:param type="nodeHorzAlign" val="l"/>
        </dgm:alg>
      </dgm:if>
      <dgm:else name="Name2">
        <dgm:alg type="lin">
          <dgm:param type="linDir" val="fromT"/>
          <dgm:param type="vertAlign" val="mid"/>
          <dgm:param type="horzAlign" val="r"/>
          <dgm:param type="nodeHorzAlign" val="r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parentLin" refType="w"/>
      <dgm:constr type="h" for="ch" forName="parentLin" val="INF"/>
      <dgm:constr type="w" for="des" forName="parentLeftMargin" refType="w" fact="0.05"/>
      <dgm:constr type="w" for="des" forName="parentText" refType="w" fact="0.7"/>
      <dgm:constr type="h" for="des" forName="parentText" refType="primFontSz" refFor="des" refForName="parentText" fact="0.82"/>
      <dgm:constr type="h" for="ch" forName="negativeSpace" refType="primFontSz" refFor="des" refForName="parentText" fact="-0.41"/>
      <dgm:constr type="h" for="ch" forName="negativeSpace" refType="h" refFor="des" refForName="parentText" op="lte" fact="-0.82"/>
      <dgm:constr type="h" for="ch" forName="negativeSpace" refType="h" refFor="des" refForName="parentText" op="gte" fact="-0.82"/>
      <dgm:constr type="w" for="ch" forName="childText" refType="w"/>
      <dgm:constr type="h" for="ch" forName="childText" refType="primFontSz" refFor="des" refForName="parentText" fact="0.7"/>
      <dgm:constr type="primFontSz" for="des" forName="parentText" val="65"/>
      <dgm:constr type="primFontSz" for="ch" forName="childText" refType="primFontSz" refFor="des" refForName="parentText"/>
      <dgm:constr type="tMarg" for="ch" forName="childText" refType="primFontSz" refFor="des" refForName="parentText" fact="1.64"/>
      <dgm:constr type="tMarg" for="ch" forName="childText" refType="h" refFor="des" refForName="parentText" op="lte" fact="3.28"/>
      <dgm:constr type="tMarg" for="ch" forName="childText" refType="h" refFor="des" refForName="parentText" op="gte" fact="3.28"/>
      <dgm:constr type="lMarg" for="ch" forName="childText" refType="w" fact="0.22"/>
      <dgm:constr type="rMarg" for="ch" forName="childText" refType="lMarg" refFor="ch" refForName="childText"/>
      <dgm:constr type="lMarg" for="des" forName="parentText" refType="w" fact="0.075"/>
      <dgm:constr type="rMarg" for="des" forName="parentText" refType="lMarg" refFor="des" refForName="parentText"/>
      <dgm:constr type="h" for="ch" forName="spaceBetweenRectangles" refType="primFontSz" refFor="des" refForName="parentText" fact="0.15"/>
    </dgm:constrLst>
    <dgm:ruleLst>
      <dgm:rule type="primFontSz" for="des" forName="parentText" val="5" fact="NaN" max="NaN"/>
    </dgm:ruleLst>
    <dgm:forEach name="Name3" axis="ch" ptType="node">
      <dgm:layoutNode name="parentLin">
        <dgm:choose name="Name4">
          <dgm:if name="Name5" func="var" arg="dir" op="equ" val="norm">
            <dgm:alg type="lin">
              <dgm:param type="linDir" val="fromL"/>
              <dgm:param type="horzAlign" val="l"/>
              <dgm:param type="nodeHorzAlign" val="l"/>
            </dgm:alg>
          </dgm:if>
          <dgm:else name="Name6">
            <dgm:alg type="lin">
              <dgm:param type="linDir" val="fromR"/>
              <dgm:param type="horzAlign" val="r"/>
              <dgm:param type="nodeHorzAlign" val="r"/>
            </dgm:alg>
          </dgm:else>
        </dgm:choose>
        <dgm:shape xmlns:r="http://schemas.openxmlformats.org/officeDocument/2006/relationships" r:blip="">
          <dgm:adjLst/>
        </dgm:shape>
        <dgm:presOf/>
        <dgm:constrLst/>
        <dgm:ruleLst/>
        <dgm:layoutNode name="parentLeftMargin">
          <dgm:alg type="sp"/>
          <dgm:shape xmlns:r="http://schemas.openxmlformats.org/officeDocument/2006/relationships" type="rect" r:blip="" hideGeom="1">
            <dgm:adjLst/>
          </dgm:shape>
          <dgm:presOf axis="self"/>
          <dgm:constrLst>
            <dgm:constr type="h"/>
          </dgm:constrLst>
          <dgm:ruleLst/>
        </dgm:layoutNode>
        <dgm:layoutNode name="parentText" styleLbl="node1">
          <dgm:varLst>
            <dgm:chMax val="0"/>
            <dgm:bulletEnabled val="1"/>
          </dgm:varLst>
          <dgm:choose name="Name7">
            <dgm:if name="Name8" func="var" arg="dir" op="equ" val="norm">
              <dgm:alg type="tx">
                <dgm:param type="parTxLTRAlign" val="l"/>
                <dgm:param type="parTxRTLAlign" val="l"/>
              </dgm:alg>
            </dgm:if>
            <dgm:else name="Name9">
              <dgm:alg type="tx">
                <dgm:param type="parTxLTRAlign" val="r"/>
                <dgm:param type="parTxRTLAlign" val="r"/>
              </dgm:alg>
            </dgm:else>
          </dgm:choose>
          <dgm:shape xmlns:r="http://schemas.openxmlformats.org/officeDocument/2006/relationships" type="roundRect" r:blip="">
            <dgm:adjLst/>
          </dgm:shape>
          <dgm:presOf axis="self" ptType="node"/>
          <dgm:constrLst>
            <dgm:constr type="tMarg"/>
            <dgm:constr type="bMarg"/>
          </dgm:constrLst>
          <dgm:ruleLst/>
        </dgm:layoutNode>
      </dgm:layoutNode>
      <dgm:layoutNode name="negativeSpace">
        <dgm:alg type="sp"/>
        <dgm:shape xmlns:r="http://schemas.openxmlformats.org/officeDocument/2006/relationships" r:blip="">
          <dgm:adjLst/>
        </dgm:shape>
        <dgm:presOf/>
        <dgm:constrLst/>
        <dgm:ruleLst/>
      </dgm:layoutNode>
      <dgm:layoutNode name="childText" styleLbl="conFgAcc1">
        <dgm:varLst>
          <dgm:bulletEnabled val="1"/>
        </dgm:varLst>
        <dgm:alg type="tx">
          <dgm:param type="stBulletLvl" val="1"/>
        </dgm:alg>
        <dgm:shape xmlns:r="http://schemas.openxmlformats.org/officeDocument/2006/relationships" type="rect" r:blip="" zOrderOff="-2">
          <dgm:adjLst/>
        </dgm:shape>
        <dgm:presOf axis="des" ptType="node"/>
        <dgm:constrLst>
          <dgm:constr type="secFontSz" refType="primFontSz"/>
        </dgm:constrLst>
        <dgm:ruleLst>
          <dgm:rule type="h" val="INF" fact="NaN" max="NaN"/>
        </dgm:ruleLst>
      </dgm:layoutNode>
      <dgm:forEach name="Name10" axis="followSib" ptType="sibTrans" cnt="1">
        <dgm:layoutNode name="spaceBetweenRectangles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3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4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5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6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7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912506-C1B1-6A4C-932E-FF6CC5771AA9}" type="datetimeFigureOut">
              <a:rPr lang="en-US" smtClean="0"/>
              <a:t>5/19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2D6CEF-E9B0-8548-98D4-B64F2444CE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0211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www.cancer.org</a:t>
            </a:r>
            <a:r>
              <a:rPr lang="en-US" dirty="0"/>
              <a:t>/treatment/understanding-your-diagnosis/tests/testing-biopsy-and-cytology-specimens-for-cancer/how-is-cancer-</a:t>
            </a:r>
            <a:r>
              <a:rPr lang="en-US" dirty="0" err="1"/>
              <a:t>diagnosed.html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407976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www.cancer.gov</a:t>
            </a:r>
            <a:r>
              <a:rPr lang="en-US" dirty="0"/>
              <a:t>/about-cancer/treatment/types/surger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9543563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www.cancer.gov</a:t>
            </a:r>
            <a:r>
              <a:rPr lang="en-US" dirty="0"/>
              <a:t>/about-cancer/treatment/types/surger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7272264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www.cancer.net</a:t>
            </a:r>
            <a:r>
              <a:rPr lang="en-US" dirty="0"/>
              <a:t>/navigating-cancer-care/how-cancer-treated/surgery/side-effects-surger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6373654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www.cancer.gov</a:t>
            </a:r>
            <a:r>
              <a:rPr lang="en-US" dirty="0"/>
              <a:t>/about-cancer/treatment/types/stem-cell-transplant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238648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www.cancer.gov</a:t>
            </a:r>
            <a:r>
              <a:rPr lang="en-US" dirty="0"/>
              <a:t>/about-cancer/treatment/types/stem-cell-transplant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1524349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www.cancer.gov</a:t>
            </a:r>
            <a:r>
              <a:rPr lang="en-US" dirty="0"/>
              <a:t>/about-cancer/treatment/types/stem-cell-transplant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96845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www.cancer.org</a:t>
            </a:r>
            <a:r>
              <a:rPr lang="en-US" dirty="0"/>
              <a:t>/healthy/find-cancer-</a:t>
            </a:r>
            <a:r>
              <a:rPr lang="en-US" dirty="0" err="1"/>
              <a:t>early.html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751913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www.cancer.gov</a:t>
            </a:r>
            <a:r>
              <a:rPr lang="en-US" dirty="0"/>
              <a:t>/about-cancer/screening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821621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www.lung.org</a:t>
            </a:r>
            <a:r>
              <a:rPr lang="en-US" dirty="0"/>
              <a:t>/research/state-of-lung-cancer/states/Kentucky</a:t>
            </a:r>
          </a:p>
          <a:p>
            <a:endParaRPr lang="en-US" dirty="0"/>
          </a:p>
          <a:p>
            <a:r>
              <a:rPr lang="en-US" b="0" dirty="0"/>
              <a:t>https://</a:t>
            </a:r>
            <a:r>
              <a:rPr lang="en-US" b="0" dirty="0" err="1"/>
              <a:t>cancerstatisticscenter.cancer.org</a:t>
            </a:r>
            <a:r>
              <a:rPr lang="en-US" b="0" dirty="0"/>
              <a:t>/#!/state/Kentucky</a:t>
            </a:r>
          </a:p>
          <a:p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589177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www.cancer.org</a:t>
            </a:r>
            <a:r>
              <a:rPr lang="en-US" dirty="0"/>
              <a:t>/treatment/treatments-and-side-effects/treatment-types/chemotherapy/how-is-chemotherapy-used-to-treat-</a:t>
            </a:r>
            <a:r>
              <a:rPr lang="en-US" dirty="0" err="1"/>
              <a:t>cancer.html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02413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www.cancer.org</a:t>
            </a:r>
            <a:r>
              <a:rPr lang="en-US" dirty="0"/>
              <a:t>/treatment/treatments-and-side-effects/treatment-types/chemotherapy/how-is-chemotherapy-used-to-treat-</a:t>
            </a:r>
            <a:r>
              <a:rPr lang="en-US" dirty="0" err="1"/>
              <a:t>cancer.html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198052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www.cancer.gov</a:t>
            </a:r>
            <a:r>
              <a:rPr lang="en-US" dirty="0"/>
              <a:t>/about-cancer/treatment/types/radiation-therap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860529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www.cancer.gov</a:t>
            </a:r>
            <a:r>
              <a:rPr lang="en-US" dirty="0"/>
              <a:t>/about-cancer/treatment/types/radiation-therap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9176516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www.cancer.net</a:t>
            </a:r>
            <a:r>
              <a:rPr lang="en-US" dirty="0"/>
              <a:t>/navigating-cancer-care/how-cancer-treated/radiation-therapy/side-effects-radiation-therap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045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C4609C-3B0F-414F-A318-1710F3CB562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D82E014-8CC0-1A43-A974-17528DC50DC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BD9FB9-4393-6E44-A6CE-9EC83A1AF2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C47-83A7-4A4C-BC12-D9DEC215109B}" type="datetimeFigureOut">
              <a:rPr lang="en-US" smtClean="0"/>
              <a:t>5/1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4AD60B-37E8-2D40-B743-729D215CBC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BA5541-A17F-AE41-8426-104B479A9E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BB60E-A4BE-7C4B-B36F-2D418C460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95650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8C5C2A-0E83-C846-A7EC-6A68BD9DBF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AE6FD23-248C-C44A-A723-3D8218D74B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F8E10C-B4D4-844E-88AD-50BACB3F26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C47-83A7-4A4C-BC12-D9DEC215109B}" type="datetimeFigureOut">
              <a:rPr lang="en-US" smtClean="0"/>
              <a:t>5/1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2E3DA7-AE42-1846-9000-F0AC6BC5C5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9DA9DA-D75D-F344-89DB-BABAA5F3B8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BB60E-A4BE-7C4B-B36F-2D418C460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302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566E520-6483-5A4D-BE6B-3D654CD140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EE6697B-9126-E247-8D2F-B8D886C4C9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081534-B918-C54C-A653-C5F142EC1F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C47-83A7-4A4C-BC12-D9DEC215109B}" type="datetimeFigureOut">
              <a:rPr lang="en-US" smtClean="0"/>
              <a:t>5/1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98FFEB-1E9A-7E4C-96A9-B9AAED1F26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35AA49-7BC8-8C45-8708-93FC152C89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BB60E-A4BE-7C4B-B36F-2D418C460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2202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E852DB-2C0F-1E42-AA63-94727BA453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00C6D3-38AC-0341-8EA2-BE5E6045283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C21DCD-6ECC-554D-AAED-1FA2DF48A3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C47-83A7-4A4C-BC12-D9DEC215109B}" type="datetimeFigureOut">
              <a:rPr lang="en-US" smtClean="0"/>
              <a:t>5/1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17848B-677A-9645-83C2-2160CC2B47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F9E34D-2E1D-3240-8287-EBC114E0DE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BB60E-A4BE-7C4B-B36F-2D418C460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15125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9FB14A-FF1C-E545-93A9-214F13B05B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5055C2-ADA0-364E-93BC-40BF2FD9E6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DC9775-8430-CF45-99E7-BBC43E7EDF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C47-83A7-4A4C-BC12-D9DEC215109B}" type="datetimeFigureOut">
              <a:rPr lang="en-US" smtClean="0"/>
              <a:t>5/1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CA008C-49C8-0A47-9241-50A9B6E451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B285BC-13B1-814A-972E-ACE4C4C68B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BB60E-A4BE-7C4B-B36F-2D418C460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83581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056DCE-A640-164A-9A9E-8B83102E36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9DB168-6DB1-CD4D-BC76-6FE37744FA9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95A1882-708A-3841-BCF9-CF8CFB86AE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1DA11E-621D-9948-846E-CC78EAA154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C47-83A7-4A4C-BC12-D9DEC215109B}" type="datetimeFigureOut">
              <a:rPr lang="en-US" smtClean="0"/>
              <a:t>5/1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14877D-2FF5-5741-8807-ABCE42F165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02CADB-4019-EF4F-8EEF-7251DDFB3E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BB60E-A4BE-7C4B-B36F-2D418C460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83282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B0C36E-42BC-B241-B899-3AC6A3F38F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E49590-B428-304A-A8E8-23180F63D0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E6076C-922C-7D44-82D5-AF16D2D7AC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5C38731-9D4C-3844-B26C-86F5645FDA3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FC1E070-042D-9C41-A599-6710668C8B1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218A60A-468D-B941-BEDC-A4A70EAB08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C47-83A7-4A4C-BC12-D9DEC215109B}" type="datetimeFigureOut">
              <a:rPr lang="en-US" smtClean="0"/>
              <a:t>5/19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2064E80-C456-BA46-BA41-0261E36AF5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479D005-7944-AF47-BCC3-C6B57862D3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BB60E-A4BE-7C4B-B36F-2D418C460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2971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6D6A1A-B864-994E-AC16-15D03102CB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1637F8E-DDB5-8146-836D-D24E435AB1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C47-83A7-4A4C-BC12-D9DEC215109B}" type="datetimeFigureOut">
              <a:rPr lang="en-US" smtClean="0"/>
              <a:t>5/19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C4DC44-BE55-9E42-92DB-E17613E8E6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4CD79B9-AF7E-A748-A18C-20970A96C1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BB60E-A4BE-7C4B-B36F-2D418C460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1253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291BDF9-FE6F-7F4F-8DEB-CA4B492F1F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C47-83A7-4A4C-BC12-D9DEC215109B}" type="datetimeFigureOut">
              <a:rPr lang="en-US" smtClean="0"/>
              <a:t>5/19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2913517-184E-8E4D-A5E3-EFA6A9FA91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995660B-68EA-8446-A4D3-76238883D0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BB60E-A4BE-7C4B-B36F-2D418C460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446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2A3D09-BC43-2340-9FB9-2EDA0F91A7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7FE945-3BF8-0F4C-B666-E9BF02C2595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5E15A8E-862B-9B41-B2B8-8F5A0B565E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5CAFAEF-2A01-FB45-BB92-F18722D0D6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C47-83A7-4A4C-BC12-D9DEC215109B}" type="datetimeFigureOut">
              <a:rPr lang="en-US" smtClean="0"/>
              <a:t>5/1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40D9B1-FB01-2D4A-B633-C3047F1CD2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76ADEBD-BC38-FE46-BDAF-A1E82059C1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BB60E-A4BE-7C4B-B36F-2D418C460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69291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B960A0-33E6-214C-9F5D-32F48AE0AD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0A71142-0BFA-C74B-825E-DC44A31923D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D98AD81-0B49-6743-89EE-0BB0040039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1F4530-B573-DF44-B06C-D5A61BE0AE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C47-83A7-4A4C-BC12-D9DEC215109B}" type="datetimeFigureOut">
              <a:rPr lang="en-US" smtClean="0"/>
              <a:t>5/1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FC4A83E-C7A8-0341-84EC-F5979FC42B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97A28C-B6FC-E345-839B-8E8F3026C1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BB60E-A4BE-7C4B-B36F-2D418C460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05692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C624326-72CA-2844-8670-C3944D9ABF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82DF56-5A58-6445-B155-9B735C7150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32AE30-FFA8-0243-8622-04197E3E87C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F45C47-83A7-4A4C-BC12-D9DEC215109B}" type="datetimeFigureOut">
              <a:rPr lang="en-US" smtClean="0"/>
              <a:t>5/1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0D89C0-38A9-A849-91FD-E474E32FF0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4337C5-4A64-4A46-B4DF-5610B030581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ABB60E-A4BE-7C4B-B36F-2D418C460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254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3.xml"/><Relationship Id="rId2" Type="http://schemas.openxmlformats.org/officeDocument/2006/relationships/diagramData" Target="../diagrams/data3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3.xml"/><Relationship Id="rId5" Type="http://schemas.openxmlformats.org/officeDocument/2006/relationships/diagramColors" Target="../diagrams/colors3.xml"/><Relationship Id="rId4" Type="http://schemas.openxmlformats.org/officeDocument/2006/relationships/diagramQuickStyle" Target="../diagrams/quickStyle3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sv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4.xml"/><Relationship Id="rId7" Type="http://schemas.microsoft.com/office/2007/relationships/diagramDrawing" Target="../diagrams/drawing4.xml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4.xml"/><Relationship Id="rId5" Type="http://schemas.openxmlformats.org/officeDocument/2006/relationships/diagramQuickStyle" Target="../diagrams/quickStyle4.xml"/><Relationship Id="rId4" Type="http://schemas.openxmlformats.org/officeDocument/2006/relationships/diagramLayout" Target="../diagrams/layout4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5.xml"/><Relationship Id="rId7" Type="http://schemas.microsoft.com/office/2007/relationships/diagramDrawing" Target="../diagrams/drawing5.xml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5.xml"/><Relationship Id="rId5" Type="http://schemas.openxmlformats.org/officeDocument/2006/relationships/diagramQuickStyle" Target="../diagrams/quickStyle5.xml"/><Relationship Id="rId4" Type="http://schemas.openxmlformats.org/officeDocument/2006/relationships/diagramLayout" Target="../diagrams/layout5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6.xml"/><Relationship Id="rId7" Type="http://schemas.microsoft.com/office/2007/relationships/diagramDrawing" Target="../diagrams/drawing6.xml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6.xml"/><Relationship Id="rId5" Type="http://schemas.openxmlformats.org/officeDocument/2006/relationships/diagramQuickStyle" Target="../diagrams/quickStyle6.xml"/><Relationship Id="rId4" Type="http://schemas.openxmlformats.org/officeDocument/2006/relationships/diagramLayout" Target="../diagrams/layout6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svg"/><Relationship Id="rId5" Type="http://schemas.openxmlformats.org/officeDocument/2006/relationships/image" Target="../media/image17.png"/><Relationship Id="rId4" Type="http://schemas.openxmlformats.org/officeDocument/2006/relationships/image" Target="../media/image16.sv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f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7.xml"/><Relationship Id="rId7" Type="http://schemas.microsoft.com/office/2007/relationships/diagramDrawing" Target="../diagrams/drawing7.xml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7.xml"/><Relationship Id="rId5" Type="http://schemas.openxmlformats.org/officeDocument/2006/relationships/diagramQuickStyle" Target="../diagrams/quickStyle7.xml"/><Relationship Id="rId4" Type="http://schemas.openxmlformats.org/officeDocument/2006/relationships/diagramLayout" Target="../diagrams/layout7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1.svg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svg"/><Relationship Id="rId5" Type="http://schemas.openxmlformats.org/officeDocument/2006/relationships/image" Target="../media/image6.png"/><Relationship Id="rId4" Type="http://schemas.openxmlformats.org/officeDocument/2006/relationships/image" Target="../media/image5.sv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2.xml"/><Relationship Id="rId2" Type="http://schemas.openxmlformats.org/officeDocument/2006/relationships/diagramData" Target="../diagrams/data2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2.xml"/><Relationship Id="rId5" Type="http://schemas.openxmlformats.org/officeDocument/2006/relationships/diagramColors" Target="../diagrams/colors2.xml"/><Relationship Id="rId4" Type="http://schemas.openxmlformats.org/officeDocument/2006/relationships/diagramQuickStyle" Target="../diagrams/quickStyle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95B96B88-480A-054E-9504-392E766DCC1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5135328" y="2325880"/>
            <a:ext cx="6105828" cy="1560320"/>
          </a:xfrm>
        </p:spPr>
        <p:txBody>
          <a:bodyPr>
            <a:normAutofit fontScale="90000"/>
          </a:bodyPr>
          <a:lstStyle/>
          <a:p>
            <a:pPr algn="l"/>
            <a:r>
              <a:rPr lang="en-US" sz="58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NCER IN THE COMMONWEALTH</a:t>
            </a:r>
          </a:p>
        </p:txBody>
      </p:sp>
      <p:sp>
        <p:nvSpPr>
          <p:cNvPr id="7" name="Subtitle 2">
            <a:extLst>
              <a:ext uri="{FF2B5EF4-FFF2-40B4-BE49-F238E27FC236}">
                <a16:creationId xmlns:a16="http://schemas.microsoft.com/office/drawing/2014/main" id="{9167255E-73B0-CD40-B0ED-FBC2E3E9DE2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5135328" y="4217598"/>
            <a:ext cx="6420679" cy="440822"/>
          </a:xfrm>
        </p:spPr>
        <p:txBody>
          <a:bodyPr>
            <a:noAutofit/>
          </a:bodyPr>
          <a:lstStyle/>
          <a:p>
            <a:pPr algn="l"/>
            <a:r>
              <a:rPr lang="en-US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sson 3, Part 1: </a:t>
            </a:r>
            <a:r>
              <a:rPr lang="en-US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ncer Treatment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7218D9FF-93B8-BB4C-ADD6-DC0081775557}"/>
              </a:ext>
            </a:extLst>
          </p:cNvPr>
          <p:cNvCxnSpPr/>
          <p:nvPr/>
        </p:nvCxnSpPr>
        <p:spPr>
          <a:xfrm>
            <a:off x="5204902" y="3985592"/>
            <a:ext cx="6105828" cy="0"/>
          </a:xfrm>
          <a:prstGeom prst="line">
            <a:avLst/>
          </a:prstGeom>
          <a:ln w="19050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" name="Picture 7" descr="A picture containing grass, purple, sitting, blanket&#10;&#10;Description automatically generated">
            <a:extLst>
              <a:ext uri="{FF2B5EF4-FFF2-40B4-BE49-F238E27FC236}">
                <a16:creationId xmlns:a16="http://schemas.microsoft.com/office/drawing/2014/main" id="{3FE707AC-FFD7-964A-9588-45B5F91A9C7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-126"/>
          <a:stretch/>
        </p:blipFill>
        <p:spPr>
          <a:xfrm>
            <a:off x="-1" y="0"/>
            <a:ext cx="462516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9683994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286410-93FD-6E44-84C3-7353531095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2145" y="940910"/>
            <a:ext cx="4471588" cy="4976179"/>
          </a:xfrm>
        </p:spPr>
        <p:txBody>
          <a:bodyPr>
            <a:normAutofit/>
          </a:bodyPr>
          <a:lstStyle/>
          <a:p>
            <a:r>
              <a:rPr lang="en-US" sz="60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 Common Types of Cancer Treatment</a:t>
            </a:r>
          </a:p>
        </p:txBody>
      </p:sp>
      <p:graphicFrame>
        <p:nvGraphicFramePr>
          <p:cNvPr id="24" name="Content Placeholder 2">
            <a:extLst>
              <a:ext uri="{FF2B5EF4-FFF2-40B4-BE49-F238E27FC236}">
                <a16:creationId xmlns:a16="http://schemas.microsoft.com/office/drawing/2014/main" id="{7BBCEEEC-4064-4C6E-BD93-B56A4C3763E8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102464060"/>
              </p:ext>
            </p:extLst>
          </p:nvPr>
        </p:nvGraphicFramePr>
        <p:xfrm>
          <a:off x="5247020" y="699997"/>
          <a:ext cx="6240669" cy="54864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116343331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A510038B-27A9-AB47-AE42-409383ECF5A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636931" y="0"/>
            <a:ext cx="5555069" cy="6858000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55854361-84B0-9549-881C-393FF7D0B8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3277" y="146249"/>
            <a:ext cx="5228393" cy="1203579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lnSpc>
                <a:spcPct val="100000"/>
              </a:lnSpc>
            </a:pPr>
            <a:r>
              <a:rPr lang="en-US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emotherap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0CEAAA-0E4C-3347-BFE1-603507FB82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64420" y="1696706"/>
            <a:ext cx="5207195" cy="4704094"/>
          </a:xfrm>
        </p:spPr>
        <p:txBody>
          <a:bodyPr>
            <a:noAutofit/>
          </a:bodyPr>
          <a:lstStyle/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One of the most common types of cancer treatments.</a:t>
            </a:r>
          </a:p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Uses powerful chemicals to kill cancer cells.</a:t>
            </a:r>
          </a:p>
          <a:p>
            <a:pPr lvl="1"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an include just 1 drug or multiple infused through an IV.</a:t>
            </a:r>
          </a:p>
          <a:p>
            <a:pPr lvl="1"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Multiple drugs must be given in a specific order.</a:t>
            </a:r>
          </a:p>
          <a:p>
            <a:pPr lvl="1"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The type of drugs used are decided by the size of the tumor, stage of the cancer, patient’s age, and patient’s overall health.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07C52CC-F9D6-254E-A9CB-65CC5835BDED}"/>
              </a:ext>
            </a:extLst>
          </p:cNvPr>
          <p:cNvSpPr/>
          <p:nvPr/>
        </p:nvSpPr>
        <p:spPr>
          <a:xfrm>
            <a:off x="6636931" y="0"/>
            <a:ext cx="5555069" cy="6858000"/>
          </a:xfrm>
          <a:prstGeom prst="rect">
            <a:avLst/>
          </a:prstGeom>
          <a:solidFill>
            <a:srgbClr val="0033A0">
              <a:alpha val="72941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223407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13">
            <a:extLst>
              <a:ext uri="{FF2B5EF4-FFF2-40B4-BE49-F238E27FC236}">
                <a16:creationId xmlns:a16="http://schemas.microsoft.com/office/drawing/2014/main" id="{3F342C8A-9382-094A-AA3B-C62FD287FA9D}"/>
              </a:ext>
            </a:extLst>
          </p:cNvPr>
          <p:cNvSpPr/>
          <p:nvPr/>
        </p:nvSpPr>
        <p:spPr>
          <a:xfrm>
            <a:off x="4666840" y="4149494"/>
            <a:ext cx="6612487" cy="1687286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849745DD-A2E4-684B-A47A-1509DEDD8920}"/>
              </a:ext>
            </a:extLst>
          </p:cNvPr>
          <p:cNvSpPr/>
          <p:nvPr/>
        </p:nvSpPr>
        <p:spPr>
          <a:xfrm>
            <a:off x="4666841" y="2144484"/>
            <a:ext cx="6612487" cy="1687286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32198506-4B48-5A49-9E33-AABCD5DB47CA}"/>
              </a:ext>
            </a:extLst>
          </p:cNvPr>
          <p:cNvSpPr/>
          <p:nvPr/>
        </p:nvSpPr>
        <p:spPr>
          <a:xfrm>
            <a:off x="729344" y="2144485"/>
            <a:ext cx="3810000" cy="1687286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60AB31D0-8AE7-8540-8283-6CB3351B1251}"/>
              </a:ext>
            </a:extLst>
          </p:cNvPr>
          <p:cNvSpPr/>
          <p:nvPr/>
        </p:nvSpPr>
        <p:spPr>
          <a:xfrm>
            <a:off x="729344" y="4149494"/>
            <a:ext cx="3810000" cy="1687286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797F039-20F5-954B-8113-995C6B43F7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29344" y="606564"/>
            <a:ext cx="10549984" cy="960979"/>
          </a:xfrm>
        </p:spPr>
        <p:txBody>
          <a:bodyPr anchor="t">
            <a:normAutofit/>
          </a:bodyPr>
          <a:lstStyle/>
          <a:p>
            <a:pPr>
              <a:lnSpc>
                <a:spcPct val="100000"/>
              </a:lnSpc>
            </a:pPr>
            <a:r>
              <a:rPr lang="en-US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oadjuvant vs. Adjuvant Chemo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E9160EAC-920E-2C4F-A2D8-E19D6DCC28A3}"/>
              </a:ext>
            </a:extLst>
          </p:cNvPr>
          <p:cNvSpPr/>
          <p:nvPr/>
        </p:nvSpPr>
        <p:spPr>
          <a:xfrm>
            <a:off x="4925083" y="2295631"/>
            <a:ext cx="6096000" cy="1384995"/>
          </a:xfrm>
          <a:prstGeom prst="rect">
            <a:avLst/>
          </a:prstGeom>
        </p:spPr>
        <p:txBody>
          <a:bodyPr>
            <a:spAutoFit/>
          </a:bodyPr>
          <a:lstStyle/>
          <a:p>
            <a:pPr lvl="0"/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Chemo used to shrink a tumor before another type of treatment is completed.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A49C6542-277B-0347-BAF8-B2D8DB2966BA}"/>
              </a:ext>
            </a:extLst>
          </p:cNvPr>
          <p:cNvSpPr/>
          <p:nvPr/>
        </p:nvSpPr>
        <p:spPr>
          <a:xfrm>
            <a:off x="4925083" y="4300639"/>
            <a:ext cx="6096000" cy="1384995"/>
          </a:xfrm>
          <a:prstGeom prst="rect">
            <a:avLst/>
          </a:prstGeom>
        </p:spPr>
        <p:txBody>
          <a:bodyPr>
            <a:spAutoFit/>
          </a:bodyPr>
          <a:lstStyle/>
          <a:p>
            <a:pPr lvl="0"/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Chemo used to kill any remaining cancer cells following another type of treatment.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DFC62B0-083D-A242-9D70-20F74682AB77}"/>
              </a:ext>
            </a:extLst>
          </p:cNvPr>
          <p:cNvSpPr/>
          <p:nvPr/>
        </p:nvSpPr>
        <p:spPr>
          <a:xfrm>
            <a:off x="1157016" y="2705213"/>
            <a:ext cx="2954655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3600" b="1" dirty="0">
                <a:solidFill>
                  <a:schemeClr val="accent5">
                    <a:lumMod val="40000"/>
                    <a:lumOff val="6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oadjuvant</a:t>
            </a:r>
            <a:endParaRPr lang="en-US" sz="3600" dirty="0">
              <a:solidFill>
                <a:schemeClr val="accent5">
                  <a:lumMod val="40000"/>
                  <a:lumOff val="60000"/>
                </a:schemeClr>
              </a:solidFill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FB7D2907-83F8-AB41-B9E3-0586A119C5DE}"/>
              </a:ext>
            </a:extLst>
          </p:cNvPr>
          <p:cNvSpPr/>
          <p:nvPr/>
        </p:nvSpPr>
        <p:spPr>
          <a:xfrm>
            <a:off x="1457627" y="4669971"/>
            <a:ext cx="2159566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3600" b="1" dirty="0">
                <a:solidFill>
                  <a:schemeClr val="accent2">
                    <a:lumMod val="20000"/>
                    <a:lumOff val="8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juvant</a:t>
            </a:r>
          </a:p>
        </p:txBody>
      </p:sp>
    </p:spTree>
    <p:extLst>
      <p:ext uri="{BB962C8B-B14F-4D97-AF65-F5344CB8AC3E}">
        <p14:creationId xmlns:p14="http://schemas.microsoft.com/office/powerpoint/2010/main" val="115620368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ED5EDE74-D934-AD47-9FF8-57D7326C364D}"/>
              </a:ext>
            </a:extLst>
          </p:cNvPr>
          <p:cNvSpPr/>
          <p:nvPr/>
        </p:nvSpPr>
        <p:spPr>
          <a:xfrm>
            <a:off x="0" y="0"/>
            <a:ext cx="5392396" cy="68580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2243C096-1EDF-6547-911C-77112EDB3AD1}"/>
              </a:ext>
            </a:extLst>
          </p:cNvPr>
          <p:cNvSpPr/>
          <p:nvPr/>
        </p:nvSpPr>
        <p:spPr>
          <a:xfrm>
            <a:off x="2079171" y="1654629"/>
            <a:ext cx="2362200" cy="1970314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EB48A6BC-0D15-9440-AEF5-CEBD5ADF52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143812" y="468086"/>
            <a:ext cx="4816589" cy="1589314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lnSpc>
                <a:spcPct val="100000"/>
              </a:lnSpc>
            </a:pPr>
            <a:r>
              <a:rPr lang="en-US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de Effects of Chemotherapy</a:t>
            </a:r>
          </a:p>
        </p:txBody>
      </p:sp>
      <p:pic>
        <p:nvPicPr>
          <p:cNvPr id="7" name="Graphic 6" descr="IV">
            <a:extLst>
              <a:ext uri="{FF2B5EF4-FFF2-40B4-BE49-F238E27FC236}">
                <a16:creationId xmlns:a16="http://schemas.microsoft.com/office/drawing/2014/main" id="{B9D0063A-117A-45DA-8E48-5CF35BF47F4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695815" y="699900"/>
            <a:ext cx="5031557" cy="5031557"/>
          </a:xfrm>
          <a:prstGeom prst="rect">
            <a:avLst/>
          </a:prstGeom>
        </p:spPr>
      </p:pic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F41BBB-8216-F049-B335-72D9A97C48A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143812" y="2383971"/>
            <a:ext cx="5031557" cy="4005943"/>
          </a:xfrm>
        </p:spPr>
        <p:txBody>
          <a:bodyPr anchor="t">
            <a:normAutofit lnSpcReduction="10000"/>
          </a:bodyPr>
          <a:lstStyle/>
          <a:p>
            <a:pPr>
              <a:lnSpc>
                <a:spcPct val="120000"/>
              </a:lnSpc>
            </a:pPr>
            <a:r>
              <a: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cause chemotherapy kills cells, damage to normal cells is common. </a:t>
            </a:r>
          </a:p>
          <a:p>
            <a:pPr lvl="1"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Hair loss</a:t>
            </a:r>
          </a:p>
          <a:p>
            <a:pPr lvl="1"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Easy bruising and bleeding</a:t>
            </a:r>
          </a:p>
          <a:p>
            <a:pPr lvl="1"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Fatigue</a:t>
            </a:r>
          </a:p>
          <a:p>
            <a:pPr lvl="1"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ppetite changes</a:t>
            </a:r>
          </a:p>
          <a:p>
            <a:pPr lvl="1"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Nausea and vomiting</a:t>
            </a:r>
          </a:p>
          <a:p>
            <a:pPr lvl="1"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Weight changes</a:t>
            </a:r>
          </a:p>
          <a:p>
            <a:pPr>
              <a:lnSpc>
                <a:spcPct val="120000"/>
              </a:lnSpc>
            </a:pPr>
            <a:r>
              <a: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t every patient will see every symptom.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A71736F5-6A3B-574E-8139-2D3CAC5B7493}"/>
              </a:ext>
            </a:extLst>
          </p:cNvPr>
          <p:cNvSpPr/>
          <p:nvPr/>
        </p:nvSpPr>
        <p:spPr>
          <a:xfrm>
            <a:off x="3059394" y="5042020"/>
            <a:ext cx="284307" cy="2134266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119299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407D1BA0-3B37-CF4E-A93E-31851AD96AA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636931" y="0"/>
            <a:ext cx="5555069" cy="6858000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2F4FEB67-25EC-9F4A-B920-5FF4642780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8293" y="551205"/>
            <a:ext cx="5011380" cy="783420"/>
          </a:xfrm>
        </p:spPr>
        <p:txBody>
          <a:bodyPr vert="horz" lIns="91440" tIns="45720" rIns="91440" bIns="45720" rtlCol="0" anchor="t">
            <a:normAutofit fontScale="90000"/>
          </a:bodyPr>
          <a:lstStyle/>
          <a:p>
            <a:pPr>
              <a:lnSpc>
                <a:spcPct val="100000"/>
              </a:lnSpc>
            </a:pPr>
            <a:r>
              <a:rPr lang="en-US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diation Therap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808DD0-4757-1940-A20D-F7F9928FA1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68472" y="1837726"/>
            <a:ext cx="6339977" cy="4469069"/>
          </a:xfrm>
        </p:spPr>
        <p:txBody>
          <a:bodyPr>
            <a:no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Uses high doses of radiation to kill cancer cells and shrink tumors.</a:t>
            </a:r>
          </a:p>
          <a:p>
            <a:pPr lvl="1"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adiation = the same technique that allows us to look at broken bones with an x-ray.</a:t>
            </a:r>
          </a:p>
          <a:p>
            <a:pPr lvl="1"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adiation damages the DNA of the cancer cells.</a:t>
            </a: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Radiation doesn’t work immediately.</a:t>
            </a:r>
          </a:p>
          <a:p>
            <a:pPr lvl="1"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ays or weeks of treatment is needed before cancer cells begin die.</a:t>
            </a:r>
          </a:p>
          <a:p>
            <a:pPr lvl="1"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ancer cells continue to die after treatment concludes.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6BEA27F5-EC90-3D4B-8E6A-E1022A3349C5}"/>
              </a:ext>
            </a:extLst>
          </p:cNvPr>
          <p:cNvSpPr/>
          <p:nvPr/>
        </p:nvSpPr>
        <p:spPr>
          <a:xfrm>
            <a:off x="6636931" y="0"/>
            <a:ext cx="5555069" cy="6858000"/>
          </a:xfrm>
          <a:prstGeom prst="rect">
            <a:avLst/>
          </a:prstGeom>
          <a:solidFill>
            <a:srgbClr val="0033A0">
              <a:alpha val="72941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043280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3043AD-2C4B-1F49-9528-435797BB20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0624" y="1012004"/>
            <a:ext cx="4862576" cy="4795408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60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ternal vs. Internal Beam Radiation</a:t>
            </a:r>
          </a:p>
        </p:txBody>
      </p:sp>
      <p:graphicFrame>
        <p:nvGraphicFramePr>
          <p:cNvPr id="5" name="Content Placeholder 2">
            <a:extLst>
              <a:ext uri="{FF2B5EF4-FFF2-40B4-BE49-F238E27FC236}">
                <a16:creationId xmlns:a16="http://schemas.microsoft.com/office/drawing/2014/main" id="{B12AF87F-5C66-4C41-9EDB-27781E6DA7AB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121149171"/>
              </p:ext>
            </p:extLst>
          </p:nvPr>
        </p:nvGraphicFramePr>
        <p:xfrm>
          <a:off x="5561161" y="992387"/>
          <a:ext cx="5393367" cy="487322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350026646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76CECB-BC24-7249-9ACE-9CBCD131EC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2144" y="940910"/>
            <a:ext cx="4645511" cy="4976179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60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de Effects of Radiation Therapy</a:t>
            </a:r>
          </a:p>
        </p:txBody>
      </p:sp>
      <p:graphicFrame>
        <p:nvGraphicFramePr>
          <p:cNvPr id="5" name="Content Placeholder 2">
            <a:extLst>
              <a:ext uri="{FF2B5EF4-FFF2-40B4-BE49-F238E27FC236}">
                <a16:creationId xmlns:a16="http://schemas.microsoft.com/office/drawing/2014/main" id="{CDE87584-6525-46D1-9BF9-4F03821A4517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687385983"/>
              </p:ext>
            </p:extLst>
          </p:nvPr>
        </p:nvGraphicFramePr>
        <p:xfrm>
          <a:off x="5247020" y="699997"/>
          <a:ext cx="6240669" cy="54864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333947790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A3B1DA-6176-5847-8C89-0813126BA6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32786" y="506743"/>
            <a:ext cx="5228393" cy="886222"/>
          </a:xfrm>
        </p:spPr>
        <p:txBody>
          <a:bodyPr vert="horz" lIns="91440" tIns="45720" rIns="91440" bIns="45720" rtlCol="0" anchor="t">
            <a:normAutofit/>
          </a:bodyPr>
          <a:lstStyle/>
          <a:p>
            <a:pPr>
              <a:lnSpc>
                <a:spcPct val="100000"/>
              </a:lnSpc>
            </a:pPr>
            <a:r>
              <a:rPr lang="en-US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rger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A27232-B491-5642-82BC-3C41EE00E4A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26679" y="1706703"/>
            <a:ext cx="5228392" cy="2582470"/>
          </a:xfrm>
        </p:spPr>
        <p:txBody>
          <a:bodyPr>
            <a:noAutofit/>
          </a:bodyPr>
          <a:lstStyle/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rgeon removes tumor from specific part of the body.</a:t>
            </a:r>
          </a:p>
          <a:p>
            <a:pPr lvl="1"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an remove the entire tumor or just remove some of it</a:t>
            </a:r>
          </a:p>
          <a:p>
            <a:pPr lvl="1"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Only remove some of it if removing all would damage another part of the body</a:t>
            </a:r>
          </a:p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Removing some or all the tumor may help treatments proceed better.</a:t>
            </a:r>
          </a:p>
          <a:p>
            <a:pPr lvl="1"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an also help relieve pain or pressure around the tumor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617F628-BF35-0D44-A09E-2AF3DF58438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636931" y="0"/>
            <a:ext cx="5555069" cy="685800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D4608E03-E73E-BF4E-A563-AD3707B87DEC}"/>
              </a:ext>
            </a:extLst>
          </p:cNvPr>
          <p:cNvSpPr/>
          <p:nvPr/>
        </p:nvSpPr>
        <p:spPr>
          <a:xfrm>
            <a:off x="6636931" y="0"/>
            <a:ext cx="5555069" cy="6858000"/>
          </a:xfrm>
          <a:prstGeom prst="rect">
            <a:avLst/>
          </a:prstGeom>
          <a:solidFill>
            <a:srgbClr val="0033A0">
              <a:alpha val="72941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4211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47413A-CCDE-CD4F-943F-737AD68B01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0623" y="606564"/>
            <a:ext cx="10858705" cy="1246260"/>
          </a:xfrm>
        </p:spPr>
        <p:txBody>
          <a:bodyPr vert="horz" lIns="91440" tIns="45720" rIns="91440" bIns="45720" rtlCol="0" anchor="t">
            <a:normAutofit/>
          </a:bodyPr>
          <a:lstStyle/>
          <a:p>
            <a:pPr>
              <a:lnSpc>
                <a:spcPct val="100000"/>
              </a:lnSpc>
            </a:pPr>
            <a:r>
              <a:rPr lang="en-US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pen vs. Minimally Invasive Surgery</a:t>
            </a:r>
          </a:p>
        </p:txBody>
      </p:sp>
      <p:graphicFrame>
        <p:nvGraphicFramePr>
          <p:cNvPr id="5" name="Content Placeholder 2">
            <a:extLst>
              <a:ext uri="{FF2B5EF4-FFF2-40B4-BE49-F238E27FC236}">
                <a16:creationId xmlns:a16="http://schemas.microsoft.com/office/drawing/2014/main" id="{93286694-7D94-433F-83FF-3AEE66567D7F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938384908"/>
              </p:ext>
            </p:extLst>
          </p:nvPr>
        </p:nvGraphicFramePr>
        <p:xfrm>
          <a:off x="1640793" y="1852824"/>
          <a:ext cx="9638535" cy="4398611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292743048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700F5E39-9757-6046-96C8-2157475942AE}"/>
              </a:ext>
            </a:extLst>
          </p:cNvPr>
          <p:cNvSpPr/>
          <p:nvPr/>
        </p:nvSpPr>
        <p:spPr>
          <a:xfrm>
            <a:off x="6867968" y="-68367"/>
            <a:ext cx="5392396" cy="7101555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C5730A82-018D-074B-B1B6-5E5DE327B1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19782" y="463254"/>
            <a:ext cx="4816589" cy="1604827"/>
          </a:xfrm>
        </p:spPr>
        <p:txBody>
          <a:bodyPr anchor="b">
            <a:normAutofit/>
          </a:bodyPr>
          <a:lstStyle/>
          <a:p>
            <a:pPr>
              <a:lnSpc>
                <a:spcPct val="100000"/>
              </a:lnSpc>
            </a:pPr>
            <a:r>
              <a:rPr lang="en-US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de Effects of Cancer Surger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9B0E5E-C445-1045-AB34-B010D64CA80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928642" y="2380409"/>
            <a:ext cx="5677258" cy="3720100"/>
          </a:xfrm>
        </p:spPr>
        <p:txBody>
          <a:bodyPr anchor="t">
            <a:normAutofit fontScale="92500" lnSpcReduction="10000"/>
          </a:bodyPr>
          <a:lstStyle/>
          <a:p>
            <a:pPr>
              <a:lnSpc>
                <a:spcPct val="100000"/>
              </a:lnSpc>
            </a:pPr>
            <a:r>
              <a:rPr lang="en-US" sz="2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milar to side effects of other surgeries.</a:t>
            </a:r>
          </a:p>
          <a:p>
            <a:pPr>
              <a:lnSpc>
                <a:spcPct val="100000"/>
              </a:lnSpc>
            </a:pPr>
            <a:r>
              <a:rPr lang="en-US" sz="2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ny side effects occur during the recovery period.</a:t>
            </a:r>
          </a:p>
          <a:p>
            <a:pPr lvl="1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ain </a:t>
            </a:r>
          </a:p>
          <a:p>
            <a:pPr lvl="1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atigue </a:t>
            </a:r>
          </a:p>
          <a:p>
            <a:pPr lvl="1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ppetite loss</a:t>
            </a:r>
          </a:p>
          <a:p>
            <a:pPr lvl="1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welling, bruising, and numbness around surgery site</a:t>
            </a:r>
          </a:p>
          <a:p>
            <a:pPr lvl="1">
              <a:lnSpc>
                <a:spcPct val="100000"/>
              </a:lnSpc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ossible infection</a:t>
            </a:r>
          </a:p>
          <a:p>
            <a:pPr marL="457200" lvl="1" indent="0">
              <a:buNone/>
            </a:pPr>
            <a:endParaRPr 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ADC0690C-FC16-674F-BA1E-516F79225408}"/>
              </a:ext>
            </a:extLst>
          </p:cNvPr>
          <p:cNvGrpSpPr/>
          <p:nvPr/>
        </p:nvGrpSpPr>
        <p:grpSpPr>
          <a:xfrm>
            <a:off x="7096615" y="1265667"/>
            <a:ext cx="5031557" cy="5031557"/>
            <a:chOff x="695815" y="699900"/>
            <a:chExt cx="5031557" cy="5031557"/>
          </a:xfrm>
        </p:grpSpPr>
        <p:pic>
          <p:nvPicPr>
            <p:cNvPr id="7" name="Graphic 6" descr="Medicine">
              <a:extLst>
                <a:ext uri="{FF2B5EF4-FFF2-40B4-BE49-F238E27FC236}">
                  <a16:creationId xmlns:a16="http://schemas.microsoft.com/office/drawing/2014/main" id="{8E9A4914-E125-4B77-8933-B079513F54C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695815" y="699900"/>
              <a:ext cx="5031557" cy="5031557"/>
            </a:xfrm>
            <a:prstGeom prst="rect">
              <a:avLst/>
            </a:prstGeom>
          </p:spPr>
        </p:pic>
        <p:pic>
          <p:nvPicPr>
            <p:cNvPr id="5" name="Graphic 4" descr="Medicine">
              <a:extLst>
                <a:ext uri="{FF2B5EF4-FFF2-40B4-BE49-F238E27FC236}">
                  <a16:creationId xmlns:a16="http://schemas.microsoft.com/office/drawing/2014/main" id="{D04F8D96-3E7C-A642-9717-D6F547DA7D4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screen">
              <a:extLst>
                <a:ext uri="{28A0092B-C50C-407E-A947-70E740481C1C}">
                  <a14:useLocalDpi xmlns:a14="http://schemas.microsoft.com/office/drawing/2010/main"/>
                </a:ex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rcRect l="41568" t="71889" r="17159" b="5352"/>
            <a:stretch/>
          </p:blipFill>
          <p:spPr>
            <a:xfrm>
              <a:off x="2785931" y="4315626"/>
              <a:ext cx="2076628" cy="1145137"/>
            </a:xfrm>
            <a:prstGeom prst="ellipse">
              <a:avLst/>
            </a:prstGeom>
          </p:spPr>
        </p:pic>
        <p:sp>
          <p:nvSpPr>
            <p:cNvPr id="4" name="Round Same Side Corner Rectangle 3">
              <a:extLst>
                <a:ext uri="{FF2B5EF4-FFF2-40B4-BE49-F238E27FC236}">
                  <a16:creationId xmlns:a16="http://schemas.microsoft.com/office/drawing/2014/main" id="{DF26EBFF-DEF8-344C-991B-D9A123B884C3}"/>
                </a:ext>
              </a:extLst>
            </p:cNvPr>
            <p:cNvSpPr/>
            <p:nvPr/>
          </p:nvSpPr>
          <p:spPr>
            <a:xfrm rot="16200000">
              <a:off x="2744271" y="2340477"/>
              <a:ext cx="914400" cy="1754029"/>
            </a:xfrm>
            <a:prstGeom prst="round2SameRect">
              <a:avLst>
                <a:gd name="adj1" fmla="val 9190"/>
                <a:gd name="adj2" fmla="val 0"/>
              </a:avLst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1943423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sitting, door, snow, standing&#10;&#10;Description automatically generated">
            <a:extLst>
              <a:ext uri="{FF2B5EF4-FFF2-40B4-BE49-F238E27FC236}">
                <a16:creationId xmlns:a16="http://schemas.microsoft.com/office/drawing/2014/main" id="{001A086B-3E83-D946-983D-337CCADB903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5400000">
            <a:off x="2683867" y="-2683868"/>
            <a:ext cx="6857999" cy="12225737"/>
          </a:xfrm>
          <a:prstGeom prst="rect">
            <a:avLst/>
          </a:prstGeom>
        </p:spPr>
      </p:pic>
      <p:sp>
        <p:nvSpPr>
          <p:cNvPr id="6" name="Title 1">
            <a:extLst>
              <a:ext uri="{FF2B5EF4-FFF2-40B4-BE49-F238E27FC236}">
                <a16:creationId xmlns:a16="http://schemas.microsoft.com/office/drawing/2014/main" id="{A714D208-9323-6840-A689-74EB10860B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544461" y="2617286"/>
            <a:ext cx="7103078" cy="2135867"/>
          </a:xfrm>
        </p:spPr>
        <p:txBody>
          <a:bodyPr anchor="b">
            <a:noAutofit/>
          </a:bodyPr>
          <a:lstStyle/>
          <a:p>
            <a:pPr algn="ctr"/>
            <a:r>
              <a:rPr lang="en-US" sz="100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VITY</a:t>
            </a:r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D13E15C7-181A-4F45-B98B-4AB6076D6C27}"/>
              </a:ext>
            </a:extLst>
          </p:cNvPr>
          <p:cNvSpPr/>
          <p:nvPr/>
        </p:nvSpPr>
        <p:spPr>
          <a:xfrm>
            <a:off x="4774019" y="2617286"/>
            <a:ext cx="466155" cy="466155"/>
          </a:xfrm>
          <a:prstGeom prst="ellipse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CB7800A7-5E48-B348-AAE0-7F88BDB88DFF}"/>
              </a:ext>
            </a:extLst>
          </p:cNvPr>
          <p:cNvSpPr/>
          <p:nvPr/>
        </p:nvSpPr>
        <p:spPr>
          <a:xfrm>
            <a:off x="5868318" y="2617286"/>
            <a:ext cx="466155" cy="466155"/>
          </a:xfrm>
          <a:prstGeom prst="ellipse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accent1"/>
              </a:solidFill>
            </a:endParaRPr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92B0E41C-5917-884A-92AA-14597EF33BEF}"/>
              </a:ext>
            </a:extLst>
          </p:cNvPr>
          <p:cNvSpPr/>
          <p:nvPr/>
        </p:nvSpPr>
        <p:spPr>
          <a:xfrm>
            <a:off x="6962617" y="2617285"/>
            <a:ext cx="466155" cy="466155"/>
          </a:xfrm>
          <a:prstGeom prst="ellipse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101927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6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7" dur="29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911" tmFilter="0,0; 0.14,0.36; 0.43,0.73; 0.71,0.91; 1.0,1.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-0.25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332" tmFilter="0.0,0.0; 0.25,0.07; 0.50,0.2; 0.75,0.467; 1.0,1.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3">
                                          <p:val>
                                            <p:fltVal val="0.5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0" dur="332" tmFilter="0, 0; 0.125,0.2665; 0.25,0.4; 0.375,0.465; 0.5,0.5;  0.625,0.535; 0.75,0.6; 0.875,0.7335; 1,1">
                                          <p:stCondLst>
                                            <p:cond delay="332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9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1" dur="166" tmFilter="0, 0; 0.125,0.2665; 0.25,0.4; 0.375,0.465; 0.5,0.5;  0.625,0.535; 0.75,0.6; 0.875,0.7335; 1,1">
                                          <p:stCondLst>
                                            <p:cond delay="662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27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2" dur="82" tmFilter="0, 0; 0.125,0.2665; 0.25,0.4; 0.375,0.465; 0.5,0.5;  0.625,0.535; 0.75,0.6; 0.875,0.7335; 1,1">
                                          <p:stCondLst>
                                            <p:cond delay="828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81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Scale>
                                      <p:cBhvr>
                                        <p:cTn id="13" dur="13">
                                          <p:stCondLst>
                                            <p:cond delay="325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60000"/>
                                    </p:animScale>
                                    <p:animScale>
                                      <p:cBhvr>
                                        <p:cTn id="14" dur="83" decel="50000">
                                          <p:stCondLst>
                                            <p:cond delay="338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15" dur="13">
                                          <p:stCondLst>
                                            <p:cond delay="656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80000"/>
                                    </p:animScale>
                                    <p:animScale>
                                      <p:cBhvr>
                                        <p:cTn id="16" dur="83" decel="50000">
                                          <p:stCondLst>
                                            <p:cond delay="669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17" dur="13">
                                          <p:stCondLst>
                                            <p:cond delay="821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90000"/>
                                    </p:animScale>
                                    <p:animScale>
                                      <p:cBhvr>
                                        <p:cTn id="18" dur="83" decel="50000">
                                          <p:stCondLst>
                                            <p:cond delay="834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19" dur="13">
                                          <p:stCondLst>
                                            <p:cond delay="904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95000"/>
                                    </p:animScale>
                                    <p:animScale>
                                      <p:cBhvr>
                                        <p:cTn id="20" dur="83" decel="50000">
                                          <p:stCondLst>
                                            <p:cond delay="917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100000"/>
                                    </p:animScale>
                                  </p:childTnLst>
                                </p:cTn>
                              </p:par>
                              <p:par>
                                <p:cTn id="21" presetID="26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23" dur="29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4" dur="911" tmFilter="0,0; 0.14,0.36; 0.43,0.73; 0.71,0.91; 1.0,1.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-0.25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5" dur="332" tmFilter="0.0,0.0; 0.25,0.07; 0.50,0.2; 0.75,0.467; 1.0,1.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3">
                                          <p:val>
                                            <p:fltVal val="0.5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6" dur="332" tmFilter="0, 0; 0.125,0.2665; 0.25,0.4; 0.375,0.465; 0.5,0.5;  0.625,0.535; 0.75,0.6; 0.875,0.7335; 1,1">
                                          <p:stCondLst>
                                            <p:cond delay="332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9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7" dur="166" tmFilter="0, 0; 0.125,0.2665; 0.25,0.4; 0.375,0.465; 0.5,0.5;  0.625,0.535; 0.75,0.6; 0.875,0.7335; 1,1">
                                          <p:stCondLst>
                                            <p:cond delay="662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27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8" dur="82" tmFilter="0, 0; 0.125,0.2665; 0.25,0.4; 0.375,0.465; 0.5,0.5;  0.625,0.535; 0.75,0.6; 0.875,0.7335; 1,1">
                                          <p:stCondLst>
                                            <p:cond delay="828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81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Scale>
                                      <p:cBhvr>
                                        <p:cTn id="29" dur="13">
                                          <p:stCondLst>
                                            <p:cond delay="325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60000"/>
                                    </p:animScale>
                                    <p:animScale>
                                      <p:cBhvr>
                                        <p:cTn id="30" dur="83" decel="50000">
                                          <p:stCondLst>
                                            <p:cond delay="338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31" dur="13">
                                          <p:stCondLst>
                                            <p:cond delay="656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80000"/>
                                    </p:animScale>
                                    <p:animScale>
                                      <p:cBhvr>
                                        <p:cTn id="32" dur="83" decel="50000">
                                          <p:stCondLst>
                                            <p:cond delay="669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33" dur="13">
                                          <p:stCondLst>
                                            <p:cond delay="821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90000"/>
                                    </p:animScale>
                                    <p:animScale>
                                      <p:cBhvr>
                                        <p:cTn id="34" dur="83" decel="50000">
                                          <p:stCondLst>
                                            <p:cond delay="834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35" dur="13">
                                          <p:stCondLst>
                                            <p:cond delay="904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95000"/>
                                    </p:animScale>
                                    <p:animScale>
                                      <p:cBhvr>
                                        <p:cTn id="36" dur="83" decel="50000">
                                          <p:stCondLst>
                                            <p:cond delay="917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100000"/>
                                    </p:animScale>
                                  </p:childTnLst>
                                </p:cTn>
                              </p:par>
                              <p:par>
                                <p:cTn id="37" presetID="26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39" dur="29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40" dur="911" tmFilter="0,0; 0.14,0.36; 0.43,0.73; 0.71,0.91; 1.0,1.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-0.25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1" dur="332" tmFilter="0.0,0.0; 0.25,0.07; 0.50,0.2; 0.75,0.467; 1.0,1.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3">
                                          <p:val>
                                            <p:fltVal val="0.5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2" dur="332" tmFilter="0, 0; 0.125,0.2665; 0.25,0.4; 0.375,0.465; 0.5,0.5;  0.625,0.535; 0.75,0.6; 0.875,0.7335; 1,1">
                                          <p:stCondLst>
                                            <p:cond delay="332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9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3" dur="166" tmFilter="0, 0; 0.125,0.2665; 0.25,0.4; 0.375,0.465; 0.5,0.5;  0.625,0.535; 0.75,0.6; 0.875,0.7335; 1,1">
                                          <p:stCondLst>
                                            <p:cond delay="662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27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4" dur="82" tmFilter="0, 0; 0.125,0.2665; 0.25,0.4; 0.375,0.465; 0.5,0.5;  0.625,0.535; 0.75,0.6; 0.875,0.7335; 1,1">
                                          <p:stCondLst>
                                            <p:cond delay="828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81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Scale>
                                      <p:cBhvr>
                                        <p:cTn id="45" dur="13">
                                          <p:stCondLst>
                                            <p:cond delay="325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60000"/>
                                    </p:animScale>
                                    <p:animScale>
                                      <p:cBhvr>
                                        <p:cTn id="46" dur="83" decel="50000">
                                          <p:stCondLst>
                                            <p:cond delay="338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47" dur="13">
                                          <p:stCondLst>
                                            <p:cond delay="656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80000"/>
                                    </p:animScale>
                                    <p:animScale>
                                      <p:cBhvr>
                                        <p:cTn id="48" dur="83" decel="50000">
                                          <p:stCondLst>
                                            <p:cond delay="669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49" dur="13">
                                          <p:stCondLst>
                                            <p:cond delay="821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90000"/>
                                    </p:animScale>
                                    <p:animScale>
                                      <p:cBhvr>
                                        <p:cTn id="50" dur="83" decel="50000">
                                          <p:stCondLst>
                                            <p:cond delay="834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51" dur="13">
                                          <p:stCondLst>
                                            <p:cond delay="904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95000"/>
                                    </p:animScale>
                                    <p:animScale>
                                      <p:cBhvr>
                                        <p:cTn id="52" dur="83" decel="50000">
                                          <p:stCondLst>
                                            <p:cond delay="917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100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 animBg="1"/>
      <p:bldP spid="8" grpId="0" animBg="1"/>
      <p:bldP spid="9" grpId="0" animBg="1"/>
    </p:bld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6081A5-7992-7641-BEE0-6636B76D70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15459" y="58786"/>
            <a:ext cx="7768784" cy="1006085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em Cell Transpla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3E075BA-5E2B-BC47-A2BB-F42FC900972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88138" y="1492467"/>
            <a:ext cx="4342678" cy="3095445"/>
          </a:xfrm>
        </p:spPr>
        <p:txBody>
          <a:bodyPr anchor="t">
            <a:noAutofit/>
          </a:bodyPr>
          <a:lstStyle/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sz="2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hat are stem cells?</a:t>
            </a:r>
          </a:p>
          <a:p>
            <a:pPr lvl="1">
              <a:lnSpc>
                <a:spcPct val="100000"/>
              </a:lnSpc>
              <a:spcBef>
                <a:spcPts val="600"/>
              </a:spcBef>
            </a:pPr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 young cell that can develop into nearly any cell type.</a:t>
            </a:r>
          </a:p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sz="2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eats cancer by restoring stem cells in cancer patients whose stem cells have been destroyed by chemotherapy/radiation. </a:t>
            </a:r>
          </a:p>
          <a:p>
            <a:pPr lvl="1">
              <a:lnSpc>
                <a:spcPct val="100000"/>
              </a:lnSpc>
              <a:spcBef>
                <a:spcPts val="600"/>
              </a:spcBef>
            </a:pPr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tores white blood cells, red blood cells, and platelets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7C8ADEF-0559-C748-81AF-9CCF63305B1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43332" y="2089819"/>
            <a:ext cx="6783856" cy="33989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193458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D305F6-5279-4E47-8595-C76336EF84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05185" y="2178841"/>
            <a:ext cx="4177013" cy="2500317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lnSpc>
                <a:spcPct val="100000"/>
              </a:lnSpc>
            </a:pPr>
            <a:r>
              <a:rPr lang="en-US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utologous, Allogeneic, and Syngeneic</a:t>
            </a:r>
          </a:p>
        </p:txBody>
      </p:sp>
      <p:graphicFrame>
        <p:nvGraphicFramePr>
          <p:cNvPr id="24" name="Content Placeholder 2">
            <a:extLst>
              <a:ext uri="{FF2B5EF4-FFF2-40B4-BE49-F238E27FC236}">
                <a16:creationId xmlns:a16="http://schemas.microsoft.com/office/drawing/2014/main" id="{9366E5D8-1595-4C03-B2C2-6B31C6AB4D2C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974126317"/>
              </p:ext>
            </p:extLst>
          </p:nvPr>
        </p:nvGraphicFramePr>
        <p:xfrm>
          <a:off x="5561161" y="992387"/>
          <a:ext cx="5924387" cy="487322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1716760810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A202C686-F6E1-3C49-9C20-775488608278}"/>
              </a:ext>
            </a:extLst>
          </p:cNvPr>
          <p:cNvSpPr/>
          <p:nvPr/>
        </p:nvSpPr>
        <p:spPr>
          <a:xfrm>
            <a:off x="6799604" y="0"/>
            <a:ext cx="5392396" cy="68580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838049EF-51EE-8C4D-91B1-ACDD52F491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51867" y="627564"/>
            <a:ext cx="5537837" cy="1325563"/>
          </a:xfrm>
        </p:spPr>
        <p:txBody>
          <a:bodyPr vert="horz" lIns="91440" tIns="45720" rIns="91440" bIns="45720" rtlCol="0" anchor="b">
            <a:normAutofit fontScale="90000"/>
          </a:bodyPr>
          <a:lstStyle/>
          <a:p>
            <a:pPr>
              <a:lnSpc>
                <a:spcPct val="100000"/>
              </a:lnSpc>
            </a:pPr>
            <a:r>
              <a:rPr lang="en-US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de Effects of Stem Cell Transplant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377866-CC09-C84D-A91E-A8E737078A5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36429" y="2278173"/>
            <a:ext cx="4959571" cy="4079898"/>
          </a:xfrm>
        </p:spPr>
        <p:txBody>
          <a:bodyPr anchor="ctr">
            <a:normAutofit/>
          </a:bodyPr>
          <a:lstStyle/>
          <a:p>
            <a:pPr>
              <a:lnSpc>
                <a:spcPct val="100000"/>
              </a:lnSpc>
              <a:spcBef>
                <a:spcPts val="1200"/>
              </a:spcBef>
            </a:pP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Graft-versus-host disease</a:t>
            </a:r>
          </a:p>
          <a:p>
            <a:pPr lvl="1">
              <a:lnSpc>
                <a:spcPct val="100000"/>
              </a:lnSpc>
              <a:spcBef>
                <a:spcPts val="1200"/>
              </a:spcBef>
            </a:pPr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When white blood cells from the donor recognize cells in the patient’s body as foreign and attack them.</a:t>
            </a:r>
          </a:p>
          <a:p>
            <a:pPr lvl="1">
              <a:lnSpc>
                <a:spcPct val="100000"/>
              </a:lnSpc>
              <a:spcBef>
                <a:spcPts val="1200"/>
              </a:spcBef>
            </a:pPr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Causes damage to skin, liver, intestines, and other organs.</a:t>
            </a:r>
          </a:p>
          <a:p>
            <a:pPr lvl="1">
              <a:lnSpc>
                <a:spcPct val="100000"/>
              </a:lnSpc>
              <a:spcBef>
                <a:spcPts val="1200"/>
              </a:spcBef>
            </a:pPr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The closer related the patient is to the donor, the less likely they are to develop this. 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792427A5-9BDF-B546-A08C-73D4E30F5981}"/>
              </a:ext>
            </a:extLst>
          </p:cNvPr>
          <p:cNvSpPr/>
          <p:nvPr/>
        </p:nvSpPr>
        <p:spPr>
          <a:xfrm>
            <a:off x="8445788" y="1582293"/>
            <a:ext cx="2362200" cy="1970314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Graphic 8" descr="IV">
            <a:extLst>
              <a:ext uri="{FF2B5EF4-FFF2-40B4-BE49-F238E27FC236}">
                <a16:creationId xmlns:a16="http://schemas.microsoft.com/office/drawing/2014/main" id="{B40AE9E9-7B95-2644-8E16-9B94EB4667F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7062432" y="627564"/>
            <a:ext cx="5031557" cy="5031557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E32401E8-D7F4-EC42-9B09-27071BF82053}"/>
              </a:ext>
            </a:extLst>
          </p:cNvPr>
          <p:cNvSpPr/>
          <p:nvPr/>
        </p:nvSpPr>
        <p:spPr>
          <a:xfrm>
            <a:off x="9426011" y="4969684"/>
            <a:ext cx="284307" cy="2134266"/>
          </a:xfrm>
          <a:prstGeom prst="rect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595367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CF4ECB-1AAE-7B46-831A-8ACD4638FC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 vert="horz" lIns="91440" tIns="45720" rIns="91440" bIns="45720" rtlCol="0" anchor="ctr">
            <a:normAutofit/>
          </a:bodyPr>
          <a:lstStyle/>
          <a:p>
            <a:r>
              <a:rPr lang="en-US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mmary</a:t>
            </a:r>
          </a:p>
        </p:txBody>
      </p:sp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49AE121A-74DF-F04A-9480-490FDD817E16}"/>
              </a:ext>
            </a:extLst>
          </p:cNvPr>
          <p:cNvSpPr txBox="1">
            <a:spLocks/>
          </p:cNvSpPr>
          <p:nvPr/>
        </p:nvSpPr>
        <p:spPr>
          <a:xfrm>
            <a:off x="965200" y="1690688"/>
            <a:ext cx="9605948" cy="431579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10000"/>
              </a:lnSpc>
            </a:pP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ancer is diagnosed with a scan followed by a biopsy.</a:t>
            </a:r>
          </a:p>
          <a:p>
            <a:pPr>
              <a:lnSpc>
                <a:spcPct val="110000"/>
              </a:lnSpc>
            </a:pP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Early detection is the key to survival!</a:t>
            </a:r>
          </a:p>
          <a:p>
            <a:pPr lvl="1"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Barriers to early detection include a lack of access </a:t>
            </a:r>
            <a:r>
              <a:rPr lang="en-US" sz="2200">
                <a:latin typeface="Arial" panose="020B0604020202020204" pitchFamily="34" charset="0"/>
                <a:cs typeface="Arial" panose="020B0604020202020204" pitchFamily="34" charset="0"/>
              </a:rPr>
              <a:t>to healthcare.</a:t>
            </a:r>
            <a:endParaRPr 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1"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Rural areas have lower rates of early detection, which means they have a higher number of late-stage cancer cases.</a:t>
            </a:r>
          </a:p>
          <a:p>
            <a:pPr>
              <a:lnSpc>
                <a:spcPct val="110000"/>
              </a:lnSpc>
            </a:pP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There are 4 types of common cancer treatment: Chemotherapy, radiation therapy, surgery, and stem cell transplant.</a:t>
            </a:r>
          </a:p>
          <a:p>
            <a:pPr lvl="1"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Each treatment interacts with the body differently.</a:t>
            </a:r>
          </a:p>
          <a:p>
            <a:pPr lvl="1"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Each treatment has different side effects.</a:t>
            </a:r>
          </a:p>
        </p:txBody>
      </p:sp>
    </p:spTree>
    <p:extLst>
      <p:ext uri="{BB962C8B-B14F-4D97-AF65-F5344CB8AC3E}">
        <p14:creationId xmlns:p14="http://schemas.microsoft.com/office/powerpoint/2010/main" val="3721845719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sitting, door, snow, standing&#10;&#10;Description automatically generated">
            <a:extLst>
              <a:ext uri="{FF2B5EF4-FFF2-40B4-BE49-F238E27FC236}">
                <a16:creationId xmlns:a16="http://schemas.microsoft.com/office/drawing/2014/main" id="{001A086B-3E83-D946-983D-337CCADB903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5400000">
            <a:off x="2683867" y="-2683868"/>
            <a:ext cx="6857999" cy="12225737"/>
          </a:xfrm>
          <a:prstGeom prst="rect">
            <a:avLst/>
          </a:prstGeom>
        </p:spPr>
      </p:pic>
      <p:sp>
        <p:nvSpPr>
          <p:cNvPr id="6" name="Title 1">
            <a:extLst>
              <a:ext uri="{FF2B5EF4-FFF2-40B4-BE49-F238E27FC236}">
                <a16:creationId xmlns:a16="http://schemas.microsoft.com/office/drawing/2014/main" id="{A714D208-9323-6840-A689-74EB10860B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544460" y="2617286"/>
            <a:ext cx="7777175" cy="2135867"/>
          </a:xfrm>
        </p:spPr>
        <p:txBody>
          <a:bodyPr anchor="b">
            <a:noAutofit/>
          </a:bodyPr>
          <a:lstStyle/>
          <a:p>
            <a:pPr algn="ctr"/>
            <a:r>
              <a:rPr lang="en-US" sz="100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QUESTIONS</a:t>
            </a:r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D13E15C7-181A-4F45-B98B-4AB6076D6C27}"/>
              </a:ext>
            </a:extLst>
          </p:cNvPr>
          <p:cNvSpPr/>
          <p:nvPr/>
        </p:nvSpPr>
        <p:spPr>
          <a:xfrm>
            <a:off x="4774019" y="2617286"/>
            <a:ext cx="466155" cy="466155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CB7800A7-5E48-B348-AAE0-7F88BDB88DFF}"/>
              </a:ext>
            </a:extLst>
          </p:cNvPr>
          <p:cNvSpPr/>
          <p:nvPr/>
        </p:nvSpPr>
        <p:spPr>
          <a:xfrm>
            <a:off x="5868318" y="2617286"/>
            <a:ext cx="466155" cy="466155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accent1"/>
              </a:solidFill>
            </a:endParaRPr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92B0E41C-5917-884A-92AA-14597EF33BEF}"/>
              </a:ext>
            </a:extLst>
          </p:cNvPr>
          <p:cNvSpPr/>
          <p:nvPr/>
        </p:nvSpPr>
        <p:spPr>
          <a:xfrm>
            <a:off x="6962617" y="2617285"/>
            <a:ext cx="466155" cy="466155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770380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6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7" dur="29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911" tmFilter="0,0; 0.14,0.36; 0.43,0.73; 0.71,0.91; 1.0,1.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-0.25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332" tmFilter="0.0,0.0; 0.25,0.07; 0.50,0.2; 0.75,0.467; 1.0,1.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3">
                                          <p:val>
                                            <p:fltVal val="0.5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0" dur="332" tmFilter="0, 0; 0.125,0.2665; 0.25,0.4; 0.375,0.465; 0.5,0.5;  0.625,0.535; 0.75,0.6; 0.875,0.7335; 1,1">
                                          <p:stCondLst>
                                            <p:cond delay="332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9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1" dur="166" tmFilter="0, 0; 0.125,0.2665; 0.25,0.4; 0.375,0.465; 0.5,0.5;  0.625,0.535; 0.75,0.6; 0.875,0.7335; 1,1">
                                          <p:stCondLst>
                                            <p:cond delay="662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27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2" dur="82" tmFilter="0, 0; 0.125,0.2665; 0.25,0.4; 0.375,0.465; 0.5,0.5;  0.625,0.535; 0.75,0.6; 0.875,0.7335; 1,1">
                                          <p:stCondLst>
                                            <p:cond delay="828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81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Scale>
                                      <p:cBhvr>
                                        <p:cTn id="13" dur="13">
                                          <p:stCondLst>
                                            <p:cond delay="325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60000"/>
                                    </p:animScale>
                                    <p:animScale>
                                      <p:cBhvr>
                                        <p:cTn id="14" dur="83" decel="50000">
                                          <p:stCondLst>
                                            <p:cond delay="338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15" dur="13">
                                          <p:stCondLst>
                                            <p:cond delay="656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80000"/>
                                    </p:animScale>
                                    <p:animScale>
                                      <p:cBhvr>
                                        <p:cTn id="16" dur="83" decel="50000">
                                          <p:stCondLst>
                                            <p:cond delay="669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17" dur="13">
                                          <p:stCondLst>
                                            <p:cond delay="821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90000"/>
                                    </p:animScale>
                                    <p:animScale>
                                      <p:cBhvr>
                                        <p:cTn id="18" dur="83" decel="50000">
                                          <p:stCondLst>
                                            <p:cond delay="834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19" dur="13">
                                          <p:stCondLst>
                                            <p:cond delay="904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95000"/>
                                    </p:animScale>
                                    <p:animScale>
                                      <p:cBhvr>
                                        <p:cTn id="20" dur="83" decel="50000">
                                          <p:stCondLst>
                                            <p:cond delay="917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100000"/>
                                    </p:animScale>
                                  </p:childTnLst>
                                </p:cTn>
                              </p:par>
                              <p:par>
                                <p:cTn id="21" presetID="26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23" dur="29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4" dur="911" tmFilter="0,0; 0.14,0.36; 0.43,0.73; 0.71,0.91; 1.0,1.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-0.25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5" dur="332" tmFilter="0.0,0.0; 0.25,0.07; 0.50,0.2; 0.75,0.467; 1.0,1.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3">
                                          <p:val>
                                            <p:fltVal val="0.5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6" dur="332" tmFilter="0, 0; 0.125,0.2665; 0.25,0.4; 0.375,0.465; 0.5,0.5;  0.625,0.535; 0.75,0.6; 0.875,0.7335; 1,1">
                                          <p:stCondLst>
                                            <p:cond delay="332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9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7" dur="166" tmFilter="0, 0; 0.125,0.2665; 0.25,0.4; 0.375,0.465; 0.5,0.5;  0.625,0.535; 0.75,0.6; 0.875,0.7335; 1,1">
                                          <p:stCondLst>
                                            <p:cond delay="662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27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8" dur="82" tmFilter="0, 0; 0.125,0.2665; 0.25,0.4; 0.375,0.465; 0.5,0.5;  0.625,0.535; 0.75,0.6; 0.875,0.7335; 1,1">
                                          <p:stCondLst>
                                            <p:cond delay="828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81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Scale>
                                      <p:cBhvr>
                                        <p:cTn id="29" dur="13">
                                          <p:stCondLst>
                                            <p:cond delay="325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60000"/>
                                    </p:animScale>
                                    <p:animScale>
                                      <p:cBhvr>
                                        <p:cTn id="30" dur="83" decel="50000">
                                          <p:stCondLst>
                                            <p:cond delay="338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31" dur="13">
                                          <p:stCondLst>
                                            <p:cond delay="656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80000"/>
                                    </p:animScale>
                                    <p:animScale>
                                      <p:cBhvr>
                                        <p:cTn id="32" dur="83" decel="50000">
                                          <p:stCondLst>
                                            <p:cond delay="669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33" dur="13">
                                          <p:stCondLst>
                                            <p:cond delay="821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90000"/>
                                    </p:animScale>
                                    <p:animScale>
                                      <p:cBhvr>
                                        <p:cTn id="34" dur="83" decel="50000">
                                          <p:stCondLst>
                                            <p:cond delay="834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35" dur="13">
                                          <p:stCondLst>
                                            <p:cond delay="904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95000"/>
                                    </p:animScale>
                                    <p:animScale>
                                      <p:cBhvr>
                                        <p:cTn id="36" dur="83" decel="50000">
                                          <p:stCondLst>
                                            <p:cond delay="917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100000"/>
                                    </p:animScale>
                                  </p:childTnLst>
                                </p:cTn>
                              </p:par>
                              <p:par>
                                <p:cTn id="37" presetID="26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39" dur="29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40" dur="911" tmFilter="0,0; 0.14,0.36; 0.43,0.73; 0.71,0.91; 1.0,1.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-0.25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1" dur="332" tmFilter="0.0,0.0; 0.25,0.07; 0.50,0.2; 0.75,0.467; 1.0,1.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3">
                                          <p:val>
                                            <p:fltVal val="0.5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2" dur="332" tmFilter="0, 0; 0.125,0.2665; 0.25,0.4; 0.375,0.465; 0.5,0.5;  0.625,0.535; 0.75,0.6; 0.875,0.7335; 1,1">
                                          <p:stCondLst>
                                            <p:cond delay="332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9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3" dur="166" tmFilter="0, 0; 0.125,0.2665; 0.25,0.4; 0.375,0.465; 0.5,0.5;  0.625,0.535; 0.75,0.6; 0.875,0.7335; 1,1">
                                          <p:stCondLst>
                                            <p:cond delay="662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27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4" dur="82" tmFilter="0, 0; 0.125,0.2665; 0.25,0.4; 0.375,0.465; 0.5,0.5;  0.625,0.535; 0.75,0.6; 0.875,0.7335; 1,1">
                                          <p:stCondLst>
                                            <p:cond delay="828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81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Scale>
                                      <p:cBhvr>
                                        <p:cTn id="45" dur="13">
                                          <p:stCondLst>
                                            <p:cond delay="325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60000"/>
                                    </p:animScale>
                                    <p:animScale>
                                      <p:cBhvr>
                                        <p:cTn id="46" dur="83" decel="50000">
                                          <p:stCondLst>
                                            <p:cond delay="338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47" dur="13">
                                          <p:stCondLst>
                                            <p:cond delay="656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80000"/>
                                    </p:animScale>
                                    <p:animScale>
                                      <p:cBhvr>
                                        <p:cTn id="48" dur="83" decel="50000">
                                          <p:stCondLst>
                                            <p:cond delay="669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49" dur="13">
                                          <p:stCondLst>
                                            <p:cond delay="821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90000"/>
                                    </p:animScale>
                                    <p:animScale>
                                      <p:cBhvr>
                                        <p:cTn id="50" dur="83" decel="50000">
                                          <p:stCondLst>
                                            <p:cond delay="834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51" dur="13">
                                          <p:stCondLst>
                                            <p:cond delay="904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95000"/>
                                    </p:animScale>
                                    <p:animScale>
                                      <p:cBhvr>
                                        <p:cTn id="52" dur="83" decel="50000">
                                          <p:stCondLst>
                                            <p:cond delay="917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100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 animBg="1"/>
      <p:bldP spid="8" grpId="0" animBg="1"/>
      <p:bldP spid="9" grpId="0" animBg="1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EACAAD-01BC-7D44-AFE9-329691FF58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ncer </a:t>
            </a:r>
            <a:r>
              <a:rPr lang="en-US" b="1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eatments In Depth</a:t>
            </a:r>
            <a:endParaRPr lang="en-US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DB9EFB-9CF2-064A-B24F-3159702A927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>
              <a:spcBef>
                <a:spcPts val="900"/>
              </a:spcBef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You will each be assigned into a group. There will be a total of 4 groups. </a:t>
            </a:r>
          </a:p>
          <a:p>
            <a:pPr>
              <a:spcBef>
                <a:spcPts val="900"/>
              </a:spcBef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Your group will be assigned one of the following cancer treatments. Research it in depth. </a:t>
            </a:r>
          </a:p>
          <a:p>
            <a:pPr lvl="1">
              <a:spcBef>
                <a:spcPts val="900"/>
              </a:spcBef>
              <a:buFont typeface="System Font Regular"/>
              <a:buChar char="–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hemotherapy, radiation therapy, surgery, stem cell transplant</a:t>
            </a:r>
          </a:p>
          <a:p>
            <a:pPr>
              <a:spcBef>
                <a:spcPts val="900"/>
              </a:spcBef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You will then partner with another group and explain to them how this treatment works.</a:t>
            </a:r>
          </a:p>
          <a:p>
            <a:pPr lvl="1">
              <a:lnSpc>
                <a:spcPct val="100000"/>
              </a:lnSpc>
              <a:spcBef>
                <a:spcPts val="900"/>
              </a:spcBef>
              <a:buFont typeface="System Font Regular"/>
              <a:buChar char="–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int: Consider how the treatment works, why it is useful, and what side effects it may cause.</a:t>
            </a:r>
          </a:p>
        </p:txBody>
      </p:sp>
    </p:spTree>
    <p:extLst>
      <p:ext uri="{BB962C8B-B14F-4D97-AF65-F5344CB8AC3E}">
        <p14:creationId xmlns:p14="http://schemas.microsoft.com/office/powerpoint/2010/main" val="41182582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4AD701DC-B23C-D54F-B9C0-5245EAA26AB4}"/>
              </a:ext>
            </a:extLst>
          </p:cNvPr>
          <p:cNvSpPr/>
          <p:nvPr/>
        </p:nvSpPr>
        <p:spPr>
          <a:xfrm>
            <a:off x="0" y="0"/>
            <a:ext cx="7871254" cy="7018638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0DF1917D-545E-EB49-AEF1-6EC7F5934D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2899" y="301628"/>
            <a:ext cx="5472200" cy="1873159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w is Cancer Diagnosed?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920F69-4A3B-9549-A81B-FE339BB2F3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22899" y="2174788"/>
            <a:ext cx="5211781" cy="3801109"/>
          </a:xfrm>
        </p:spPr>
        <p:txBody>
          <a:bodyPr anchor="t">
            <a:noAutofit/>
          </a:bodyPr>
          <a:lstStyle/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sz="2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s may come in with a lump, but the cells of the lump must be examined closer to determine if it is cancer.</a:t>
            </a:r>
          </a:p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sz="2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ten diagnosed with a scan, followed by a biopsy.</a:t>
            </a:r>
          </a:p>
          <a:p>
            <a:pPr lvl="1">
              <a:lnSpc>
                <a:spcPct val="100000"/>
              </a:lnSpc>
              <a:spcBef>
                <a:spcPts val="600"/>
              </a:spcBef>
              <a:buFont typeface="System Font Regular"/>
              <a:buChar char="–"/>
            </a:pPr>
            <a:r>
              <a:rPr lang="en-US" sz="2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opsy: A procedure in which a doctor removes a sample of the cancer to be sent to the lab.</a:t>
            </a:r>
          </a:p>
          <a:p>
            <a:pPr lvl="1">
              <a:lnSpc>
                <a:spcPct val="100000"/>
              </a:lnSpc>
              <a:spcBef>
                <a:spcPts val="600"/>
              </a:spcBef>
              <a:buFont typeface="System Font Regular"/>
              <a:buChar char="–"/>
            </a:pPr>
            <a:r>
              <a:rPr lang="en-US" sz="2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 expert will then look at the sample with a microscope to see if it is cancerous.</a:t>
            </a:r>
          </a:p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sz="2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nce cancer is diagnosed, it can be treated.</a:t>
            </a:r>
          </a:p>
        </p:txBody>
      </p:sp>
      <p:pic>
        <p:nvPicPr>
          <p:cNvPr id="4" name="Picture 3" descr="A screenshot of a cell phone&#10;&#10;Description automatically generated">
            <a:extLst>
              <a:ext uri="{FF2B5EF4-FFF2-40B4-BE49-F238E27FC236}">
                <a16:creationId xmlns:a16="http://schemas.microsoft.com/office/drawing/2014/main" id="{F37E4EF2-FE47-C447-BE05-EB1C2B70814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95099" y="2174789"/>
            <a:ext cx="5968902" cy="39170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96690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phic 4" descr="DNA">
            <a:extLst>
              <a:ext uri="{FF2B5EF4-FFF2-40B4-BE49-F238E27FC236}">
                <a16:creationId xmlns:a16="http://schemas.microsoft.com/office/drawing/2014/main" id="{406E1F88-C73C-BD47-9D1A-BA26CE83027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7850378" y="1014539"/>
            <a:ext cx="5031557" cy="5031557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DA0BA24C-962B-2946-8F73-CA2B0C4E68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27903" y="406016"/>
            <a:ext cx="7821826" cy="1167623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hat is Early Detection?</a:t>
            </a:r>
          </a:p>
        </p:txBody>
      </p:sp>
      <p:pic>
        <p:nvPicPr>
          <p:cNvPr id="7" name="Graphic 6" descr="DNA">
            <a:extLst>
              <a:ext uri="{FF2B5EF4-FFF2-40B4-BE49-F238E27FC236}">
                <a16:creationId xmlns:a16="http://schemas.microsoft.com/office/drawing/2014/main" id="{4EFA88A7-F5B7-4CD1-B40E-6ADB68E0BD3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7788593" y="1063968"/>
            <a:ext cx="5031557" cy="5031557"/>
          </a:xfrm>
          <a:prstGeom prst="rect">
            <a:avLst/>
          </a:prstGeom>
        </p:spPr>
      </p:pic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05D315-5769-CE4E-80D4-500B60190F2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27903" y="2012603"/>
            <a:ext cx="7216347" cy="3594528"/>
          </a:xfrm>
        </p:spPr>
        <p:txBody>
          <a:bodyPr anchor="t">
            <a:noAutofit/>
          </a:bodyPr>
          <a:lstStyle/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hen cancer is found during its early stages of development:</a:t>
            </a:r>
          </a:p>
          <a:p>
            <a:pPr lvl="1">
              <a:lnSpc>
                <a:spcPct val="100000"/>
              </a:lnSpc>
              <a:spcBef>
                <a:spcPts val="600"/>
              </a:spcBef>
            </a:pPr>
            <a:r>
              <a:rPr lang="en-US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t is small.</a:t>
            </a:r>
          </a:p>
          <a:p>
            <a:pPr lvl="1">
              <a:lnSpc>
                <a:spcPct val="100000"/>
              </a:lnSpc>
              <a:spcBef>
                <a:spcPts val="600"/>
              </a:spcBef>
            </a:pPr>
            <a:r>
              <a:rPr lang="en-US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t </a:t>
            </a:r>
            <a:r>
              <a:rPr lang="en-US"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asn’t spread.</a:t>
            </a:r>
            <a:endParaRPr lang="en-US" sz="2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rely are there signs/symptoms during this stage.</a:t>
            </a:r>
          </a:p>
          <a:p>
            <a:pPr lvl="1">
              <a:lnSpc>
                <a:spcPct val="100000"/>
              </a:lnSpc>
              <a:spcBef>
                <a:spcPts val="600"/>
              </a:spcBef>
            </a:pP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Early detection is achieved by completing a regular screening test for a certain cancer type.</a:t>
            </a:r>
          </a:p>
        </p:txBody>
      </p:sp>
    </p:spTree>
    <p:extLst>
      <p:ext uri="{BB962C8B-B14F-4D97-AF65-F5344CB8AC3E}">
        <p14:creationId xmlns:p14="http://schemas.microsoft.com/office/powerpoint/2010/main" val="406250382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3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5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1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2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3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5" dur="5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6" dur="5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D804F9-3805-4544-8033-7E5A813916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2144" y="940910"/>
            <a:ext cx="5069451" cy="4976179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54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hy is Early Detection Important?</a:t>
            </a:r>
          </a:p>
        </p:txBody>
      </p:sp>
      <p:graphicFrame>
        <p:nvGraphicFramePr>
          <p:cNvPr id="5" name="Content Placeholder 2">
            <a:extLst>
              <a:ext uri="{FF2B5EF4-FFF2-40B4-BE49-F238E27FC236}">
                <a16:creationId xmlns:a16="http://schemas.microsoft.com/office/drawing/2014/main" id="{4857F3F2-23AB-4303-87C0-FC40ABA0998B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407991242"/>
              </p:ext>
            </p:extLst>
          </p:nvPr>
        </p:nvGraphicFramePr>
        <p:xfrm>
          <a:off x="5766179" y="805218"/>
          <a:ext cx="5710451" cy="5329163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25383825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0" name="Rectangle 9">
            <a:extLst>
              <a:ext uri="{FF2B5EF4-FFF2-40B4-BE49-F238E27FC236}">
                <a16:creationId xmlns:a16="http://schemas.microsoft.com/office/drawing/2014/main" id="{70DFA0FD-AB28-4B25-B870-4D2BBC35BA1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1695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Picture 4" descr="A picture containing light, traffic, lit, cake&#10;&#10;Description automatically generated">
            <a:extLst>
              <a:ext uri="{FF2B5EF4-FFF2-40B4-BE49-F238E27FC236}">
                <a16:creationId xmlns:a16="http://schemas.microsoft.com/office/drawing/2014/main" id="{E483249B-0F8A-094C-A703-AEB13F0104C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alphaModFix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833976" y="10"/>
            <a:ext cx="6394152" cy="6857990"/>
          </a:xfrm>
          <a:prstGeom prst="rect">
            <a:avLst/>
          </a:prstGeom>
        </p:spPr>
      </p:pic>
      <p:grpSp>
        <p:nvGrpSpPr>
          <p:cNvPr id="12" name="Group 11">
            <a:extLst>
              <a:ext uri="{FF2B5EF4-FFF2-40B4-BE49-F238E27FC236}">
                <a16:creationId xmlns:a16="http://schemas.microsoft.com/office/drawing/2014/main" id="{0D628DFB-9CD1-4E2B-8B44-9FDF7E80F6D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5579564" y="0"/>
            <a:ext cx="6648564" cy="6858000"/>
            <a:chOff x="5705128" y="0"/>
            <a:chExt cx="6648564" cy="6858000"/>
          </a:xfrm>
        </p:grpSpPr>
        <p:sp>
          <p:nvSpPr>
            <p:cNvPr id="13" name="Freeform: Shape 12">
              <a:extLst>
                <a:ext uri="{FF2B5EF4-FFF2-40B4-BE49-F238E27FC236}">
                  <a16:creationId xmlns:a16="http://schemas.microsoft.com/office/drawing/2014/main" id="{4CB07514-66C4-498E-85FA-6CCDFB2531C2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868018" y="0"/>
              <a:ext cx="6485674" cy="6858000"/>
            </a:xfrm>
            <a:custGeom>
              <a:avLst/>
              <a:gdLst>
                <a:gd name="connsiteX0" fmla="*/ 1720317 w 6237794"/>
                <a:gd name="connsiteY0" fmla="*/ 0 h 6858000"/>
                <a:gd name="connsiteX1" fmla="*/ 2433560 w 6237794"/>
                <a:gd name="connsiteY1" fmla="*/ 0 h 6858000"/>
                <a:gd name="connsiteX2" fmla="*/ 2351473 w 6237794"/>
                <a:gd name="connsiteY2" fmla="*/ 41605 h 6858000"/>
                <a:gd name="connsiteX3" fmla="*/ 1473152 w 6237794"/>
                <a:gd name="connsiteY3" fmla="*/ 667521 h 6858000"/>
                <a:gd name="connsiteX4" fmla="*/ 982876 w 6237794"/>
                <a:gd name="connsiteY4" fmla="*/ 1193803 h 6858000"/>
                <a:gd name="connsiteX5" fmla="*/ 595242 w 6237794"/>
                <a:gd name="connsiteY5" fmla="*/ 1798192 h 6858000"/>
                <a:gd name="connsiteX6" fmla="*/ 332174 w 6237794"/>
                <a:gd name="connsiteY6" fmla="*/ 2466315 h 6858000"/>
                <a:gd name="connsiteX7" fmla="*/ 236500 w 6237794"/>
                <a:gd name="connsiteY7" fmla="*/ 3178573 h 6858000"/>
                <a:gd name="connsiteX8" fmla="*/ 276860 w 6237794"/>
                <a:gd name="connsiteY8" fmla="*/ 3527298 h 6858000"/>
                <a:gd name="connsiteX9" fmla="*/ 396054 w 6237794"/>
                <a:gd name="connsiteY9" fmla="*/ 3853520 h 6858000"/>
                <a:gd name="connsiteX10" fmla="*/ 479243 w 6237794"/>
                <a:gd name="connsiteY10" fmla="*/ 4007121 h 6858000"/>
                <a:gd name="connsiteX11" fmla="*/ 574772 w 6237794"/>
                <a:gd name="connsiteY11" fmla="*/ 4155787 h 6858000"/>
                <a:gd name="connsiteX12" fmla="*/ 795447 w 6237794"/>
                <a:gd name="connsiteY12" fmla="*/ 4443100 h 6858000"/>
                <a:gd name="connsiteX13" fmla="*/ 1034270 w 6237794"/>
                <a:gd name="connsiteY13" fmla="*/ 4732591 h 6858000"/>
                <a:gd name="connsiteX14" fmla="*/ 1153028 w 6237794"/>
                <a:gd name="connsiteY14" fmla="*/ 4883725 h 6858000"/>
                <a:gd name="connsiteX15" fmla="*/ 1210084 w 6237794"/>
                <a:gd name="connsiteY15" fmla="*/ 4957912 h 6858000"/>
                <a:gd name="connsiteX16" fmla="*/ 1265979 w 6237794"/>
                <a:gd name="connsiteY16" fmla="*/ 5028906 h 6858000"/>
                <a:gd name="connsiteX17" fmla="*/ 1746238 w 6237794"/>
                <a:gd name="connsiteY17" fmla="*/ 5553590 h 6858000"/>
                <a:gd name="connsiteX18" fmla="*/ 2001611 w 6237794"/>
                <a:gd name="connsiteY18" fmla="*/ 5789654 h 6858000"/>
                <a:gd name="connsiteX19" fmla="*/ 2269035 w 6237794"/>
                <a:gd name="connsiteY19" fmla="*/ 6007280 h 6858000"/>
                <a:gd name="connsiteX20" fmla="*/ 2866455 w 6237794"/>
                <a:gd name="connsiteY20" fmla="*/ 6351505 h 6858000"/>
                <a:gd name="connsiteX21" fmla="*/ 3200661 w 6237794"/>
                <a:gd name="connsiteY21" fmla="*/ 6448777 h 6858000"/>
                <a:gd name="connsiteX22" fmla="*/ 3286318 w 6237794"/>
                <a:gd name="connsiteY22" fmla="*/ 6465908 h 6858000"/>
                <a:gd name="connsiteX23" fmla="*/ 3372701 w 6237794"/>
                <a:gd name="connsiteY23" fmla="*/ 6480281 h 6858000"/>
                <a:gd name="connsiteX24" fmla="*/ 3547063 w 6237794"/>
                <a:gd name="connsiteY24" fmla="*/ 6500896 h 6858000"/>
                <a:gd name="connsiteX25" fmla="*/ 3634753 w 6237794"/>
                <a:gd name="connsiteY25" fmla="*/ 6507575 h 6858000"/>
                <a:gd name="connsiteX26" fmla="*/ 3722733 w 6237794"/>
                <a:gd name="connsiteY26" fmla="*/ 6512221 h 6858000"/>
                <a:gd name="connsiteX27" fmla="*/ 3811003 w 6237794"/>
                <a:gd name="connsiteY27" fmla="*/ 6514253 h 6858000"/>
                <a:gd name="connsiteX28" fmla="*/ 3899418 w 6237794"/>
                <a:gd name="connsiteY28" fmla="*/ 6513817 h 6858000"/>
                <a:gd name="connsiteX29" fmla="*/ 3943698 w 6237794"/>
                <a:gd name="connsiteY29" fmla="*/ 6513381 h 6858000"/>
                <a:gd name="connsiteX30" fmla="*/ 3986381 w 6237794"/>
                <a:gd name="connsiteY30" fmla="*/ 6511495 h 6858000"/>
                <a:gd name="connsiteX31" fmla="*/ 4028919 w 6237794"/>
                <a:gd name="connsiteY31" fmla="*/ 6509317 h 6858000"/>
                <a:gd name="connsiteX32" fmla="*/ 4071312 w 6237794"/>
                <a:gd name="connsiteY32" fmla="*/ 6505833 h 6858000"/>
                <a:gd name="connsiteX33" fmla="*/ 4239432 w 6237794"/>
                <a:gd name="connsiteY33" fmla="*/ 6485072 h 6858000"/>
                <a:gd name="connsiteX34" fmla="*/ 4879826 w 6237794"/>
                <a:gd name="connsiteY34" fmla="*/ 6274849 h 6858000"/>
                <a:gd name="connsiteX35" fmla="*/ 5471439 w 6237794"/>
                <a:gd name="connsiteY35" fmla="*/ 5906235 h 6858000"/>
                <a:gd name="connsiteX36" fmla="*/ 5614877 w 6237794"/>
                <a:gd name="connsiteY36" fmla="*/ 5797930 h 6858000"/>
                <a:gd name="connsiteX37" fmla="*/ 5758316 w 6237794"/>
                <a:gd name="connsiteY37" fmla="*/ 5685995 h 6858000"/>
                <a:gd name="connsiteX38" fmla="*/ 6048824 w 6237794"/>
                <a:gd name="connsiteY38" fmla="*/ 5453705 h 6858000"/>
                <a:gd name="connsiteX39" fmla="*/ 6237794 w 6237794"/>
                <a:gd name="connsiteY39" fmla="*/ 5308644 h 6858000"/>
                <a:gd name="connsiteX40" fmla="*/ 6237794 w 6237794"/>
                <a:gd name="connsiteY40" fmla="*/ 6081399 h 6858000"/>
                <a:gd name="connsiteX41" fmla="*/ 6123011 w 6237794"/>
                <a:gd name="connsiteY41" fmla="*/ 6166399 h 6858000"/>
                <a:gd name="connsiteX42" fmla="*/ 5965925 w 6237794"/>
                <a:gd name="connsiteY42" fmla="*/ 6278479 h 6858000"/>
                <a:gd name="connsiteX43" fmla="*/ 5803903 w 6237794"/>
                <a:gd name="connsiteY43" fmla="*/ 6387364 h 6858000"/>
                <a:gd name="connsiteX44" fmla="*/ 5463744 w 6237794"/>
                <a:gd name="connsiteY44" fmla="*/ 6591780 h 6858000"/>
                <a:gd name="connsiteX45" fmla="*/ 5097888 w 6237794"/>
                <a:gd name="connsiteY45" fmla="*/ 6765562 h 6858000"/>
                <a:gd name="connsiteX46" fmla="*/ 4905602 w 6237794"/>
                <a:gd name="connsiteY46" fmla="*/ 6836446 h 6858000"/>
                <a:gd name="connsiteX47" fmla="*/ 4831447 w 6237794"/>
                <a:gd name="connsiteY47" fmla="*/ 6858000 h 6858000"/>
                <a:gd name="connsiteX48" fmla="*/ 3036485 w 6237794"/>
                <a:gd name="connsiteY48" fmla="*/ 6858000 h 6858000"/>
                <a:gd name="connsiteX49" fmla="*/ 2911533 w 6237794"/>
                <a:gd name="connsiteY49" fmla="*/ 6825558 h 6858000"/>
                <a:gd name="connsiteX50" fmla="*/ 2719386 w 6237794"/>
                <a:gd name="connsiteY50" fmla="*/ 6767158 h 6858000"/>
                <a:gd name="connsiteX51" fmla="*/ 1980415 w 6237794"/>
                <a:gd name="connsiteY51" fmla="*/ 6440210 h 6858000"/>
                <a:gd name="connsiteX52" fmla="*/ 1357588 w 6237794"/>
                <a:gd name="connsiteY52" fmla="*/ 5931206 h 6858000"/>
                <a:gd name="connsiteX53" fmla="*/ 1105118 w 6237794"/>
                <a:gd name="connsiteY53" fmla="*/ 5624874 h 6858000"/>
                <a:gd name="connsiteX54" fmla="*/ 884588 w 6237794"/>
                <a:gd name="connsiteY54" fmla="*/ 5300539 h 6858000"/>
                <a:gd name="connsiteX55" fmla="*/ 833049 w 6237794"/>
                <a:gd name="connsiteY55" fmla="*/ 5217931 h 6858000"/>
                <a:gd name="connsiteX56" fmla="*/ 783833 w 6237794"/>
                <a:gd name="connsiteY56" fmla="*/ 5137791 h 6858000"/>
                <a:gd name="connsiteX57" fmla="*/ 686706 w 6237794"/>
                <a:gd name="connsiteY57" fmla="*/ 4982447 h 6858000"/>
                <a:gd name="connsiteX58" fmla="*/ 485485 w 6237794"/>
                <a:gd name="connsiteY58" fmla="*/ 4665082 h 6858000"/>
                <a:gd name="connsiteX59" fmla="*/ 289055 w 6237794"/>
                <a:gd name="connsiteY59" fmla="*/ 4329568 h 6858000"/>
                <a:gd name="connsiteX60" fmla="*/ 200495 w 6237794"/>
                <a:gd name="connsiteY60" fmla="*/ 4151721 h 6858000"/>
                <a:gd name="connsiteX61" fmla="*/ 125291 w 6237794"/>
                <a:gd name="connsiteY61" fmla="*/ 3965600 h 6858000"/>
                <a:gd name="connsiteX62" fmla="*/ 67654 w 6237794"/>
                <a:gd name="connsiteY62" fmla="*/ 3772509 h 6858000"/>
                <a:gd name="connsiteX63" fmla="*/ 46168 w 6237794"/>
                <a:gd name="connsiteY63" fmla="*/ 3674076 h 6858000"/>
                <a:gd name="connsiteX64" fmla="*/ 36731 w 6237794"/>
                <a:gd name="connsiteY64" fmla="*/ 3624714 h 6858000"/>
                <a:gd name="connsiteX65" fmla="*/ 28891 w 6237794"/>
                <a:gd name="connsiteY65" fmla="*/ 3575208 h 6858000"/>
                <a:gd name="connsiteX66" fmla="*/ 0 w 6237794"/>
                <a:gd name="connsiteY66" fmla="*/ 3178573 h 6858000"/>
                <a:gd name="connsiteX67" fmla="*/ 80575 w 6237794"/>
                <a:gd name="connsiteY67" fmla="*/ 2405774 h 6858000"/>
                <a:gd name="connsiteX68" fmla="*/ 322737 w 6237794"/>
                <a:gd name="connsiteY68" fmla="*/ 1665351 h 6858000"/>
                <a:gd name="connsiteX69" fmla="*/ 1230700 w 6237794"/>
                <a:gd name="connsiteY69" fmla="*/ 407938 h 6858000"/>
                <a:gd name="connsiteX70" fmla="*/ 1521825 w 6237794"/>
                <a:gd name="connsiteY70" fmla="*/ 149443 h 68580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</a:cxnLst>
              <a:rect l="l" t="t" r="r" b="b"/>
              <a:pathLst>
                <a:path w="6237794" h="6858000">
                  <a:moveTo>
                    <a:pt x="1720317" y="0"/>
                  </a:moveTo>
                  <a:lnTo>
                    <a:pt x="2433560" y="0"/>
                  </a:lnTo>
                  <a:lnTo>
                    <a:pt x="2351473" y="41605"/>
                  </a:lnTo>
                  <a:cubicBezTo>
                    <a:pt x="2036528" y="216271"/>
                    <a:pt x="1740794" y="426339"/>
                    <a:pt x="1473152" y="667521"/>
                  </a:cubicBezTo>
                  <a:cubicBezTo>
                    <a:pt x="1295305" y="828818"/>
                    <a:pt x="1130525" y="1004777"/>
                    <a:pt x="982876" y="1193803"/>
                  </a:cubicBezTo>
                  <a:cubicBezTo>
                    <a:pt x="834936" y="1382538"/>
                    <a:pt x="704418" y="1584921"/>
                    <a:pt x="595242" y="1798192"/>
                  </a:cubicBezTo>
                  <a:cubicBezTo>
                    <a:pt x="486066" y="2011317"/>
                    <a:pt x="395183" y="2234461"/>
                    <a:pt x="332174" y="2466315"/>
                  </a:cubicBezTo>
                  <a:cubicBezTo>
                    <a:pt x="269166" y="2697588"/>
                    <a:pt x="236355" y="2938008"/>
                    <a:pt x="236500" y="3178573"/>
                  </a:cubicBezTo>
                  <a:cubicBezTo>
                    <a:pt x="237807" y="3296751"/>
                    <a:pt x="249421" y="3414057"/>
                    <a:pt x="276860" y="3527298"/>
                  </a:cubicBezTo>
                  <a:cubicBezTo>
                    <a:pt x="303864" y="3640684"/>
                    <a:pt x="345821" y="3749135"/>
                    <a:pt x="396054" y="3853520"/>
                  </a:cubicBezTo>
                  <a:cubicBezTo>
                    <a:pt x="421461" y="3905640"/>
                    <a:pt x="449626" y="3956743"/>
                    <a:pt x="479243" y="4007121"/>
                  </a:cubicBezTo>
                  <a:cubicBezTo>
                    <a:pt x="509295" y="4057354"/>
                    <a:pt x="541380" y="4106861"/>
                    <a:pt x="574772" y="4155787"/>
                  </a:cubicBezTo>
                  <a:cubicBezTo>
                    <a:pt x="642426" y="4253348"/>
                    <a:pt x="717630" y="4348007"/>
                    <a:pt x="795447" y="4443100"/>
                  </a:cubicBezTo>
                  <a:cubicBezTo>
                    <a:pt x="873264" y="4538339"/>
                    <a:pt x="954565" y="4633577"/>
                    <a:pt x="1034270" y="4732591"/>
                  </a:cubicBezTo>
                  <a:cubicBezTo>
                    <a:pt x="1074195" y="4781952"/>
                    <a:pt x="1113684" y="4832476"/>
                    <a:pt x="1153028" y="4883725"/>
                  </a:cubicBezTo>
                  <a:lnTo>
                    <a:pt x="1210084" y="4957912"/>
                  </a:lnTo>
                  <a:cubicBezTo>
                    <a:pt x="1228813" y="4981576"/>
                    <a:pt x="1246670" y="5005822"/>
                    <a:pt x="1265979" y="5028906"/>
                  </a:cubicBezTo>
                  <a:cubicBezTo>
                    <a:pt x="1416677" y="5216770"/>
                    <a:pt x="1580151" y="5389681"/>
                    <a:pt x="1746238" y="5553590"/>
                  </a:cubicBezTo>
                  <a:cubicBezTo>
                    <a:pt x="1829717" y="5635182"/>
                    <a:pt x="1914648" y="5714015"/>
                    <a:pt x="2001611" y="5789654"/>
                  </a:cubicBezTo>
                  <a:cubicBezTo>
                    <a:pt x="2088575" y="5865293"/>
                    <a:pt x="2177135" y="5938465"/>
                    <a:pt x="2269035" y="6007280"/>
                  </a:cubicBezTo>
                  <a:cubicBezTo>
                    <a:pt x="2452108" y="6145202"/>
                    <a:pt x="2649554" y="6268461"/>
                    <a:pt x="2866455" y="6351505"/>
                  </a:cubicBezTo>
                  <a:cubicBezTo>
                    <a:pt x="2974615" y="6393027"/>
                    <a:pt x="3086694" y="6424821"/>
                    <a:pt x="3200661" y="6448777"/>
                  </a:cubicBezTo>
                  <a:cubicBezTo>
                    <a:pt x="3229262" y="6454438"/>
                    <a:pt x="3257572" y="6460971"/>
                    <a:pt x="3286318" y="6465908"/>
                  </a:cubicBezTo>
                  <a:lnTo>
                    <a:pt x="3372701" y="6480281"/>
                  </a:lnTo>
                  <a:cubicBezTo>
                    <a:pt x="3430628" y="6487975"/>
                    <a:pt x="3488556" y="6496106"/>
                    <a:pt x="3547063" y="6500896"/>
                  </a:cubicBezTo>
                  <a:cubicBezTo>
                    <a:pt x="3576245" y="6503654"/>
                    <a:pt x="3605426" y="6506268"/>
                    <a:pt x="3634753" y="6507575"/>
                  </a:cubicBezTo>
                  <a:cubicBezTo>
                    <a:pt x="3664079" y="6509026"/>
                    <a:pt x="3693261" y="6511350"/>
                    <a:pt x="3722733" y="6512221"/>
                  </a:cubicBezTo>
                  <a:lnTo>
                    <a:pt x="3811003" y="6514253"/>
                  </a:lnTo>
                  <a:cubicBezTo>
                    <a:pt x="3840329" y="6514979"/>
                    <a:pt x="3869946" y="6513963"/>
                    <a:pt x="3899418" y="6513817"/>
                  </a:cubicBezTo>
                  <a:lnTo>
                    <a:pt x="3943698" y="6513381"/>
                  </a:lnTo>
                  <a:cubicBezTo>
                    <a:pt x="3958071" y="6512946"/>
                    <a:pt x="3972154" y="6512075"/>
                    <a:pt x="3986381" y="6511495"/>
                  </a:cubicBezTo>
                  <a:cubicBezTo>
                    <a:pt x="4000609" y="6510768"/>
                    <a:pt x="4014837" y="6510333"/>
                    <a:pt x="4028919" y="6509317"/>
                  </a:cubicBezTo>
                  <a:lnTo>
                    <a:pt x="4071312" y="6505833"/>
                  </a:lnTo>
                  <a:cubicBezTo>
                    <a:pt x="4127788" y="6501332"/>
                    <a:pt x="4183828" y="6493782"/>
                    <a:pt x="4239432" y="6485072"/>
                  </a:cubicBezTo>
                  <a:cubicBezTo>
                    <a:pt x="4461994" y="6448195"/>
                    <a:pt x="4675992" y="6376041"/>
                    <a:pt x="4879826" y="6274849"/>
                  </a:cubicBezTo>
                  <a:cubicBezTo>
                    <a:pt x="5084386" y="6174820"/>
                    <a:pt x="5279074" y="6046770"/>
                    <a:pt x="5471439" y="5906235"/>
                  </a:cubicBezTo>
                  <a:cubicBezTo>
                    <a:pt x="5519494" y="5871246"/>
                    <a:pt x="5567258" y="5834806"/>
                    <a:pt x="5614877" y="5797930"/>
                  </a:cubicBezTo>
                  <a:cubicBezTo>
                    <a:pt x="5662787" y="5761199"/>
                    <a:pt x="5710551" y="5723887"/>
                    <a:pt x="5758316" y="5685995"/>
                  </a:cubicBezTo>
                  <a:lnTo>
                    <a:pt x="6048824" y="5453705"/>
                  </a:lnTo>
                  <a:lnTo>
                    <a:pt x="6237794" y="5308644"/>
                  </a:lnTo>
                  <a:lnTo>
                    <a:pt x="6237794" y="6081399"/>
                  </a:lnTo>
                  <a:lnTo>
                    <a:pt x="6123011" y="6166399"/>
                  </a:lnTo>
                  <a:cubicBezTo>
                    <a:pt x="6071326" y="6204001"/>
                    <a:pt x="6019061" y="6241458"/>
                    <a:pt x="5965925" y="6278479"/>
                  </a:cubicBezTo>
                  <a:cubicBezTo>
                    <a:pt x="5912644" y="6315210"/>
                    <a:pt x="5858927" y="6351650"/>
                    <a:pt x="5803903" y="6387364"/>
                  </a:cubicBezTo>
                  <a:cubicBezTo>
                    <a:pt x="5694437" y="6458938"/>
                    <a:pt x="5581486" y="6528335"/>
                    <a:pt x="5463744" y="6591780"/>
                  </a:cubicBezTo>
                  <a:cubicBezTo>
                    <a:pt x="5346147" y="6655514"/>
                    <a:pt x="5224486" y="6714748"/>
                    <a:pt x="5097888" y="6765562"/>
                  </a:cubicBezTo>
                  <a:cubicBezTo>
                    <a:pt x="5034879" y="6791332"/>
                    <a:pt x="4970700" y="6815005"/>
                    <a:pt x="4905602" y="6836446"/>
                  </a:cubicBezTo>
                  <a:lnTo>
                    <a:pt x="4831447" y="6858000"/>
                  </a:lnTo>
                  <a:lnTo>
                    <a:pt x="3036485" y="6858000"/>
                  </a:lnTo>
                  <a:lnTo>
                    <a:pt x="2911533" y="6825558"/>
                  </a:lnTo>
                  <a:cubicBezTo>
                    <a:pt x="2847182" y="6807410"/>
                    <a:pt x="2783121" y="6787919"/>
                    <a:pt x="2719386" y="6767158"/>
                  </a:cubicBezTo>
                  <a:cubicBezTo>
                    <a:pt x="2464884" y="6683389"/>
                    <a:pt x="2213285" y="6579149"/>
                    <a:pt x="1980415" y="6440210"/>
                  </a:cubicBezTo>
                  <a:cubicBezTo>
                    <a:pt x="1747399" y="6301563"/>
                    <a:pt x="1539355" y="6125749"/>
                    <a:pt x="1357588" y="5931206"/>
                  </a:cubicBezTo>
                  <a:cubicBezTo>
                    <a:pt x="1266269" y="5834080"/>
                    <a:pt x="1183226" y="5730711"/>
                    <a:pt x="1105118" y="5624874"/>
                  </a:cubicBezTo>
                  <a:cubicBezTo>
                    <a:pt x="1027446" y="5518601"/>
                    <a:pt x="953549" y="5410732"/>
                    <a:pt x="884588" y="5300539"/>
                  </a:cubicBezTo>
                  <a:cubicBezTo>
                    <a:pt x="866876" y="5273245"/>
                    <a:pt x="850180" y="5245516"/>
                    <a:pt x="833049" y="5217931"/>
                  </a:cubicBezTo>
                  <a:lnTo>
                    <a:pt x="783833" y="5137791"/>
                  </a:lnTo>
                  <a:cubicBezTo>
                    <a:pt x="752328" y="5085962"/>
                    <a:pt x="719662" y="5034567"/>
                    <a:pt x="686706" y="4982447"/>
                  </a:cubicBezTo>
                  <a:lnTo>
                    <a:pt x="485485" y="4665082"/>
                  </a:lnTo>
                  <a:cubicBezTo>
                    <a:pt x="417976" y="4556922"/>
                    <a:pt x="351338" y="4445568"/>
                    <a:pt x="289055" y="4329568"/>
                  </a:cubicBezTo>
                  <a:cubicBezTo>
                    <a:pt x="257987" y="4271496"/>
                    <a:pt x="227934" y="4212408"/>
                    <a:pt x="200495" y="4151721"/>
                  </a:cubicBezTo>
                  <a:cubicBezTo>
                    <a:pt x="173201" y="4090891"/>
                    <a:pt x="147794" y="4028898"/>
                    <a:pt x="125291" y="3965600"/>
                  </a:cubicBezTo>
                  <a:cubicBezTo>
                    <a:pt x="103224" y="3902155"/>
                    <a:pt x="83624" y="3837840"/>
                    <a:pt x="67654" y="3772509"/>
                  </a:cubicBezTo>
                  <a:cubicBezTo>
                    <a:pt x="60105" y="3739843"/>
                    <a:pt x="52410" y="3707032"/>
                    <a:pt x="46168" y="3674076"/>
                  </a:cubicBezTo>
                  <a:lnTo>
                    <a:pt x="36731" y="3624714"/>
                  </a:lnTo>
                  <a:lnTo>
                    <a:pt x="28891" y="3575208"/>
                  </a:lnTo>
                  <a:cubicBezTo>
                    <a:pt x="8566" y="3442948"/>
                    <a:pt x="0" y="3310252"/>
                    <a:pt x="0" y="3178573"/>
                  </a:cubicBezTo>
                  <a:cubicBezTo>
                    <a:pt x="726" y="2919425"/>
                    <a:pt x="27730" y="2660277"/>
                    <a:pt x="80575" y="2405774"/>
                  </a:cubicBezTo>
                  <a:cubicBezTo>
                    <a:pt x="133276" y="2151417"/>
                    <a:pt x="213997" y="1901996"/>
                    <a:pt x="322737" y="1665351"/>
                  </a:cubicBezTo>
                  <a:cubicBezTo>
                    <a:pt x="541235" y="1192061"/>
                    <a:pt x="857875" y="768568"/>
                    <a:pt x="1230700" y="407938"/>
                  </a:cubicBezTo>
                  <a:cubicBezTo>
                    <a:pt x="1324124" y="317781"/>
                    <a:pt x="1421323" y="231579"/>
                    <a:pt x="1521825" y="149443"/>
                  </a:cubicBezTo>
                  <a:close/>
                </a:path>
              </a:pathLst>
            </a:custGeom>
            <a:solidFill>
              <a:schemeClr val="bg1"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Freeform: Shape 13">
              <a:extLst>
                <a:ext uri="{FF2B5EF4-FFF2-40B4-BE49-F238E27FC236}">
                  <a16:creationId xmlns:a16="http://schemas.microsoft.com/office/drawing/2014/main" id="{13BFB38F-216C-4A75-8C1C-DAF998A5CB4C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875698" y="0"/>
              <a:ext cx="6477994" cy="6858000"/>
            </a:xfrm>
            <a:custGeom>
              <a:avLst/>
              <a:gdLst>
                <a:gd name="connsiteX0" fmla="*/ 5634917 w 6230407"/>
                <a:gd name="connsiteY0" fmla="*/ 0 h 6858000"/>
                <a:gd name="connsiteX1" fmla="*/ 6230407 w 6230407"/>
                <a:gd name="connsiteY1" fmla="*/ 0 h 6858000"/>
                <a:gd name="connsiteX2" fmla="*/ 6230407 w 6230407"/>
                <a:gd name="connsiteY2" fmla="*/ 322046 h 6858000"/>
                <a:gd name="connsiteX3" fmla="*/ 6061915 w 6230407"/>
                <a:gd name="connsiteY3" fmla="*/ 206288 h 6858000"/>
                <a:gd name="connsiteX4" fmla="*/ 5814792 w 6230407"/>
                <a:gd name="connsiteY4" fmla="*/ 74312 h 6858000"/>
                <a:gd name="connsiteX5" fmla="*/ 5676576 w 6230407"/>
                <a:gd name="connsiteY5" fmla="*/ 15049 h 6858000"/>
                <a:gd name="connsiteX6" fmla="*/ 1821847 w 6230407"/>
                <a:gd name="connsiteY6" fmla="*/ 0 h 6858000"/>
                <a:gd name="connsiteX7" fmla="*/ 3449591 w 6230407"/>
                <a:gd name="connsiteY7" fmla="*/ 0 h 6858000"/>
                <a:gd name="connsiteX8" fmla="*/ 3354111 w 6230407"/>
                <a:gd name="connsiteY8" fmla="*/ 29819 h 6858000"/>
                <a:gd name="connsiteX9" fmla="*/ 3177287 w 6230407"/>
                <a:gd name="connsiteY9" fmla="*/ 93621 h 6858000"/>
                <a:gd name="connsiteX10" fmla="*/ 1915374 w 6230407"/>
                <a:gd name="connsiteY10" fmla="*/ 844207 h 6858000"/>
                <a:gd name="connsiteX11" fmla="*/ 1042545 w 6230407"/>
                <a:gd name="connsiteY11" fmla="*/ 1926532 h 6858000"/>
                <a:gd name="connsiteX12" fmla="*/ 726050 w 6230407"/>
                <a:gd name="connsiteY12" fmla="*/ 3186123 h 6858000"/>
                <a:gd name="connsiteX13" fmla="*/ 1249864 w 6230407"/>
                <a:gd name="connsiteY13" fmla="*/ 4355701 h 6858000"/>
                <a:gd name="connsiteX14" fmla="*/ 1513803 w 6230407"/>
                <a:gd name="connsiteY14" fmla="*/ 4726929 h 6858000"/>
                <a:gd name="connsiteX15" fmla="*/ 3990446 w 6230407"/>
                <a:gd name="connsiteY15" fmla="*/ 6178014 h 6858000"/>
                <a:gd name="connsiteX16" fmla="*/ 5870541 w 6230407"/>
                <a:gd name="connsiteY16" fmla="*/ 5285296 h 6858000"/>
                <a:gd name="connsiteX17" fmla="*/ 6099347 w 6230407"/>
                <a:gd name="connsiteY17" fmla="*/ 5108030 h 6858000"/>
                <a:gd name="connsiteX18" fmla="*/ 6230407 w 6230407"/>
                <a:gd name="connsiteY18" fmla="*/ 5006078 h 6858000"/>
                <a:gd name="connsiteX19" fmla="*/ 6230407 w 6230407"/>
                <a:gd name="connsiteY19" fmla="*/ 5924458 h 6858000"/>
                <a:gd name="connsiteX20" fmla="*/ 6056186 w 6230407"/>
                <a:gd name="connsiteY20" fmla="*/ 6058925 h 6858000"/>
                <a:gd name="connsiteX21" fmla="*/ 4500343 w 6230407"/>
                <a:gd name="connsiteY21" fmla="*/ 6854086 h 6858000"/>
                <a:gd name="connsiteX22" fmla="*/ 4476760 w 6230407"/>
                <a:gd name="connsiteY22" fmla="*/ 6858000 h 6858000"/>
                <a:gd name="connsiteX23" fmla="*/ 3391617 w 6230407"/>
                <a:gd name="connsiteY23" fmla="*/ 6858000 h 6858000"/>
                <a:gd name="connsiteX24" fmla="*/ 3242986 w 6230407"/>
                <a:gd name="connsiteY24" fmla="*/ 6833894 h 6858000"/>
                <a:gd name="connsiteX25" fmla="*/ 913044 w 6230407"/>
                <a:gd name="connsiteY25" fmla="*/ 5134452 h 6858000"/>
                <a:gd name="connsiteX26" fmla="*/ 0 w 6230407"/>
                <a:gd name="connsiteY26" fmla="*/ 3186123 h 6858000"/>
                <a:gd name="connsiteX27" fmla="*/ 1779764 w 6230407"/>
                <a:gd name="connsiteY27" fmla="*/ 28818 h 68580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</a:cxnLst>
              <a:rect l="l" t="t" r="r" b="b"/>
              <a:pathLst>
                <a:path w="6230407" h="6858000">
                  <a:moveTo>
                    <a:pt x="5634917" y="0"/>
                  </a:moveTo>
                  <a:lnTo>
                    <a:pt x="6230407" y="0"/>
                  </a:lnTo>
                  <a:lnTo>
                    <a:pt x="6230407" y="322046"/>
                  </a:lnTo>
                  <a:lnTo>
                    <a:pt x="6061915" y="206288"/>
                  </a:lnTo>
                  <a:cubicBezTo>
                    <a:pt x="5982213" y="157828"/>
                    <a:pt x="5899796" y="113801"/>
                    <a:pt x="5814792" y="74312"/>
                  </a:cubicBezTo>
                  <a:cubicBezTo>
                    <a:pt x="5769441" y="53261"/>
                    <a:pt x="5723362" y="33505"/>
                    <a:pt x="5676576" y="15049"/>
                  </a:cubicBezTo>
                  <a:close/>
                  <a:moveTo>
                    <a:pt x="1821847" y="0"/>
                  </a:moveTo>
                  <a:lnTo>
                    <a:pt x="3449591" y="0"/>
                  </a:lnTo>
                  <a:lnTo>
                    <a:pt x="3354111" y="29819"/>
                  </a:lnTo>
                  <a:cubicBezTo>
                    <a:pt x="3295072" y="49686"/>
                    <a:pt x="3236122" y="70955"/>
                    <a:pt x="3177287" y="93621"/>
                  </a:cubicBezTo>
                  <a:cubicBezTo>
                    <a:pt x="2718951" y="269871"/>
                    <a:pt x="2282682" y="529455"/>
                    <a:pt x="1915374" y="844207"/>
                  </a:cubicBezTo>
                  <a:cubicBezTo>
                    <a:pt x="1541678" y="1164331"/>
                    <a:pt x="1247976" y="1528591"/>
                    <a:pt x="1042545" y="1926532"/>
                  </a:cubicBezTo>
                  <a:cubicBezTo>
                    <a:pt x="832613" y="2333329"/>
                    <a:pt x="726050" y="2757113"/>
                    <a:pt x="726050" y="3186123"/>
                  </a:cubicBezTo>
                  <a:cubicBezTo>
                    <a:pt x="726050" y="3618181"/>
                    <a:pt x="896057" y="3870506"/>
                    <a:pt x="1249864" y="4355701"/>
                  </a:cubicBezTo>
                  <a:cubicBezTo>
                    <a:pt x="1335230" y="4472717"/>
                    <a:pt x="1423500" y="4593798"/>
                    <a:pt x="1513803" y="4726929"/>
                  </a:cubicBezTo>
                  <a:cubicBezTo>
                    <a:pt x="2203848" y="5744068"/>
                    <a:pt x="2944562" y="6178014"/>
                    <a:pt x="3990446" y="6178014"/>
                  </a:cubicBezTo>
                  <a:cubicBezTo>
                    <a:pt x="4676863" y="6178014"/>
                    <a:pt x="5180496" y="5824498"/>
                    <a:pt x="5870541" y="5285296"/>
                  </a:cubicBezTo>
                  <a:cubicBezTo>
                    <a:pt x="5947632" y="5225046"/>
                    <a:pt x="6024723" y="5165521"/>
                    <a:pt x="6099347" y="5108030"/>
                  </a:cubicBezTo>
                  <a:lnTo>
                    <a:pt x="6230407" y="5006078"/>
                  </a:lnTo>
                  <a:lnTo>
                    <a:pt x="6230407" y="5924458"/>
                  </a:lnTo>
                  <a:lnTo>
                    <a:pt x="6056186" y="6058925"/>
                  </a:lnTo>
                  <a:cubicBezTo>
                    <a:pt x="5577260" y="6421454"/>
                    <a:pt x="5092142" y="6735949"/>
                    <a:pt x="4500343" y="6854086"/>
                  </a:cubicBezTo>
                  <a:lnTo>
                    <a:pt x="4476760" y="6858000"/>
                  </a:lnTo>
                  <a:lnTo>
                    <a:pt x="3391617" y="6858000"/>
                  </a:lnTo>
                  <a:lnTo>
                    <a:pt x="3242986" y="6833894"/>
                  </a:lnTo>
                  <a:cubicBezTo>
                    <a:pt x="2233307" y="6634206"/>
                    <a:pt x="1512986" y="6018796"/>
                    <a:pt x="913044" y="5134452"/>
                  </a:cubicBezTo>
                  <a:cubicBezTo>
                    <a:pt x="469951" y="4481428"/>
                    <a:pt x="0" y="4033545"/>
                    <a:pt x="0" y="3186123"/>
                  </a:cubicBezTo>
                  <a:cubicBezTo>
                    <a:pt x="0" y="1915018"/>
                    <a:pt x="732545" y="779286"/>
                    <a:pt x="1779764" y="28818"/>
                  </a:cubicBezTo>
                  <a:close/>
                </a:path>
              </a:pathLst>
            </a:custGeom>
            <a:solidFill>
              <a:schemeClr val="bg1"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Freeform: Shape 14">
              <a:extLst>
                <a:ext uri="{FF2B5EF4-FFF2-40B4-BE49-F238E27FC236}">
                  <a16:creationId xmlns:a16="http://schemas.microsoft.com/office/drawing/2014/main" id="{4DF24F7D-73CE-4EF0-86BC-1C1C4C5CB708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875698" y="0"/>
              <a:ext cx="6477994" cy="6858000"/>
            </a:xfrm>
            <a:custGeom>
              <a:avLst/>
              <a:gdLst>
                <a:gd name="connsiteX0" fmla="*/ 5061392 w 6230408"/>
                <a:gd name="connsiteY0" fmla="*/ 0 h 6858000"/>
                <a:gd name="connsiteX1" fmla="*/ 6230408 w 6230408"/>
                <a:gd name="connsiteY1" fmla="*/ 0 h 6858000"/>
                <a:gd name="connsiteX2" fmla="*/ 6230408 w 6230408"/>
                <a:gd name="connsiteY2" fmla="*/ 502666 h 6858000"/>
                <a:gd name="connsiteX3" fmla="*/ 6204367 w 6230408"/>
                <a:gd name="connsiteY3" fmla="*/ 480166 h 6858000"/>
                <a:gd name="connsiteX4" fmla="*/ 5753525 w 6230408"/>
                <a:gd name="connsiteY4" fmla="*/ 205991 h 6858000"/>
                <a:gd name="connsiteX5" fmla="*/ 5205685 w 6230408"/>
                <a:gd name="connsiteY5" fmla="*/ 25948 h 6858000"/>
                <a:gd name="connsiteX6" fmla="*/ 1821847 w 6230408"/>
                <a:gd name="connsiteY6" fmla="*/ 0 h 6858000"/>
                <a:gd name="connsiteX7" fmla="*/ 4114919 w 6230408"/>
                <a:gd name="connsiteY7" fmla="*/ 0 h 6858000"/>
                <a:gd name="connsiteX8" fmla="*/ 4086206 w 6230408"/>
                <a:gd name="connsiteY8" fmla="*/ 3507 h 6858000"/>
                <a:gd name="connsiteX9" fmla="*/ 3229262 w 6230408"/>
                <a:gd name="connsiteY9" fmla="*/ 229075 h 6858000"/>
                <a:gd name="connsiteX10" fmla="*/ 2009741 w 6230408"/>
                <a:gd name="connsiteY10" fmla="*/ 954400 h 6858000"/>
                <a:gd name="connsiteX11" fmla="*/ 1171466 w 6230408"/>
                <a:gd name="connsiteY11" fmla="*/ 1993025 h 6858000"/>
                <a:gd name="connsiteX12" fmla="*/ 871086 w 6230408"/>
                <a:gd name="connsiteY12" fmla="*/ 3186123 h 6858000"/>
                <a:gd name="connsiteX13" fmla="*/ 1367025 w 6230408"/>
                <a:gd name="connsiteY13" fmla="*/ 4270190 h 6858000"/>
                <a:gd name="connsiteX14" fmla="*/ 1633868 w 6230408"/>
                <a:gd name="connsiteY14" fmla="*/ 4645483 h 6858000"/>
                <a:gd name="connsiteX15" fmla="*/ 2651877 w 6230408"/>
                <a:gd name="connsiteY15" fmla="*/ 5684689 h 6858000"/>
                <a:gd name="connsiteX16" fmla="*/ 3990301 w 6230408"/>
                <a:gd name="connsiteY16" fmla="*/ 6032833 h 6858000"/>
                <a:gd name="connsiteX17" fmla="*/ 4851225 w 6230408"/>
                <a:gd name="connsiteY17" fmla="*/ 5811141 h 6858000"/>
                <a:gd name="connsiteX18" fmla="*/ 5780965 w 6230408"/>
                <a:gd name="connsiteY18" fmla="*/ 5171038 h 6858000"/>
                <a:gd name="connsiteX19" fmla="*/ 6010496 w 6230408"/>
                <a:gd name="connsiteY19" fmla="*/ 4993191 h 6858000"/>
                <a:gd name="connsiteX20" fmla="*/ 6230408 w 6230408"/>
                <a:gd name="connsiteY20" fmla="*/ 4822117 h 6858000"/>
                <a:gd name="connsiteX21" fmla="*/ 6230408 w 6230408"/>
                <a:gd name="connsiteY21" fmla="*/ 5924457 h 6858000"/>
                <a:gd name="connsiteX22" fmla="*/ 6056186 w 6230408"/>
                <a:gd name="connsiteY22" fmla="*/ 6058925 h 6858000"/>
                <a:gd name="connsiteX23" fmla="*/ 4500343 w 6230408"/>
                <a:gd name="connsiteY23" fmla="*/ 6854086 h 6858000"/>
                <a:gd name="connsiteX24" fmla="*/ 4476760 w 6230408"/>
                <a:gd name="connsiteY24" fmla="*/ 6858000 h 6858000"/>
                <a:gd name="connsiteX25" fmla="*/ 3391617 w 6230408"/>
                <a:gd name="connsiteY25" fmla="*/ 6858000 h 6858000"/>
                <a:gd name="connsiteX26" fmla="*/ 3242986 w 6230408"/>
                <a:gd name="connsiteY26" fmla="*/ 6833894 h 6858000"/>
                <a:gd name="connsiteX27" fmla="*/ 913044 w 6230408"/>
                <a:gd name="connsiteY27" fmla="*/ 5134452 h 6858000"/>
                <a:gd name="connsiteX28" fmla="*/ 0 w 6230408"/>
                <a:gd name="connsiteY28" fmla="*/ 3186123 h 6858000"/>
                <a:gd name="connsiteX29" fmla="*/ 1779764 w 6230408"/>
                <a:gd name="connsiteY29" fmla="*/ 28818 h 68580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</a:cxnLst>
              <a:rect l="l" t="t" r="r" b="b"/>
              <a:pathLst>
                <a:path w="6230408" h="6858000">
                  <a:moveTo>
                    <a:pt x="5061392" y="0"/>
                  </a:moveTo>
                  <a:lnTo>
                    <a:pt x="6230408" y="0"/>
                  </a:lnTo>
                  <a:lnTo>
                    <a:pt x="6230408" y="502666"/>
                  </a:lnTo>
                  <a:lnTo>
                    <a:pt x="6204367" y="480166"/>
                  </a:lnTo>
                  <a:cubicBezTo>
                    <a:pt x="6064466" y="372115"/>
                    <a:pt x="5913877" y="280469"/>
                    <a:pt x="5753525" y="205991"/>
                  </a:cubicBezTo>
                  <a:cubicBezTo>
                    <a:pt x="5581848" y="126214"/>
                    <a:pt x="5398775" y="66109"/>
                    <a:pt x="5205685" y="25948"/>
                  </a:cubicBezTo>
                  <a:close/>
                  <a:moveTo>
                    <a:pt x="1821847" y="0"/>
                  </a:moveTo>
                  <a:lnTo>
                    <a:pt x="4114919" y="0"/>
                  </a:lnTo>
                  <a:lnTo>
                    <a:pt x="4086206" y="3507"/>
                  </a:lnTo>
                  <a:cubicBezTo>
                    <a:pt x="3798985" y="45364"/>
                    <a:pt x="3509190" y="121369"/>
                    <a:pt x="3229262" y="229075"/>
                  </a:cubicBezTo>
                  <a:cubicBezTo>
                    <a:pt x="2786315" y="399518"/>
                    <a:pt x="2364564" y="650390"/>
                    <a:pt x="2009741" y="954400"/>
                  </a:cubicBezTo>
                  <a:cubicBezTo>
                    <a:pt x="1655354" y="1257973"/>
                    <a:pt x="1365573" y="1617151"/>
                    <a:pt x="1171466" y="1993025"/>
                  </a:cubicBezTo>
                  <a:cubicBezTo>
                    <a:pt x="972132" y="2379061"/>
                    <a:pt x="871086" y="2780487"/>
                    <a:pt x="871086" y="3186123"/>
                  </a:cubicBezTo>
                  <a:cubicBezTo>
                    <a:pt x="871086" y="3573756"/>
                    <a:pt x="1023091" y="3798642"/>
                    <a:pt x="1367025" y="4270190"/>
                  </a:cubicBezTo>
                  <a:cubicBezTo>
                    <a:pt x="1453117" y="4388222"/>
                    <a:pt x="1542113" y="4510319"/>
                    <a:pt x="1633868" y="4645483"/>
                  </a:cubicBezTo>
                  <a:cubicBezTo>
                    <a:pt x="1958347" y="5123709"/>
                    <a:pt x="2291248" y="5463723"/>
                    <a:pt x="2651877" y="5684689"/>
                  </a:cubicBezTo>
                  <a:cubicBezTo>
                    <a:pt x="3034139" y="5919011"/>
                    <a:pt x="3472005" y="6032833"/>
                    <a:pt x="3990301" y="6032833"/>
                  </a:cubicBezTo>
                  <a:cubicBezTo>
                    <a:pt x="4284438" y="6032833"/>
                    <a:pt x="4557959" y="5962420"/>
                    <a:pt x="4851225" y="5811141"/>
                  </a:cubicBezTo>
                  <a:cubicBezTo>
                    <a:pt x="5152330" y="5655798"/>
                    <a:pt x="5450387" y="5429315"/>
                    <a:pt x="5780965" y="5171038"/>
                  </a:cubicBezTo>
                  <a:cubicBezTo>
                    <a:pt x="5858491" y="5110498"/>
                    <a:pt x="5935727" y="5050828"/>
                    <a:pt x="6010496" y="4993191"/>
                  </a:cubicBezTo>
                  <a:lnTo>
                    <a:pt x="6230408" y="4822117"/>
                  </a:lnTo>
                  <a:lnTo>
                    <a:pt x="6230408" y="5924457"/>
                  </a:lnTo>
                  <a:lnTo>
                    <a:pt x="6056186" y="6058925"/>
                  </a:lnTo>
                  <a:cubicBezTo>
                    <a:pt x="5577260" y="6421454"/>
                    <a:pt x="5092142" y="6735949"/>
                    <a:pt x="4500343" y="6854086"/>
                  </a:cubicBezTo>
                  <a:lnTo>
                    <a:pt x="4476760" y="6858000"/>
                  </a:lnTo>
                  <a:lnTo>
                    <a:pt x="3391617" y="6858000"/>
                  </a:lnTo>
                  <a:lnTo>
                    <a:pt x="3242986" y="6833894"/>
                  </a:lnTo>
                  <a:cubicBezTo>
                    <a:pt x="2233307" y="6634206"/>
                    <a:pt x="1512986" y="6018796"/>
                    <a:pt x="913044" y="5134452"/>
                  </a:cubicBezTo>
                  <a:cubicBezTo>
                    <a:pt x="469951" y="4481428"/>
                    <a:pt x="0" y="4033545"/>
                    <a:pt x="0" y="3186123"/>
                  </a:cubicBezTo>
                  <a:cubicBezTo>
                    <a:pt x="0" y="1915018"/>
                    <a:pt x="732545" y="779286"/>
                    <a:pt x="1779764" y="28818"/>
                  </a:cubicBezTo>
                  <a:close/>
                </a:path>
              </a:pathLst>
            </a:custGeom>
            <a:solidFill>
              <a:schemeClr val="bg1"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 useBgFill="1">
          <p:nvSpPr>
            <p:cNvPr id="16" name="Freeform: Shape 15">
              <a:extLst>
                <a:ext uri="{FF2B5EF4-FFF2-40B4-BE49-F238E27FC236}">
                  <a16:creationId xmlns:a16="http://schemas.microsoft.com/office/drawing/2014/main" id="{EC3445B6-9C0D-4865-BF68-CD74892D0E08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705128" y="0"/>
              <a:ext cx="6648564" cy="6858000"/>
            </a:xfrm>
            <a:custGeom>
              <a:avLst/>
              <a:gdLst>
                <a:gd name="connsiteX0" fmla="*/ 1242460 w 6394458"/>
                <a:gd name="connsiteY0" fmla="*/ 0 h 6858000"/>
                <a:gd name="connsiteX1" fmla="*/ 2160732 w 6394458"/>
                <a:gd name="connsiteY1" fmla="*/ 0 h 6858000"/>
                <a:gd name="connsiteX2" fmla="*/ 2096124 w 6394458"/>
                <a:gd name="connsiteY2" fmla="*/ 41936 h 6858000"/>
                <a:gd name="connsiteX3" fmla="*/ 1942232 w 6394458"/>
                <a:gd name="connsiteY3" fmla="*/ 154451 h 6858000"/>
                <a:gd name="connsiteX4" fmla="*/ 1941942 w 6394458"/>
                <a:gd name="connsiteY4" fmla="*/ 154741 h 6858000"/>
                <a:gd name="connsiteX5" fmla="*/ 1941652 w 6394458"/>
                <a:gd name="connsiteY5" fmla="*/ 155032 h 6858000"/>
                <a:gd name="connsiteX6" fmla="*/ 1878498 w 6394458"/>
                <a:gd name="connsiteY6" fmla="*/ 203377 h 6858000"/>
                <a:gd name="connsiteX7" fmla="*/ 1865722 w 6394458"/>
                <a:gd name="connsiteY7" fmla="*/ 213395 h 6858000"/>
                <a:gd name="connsiteX8" fmla="*/ 1791679 w 6394458"/>
                <a:gd name="connsiteY8" fmla="*/ 272483 h 6858000"/>
                <a:gd name="connsiteX9" fmla="*/ 1503495 w 6394458"/>
                <a:gd name="connsiteY9" fmla="*/ 525389 h 6858000"/>
                <a:gd name="connsiteX10" fmla="*/ 990135 w 6394458"/>
                <a:gd name="connsiteY10" fmla="*/ 1098128 h 6858000"/>
                <a:gd name="connsiteX11" fmla="*/ 771637 w 6394458"/>
                <a:gd name="connsiteY11" fmla="*/ 1416800 h 6858000"/>
                <a:gd name="connsiteX12" fmla="*/ 585660 w 6394458"/>
                <a:gd name="connsiteY12" fmla="*/ 1756960 h 6858000"/>
                <a:gd name="connsiteX13" fmla="*/ 585515 w 6394458"/>
                <a:gd name="connsiteY13" fmla="*/ 1757395 h 6858000"/>
                <a:gd name="connsiteX14" fmla="*/ 585370 w 6394458"/>
                <a:gd name="connsiteY14" fmla="*/ 1757831 h 6858000"/>
                <a:gd name="connsiteX15" fmla="*/ 544574 w 6394458"/>
                <a:gd name="connsiteY15" fmla="*/ 1845230 h 6858000"/>
                <a:gd name="connsiteX16" fmla="*/ 524539 w 6394458"/>
                <a:gd name="connsiteY16" fmla="*/ 1889510 h 6858000"/>
                <a:gd name="connsiteX17" fmla="*/ 505666 w 6394458"/>
                <a:gd name="connsiteY17" fmla="*/ 1933935 h 6858000"/>
                <a:gd name="connsiteX18" fmla="*/ 502762 w 6394458"/>
                <a:gd name="connsiteY18" fmla="*/ 1940904 h 6858000"/>
                <a:gd name="connsiteX19" fmla="*/ 469661 w 6394458"/>
                <a:gd name="connsiteY19" fmla="*/ 2023512 h 6858000"/>
                <a:gd name="connsiteX20" fmla="*/ 456885 w 6394458"/>
                <a:gd name="connsiteY20" fmla="*/ 2057049 h 6858000"/>
                <a:gd name="connsiteX21" fmla="*/ 435688 w 6394458"/>
                <a:gd name="connsiteY21" fmla="*/ 2114395 h 6858000"/>
                <a:gd name="connsiteX22" fmla="*/ 435543 w 6394458"/>
                <a:gd name="connsiteY22" fmla="*/ 2114976 h 6858000"/>
                <a:gd name="connsiteX23" fmla="*/ 435253 w 6394458"/>
                <a:gd name="connsiteY23" fmla="*/ 2115557 h 6858000"/>
                <a:gd name="connsiteX24" fmla="*/ 324770 w 6394458"/>
                <a:gd name="connsiteY24" fmla="*/ 2488382 h 6858000"/>
                <a:gd name="connsiteX25" fmla="*/ 235338 w 6394458"/>
                <a:gd name="connsiteY25" fmla="*/ 3261036 h 6858000"/>
                <a:gd name="connsiteX26" fmla="*/ 272505 w 6394458"/>
                <a:gd name="connsiteY26" fmla="*/ 3641991 h 6858000"/>
                <a:gd name="connsiteX27" fmla="*/ 385891 w 6394458"/>
                <a:gd name="connsiteY27" fmla="*/ 4006104 h 6858000"/>
                <a:gd name="connsiteX28" fmla="*/ 386182 w 6394458"/>
                <a:gd name="connsiteY28" fmla="*/ 4006685 h 6858000"/>
                <a:gd name="connsiteX29" fmla="*/ 386472 w 6394458"/>
                <a:gd name="connsiteY29" fmla="*/ 4007266 h 6858000"/>
                <a:gd name="connsiteX30" fmla="*/ 413911 w 6394458"/>
                <a:gd name="connsiteY30" fmla="*/ 4068823 h 6858000"/>
                <a:gd name="connsiteX31" fmla="*/ 425380 w 6394458"/>
                <a:gd name="connsiteY31" fmla="*/ 4093794 h 6858000"/>
                <a:gd name="connsiteX32" fmla="*/ 435834 w 6394458"/>
                <a:gd name="connsiteY32" fmla="*/ 4114845 h 6858000"/>
                <a:gd name="connsiteX33" fmla="*/ 468644 w 6394458"/>
                <a:gd name="connsiteY33" fmla="*/ 4178435 h 6858000"/>
                <a:gd name="connsiteX34" fmla="*/ 468935 w 6394458"/>
                <a:gd name="connsiteY34" fmla="*/ 4179015 h 6858000"/>
                <a:gd name="connsiteX35" fmla="*/ 469225 w 6394458"/>
                <a:gd name="connsiteY35" fmla="*/ 4179596 h 6858000"/>
                <a:gd name="connsiteX36" fmla="*/ 566496 w 6394458"/>
                <a:gd name="connsiteY36" fmla="*/ 4345828 h 6858000"/>
                <a:gd name="connsiteX37" fmla="*/ 674366 w 6394458"/>
                <a:gd name="connsiteY37" fmla="*/ 4507124 h 6858000"/>
                <a:gd name="connsiteX38" fmla="*/ 790946 w 6394458"/>
                <a:gd name="connsiteY38" fmla="*/ 4665372 h 6858000"/>
                <a:gd name="connsiteX39" fmla="*/ 938015 w 6394458"/>
                <a:gd name="connsiteY39" fmla="*/ 4855559 h 6858000"/>
                <a:gd name="connsiteX40" fmla="*/ 1035286 w 6394458"/>
                <a:gd name="connsiteY40" fmla="*/ 4980269 h 6858000"/>
                <a:gd name="connsiteX41" fmla="*/ 1158254 w 6394458"/>
                <a:gd name="connsiteY41" fmla="*/ 5140985 h 6858000"/>
                <a:gd name="connsiteX42" fmla="*/ 1221118 w 6394458"/>
                <a:gd name="connsiteY42" fmla="*/ 5226351 h 6858000"/>
                <a:gd name="connsiteX43" fmla="*/ 1277448 w 6394458"/>
                <a:gd name="connsiteY43" fmla="*/ 5303007 h 6858000"/>
                <a:gd name="connsiteX44" fmla="*/ 1277739 w 6394458"/>
                <a:gd name="connsiteY44" fmla="*/ 5303297 h 6858000"/>
                <a:gd name="connsiteX45" fmla="*/ 1278029 w 6394458"/>
                <a:gd name="connsiteY45" fmla="*/ 5303588 h 6858000"/>
                <a:gd name="connsiteX46" fmla="*/ 1376607 w 6394458"/>
                <a:gd name="connsiteY46" fmla="*/ 5433525 h 6858000"/>
                <a:gd name="connsiteX47" fmla="*/ 1395625 w 6394458"/>
                <a:gd name="connsiteY47" fmla="*/ 5458060 h 6858000"/>
                <a:gd name="connsiteX48" fmla="*/ 1405207 w 6394458"/>
                <a:gd name="connsiteY48" fmla="*/ 5469965 h 6858000"/>
                <a:gd name="connsiteX49" fmla="*/ 1518739 w 6394458"/>
                <a:gd name="connsiteY49" fmla="*/ 5607597 h 6858000"/>
                <a:gd name="connsiteX50" fmla="*/ 1779194 w 6394458"/>
                <a:gd name="connsiteY50" fmla="*/ 5888957 h 6858000"/>
                <a:gd name="connsiteX51" fmla="*/ 2361805 w 6394458"/>
                <a:gd name="connsiteY51" fmla="*/ 6356876 h 6858000"/>
                <a:gd name="connsiteX52" fmla="*/ 2682656 w 6394458"/>
                <a:gd name="connsiteY52" fmla="*/ 6532110 h 6858000"/>
                <a:gd name="connsiteX53" fmla="*/ 2682946 w 6394458"/>
                <a:gd name="connsiteY53" fmla="*/ 6532255 h 6858000"/>
                <a:gd name="connsiteX54" fmla="*/ 2683236 w 6394458"/>
                <a:gd name="connsiteY54" fmla="*/ 6532400 h 6858000"/>
                <a:gd name="connsiteX55" fmla="*/ 3021944 w 6394458"/>
                <a:gd name="connsiteY55" fmla="*/ 6664805 h 6858000"/>
                <a:gd name="connsiteX56" fmla="*/ 3375605 w 6394458"/>
                <a:gd name="connsiteY56" fmla="*/ 6756415 h 6858000"/>
                <a:gd name="connsiteX57" fmla="*/ 3555048 w 6394458"/>
                <a:gd name="connsiteY57" fmla="*/ 6786612 h 6858000"/>
                <a:gd name="connsiteX58" fmla="*/ 3735218 w 6394458"/>
                <a:gd name="connsiteY58" fmla="*/ 6807083 h 6858000"/>
                <a:gd name="connsiteX59" fmla="*/ 4108188 w 6394458"/>
                <a:gd name="connsiteY59" fmla="*/ 6823343 h 6858000"/>
                <a:gd name="connsiteX60" fmla="*/ 4126917 w 6394458"/>
                <a:gd name="connsiteY60" fmla="*/ 6823343 h 6858000"/>
                <a:gd name="connsiteX61" fmla="*/ 4151597 w 6394458"/>
                <a:gd name="connsiteY61" fmla="*/ 6823488 h 6858000"/>
                <a:gd name="connsiteX62" fmla="*/ 4199652 w 6394458"/>
                <a:gd name="connsiteY62" fmla="*/ 6822763 h 6858000"/>
                <a:gd name="connsiteX63" fmla="*/ 4200088 w 6394458"/>
                <a:gd name="connsiteY63" fmla="*/ 6822763 h 6858000"/>
                <a:gd name="connsiteX64" fmla="*/ 4200523 w 6394458"/>
                <a:gd name="connsiteY64" fmla="*/ 6822763 h 6858000"/>
                <a:gd name="connsiteX65" fmla="*/ 4245675 w 6394458"/>
                <a:gd name="connsiteY65" fmla="*/ 6821601 h 6858000"/>
                <a:gd name="connsiteX66" fmla="*/ 4291117 w 6394458"/>
                <a:gd name="connsiteY66" fmla="*/ 6819277 h 6858000"/>
                <a:gd name="connsiteX67" fmla="*/ 4469108 w 6394458"/>
                <a:gd name="connsiteY67" fmla="*/ 6803743 h 6858000"/>
                <a:gd name="connsiteX68" fmla="*/ 5157267 w 6394458"/>
                <a:gd name="connsiteY68" fmla="*/ 6617766 h 6858000"/>
                <a:gd name="connsiteX69" fmla="*/ 5484069 w 6394458"/>
                <a:gd name="connsiteY69" fmla="*/ 6455744 h 6858000"/>
                <a:gd name="connsiteX70" fmla="*/ 5801144 w 6394458"/>
                <a:gd name="connsiteY70" fmla="*/ 6257717 h 6858000"/>
                <a:gd name="connsiteX71" fmla="*/ 6111106 w 6394458"/>
                <a:gd name="connsiteY71" fmla="*/ 6032542 h 6858000"/>
                <a:gd name="connsiteX72" fmla="*/ 6264127 w 6394458"/>
                <a:gd name="connsiteY72" fmla="*/ 5913203 h 6858000"/>
                <a:gd name="connsiteX73" fmla="*/ 6394458 w 6394458"/>
                <a:gd name="connsiteY73" fmla="*/ 5808939 h 6858000"/>
                <a:gd name="connsiteX74" fmla="*/ 6394458 w 6394458"/>
                <a:gd name="connsiteY74" fmla="*/ 6858000 h 6858000"/>
                <a:gd name="connsiteX75" fmla="*/ 2234128 w 6394458"/>
                <a:gd name="connsiteY75" fmla="*/ 6858000 h 6858000"/>
                <a:gd name="connsiteX76" fmla="*/ 2151583 w 6394458"/>
                <a:gd name="connsiteY76" fmla="*/ 6802146 h 6858000"/>
                <a:gd name="connsiteX77" fmla="*/ 593791 w 6394458"/>
                <a:gd name="connsiteY77" fmla="*/ 5241450 h 6858000"/>
                <a:gd name="connsiteX78" fmla="*/ 0 w 6394458"/>
                <a:gd name="connsiteY78" fmla="*/ 3044861 h 6858000"/>
                <a:gd name="connsiteX79" fmla="*/ 342337 w 6394458"/>
                <a:gd name="connsiteY79" fmla="*/ 1349581 h 6858000"/>
                <a:gd name="connsiteX80" fmla="*/ 1129762 w 6394458"/>
                <a:gd name="connsiteY80" fmla="*/ 118183 h 68580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</a:cxnLst>
              <a:rect l="l" t="t" r="r" b="b"/>
              <a:pathLst>
                <a:path w="6394458" h="6858000">
                  <a:moveTo>
                    <a:pt x="1242460" y="0"/>
                  </a:moveTo>
                  <a:lnTo>
                    <a:pt x="2160732" y="0"/>
                  </a:lnTo>
                  <a:lnTo>
                    <a:pt x="2096124" y="41936"/>
                  </a:lnTo>
                  <a:cubicBezTo>
                    <a:pt x="2053586" y="71988"/>
                    <a:pt x="1997691" y="111913"/>
                    <a:pt x="1942232" y="154451"/>
                  </a:cubicBezTo>
                  <a:lnTo>
                    <a:pt x="1941942" y="154741"/>
                  </a:lnTo>
                  <a:lnTo>
                    <a:pt x="1941652" y="155032"/>
                  </a:lnTo>
                  <a:cubicBezTo>
                    <a:pt x="1920455" y="170711"/>
                    <a:pt x="1899113" y="187262"/>
                    <a:pt x="1878498" y="203377"/>
                  </a:cubicBezTo>
                  <a:lnTo>
                    <a:pt x="1865722" y="213395"/>
                  </a:lnTo>
                  <a:cubicBezTo>
                    <a:pt x="1838863" y="233865"/>
                    <a:pt x="1813311" y="254771"/>
                    <a:pt x="1791679" y="272483"/>
                  </a:cubicBezTo>
                  <a:cubicBezTo>
                    <a:pt x="1684245" y="360463"/>
                    <a:pt x="1590023" y="443216"/>
                    <a:pt x="1503495" y="525389"/>
                  </a:cubicBezTo>
                  <a:cubicBezTo>
                    <a:pt x="1315050" y="703090"/>
                    <a:pt x="1142430" y="895746"/>
                    <a:pt x="990135" y="1098128"/>
                  </a:cubicBezTo>
                  <a:cubicBezTo>
                    <a:pt x="911301" y="1202949"/>
                    <a:pt x="837695" y="1310238"/>
                    <a:pt x="771637" y="1416800"/>
                  </a:cubicBezTo>
                  <a:cubicBezTo>
                    <a:pt x="697595" y="1538898"/>
                    <a:pt x="636764" y="1650106"/>
                    <a:pt x="585660" y="1756960"/>
                  </a:cubicBezTo>
                  <a:lnTo>
                    <a:pt x="585515" y="1757395"/>
                  </a:lnTo>
                  <a:lnTo>
                    <a:pt x="585370" y="1757831"/>
                  </a:lnTo>
                  <a:cubicBezTo>
                    <a:pt x="570271" y="1788174"/>
                    <a:pt x="556334" y="1818952"/>
                    <a:pt x="544574" y="1845230"/>
                  </a:cubicBezTo>
                  <a:lnTo>
                    <a:pt x="524539" y="1889510"/>
                  </a:lnTo>
                  <a:lnTo>
                    <a:pt x="505666" y="1933935"/>
                  </a:lnTo>
                  <a:lnTo>
                    <a:pt x="502762" y="1940904"/>
                  </a:lnTo>
                  <a:cubicBezTo>
                    <a:pt x="491002" y="1969214"/>
                    <a:pt x="479823" y="1996073"/>
                    <a:pt x="469661" y="2023512"/>
                  </a:cubicBezTo>
                  <a:cubicBezTo>
                    <a:pt x="465450" y="2034691"/>
                    <a:pt x="461240" y="2045870"/>
                    <a:pt x="456885" y="2057049"/>
                  </a:cubicBezTo>
                  <a:cubicBezTo>
                    <a:pt x="449190" y="2076794"/>
                    <a:pt x="442076" y="2095522"/>
                    <a:pt x="435688" y="2114395"/>
                  </a:cubicBezTo>
                  <a:lnTo>
                    <a:pt x="435543" y="2114976"/>
                  </a:lnTo>
                  <a:lnTo>
                    <a:pt x="435253" y="2115557"/>
                  </a:lnTo>
                  <a:cubicBezTo>
                    <a:pt x="390392" y="2239687"/>
                    <a:pt x="353226" y="2365123"/>
                    <a:pt x="324770" y="2488382"/>
                  </a:cubicBezTo>
                  <a:cubicBezTo>
                    <a:pt x="265391" y="2742158"/>
                    <a:pt x="235193" y="3002178"/>
                    <a:pt x="235338" y="3261036"/>
                  </a:cubicBezTo>
                  <a:cubicBezTo>
                    <a:pt x="236210" y="3391989"/>
                    <a:pt x="248695" y="3520474"/>
                    <a:pt x="272505" y="3641991"/>
                  </a:cubicBezTo>
                  <a:cubicBezTo>
                    <a:pt x="299073" y="3770621"/>
                    <a:pt x="337110" y="3893154"/>
                    <a:pt x="385891" y="4006104"/>
                  </a:cubicBezTo>
                  <a:lnTo>
                    <a:pt x="386182" y="4006685"/>
                  </a:lnTo>
                  <a:lnTo>
                    <a:pt x="386472" y="4007266"/>
                  </a:lnTo>
                  <a:cubicBezTo>
                    <a:pt x="394747" y="4027591"/>
                    <a:pt x="404039" y="4047626"/>
                    <a:pt x="413911" y="4068823"/>
                  </a:cubicBezTo>
                  <a:cubicBezTo>
                    <a:pt x="417686" y="4077098"/>
                    <a:pt x="421606" y="4085374"/>
                    <a:pt x="425380" y="4093794"/>
                  </a:cubicBezTo>
                  <a:cubicBezTo>
                    <a:pt x="428865" y="4100908"/>
                    <a:pt x="432349" y="4107876"/>
                    <a:pt x="435834" y="4114845"/>
                  </a:cubicBezTo>
                  <a:cubicBezTo>
                    <a:pt x="446867" y="4136913"/>
                    <a:pt x="457320" y="4157819"/>
                    <a:pt x="468644" y="4178435"/>
                  </a:cubicBezTo>
                  <a:lnTo>
                    <a:pt x="468935" y="4179015"/>
                  </a:lnTo>
                  <a:lnTo>
                    <a:pt x="469225" y="4179596"/>
                  </a:lnTo>
                  <a:cubicBezTo>
                    <a:pt x="495213" y="4229103"/>
                    <a:pt x="525120" y="4280352"/>
                    <a:pt x="566496" y="4345828"/>
                  </a:cubicBezTo>
                  <a:cubicBezTo>
                    <a:pt x="598727" y="4397368"/>
                    <a:pt x="633135" y="4447745"/>
                    <a:pt x="674366" y="4507124"/>
                  </a:cubicBezTo>
                  <a:cubicBezTo>
                    <a:pt x="713129" y="4561713"/>
                    <a:pt x="753199" y="4615139"/>
                    <a:pt x="790946" y="4665372"/>
                  </a:cubicBezTo>
                  <a:cubicBezTo>
                    <a:pt x="839001" y="4729106"/>
                    <a:pt x="889379" y="4793421"/>
                    <a:pt x="938015" y="4855559"/>
                  </a:cubicBezTo>
                  <a:cubicBezTo>
                    <a:pt x="969955" y="4896355"/>
                    <a:pt x="1003056" y="4938457"/>
                    <a:pt x="1035286" y="4980269"/>
                  </a:cubicBezTo>
                  <a:cubicBezTo>
                    <a:pt x="1069113" y="5023969"/>
                    <a:pt x="1113684" y="5081606"/>
                    <a:pt x="1158254" y="5140985"/>
                  </a:cubicBezTo>
                  <a:cubicBezTo>
                    <a:pt x="1179451" y="5169005"/>
                    <a:pt x="1200647" y="5198186"/>
                    <a:pt x="1221118" y="5226351"/>
                  </a:cubicBezTo>
                  <a:cubicBezTo>
                    <a:pt x="1240572" y="5253065"/>
                    <a:pt x="1259010" y="5278471"/>
                    <a:pt x="1277448" y="5303007"/>
                  </a:cubicBezTo>
                  <a:lnTo>
                    <a:pt x="1277739" y="5303297"/>
                  </a:lnTo>
                  <a:lnTo>
                    <a:pt x="1278029" y="5303588"/>
                  </a:lnTo>
                  <a:cubicBezTo>
                    <a:pt x="1309824" y="5347287"/>
                    <a:pt x="1343796" y="5391132"/>
                    <a:pt x="1376607" y="5433525"/>
                  </a:cubicBezTo>
                  <a:lnTo>
                    <a:pt x="1395625" y="5458060"/>
                  </a:lnTo>
                  <a:lnTo>
                    <a:pt x="1405207" y="5469965"/>
                  </a:lnTo>
                  <a:cubicBezTo>
                    <a:pt x="1442083" y="5515552"/>
                    <a:pt x="1479976" y="5562736"/>
                    <a:pt x="1518739" y="5607597"/>
                  </a:cubicBezTo>
                  <a:cubicBezTo>
                    <a:pt x="1603960" y="5707481"/>
                    <a:pt x="1691650" y="5802139"/>
                    <a:pt x="1779194" y="5888957"/>
                  </a:cubicBezTo>
                  <a:cubicBezTo>
                    <a:pt x="1965606" y="6072902"/>
                    <a:pt x="2161746" y="6230423"/>
                    <a:pt x="2361805" y="6356876"/>
                  </a:cubicBezTo>
                  <a:cubicBezTo>
                    <a:pt x="2475047" y="6427870"/>
                    <a:pt x="2579867" y="6485217"/>
                    <a:pt x="2682656" y="6532110"/>
                  </a:cubicBezTo>
                  <a:lnTo>
                    <a:pt x="2682946" y="6532255"/>
                  </a:lnTo>
                  <a:lnTo>
                    <a:pt x="2683236" y="6532400"/>
                  </a:lnTo>
                  <a:cubicBezTo>
                    <a:pt x="2787767" y="6581616"/>
                    <a:pt x="2901734" y="6626187"/>
                    <a:pt x="3021944" y="6664805"/>
                  </a:cubicBezTo>
                  <a:cubicBezTo>
                    <a:pt x="3132572" y="6700374"/>
                    <a:pt x="3251620" y="6731298"/>
                    <a:pt x="3375605" y="6756415"/>
                  </a:cubicBezTo>
                  <a:cubicBezTo>
                    <a:pt x="3432661" y="6767738"/>
                    <a:pt x="3493201" y="6777901"/>
                    <a:pt x="3555048" y="6786612"/>
                  </a:cubicBezTo>
                  <a:cubicBezTo>
                    <a:pt x="3613121" y="6794742"/>
                    <a:pt x="3673807" y="6801566"/>
                    <a:pt x="3735218" y="6807083"/>
                  </a:cubicBezTo>
                  <a:cubicBezTo>
                    <a:pt x="3852670" y="6817826"/>
                    <a:pt x="3974622" y="6823052"/>
                    <a:pt x="4108188" y="6823343"/>
                  </a:cubicBezTo>
                  <a:lnTo>
                    <a:pt x="4126917" y="6823343"/>
                  </a:lnTo>
                  <a:cubicBezTo>
                    <a:pt x="4135192" y="6823488"/>
                    <a:pt x="4143322" y="6823488"/>
                    <a:pt x="4151597" y="6823488"/>
                  </a:cubicBezTo>
                  <a:cubicBezTo>
                    <a:pt x="4171487" y="6823488"/>
                    <a:pt x="4186296" y="6823343"/>
                    <a:pt x="4199652" y="6822763"/>
                  </a:cubicBezTo>
                  <a:lnTo>
                    <a:pt x="4200088" y="6822763"/>
                  </a:lnTo>
                  <a:lnTo>
                    <a:pt x="4200523" y="6822763"/>
                  </a:lnTo>
                  <a:lnTo>
                    <a:pt x="4245675" y="6821601"/>
                  </a:lnTo>
                  <a:lnTo>
                    <a:pt x="4291117" y="6819277"/>
                  </a:lnTo>
                  <a:cubicBezTo>
                    <a:pt x="4342801" y="6816955"/>
                    <a:pt x="4397825" y="6812164"/>
                    <a:pt x="4469108" y="6803743"/>
                  </a:cubicBezTo>
                  <a:cubicBezTo>
                    <a:pt x="4700672" y="6775433"/>
                    <a:pt x="4932236" y="6712860"/>
                    <a:pt x="5157267" y="6617766"/>
                  </a:cubicBezTo>
                  <a:cubicBezTo>
                    <a:pt x="5260490" y="6574648"/>
                    <a:pt x="5367344" y="6521656"/>
                    <a:pt x="5484069" y="6455744"/>
                  </a:cubicBezTo>
                  <a:cubicBezTo>
                    <a:pt x="5584535" y="6399414"/>
                    <a:pt x="5688194" y="6334663"/>
                    <a:pt x="5801144" y="6257717"/>
                  </a:cubicBezTo>
                  <a:cubicBezTo>
                    <a:pt x="5894061" y="6194419"/>
                    <a:pt x="5992638" y="6122844"/>
                    <a:pt x="6111106" y="6032542"/>
                  </a:cubicBezTo>
                  <a:cubicBezTo>
                    <a:pt x="6163081" y="5993052"/>
                    <a:pt x="6215491" y="5951676"/>
                    <a:pt x="6264127" y="5913203"/>
                  </a:cubicBezTo>
                  <a:lnTo>
                    <a:pt x="6394458" y="5808939"/>
                  </a:lnTo>
                  <a:lnTo>
                    <a:pt x="6394458" y="6858000"/>
                  </a:lnTo>
                  <a:lnTo>
                    <a:pt x="2234128" y="6858000"/>
                  </a:lnTo>
                  <a:lnTo>
                    <a:pt x="2151583" y="6802146"/>
                  </a:lnTo>
                  <a:cubicBezTo>
                    <a:pt x="1509012" y="6424386"/>
                    <a:pt x="970245" y="5884748"/>
                    <a:pt x="593791" y="5241450"/>
                  </a:cubicBezTo>
                  <a:cubicBezTo>
                    <a:pt x="205286" y="4577683"/>
                    <a:pt x="0" y="3818240"/>
                    <a:pt x="0" y="3044861"/>
                  </a:cubicBezTo>
                  <a:cubicBezTo>
                    <a:pt x="0" y="2457023"/>
                    <a:pt x="115129" y="1886606"/>
                    <a:pt x="342337" y="1349581"/>
                  </a:cubicBezTo>
                  <a:cubicBezTo>
                    <a:pt x="534284" y="895692"/>
                    <a:pt x="798705" y="482372"/>
                    <a:pt x="1129762" y="118183"/>
                  </a:cubicBezTo>
                  <a:close/>
                </a:path>
              </a:pathLst>
            </a:cu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 useBgFill="1">
          <p:nvSpPr>
            <p:cNvPr id="17" name="Freeform: Shape 16">
              <a:extLst>
                <a:ext uri="{FF2B5EF4-FFF2-40B4-BE49-F238E27FC236}">
                  <a16:creationId xmlns:a16="http://schemas.microsoft.com/office/drawing/2014/main" id="{1905757E-C772-4187-BD34-A12DC33F399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5934266" y="0"/>
              <a:ext cx="6419426" cy="6858000"/>
            </a:xfrm>
            <a:custGeom>
              <a:avLst/>
              <a:gdLst>
                <a:gd name="connsiteX0" fmla="*/ 6419426 w 6419426"/>
                <a:gd name="connsiteY0" fmla="*/ 6276207 h 6858000"/>
                <a:gd name="connsiteX1" fmla="*/ 6419426 w 6419426"/>
                <a:gd name="connsiteY1" fmla="*/ 6858000 h 6858000"/>
                <a:gd name="connsiteX2" fmla="*/ 5377226 w 6419426"/>
                <a:gd name="connsiteY2" fmla="*/ 6858000 h 6858000"/>
                <a:gd name="connsiteX3" fmla="*/ 5526079 w 6419426"/>
                <a:gd name="connsiteY3" fmla="*/ 6799309 h 6858000"/>
                <a:gd name="connsiteX4" fmla="*/ 6372097 w 6419426"/>
                <a:gd name="connsiteY4" fmla="*/ 6313400 h 6858000"/>
                <a:gd name="connsiteX5" fmla="*/ 0 w 6419426"/>
                <a:gd name="connsiteY5" fmla="*/ 3944218 h 6858000"/>
                <a:gd name="connsiteX6" fmla="*/ 31811 w 6419426"/>
                <a:gd name="connsiteY6" fmla="*/ 4082046 h 6858000"/>
                <a:gd name="connsiteX7" fmla="*/ 2375871 w 6419426"/>
                <a:gd name="connsiteY7" fmla="*/ 6799309 h 6858000"/>
                <a:gd name="connsiteX8" fmla="*/ 2524724 w 6419426"/>
                <a:gd name="connsiteY8" fmla="*/ 6858000 h 6858000"/>
                <a:gd name="connsiteX9" fmla="*/ 0 w 6419426"/>
                <a:gd name="connsiteY9" fmla="*/ 6858000 h 6858000"/>
                <a:gd name="connsiteX10" fmla="*/ 0 w 6419426"/>
                <a:gd name="connsiteY10" fmla="*/ 0 h 6858000"/>
                <a:gd name="connsiteX11" fmla="*/ 1320019 w 6419426"/>
                <a:gd name="connsiteY11" fmla="*/ 0 h 6858000"/>
                <a:gd name="connsiteX12" fmla="*/ 1089625 w 6419426"/>
                <a:gd name="connsiteY12" fmla="*/ 209396 h 6858000"/>
                <a:gd name="connsiteX13" fmla="*/ 31811 w 6419426"/>
                <a:gd name="connsiteY13" fmla="*/ 2059448 h 6858000"/>
                <a:gd name="connsiteX14" fmla="*/ 0 w 6419426"/>
                <a:gd name="connsiteY14" fmla="*/ 2197276 h 68580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</a:cxnLst>
              <a:rect l="l" t="t" r="r" b="b"/>
              <a:pathLst>
                <a:path w="6419426" h="6858000">
                  <a:moveTo>
                    <a:pt x="6419426" y="6276207"/>
                  </a:moveTo>
                  <a:lnTo>
                    <a:pt x="6419426" y="6858000"/>
                  </a:lnTo>
                  <a:lnTo>
                    <a:pt x="5377226" y="6858000"/>
                  </a:lnTo>
                  <a:lnTo>
                    <a:pt x="5526079" y="6799309"/>
                  </a:lnTo>
                  <a:cubicBezTo>
                    <a:pt x="5828657" y="6671330"/>
                    <a:pt x="6112428" y="6507594"/>
                    <a:pt x="6372097" y="6313400"/>
                  </a:cubicBezTo>
                  <a:close/>
                  <a:moveTo>
                    <a:pt x="0" y="3944218"/>
                  </a:moveTo>
                  <a:lnTo>
                    <a:pt x="31811" y="4082046"/>
                  </a:lnTo>
                  <a:cubicBezTo>
                    <a:pt x="347839" y="5310348"/>
                    <a:pt x="1226077" y="6312987"/>
                    <a:pt x="2375871" y="6799309"/>
                  </a:cubicBezTo>
                  <a:lnTo>
                    <a:pt x="2524724" y="6858000"/>
                  </a:lnTo>
                  <a:lnTo>
                    <a:pt x="0" y="6858000"/>
                  </a:lnTo>
                  <a:close/>
                  <a:moveTo>
                    <a:pt x="0" y="0"/>
                  </a:moveTo>
                  <a:lnTo>
                    <a:pt x="1320019" y="0"/>
                  </a:lnTo>
                  <a:lnTo>
                    <a:pt x="1089625" y="209396"/>
                  </a:lnTo>
                  <a:cubicBezTo>
                    <a:pt x="586180" y="712841"/>
                    <a:pt x="214775" y="1348326"/>
                    <a:pt x="31811" y="2059448"/>
                  </a:cubicBezTo>
                  <a:lnTo>
                    <a:pt x="0" y="2197276"/>
                  </a:lnTo>
                  <a:close/>
                </a:path>
              </a:pathLst>
            </a:cu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" name="Title 1">
            <a:extLst>
              <a:ext uri="{FF2B5EF4-FFF2-40B4-BE49-F238E27FC236}">
                <a16:creationId xmlns:a16="http://schemas.microsoft.com/office/drawing/2014/main" id="{90121427-7601-614B-B9AF-FE0F64B62D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8681" y="543697"/>
            <a:ext cx="6648563" cy="1554055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0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 Early Detection Common in Kentucky?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7790DC-25D7-ED45-AE47-1EB50E11CA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8682" y="2097752"/>
            <a:ext cx="5054432" cy="4437576"/>
          </a:xfrm>
        </p:spPr>
        <p:txBody>
          <a:bodyPr anchor="ctr">
            <a:normAutofit/>
          </a:bodyPr>
          <a:lstStyle/>
          <a:p>
            <a:pPr marL="0" indent="0">
              <a:spcBef>
                <a:spcPts val="600"/>
              </a:spcBef>
              <a:spcAft>
                <a:spcPts val="600"/>
              </a:spcAft>
              <a:buNone/>
            </a:pP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Not nearly as common as it should be!</a:t>
            </a:r>
          </a:p>
          <a:p>
            <a:pPr lvl="1"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nly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70%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f at-risk patients are up to date on gastrointestinal screenings.</a:t>
            </a:r>
          </a:p>
          <a:p>
            <a:pPr lvl="1"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nly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64%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f at-risk women are up to date on breast cancer screenings.</a:t>
            </a:r>
          </a:p>
          <a:p>
            <a:pPr lvl="1">
              <a:spcBef>
                <a:spcPts val="60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nly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10.3%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f at-risk lung cancer patients are properly screened for lung cancer.</a:t>
            </a:r>
          </a:p>
        </p:txBody>
      </p:sp>
    </p:spTree>
    <p:extLst>
      <p:ext uri="{BB962C8B-B14F-4D97-AF65-F5344CB8AC3E}">
        <p14:creationId xmlns:p14="http://schemas.microsoft.com/office/powerpoint/2010/main" val="212073367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5ACCA6-437B-D849-BDD6-A870E2658C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0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hat happens if early detection doesn’t occur?</a:t>
            </a:r>
          </a:p>
        </p:txBody>
      </p:sp>
      <p:graphicFrame>
        <p:nvGraphicFramePr>
          <p:cNvPr id="5" name="Content Placeholder 2">
            <a:extLst>
              <a:ext uri="{FF2B5EF4-FFF2-40B4-BE49-F238E27FC236}">
                <a16:creationId xmlns:a16="http://schemas.microsoft.com/office/drawing/2014/main" id="{29684796-C967-4250-868E-6A81E0801F06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219273399"/>
              </p:ext>
            </p:extLst>
          </p:nvPr>
        </p:nvGraphicFramePr>
        <p:xfrm>
          <a:off x="838200" y="1915885"/>
          <a:ext cx="10515600" cy="4261077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2097895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CB6162-904E-BE44-AE8E-DE439A7721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2899" y="540167"/>
            <a:ext cx="5828376" cy="1288633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0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hat are the barriers to early detection?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B7AB50-10E3-2147-A33B-6557FCB7B8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22899" y="2198914"/>
            <a:ext cx="5828376" cy="4118919"/>
          </a:xfrm>
        </p:spPr>
        <p:txBody>
          <a:bodyPr anchor="t">
            <a:noAutofit/>
          </a:bodyPr>
          <a:lstStyle/>
          <a:p>
            <a:pPr>
              <a:lnSpc>
                <a:spcPct val="100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sz="2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me Kentucky residents, especially those in rural Appalachia, do not have easy access to healthcare. Why?</a:t>
            </a:r>
          </a:p>
          <a:p>
            <a:pPr lvl="1">
              <a:lnSpc>
                <a:spcPct val="100000"/>
              </a:lnSpc>
              <a:spcBef>
                <a:spcPts val="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hey often live very far from the nearest cancer care facility.</a:t>
            </a:r>
          </a:p>
          <a:p>
            <a:pPr lvl="1">
              <a:lnSpc>
                <a:spcPct val="100000"/>
              </a:lnSpc>
              <a:spcBef>
                <a:spcPts val="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he roads may be winding and dangerous.</a:t>
            </a:r>
          </a:p>
          <a:p>
            <a:pPr lvl="1">
              <a:lnSpc>
                <a:spcPct val="100000"/>
              </a:lnSpc>
              <a:spcBef>
                <a:spcPts val="0"/>
              </a:spcBef>
              <a:spcAft>
                <a:spcPts val="600"/>
              </a:spcAft>
              <a:buFont typeface="System Font Regular"/>
              <a:buChar char="–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hey may not be able to take off work to travel to receive care.</a:t>
            </a:r>
          </a:p>
        </p:txBody>
      </p:sp>
      <p:pic>
        <p:nvPicPr>
          <p:cNvPr id="6" name="Picture 5" descr="A group of bushes and trees&#10;&#10;Description automatically generated">
            <a:extLst>
              <a:ext uri="{FF2B5EF4-FFF2-40B4-BE49-F238E27FC236}">
                <a16:creationId xmlns:a16="http://schemas.microsoft.com/office/drawing/2014/main" id="{BAA3B17C-490F-4E43-B5BF-14241E79B43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096000" y="0"/>
            <a:ext cx="6096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055249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Custom 1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0033A0"/>
      </a:accent1>
      <a:accent2>
        <a:srgbClr val="58C9E7"/>
      </a:accent2>
      <a:accent3>
        <a:srgbClr val="A5A5A5"/>
      </a:accent3>
      <a:accent4>
        <a:srgbClr val="FCB524"/>
      </a:accent4>
      <a:accent5>
        <a:srgbClr val="EF3A4C"/>
      </a:accent5>
      <a:accent6>
        <a:srgbClr val="81BD41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8</TotalTime>
  <Words>1452</Words>
  <Application>Microsoft Office PowerPoint</Application>
  <PresentationFormat>Widescreen</PresentationFormat>
  <Paragraphs>160</Paragraphs>
  <Slides>24</Slides>
  <Notes>15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4</vt:i4>
      </vt:variant>
    </vt:vector>
  </HeadingPairs>
  <TitlesOfParts>
    <vt:vector size="29" baseType="lpstr">
      <vt:lpstr>Arial</vt:lpstr>
      <vt:lpstr>Calibri</vt:lpstr>
      <vt:lpstr>Calibri Light</vt:lpstr>
      <vt:lpstr>System Font Regular</vt:lpstr>
      <vt:lpstr>Office Theme</vt:lpstr>
      <vt:lpstr>CANCER IN THE COMMONWEALTH</vt:lpstr>
      <vt:lpstr>ACTIVITY</vt:lpstr>
      <vt:lpstr>Cancer Treatments In Depth</vt:lpstr>
      <vt:lpstr>How is Cancer Diagnosed?</vt:lpstr>
      <vt:lpstr>What is Early Detection?</vt:lpstr>
      <vt:lpstr>Why is Early Detection Important?</vt:lpstr>
      <vt:lpstr>Is Early Detection Common in Kentucky?</vt:lpstr>
      <vt:lpstr>What happens if early detection doesn’t occur?</vt:lpstr>
      <vt:lpstr>What are the barriers to early detection?</vt:lpstr>
      <vt:lpstr>4 Common Types of Cancer Treatment</vt:lpstr>
      <vt:lpstr>Chemotherapy</vt:lpstr>
      <vt:lpstr>Neoadjuvant vs. Adjuvant Chemo</vt:lpstr>
      <vt:lpstr>Side Effects of Chemotherapy</vt:lpstr>
      <vt:lpstr>Radiation Therapy</vt:lpstr>
      <vt:lpstr>External vs. Internal Beam Radiation</vt:lpstr>
      <vt:lpstr>Side Effects of Radiation Therapy</vt:lpstr>
      <vt:lpstr>Surgery</vt:lpstr>
      <vt:lpstr>Open vs. Minimally Invasive Surgery</vt:lpstr>
      <vt:lpstr>Side Effects of Cancer Surgery</vt:lpstr>
      <vt:lpstr>Stem Cell Transplant</vt:lpstr>
      <vt:lpstr>Autologous, Allogeneic, and Syngeneic</vt:lpstr>
      <vt:lpstr>Side Effects of Stem Cell Transplants</vt:lpstr>
      <vt:lpstr>Summary</vt:lpstr>
      <vt:lpstr>QUESTION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ANCER IN THE COMMONWEALTH</dc:title>
  <dc:creator>Wright, Elise</dc:creator>
  <cp:lastModifiedBy>Charlotte Seidman</cp:lastModifiedBy>
  <cp:revision>29</cp:revision>
  <dcterms:created xsi:type="dcterms:W3CDTF">2020-07-30T14:59:59Z</dcterms:created>
  <dcterms:modified xsi:type="dcterms:W3CDTF">2022-05-20T00:09:05Z</dcterms:modified>
</cp:coreProperties>
</file>